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395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3077" y="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80536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17138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31569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65390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66864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89842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39168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26378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74114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16908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l-GR" smtClean="0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06079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9F935-4A9C-4E72-8F4C-BC180415EB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6AD5B-2B1F-4CD1-965D-A11155F92BD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28389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Ομάδα 2"/>
          <p:cNvGrpSpPr/>
          <p:nvPr/>
        </p:nvGrpSpPr>
        <p:grpSpPr>
          <a:xfrm>
            <a:off x="0" y="-24844"/>
            <a:ext cx="6824648" cy="8167818"/>
            <a:chOff x="0" y="-24844"/>
            <a:chExt cx="6824648" cy="8167818"/>
          </a:xfrm>
        </p:grpSpPr>
        <p:sp>
          <p:nvSpPr>
            <p:cNvPr id="434" name="60 - TextBox"/>
            <p:cNvSpPr txBox="1"/>
            <p:nvPr/>
          </p:nvSpPr>
          <p:spPr>
            <a:xfrm>
              <a:off x="0" y="-24844"/>
              <a:ext cx="28135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6</a:t>
              </a:r>
              <a:endParaRPr lang="el-G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37120" y="398223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137962" y="398223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37120" y="260930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125138" y="260930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37120" y="4707457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Εικόνα 1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775" y="5370600"/>
              <a:ext cx="1755648" cy="512729"/>
            </a:xfrm>
            <a:prstGeom prst="rect">
              <a:avLst/>
            </a:prstGeom>
          </p:spPr>
        </p:pic>
        <p:pic>
          <p:nvPicPr>
            <p:cNvPr id="16" name="Εικόνα 1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775" y="6490609"/>
              <a:ext cx="1755648" cy="512729"/>
            </a:xfrm>
            <a:prstGeom prst="rect">
              <a:avLst/>
            </a:prstGeom>
          </p:spPr>
        </p:pic>
        <p:pic>
          <p:nvPicPr>
            <p:cNvPr id="17" name="Εικόνα 1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355" y="7060427"/>
              <a:ext cx="1755648" cy="512729"/>
            </a:xfrm>
            <a:prstGeom prst="rect">
              <a:avLst/>
            </a:prstGeom>
          </p:spPr>
        </p:pic>
        <p:pic>
          <p:nvPicPr>
            <p:cNvPr id="18" name="Εικόνα 1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775" y="5920791"/>
              <a:ext cx="1755648" cy="512729"/>
            </a:xfrm>
            <a:prstGeom prst="rect">
              <a:avLst/>
            </a:prstGeom>
          </p:spPr>
        </p:pic>
        <p:pic>
          <p:nvPicPr>
            <p:cNvPr id="19" name="Εικόνα 1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757775" y="7630245"/>
              <a:ext cx="1755648" cy="512729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711916" y="5339638"/>
              <a:ext cx="5370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l-GR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05939" y="5899743"/>
              <a:ext cx="8418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sd-1(RNAi</a:t>
              </a:r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l-GR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09361" y="6452782"/>
              <a:ext cx="8418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d-9(RNAi</a:t>
              </a:r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l-GR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05939" y="7031948"/>
              <a:ext cx="11645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sd-1;ced-9(RNAi</a:t>
              </a:r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l-GR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05939" y="7611114"/>
              <a:ext cx="8418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ec-1(RNAi</a:t>
              </a:r>
              <a:r>
                <a:rPr lang="en-U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l-GR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Ευθεία γραμμή σύνδεσης 24"/>
            <p:cNvCxnSpPr/>
            <p:nvPr/>
          </p:nvCxnSpPr>
          <p:spPr>
            <a:xfrm flipV="1">
              <a:off x="795151" y="5816115"/>
              <a:ext cx="370541" cy="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3112314" y="4707457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949847" y="39822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3" name="Group 100"/>
            <p:cNvGrpSpPr>
              <a:grpSpLocks noChangeAspect="1"/>
            </p:cNvGrpSpPr>
            <p:nvPr/>
          </p:nvGrpSpPr>
          <p:grpSpPr bwMode="auto">
            <a:xfrm>
              <a:off x="413592" y="704877"/>
              <a:ext cx="2555875" cy="1824038"/>
              <a:chOff x="1107" y="434"/>
              <a:chExt cx="1610" cy="1149"/>
            </a:xfrm>
          </p:grpSpPr>
          <p:sp>
            <p:nvSpPr>
              <p:cNvPr id="64" name="AutoShape 99"/>
              <p:cNvSpPr>
                <a:spLocks noChangeAspect="1" noChangeArrowheads="1" noTextEdit="1"/>
              </p:cNvSpPr>
              <p:nvPr/>
            </p:nvSpPr>
            <p:spPr bwMode="auto">
              <a:xfrm>
                <a:off x="1107" y="472"/>
                <a:ext cx="1610" cy="1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dirty="0"/>
              </a:p>
            </p:txBody>
          </p:sp>
          <p:sp>
            <p:nvSpPr>
              <p:cNvPr id="65" name="Rectangle 101"/>
              <p:cNvSpPr>
                <a:spLocks noChangeArrowheads="1"/>
              </p:cNvSpPr>
              <p:nvPr/>
            </p:nvSpPr>
            <p:spPr bwMode="auto">
              <a:xfrm>
                <a:off x="1279" y="1364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" name="Rectangle 102"/>
              <p:cNvSpPr>
                <a:spLocks noChangeArrowheads="1"/>
              </p:cNvSpPr>
              <p:nvPr/>
            </p:nvSpPr>
            <p:spPr bwMode="auto">
              <a:xfrm>
                <a:off x="1466" y="1364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7" name="Rectangle 103"/>
              <p:cNvSpPr>
                <a:spLocks noChangeArrowheads="1"/>
              </p:cNvSpPr>
              <p:nvPr/>
            </p:nvSpPr>
            <p:spPr bwMode="auto">
              <a:xfrm>
                <a:off x="1638" y="1364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8" name="Rectangle 104"/>
              <p:cNvSpPr>
                <a:spLocks noChangeArrowheads="1"/>
              </p:cNvSpPr>
              <p:nvPr/>
            </p:nvSpPr>
            <p:spPr bwMode="auto">
              <a:xfrm>
                <a:off x="1826" y="1364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9" name="Rectangle 105"/>
              <p:cNvSpPr>
                <a:spLocks noChangeArrowheads="1"/>
              </p:cNvSpPr>
              <p:nvPr/>
            </p:nvSpPr>
            <p:spPr bwMode="auto">
              <a:xfrm>
                <a:off x="2013" y="1364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0" name="Rectangle 106"/>
              <p:cNvSpPr>
                <a:spLocks noChangeArrowheads="1"/>
              </p:cNvSpPr>
              <p:nvPr/>
            </p:nvSpPr>
            <p:spPr bwMode="auto">
              <a:xfrm>
                <a:off x="2201" y="1364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" name="Rectangle 107"/>
              <p:cNvSpPr>
                <a:spLocks noChangeArrowheads="1"/>
              </p:cNvSpPr>
              <p:nvPr/>
            </p:nvSpPr>
            <p:spPr bwMode="auto">
              <a:xfrm>
                <a:off x="2388" y="1364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" name="Freeform 108"/>
              <p:cNvSpPr>
                <a:spLocks noEditPoints="1"/>
              </p:cNvSpPr>
              <p:nvPr/>
            </p:nvSpPr>
            <p:spPr bwMode="auto">
              <a:xfrm>
                <a:off x="1293" y="1333"/>
                <a:ext cx="1132" cy="22"/>
              </a:xfrm>
              <a:custGeom>
                <a:avLst/>
                <a:gdLst>
                  <a:gd name="T0" fmla="*/ 0 w 1132"/>
                  <a:gd name="T1" fmla="*/ 0 h 22"/>
                  <a:gd name="T2" fmla="*/ 1132 w 1132"/>
                  <a:gd name="T3" fmla="*/ 0 h 22"/>
                  <a:gd name="T4" fmla="*/ 3 w 1132"/>
                  <a:gd name="T5" fmla="*/ 0 h 22"/>
                  <a:gd name="T6" fmla="*/ 3 w 1132"/>
                  <a:gd name="T7" fmla="*/ 22 h 22"/>
                  <a:gd name="T8" fmla="*/ 191 w 1132"/>
                  <a:gd name="T9" fmla="*/ 0 h 22"/>
                  <a:gd name="T10" fmla="*/ 191 w 1132"/>
                  <a:gd name="T11" fmla="*/ 22 h 22"/>
                  <a:gd name="T12" fmla="*/ 378 w 1132"/>
                  <a:gd name="T13" fmla="*/ 0 h 22"/>
                  <a:gd name="T14" fmla="*/ 378 w 1132"/>
                  <a:gd name="T15" fmla="*/ 22 h 22"/>
                  <a:gd name="T16" fmla="*/ 566 w 1132"/>
                  <a:gd name="T17" fmla="*/ 0 h 22"/>
                  <a:gd name="T18" fmla="*/ 566 w 1132"/>
                  <a:gd name="T19" fmla="*/ 22 h 22"/>
                  <a:gd name="T20" fmla="*/ 753 w 1132"/>
                  <a:gd name="T21" fmla="*/ 0 h 22"/>
                  <a:gd name="T22" fmla="*/ 753 w 1132"/>
                  <a:gd name="T23" fmla="*/ 22 h 22"/>
                  <a:gd name="T24" fmla="*/ 941 w 1132"/>
                  <a:gd name="T25" fmla="*/ 0 h 22"/>
                  <a:gd name="T26" fmla="*/ 941 w 1132"/>
                  <a:gd name="T27" fmla="*/ 22 h 22"/>
                  <a:gd name="T28" fmla="*/ 1128 w 1132"/>
                  <a:gd name="T29" fmla="*/ 0 h 22"/>
                  <a:gd name="T30" fmla="*/ 1128 w 1132"/>
                  <a:gd name="T31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1132" h="22">
                    <a:moveTo>
                      <a:pt x="0" y="0"/>
                    </a:moveTo>
                    <a:lnTo>
                      <a:pt x="1132" y="0"/>
                    </a:lnTo>
                    <a:moveTo>
                      <a:pt x="3" y="0"/>
                    </a:moveTo>
                    <a:lnTo>
                      <a:pt x="3" y="22"/>
                    </a:lnTo>
                    <a:moveTo>
                      <a:pt x="191" y="0"/>
                    </a:moveTo>
                    <a:lnTo>
                      <a:pt x="191" y="22"/>
                    </a:lnTo>
                    <a:moveTo>
                      <a:pt x="378" y="0"/>
                    </a:moveTo>
                    <a:lnTo>
                      <a:pt x="378" y="22"/>
                    </a:lnTo>
                    <a:moveTo>
                      <a:pt x="566" y="0"/>
                    </a:moveTo>
                    <a:lnTo>
                      <a:pt x="566" y="22"/>
                    </a:lnTo>
                    <a:moveTo>
                      <a:pt x="753" y="0"/>
                    </a:moveTo>
                    <a:lnTo>
                      <a:pt x="753" y="22"/>
                    </a:lnTo>
                    <a:moveTo>
                      <a:pt x="941" y="0"/>
                    </a:moveTo>
                    <a:lnTo>
                      <a:pt x="941" y="22"/>
                    </a:lnTo>
                    <a:moveTo>
                      <a:pt x="1128" y="0"/>
                    </a:moveTo>
                    <a:lnTo>
                      <a:pt x="1128" y="22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" name="Rectangle 109"/>
              <p:cNvSpPr>
                <a:spLocks noChangeArrowheads="1"/>
              </p:cNvSpPr>
              <p:nvPr/>
            </p:nvSpPr>
            <p:spPr bwMode="auto">
              <a:xfrm>
                <a:off x="1232" y="1298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4" name="Rectangle 110"/>
              <p:cNvSpPr>
                <a:spLocks noChangeArrowheads="1"/>
              </p:cNvSpPr>
              <p:nvPr/>
            </p:nvSpPr>
            <p:spPr bwMode="auto">
              <a:xfrm>
                <a:off x="1197" y="1145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" name="Rectangle 111"/>
              <p:cNvSpPr>
                <a:spLocks noChangeArrowheads="1"/>
              </p:cNvSpPr>
              <p:nvPr/>
            </p:nvSpPr>
            <p:spPr bwMode="auto">
              <a:xfrm>
                <a:off x="1197" y="996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6" name="Rectangle 112"/>
              <p:cNvSpPr>
                <a:spLocks noChangeArrowheads="1"/>
              </p:cNvSpPr>
              <p:nvPr/>
            </p:nvSpPr>
            <p:spPr bwMode="auto">
              <a:xfrm>
                <a:off x="1197" y="848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" name="Rectangle 113"/>
              <p:cNvSpPr>
                <a:spLocks noChangeArrowheads="1"/>
              </p:cNvSpPr>
              <p:nvPr/>
            </p:nvSpPr>
            <p:spPr bwMode="auto">
              <a:xfrm>
                <a:off x="1197" y="695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8" name="Rectangle 114"/>
              <p:cNvSpPr>
                <a:spLocks noChangeArrowheads="1"/>
              </p:cNvSpPr>
              <p:nvPr/>
            </p:nvSpPr>
            <p:spPr bwMode="auto">
              <a:xfrm>
                <a:off x="1162" y="546"/>
                <a:ext cx="10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9" name="Freeform 115"/>
              <p:cNvSpPr>
                <a:spLocks noEditPoints="1"/>
              </p:cNvSpPr>
              <p:nvPr/>
            </p:nvSpPr>
            <p:spPr bwMode="auto">
              <a:xfrm>
                <a:off x="1274" y="577"/>
                <a:ext cx="22" cy="759"/>
              </a:xfrm>
              <a:custGeom>
                <a:avLst/>
                <a:gdLst>
                  <a:gd name="T0" fmla="*/ 22 w 22"/>
                  <a:gd name="T1" fmla="*/ 759 h 759"/>
                  <a:gd name="T2" fmla="*/ 22 w 22"/>
                  <a:gd name="T3" fmla="*/ 0 h 759"/>
                  <a:gd name="T4" fmla="*/ 22 w 22"/>
                  <a:gd name="T5" fmla="*/ 756 h 759"/>
                  <a:gd name="T6" fmla="*/ 0 w 22"/>
                  <a:gd name="T7" fmla="*/ 756 h 759"/>
                  <a:gd name="T8" fmla="*/ 22 w 22"/>
                  <a:gd name="T9" fmla="*/ 606 h 759"/>
                  <a:gd name="T10" fmla="*/ 0 w 22"/>
                  <a:gd name="T11" fmla="*/ 606 h 759"/>
                  <a:gd name="T12" fmla="*/ 22 w 22"/>
                  <a:gd name="T13" fmla="*/ 455 h 759"/>
                  <a:gd name="T14" fmla="*/ 0 w 22"/>
                  <a:gd name="T15" fmla="*/ 455 h 759"/>
                  <a:gd name="T16" fmla="*/ 22 w 22"/>
                  <a:gd name="T17" fmla="*/ 305 h 759"/>
                  <a:gd name="T18" fmla="*/ 0 w 22"/>
                  <a:gd name="T19" fmla="*/ 305 h 759"/>
                  <a:gd name="T20" fmla="*/ 22 w 22"/>
                  <a:gd name="T21" fmla="*/ 154 h 759"/>
                  <a:gd name="T22" fmla="*/ 0 w 22"/>
                  <a:gd name="T23" fmla="*/ 154 h 759"/>
                  <a:gd name="T24" fmla="*/ 22 w 22"/>
                  <a:gd name="T25" fmla="*/ 4 h 759"/>
                  <a:gd name="T26" fmla="*/ 0 w 22"/>
                  <a:gd name="T27" fmla="*/ 4 h 7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22" h="759">
                    <a:moveTo>
                      <a:pt x="22" y="759"/>
                    </a:moveTo>
                    <a:lnTo>
                      <a:pt x="22" y="0"/>
                    </a:lnTo>
                    <a:moveTo>
                      <a:pt x="22" y="756"/>
                    </a:moveTo>
                    <a:lnTo>
                      <a:pt x="0" y="756"/>
                    </a:lnTo>
                    <a:moveTo>
                      <a:pt x="22" y="606"/>
                    </a:moveTo>
                    <a:lnTo>
                      <a:pt x="0" y="606"/>
                    </a:lnTo>
                    <a:moveTo>
                      <a:pt x="22" y="455"/>
                    </a:moveTo>
                    <a:lnTo>
                      <a:pt x="0" y="455"/>
                    </a:lnTo>
                    <a:moveTo>
                      <a:pt x="22" y="305"/>
                    </a:moveTo>
                    <a:lnTo>
                      <a:pt x="0" y="305"/>
                    </a:lnTo>
                    <a:moveTo>
                      <a:pt x="22" y="154"/>
                    </a:moveTo>
                    <a:lnTo>
                      <a:pt x="0" y="154"/>
                    </a:lnTo>
                    <a:moveTo>
                      <a:pt x="22" y="4"/>
                    </a:moveTo>
                    <a:lnTo>
                      <a:pt x="0" y="4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" name="Freeform 116"/>
              <p:cNvSpPr>
                <a:spLocks/>
              </p:cNvSpPr>
              <p:nvPr/>
            </p:nvSpPr>
            <p:spPr bwMode="auto">
              <a:xfrm>
                <a:off x="1296" y="581"/>
                <a:ext cx="1051" cy="752"/>
              </a:xfrm>
              <a:custGeom>
                <a:avLst/>
                <a:gdLst>
                  <a:gd name="T0" fmla="*/ 0 w 1051"/>
                  <a:gd name="T1" fmla="*/ 0 h 752"/>
                  <a:gd name="T2" fmla="*/ 0 w 1051"/>
                  <a:gd name="T3" fmla="*/ 0 h 752"/>
                  <a:gd name="T4" fmla="*/ 0 w 1051"/>
                  <a:gd name="T5" fmla="*/ 0 h 752"/>
                  <a:gd name="T6" fmla="*/ 38 w 1051"/>
                  <a:gd name="T7" fmla="*/ 0 h 752"/>
                  <a:gd name="T8" fmla="*/ 38 w 1051"/>
                  <a:gd name="T9" fmla="*/ 0 h 752"/>
                  <a:gd name="T10" fmla="*/ 113 w 1051"/>
                  <a:gd name="T11" fmla="*/ 0 h 752"/>
                  <a:gd name="T12" fmla="*/ 113 w 1051"/>
                  <a:gd name="T13" fmla="*/ 0 h 752"/>
                  <a:gd name="T14" fmla="*/ 188 w 1051"/>
                  <a:gd name="T15" fmla="*/ 0 h 752"/>
                  <a:gd name="T16" fmla="*/ 188 w 1051"/>
                  <a:gd name="T17" fmla="*/ 0 h 752"/>
                  <a:gd name="T18" fmla="*/ 263 w 1051"/>
                  <a:gd name="T19" fmla="*/ 0 h 752"/>
                  <a:gd name="T20" fmla="*/ 263 w 1051"/>
                  <a:gd name="T21" fmla="*/ 0 h 752"/>
                  <a:gd name="T22" fmla="*/ 338 w 1051"/>
                  <a:gd name="T23" fmla="*/ 9 h 752"/>
                  <a:gd name="T24" fmla="*/ 338 w 1051"/>
                  <a:gd name="T25" fmla="*/ 9 h 752"/>
                  <a:gd name="T26" fmla="*/ 375 w 1051"/>
                  <a:gd name="T27" fmla="*/ 53 h 752"/>
                  <a:gd name="T28" fmla="*/ 375 w 1051"/>
                  <a:gd name="T29" fmla="*/ 53 h 752"/>
                  <a:gd name="T30" fmla="*/ 413 w 1051"/>
                  <a:gd name="T31" fmla="*/ 97 h 752"/>
                  <a:gd name="T32" fmla="*/ 413 w 1051"/>
                  <a:gd name="T33" fmla="*/ 97 h 752"/>
                  <a:gd name="T34" fmla="*/ 488 w 1051"/>
                  <a:gd name="T35" fmla="*/ 184 h 752"/>
                  <a:gd name="T36" fmla="*/ 488 w 1051"/>
                  <a:gd name="T37" fmla="*/ 184 h 752"/>
                  <a:gd name="T38" fmla="*/ 563 w 1051"/>
                  <a:gd name="T39" fmla="*/ 266 h 752"/>
                  <a:gd name="T40" fmla="*/ 563 w 1051"/>
                  <a:gd name="T41" fmla="*/ 266 h 752"/>
                  <a:gd name="T42" fmla="*/ 601 w 1051"/>
                  <a:gd name="T43" fmla="*/ 342 h 752"/>
                  <a:gd name="T44" fmla="*/ 601 w 1051"/>
                  <a:gd name="T45" fmla="*/ 342 h 752"/>
                  <a:gd name="T46" fmla="*/ 638 w 1051"/>
                  <a:gd name="T47" fmla="*/ 469 h 752"/>
                  <a:gd name="T48" fmla="*/ 638 w 1051"/>
                  <a:gd name="T49" fmla="*/ 469 h 752"/>
                  <a:gd name="T50" fmla="*/ 713 w 1051"/>
                  <a:gd name="T51" fmla="*/ 547 h 752"/>
                  <a:gd name="T52" fmla="*/ 713 w 1051"/>
                  <a:gd name="T53" fmla="*/ 547 h 752"/>
                  <a:gd name="T54" fmla="*/ 788 w 1051"/>
                  <a:gd name="T55" fmla="*/ 632 h 752"/>
                  <a:gd name="T56" fmla="*/ 788 w 1051"/>
                  <a:gd name="T57" fmla="*/ 632 h 752"/>
                  <a:gd name="T58" fmla="*/ 863 w 1051"/>
                  <a:gd name="T59" fmla="*/ 688 h 752"/>
                  <a:gd name="T60" fmla="*/ 863 w 1051"/>
                  <a:gd name="T61" fmla="*/ 688 h 752"/>
                  <a:gd name="T62" fmla="*/ 938 w 1051"/>
                  <a:gd name="T63" fmla="*/ 731 h 752"/>
                  <a:gd name="T64" fmla="*/ 938 w 1051"/>
                  <a:gd name="T65" fmla="*/ 731 h 752"/>
                  <a:gd name="T66" fmla="*/ 1013 w 1051"/>
                  <a:gd name="T67" fmla="*/ 745 h 752"/>
                  <a:gd name="T68" fmla="*/ 1013 w 1051"/>
                  <a:gd name="T69" fmla="*/ 745 h 752"/>
                  <a:gd name="T70" fmla="*/ 1051 w 1051"/>
                  <a:gd name="T71" fmla="*/ 752 h 7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</a:cxnLst>
                <a:rect l="0" t="0" r="r" b="b"/>
                <a:pathLst>
                  <a:path w="1051" h="752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38" y="0"/>
                    </a:lnTo>
                    <a:lnTo>
                      <a:pt x="38" y="0"/>
                    </a:lnTo>
                    <a:lnTo>
                      <a:pt x="113" y="0"/>
                    </a:lnTo>
                    <a:lnTo>
                      <a:pt x="113" y="0"/>
                    </a:lnTo>
                    <a:lnTo>
                      <a:pt x="188" y="0"/>
                    </a:lnTo>
                    <a:lnTo>
                      <a:pt x="188" y="0"/>
                    </a:lnTo>
                    <a:lnTo>
                      <a:pt x="263" y="0"/>
                    </a:lnTo>
                    <a:lnTo>
                      <a:pt x="263" y="0"/>
                    </a:lnTo>
                    <a:lnTo>
                      <a:pt x="338" y="9"/>
                    </a:lnTo>
                    <a:lnTo>
                      <a:pt x="338" y="9"/>
                    </a:lnTo>
                    <a:lnTo>
                      <a:pt x="375" y="53"/>
                    </a:lnTo>
                    <a:lnTo>
                      <a:pt x="375" y="53"/>
                    </a:lnTo>
                    <a:lnTo>
                      <a:pt x="413" y="97"/>
                    </a:lnTo>
                    <a:lnTo>
                      <a:pt x="413" y="97"/>
                    </a:lnTo>
                    <a:lnTo>
                      <a:pt x="488" y="184"/>
                    </a:lnTo>
                    <a:lnTo>
                      <a:pt x="488" y="184"/>
                    </a:lnTo>
                    <a:lnTo>
                      <a:pt x="563" y="266"/>
                    </a:lnTo>
                    <a:lnTo>
                      <a:pt x="563" y="266"/>
                    </a:lnTo>
                    <a:lnTo>
                      <a:pt x="601" y="342"/>
                    </a:lnTo>
                    <a:lnTo>
                      <a:pt x="601" y="342"/>
                    </a:lnTo>
                    <a:lnTo>
                      <a:pt x="638" y="469"/>
                    </a:lnTo>
                    <a:lnTo>
                      <a:pt x="638" y="469"/>
                    </a:lnTo>
                    <a:lnTo>
                      <a:pt x="713" y="547"/>
                    </a:lnTo>
                    <a:lnTo>
                      <a:pt x="713" y="547"/>
                    </a:lnTo>
                    <a:lnTo>
                      <a:pt x="788" y="632"/>
                    </a:lnTo>
                    <a:lnTo>
                      <a:pt x="788" y="632"/>
                    </a:lnTo>
                    <a:lnTo>
                      <a:pt x="863" y="688"/>
                    </a:lnTo>
                    <a:lnTo>
                      <a:pt x="863" y="688"/>
                    </a:lnTo>
                    <a:lnTo>
                      <a:pt x="938" y="731"/>
                    </a:lnTo>
                    <a:lnTo>
                      <a:pt x="938" y="731"/>
                    </a:lnTo>
                    <a:lnTo>
                      <a:pt x="1013" y="745"/>
                    </a:lnTo>
                    <a:lnTo>
                      <a:pt x="1013" y="745"/>
                    </a:lnTo>
                    <a:lnTo>
                      <a:pt x="1051" y="752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" name="Freeform 117"/>
              <p:cNvSpPr>
                <a:spLocks/>
              </p:cNvSpPr>
              <p:nvPr/>
            </p:nvSpPr>
            <p:spPr bwMode="auto">
              <a:xfrm>
                <a:off x="1296" y="581"/>
                <a:ext cx="938" cy="752"/>
              </a:xfrm>
              <a:custGeom>
                <a:avLst/>
                <a:gdLst>
                  <a:gd name="T0" fmla="*/ 0 w 938"/>
                  <a:gd name="T1" fmla="*/ 0 h 752"/>
                  <a:gd name="T2" fmla="*/ 0 w 938"/>
                  <a:gd name="T3" fmla="*/ 0 h 752"/>
                  <a:gd name="T4" fmla="*/ 0 w 938"/>
                  <a:gd name="T5" fmla="*/ 0 h 752"/>
                  <a:gd name="T6" fmla="*/ 113 w 938"/>
                  <a:gd name="T7" fmla="*/ 0 h 752"/>
                  <a:gd name="T8" fmla="*/ 113 w 938"/>
                  <a:gd name="T9" fmla="*/ 0 h 752"/>
                  <a:gd name="T10" fmla="*/ 188 w 938"/>
                  <a:gd name="T11" fmla="*/ 0 h 752"/>
                  <a:gd name="T12" fmla="*/ 188 w 938"/>
                  <a:gd name="T13" fmla="*/ 0 h 752"/>
                  <a:gd name="T14" fmla="*/ 263 w 938"/>
                  <a:gd name="T15" fmla="*/ 15 h 752"/>
                  <a:gd name="T16" fmla="*/ 263 w 938"/>
                  <a:gd name="T17" fmla="*/ 15 h 752"/>
                  <a:gd name="T18" fmla="*/ 338 w 938"/>
                  <a:gd name="T19" fmla="*/ 40 h 752"/>
                  <a:gd name="T20" fmla="*/ 338 w 938"/>
                  <a:gd name="T21" fmla="*/ 40 h 752"/>
                  <a:gd name="T22" fmla="*/ 375 w 938"/>
                  <a:gd name="T23" fmla="*/ 119 h 752"/>
                  <a:gd name="T24" fmla="*/ 375 w 938"/>
                  <a:gd name="T25" fmla="*/ 119 h 752"/>
                  <a:gd name="T26" fmla="*/ 413 w 938"/>
                  <a:gd name="T27" fmla="*/ 172 h 752"/>
                  <a:gd name="T28" fmla="*/ 413 w 938"/>
                  <a:gd name="T29" fmla="*/ 172 h 752"/>
                  <a:gd name="T30" fmla="*/ 488 w 938"/>
                  <a:gd name="T31" fmla="*/ 305 h 752"/>
                  <a:gd name="T32" fmla="*/ 488 w 938"/>
                  <a:gd name="T33" fmla="*/ 305 h 752"/>
                  <a:gd name="T34" fmla="*/ 563 w 938"/>
                  <a:gd name="T35" fmla="*/ 420 h 752"/>
                  <a:gd name="T36" fmla="*/ 563 w 938"/>
                  <a:gd name="T37" fmla="*/ 420 h 752"/>
                  <a:gd name="T38" fmla="*/ 601 w 938"/>
                  <a:gd name="T39" fmla="*/ 502 h 752"/>
                  <a:gd name="T40" fmla="*/ 601 w 938"/>
                  <a:gd name="T41" fmla="*/ 502 h 752"/>
                  <a:gd name="T42" fmla="*/ 638 w 938"/>
                  <a:gd name="T43" fmla="*/ 556 h 752"/>
                  <a:gd name="T44" fmla="*/ 638 w 938"/>
                  <a:gd name="T45" fmla="*/ 556 h 752"/>
                  <a:gd name="T46" fmla="*/ 713 w 938"/>
                  <a:gd name="T47" fmla="*/ 628 h 752"/>
                  <a:gd name="T48" fmla="*/ 713 w 938"/>
                  <a:gd name="T49" fmla="*/ 628 h 752"/>
                  <a:gd name="T50" fmla="*/ 788 w 938"/>
                  <a:gd name="T51" fmla="*/ 701 h 752"/>
                  <a:gd name="T52" fmla="*/ 788 w 938"/>
                  <a:gd name="T53" fmla="*/ 701 h 752"/>
                  <a:gd name="T54" fmla="*/ 863 w 938"/>
                  <a:gd name="T55" fmla="*/ 730 h 752"/>
                  <a:gd name="T56" fmla="*/ 863 w 938"/>
                  <a:gd name="T57" fmla="*/ 730 h 752"/>
                  <a:gd name="T58" fmla="*/ 938 w 938"/>
                  <a:gd name="T59" fmla="*/ 752 h 7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938" h="752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13" y="0"/>
                    </a:lnTo>
                    <a:lnTo>
                      <a:pt x="113" y="0"/>
                    </a:lnTo>
                    <a:lnTo>
                      <a:pt x="188" y="0"/>
                    </a:lnTo>
                    <a:lnTo>
                      <a:pt x="188" y="0"/>
                    </a:lnTo>
                    <a:lnTo>
                      <a:pt x="263" y="15"/>
                    </a:lnTo>
                    <a:lnTo>
                      <a:pt x="263" y="15"/>
                    </a:lnTo>
                    <a:lnTo>
                      <a:pt x="338" y="40"/>
                    </a:lnTo>
                    <a:lnTo>
                      <a:pt x="338" y="40"/>
                    </a:lnTo>
                    <a:lnTo>
                      <a:pt x="375" y="119"/>
                    </a:lnTo>
                    <a:lnTo>
                      <a:pt x="375" y="119"/>
                    </a:lnTo>
                    <a:lnTo>
                      <a:pt x="413" y="172"/>
                    </a:lnTo>
                    <a:lnTo>
                      <a:pt x="413" y="172"/>
                    </a:lnTo>
                    <a:lnTo>
                      <a:pt x="488" y="305"/>
                    </a:lnTo>
                    <a:lnTo>
                      <a:pt x="488" y="305"/>
                    </a:lnTo>
                    <a:lnTo>
                      <a:pt x="563" y="420"/>
                    </a:lnTo>
                    <a:lnTo>
                      <a:pt x="563" y="420"/>
                    </a:lnTo>
                    <a:lnTo>
                      <a:pt x="601" y="502"/>
                    </a:lnTo>
                    <a:lnTo>
                      <a:pt x="601" y="502"/>
                    </a:lnTo>
                    <a:lnTo>
                      <a:pt x="638" y="556"/>
                    </a:lnTo>
                    <a:lnTo>
                      <a:pt x="638" y="556"/>
                    </a:lnTo>
                    <a:lnTo>
                      <a:pt x="713" y="628"/>
                    </a:lnTo>
                    <a:lnTo>
                      <a:pt x="713" y="628"/>
                    </a:lnTo>
                    <a:lnTo>
                      <a:pt x="788" y="701"/>
                    </a:lnTo>
                    <a:lnTo>
                      <a:pt x="788" y="701"/>
                    </a:lnTo>
                    <a:lnTo>
                      <a:pt x="863" y="730"/>
                    </a:lnTo>
                    <a:lnTo>
                      <a:pt x="863" y="730"/>
                    </a:lnTo>
                    <a:lnTo>
                      <a:pt x="938" y="752"/>
                    </a:lnTo>
                  </a:path>
                </a:pathLst>
              </a:custGeom>
              <a:noFill/>
              <a:ln w="17463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2" name="Freeform 118"/>
              <p:cNvSpPr>
                <a:spLocks noEditPoints="1"/>
              </p:cNvSpPr>
              <p:nvPr/>
            </p:nvSpPr>
            <p:spPr bwMode="auto">
              <a:xfrm>
                <a:off x="1296" y="575"/>
                <a:ext cx="1011" cy="763"/>
              </a:xfrm>
              <a:custGeom>
                <a:avLst/>
                <a:gdLst>
                  <a:gd name="T0" fmla="*/ 92 w 4138"/>
                  <a:gd name="T1" fmla="*/ 48 h 3119"/>
                  <a:gd name="T2" fmla="*/ 323 w 4138"/>
                  <a:gd name="T3" fmla="*/ 2 h 3119"/>
                  <a:gd name="T4" fmla="*/ 208 w 4138"/>
                  <a:gd name="T5" fmla="*/ 25 h 3119"/>
                  <a:gd name="T6" fmla="*/ 576 w 4138"/>
                  <a:gd name="T7" fmla="*/ 25 h 3119"/>
                  <a:gd name="T8" fmla="*/ 461 w 4138"/>
                  <a:gd name="T9" fmla="*/ 2 h 3119"/>
                  <a:gd name="T10" fmla="*/ 768 w 4138"/>
                  <a:gd name="T11" fmla="*/ 48 h 3119"/>
                  <a:gd name="T12" fmla="*/ 772 w 4138"/>
                  <a:gd name="T13" fmla="*/ 2 h 3119"/>
                  <a:gd name="T14" fmla="*/ 764 w 4138"/>
                  <a:gd name="T15" fmla="*/ 48 h 3119"/>
                  <a:gd name="T16" fmla="*/ 1014 w 4138"/>
                  <a:gd name="T17" fmla="*/ 43 h 3119"/>
                  <a:gd name="T18" fmla="*/ 897 w 4138"/>
                  <a:gd name="T19" fmla="*/ 46 h 3119"/>
                  <a:gd name="T20" fmla="*/ 1227 w 4138"/>
                  <a:gd name="T21" fmla="*/ 186 h 3119"/>
                  <a:gd name="T22" fmla="*/ 1148 w 4138"/>
                  <a:gd name="T23" fmla="*/ 100 h 3119"/>
                  <a:gd name="T24" fmla="*/ 1369 w 4138"/>
                  <a:gd name="T25" fmla="*/ 317 h 3119"/>
                  <a:gd name="T26" fmla="*/ 1403 w 4138"/>
                  <a:gd name="T27" fmla="*/ 289 h 3119"/>
                  <a:gd name="T28" fmla="*/ 1362 w 4138"/>
                  <a:gd name="T29" fmla="*/ 308 h 3119"/>
                  <a:gd name="T30" fmla="*/ 1507 w 4138"/>
                  <a:gd name="T31" fmla="*/ 513 h 3119"/>
                  <a:gd name="T32" fmla="*/ 1437 w 4138"/>
                  <a:gd name="T33" fmla="*/ 418 h 3119"/>
                  <a:gd name="T34" fmla="*/ 1612 w 4138"/>
                  <a:gd name="T35" fmla="*/ 741 h 3119"/>
                  <a:gd name="T36" fmla="*/ 1565 w 4138"/>
                  <a:gd name="T37" fmla="*/ 633 h 3119"/>
                  <a:gd name="T38" fmla="*/ 1671 w 4138"/>
                  <a:gd name="T39" fmla="*/ 865 h 3119"/>
                  <a:gd name="T40" fmla="*/ 1710 w 4138"/>
                  <a:gd name="T41" fmla="*/ 841 h 3119"/>
                  <a:gd name="T42" fmla="*/ 1669 w 4138"/>
                  <a:gd name="T43" fmla="*/ 863 h 3119"/>
                  <a:gd name="T44" fmla="*/ 1853 w 4138"/>
                  <a:gd name="T45" fmla="*/ 1107 h 3119"/>
                  <a:gd name="T46" fmla="*/ 1778 w 4138"/>
                  <a:gd name="T47" fmla="*/ 1017 h 3119"/>
                  <a:gd name="T48" fmla="*/ 1953 w 4138"/>
                  <a:gd name="T49" fmla="*/ 1341 h 3119"/>
                  <a:gd name="T50" fmla="*/ 1919 w 4138"/>
                  <a:gd name="T51" fmla="*/ 1229 h 3119"/>
                  <a:gd name="T52" fmla="*/ 2056 w 4138"/>
                  <a:gd name="T53" fmla="*/ 1524 h 3119"/>
                  <a:gd name="T54" fmla="*/ 2183 w 4138"/>
                  <a:gd name="T55" fmla="*/ 1596 h 3119"/>
                  <a:gd name="T56" fmla="*/ 2149 w 4138"/>
                  <a:gd name="T57" fmla="*/ 1627 h 3119"/>
                  <a:gd name="T58" fmla="*/ 2388 w 4138"/>
                  <a:gd name="T59" fmla="*/ 1848 h 3119"/>
                  <a:gd name="T60" fmla="*/ 2304 w 4138"/>
                  <a:gd name="T61" fmla="*/ 1766 h 3119"/>
                  <a:gd name="T62" fmla="*/ 2471 w 4138"/>
                  <a:gd name="T63" fmla="*/ 2013 h 3119"/>
                  <a:gd name="T64" fmla="*/ 2465 w 4138"/>
                  <a:gd name="T65" fmla="*/ 1963 h 3119"/>
                  <a:gd name="T66" fmla="*/ 2491 w 4138"/>
                  <a:gd name="T67" fmla="*/ 2060 h 3119"/>
                  <a:gd name="T68" fmla="*/ 2622 w 4138"/>
                  <a:gd name="T69" fmla="*/ 2125 h 3119"/>
                  <a:gd name="T70" fmla="*/ 2589 w 4138"/>
                  <a:gd name="T71" fmla="*/ 2158 h 3119"/>
                  <a:gd name="T72" fmla="*/ 2677 w 4138"/>
                  <a:gd name="T73" fmla="*/ 2204 h 3119"/>
                  <a:gd name="T74" fmla="*/ 2598 w 4138"/>
                  <a:gd name="T75" fmla="*/ 2128 h 3119"/>
                  <a:gd name="T76" fmla="*/ 2800 w 4138"/>
                  <a:gd name="T77" fmla="*/ 2427 h 3119"/>
                  <a:gd name="T78" fmla="*/ 2755 w 4138"/>
                  <a:gd name="T79" fmla="*/ 2318 h 3119"/>
                  <a:gd name="T80" fmla="*/ 2897 w 4138"/>
                  <a:gd name="T81" fmla="*/ 2612 h 3119"/>
                  <a:gd name="T82" fmla="*/ 3027 w 4138"/>
                  <a:gd name="T83" fmla="*/ 2684 h 3119"/>
                  <a:gd name="T84" fmla="*/ 2993 w 4138"/>
                  <a:gd name="T85" fmla="*/ 2716 h 3119"/>
                  <a:gd name="T86" fmla="*/ 3242 w 4138"/>
                  <a:gd name="T87" fmla="*/ 2912 h 3119"/>
                  <a:gd name="T88" fmla="*/ 3153 w 4138"/>
                  <a:gd name="T89" fmla="*/ 2851 h 3119"/>
                  <a:gd name="T90" fmla="*/ 3256 w 4138"/>
                  <a:gd name="T91" fmla="*/ 2937 h 3119"/>
                  <a:gd name="T92" fmla="*/ 3233 w 4138"/>
                  <a:gd name="T93" fmla="*/ 2906 h 3119"/>
                  <a:gd name="T94" fmla="*/ 3447 w 4138"/>
                  <a:gd name="T95" fmla="*/ 3020 h 3119"/>
                  <a:gd name="T96" fmla="*/ 3592 w 4138"/>
                  <a:gd name="T97" fmla="*/ 3009 h 3119"/>
                  <a:gd name="T98" fmla="*/ 3584 w 4138"/>
                  <a:gd name="T99" fmla="*/ 3055 h 3119"/>
                  <a:gd name="T100" fmla="*/ 3844 w 4138"/>
                  <a:gd name="T101" fmla="*/ 3051 h 3119"/>
                  <a:gd name="T102" fmla="*/ 3793 w 4138"/>
                  <a:gd name="T103" fmla="*/ 3066 h 3119"/>
                  <a:gd name="T104" fmla="*/ 3930 w 4138"/>
                  <a:gd name="T105" fmla="*/ 3081 h 3119"/>
                  <a:gd name="T106" fmla="*/ 3842 w 4138"/>
                  <a:gd name="T107" fmla="*/ 3051 h 3119"/>
                  <a:gd name="T108" fmla="*/ 4043 w 4138"/>
                  <a:gd name="T109" fmla="*/ 3112 h 3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</a:cxnLst>
                <a:rect l="0" t="0" r="r" b="b"/>
                <a:pathLst>
                  <a:path w="4138" h="3119">
                    <a:moveTo>
                      <a:pt x="0" y="2"/>
                    </a:moveTo>
                    <a:lnTo>
                      <a:pt x="92" y="2"/>
                    </a:lnTo>
                    <a:cubicBezTo>
                      <a:pt x="105" y="2"/>
                      <a:pt x="115" y="12"/>
                      <a:pt x="115" y="25"/>
                    </a:cubicBezTo>
                    <a:cubicBezTo>
                      <a:pt x="115" y="38"/>
                      <a:pt x="105" y="48"/>
                      <a:pt x="92" y="48"/>
                    </a:cubicBezTo>
                    <a:lnTo>
                      <a:pt x="0" y="48"/>
                    </a:lnTo>
                    <a:lnTo>
                      <a:pt x="0" y="2"/>
                    </a:lnTo>
                    <a:close/>
                    <a:moveTo>
                      <a:pt x="231" y="2"/>
                    </a:moveTo>
                    <a:lnTo>
                      <a:pt x="323" y="2"/>
                    </a:lnTo>
                    <a:cubicBezTo>
                      <a:pt x="335" y="2"/>
                      <a:pt x="346" y="12"/>
                      <a:pt x="346" y="25"/>
                    </a:cubicBezTo>
                    <a:cubicBezTo>
                      <a:pt x="346" y="38"/>
                      <a:pt x="335" y="48"/>
                      <a:pt x="323" y="48"/>
                    </a:cubicBezTo>
                    <a:lnTo>
                      <a:pt x="231" y="48"/>
                    </a:lnTo>
                    <a:cubicBezTo>
                      <a:pt x="218" y="48"/>
                      <a:pt x="208" y="38"/>
                      <a:pt x="208" y="25"/>
                    </a:cubicBezTo>
                    <a:cubicBezTo>
                      <a:pt x="208" y="12"/>
                      <a:pt x="218" y="2"/>
                      <a:pt x="231" y="2"/>
                    </a:cubicBezTo>
                    <a:close/>
                    <a:moveTo>
                      <a:pt x="461" y="2"/>
                    </a:moveTo>
                    <a:lnTo>
                      <a:pt x="553" y="2"/>
                    </a:lnTo>
                    <a:cubicBezTo>
                      <a:pt x="566" y="2"/>
                      <a:pt x="576" y="12"/>
                      <a:pt x="576" y="25"/>
                    </a:cubicBezTo>
                    <a:cubicBezTo>
                      <a:pt x="576" y="38"/>
                      <a:pt x="566" y="48"/>
                      <a:pt x="553" y="48"/>
                    </a:cubicBezTo>
                    <a:lnTo>
                      <a:pt x="461" y="48"/>
                    </a:lnTo>
                    <a:cubicBezTo>
                      <a:pt x="448" y="48"/>
                      <a:pt x="438" y="38"/>
                      <a:pt x="438" y="25"/>
                    </a:cubicBezTo>
                    <a:cubicBezTo>
                      <a:pt x="438" y="12"/>
                      <a:pt x="448" y="2"/>
                      <a:pt x="461" y="2"/>
                    </a:cubicBezTo>
                    <a:close/>
                    <a:moveTo>
                      <a:pt x="691" y="2"/>
                    </a:moveTo>
                    <a:lnTo>
                      <a:pt x="768" y="2"/>
                    </a:lnTo>
                    <a:cubicBezTo>
                      <a:pt x="781" y="2"/>
                      <a:pt x="791" y="12"/>
                      <a:pt x="791" y="25"/>
                    </a:cubicBezTo>
                    <a:cubicBezTo>
                      <a:pt x="791" y="38"/>
                      <a:pt x="781" y="48"/>
                      <a:pt x="768" y="48"/>
                    </a:cubicBezTo>
                    <a:lnTo>
                      <a:pt x="691" y="48"/>
                    </a:lnTo>
                    <a:cubicBezTo>
                      <a:pt x="679" y="48"/>
                      <a:pt x="668" y="38"/>
                      <a:pt x="668" y="25"/>
                    </a:cubicBezTo>
                    <a:cubicBezTo>
                      <a:pt x="668" y="12"/>
                      <a:pt x="679" y="2"/>
                      <a:pt x="691" y="2"/>
                    </a:cubicBezTo>
                    <a:close/>
                    <a:moveTo>
                      <a:pt x="772" y="2"/>
                    </a:moveTo>
                    <a:lnTo>
                      <a:pt x="787" y="5"/>
                    </a:lnTo>
                    <a:cubicBezTo>
                      <a:pt x="800" y="7"/>
                      <a:pt x="808" y="19"/>
                      <a:pt x="806" y="31"/>
                    </a:cubicBezTo>
                    <a:cubicBezTo>
                      <a:pt x="804" y="44"/>
                      <a:pt x="792" y="52"/>
                      <a:pt x="780" y="50"/>
                    </a:cubicBezTo>
                    <a:lnTo>
                      <a:pt x="764" y="48"/>
                    </a:lnTo>
                    <a:cubicBezTo>
                      <a:pt x="752" y="46"/>
                      <a:pt x="743" y="34"/>
                      <a:pt x="745" y="21"/>
                    </a:cubicBezTo>
                    <a:cubicBezTo>
                      <a:pt x="748" y="9"/>
                      <a:pt x="759" y="0"/>
                      <a:pt x="772" y="2"/>
                    </a:cubicBezTo>
                    <a:close/>
                    <a:moveTo>
                      <a:pt x="923" y="27"/>
                    </a:moveTo>
                    <a:lnTo>
                      <a:pt x="1014" y="43"/>
                    </a:lnTo>
                    <a:cubicBezTo>
                      <a:pt x="1027" y="45"/>
                      <a:pt x="1035" y="57"/>
                      <a:pt x="1033" y="69"/>
                    </a:cubicBezTo>
                    <a:cubicBezTo>
                      <a:pt x="1031" y="82"/>
                      <a:pt x="1019" y="90"/>
                      <a:pt x="1007" y="88"/>
                    </a:cubicBezTo>
                    <a:lnTo>
                      <a:pt x="916" y="73"/>
                    </a:lnTo>
                    <a:cubicBezTo>
                      <a:pt x="903" y="71"/>
                      <a:pt x="895" y="59"/>
                      <a:pt x="897" y="46"/>
                    </a:cubicBezTo>
                    <a:cubicBezTo>
                      <a:pt x="899" y="34"/>
                      <a:pt x="911" y="25"/>
                      <a:pt x="923" y="27"/>
                    </a:cubicBezTo>
                    <a:close/>
                    <a:moveTo>
                      <a:pt x="1148" y="100"/>
                    </a:moveTo>
                    <a:lnTo>
                      <a:pt x="1222" y="154"/>
                    </a:lnTo>
                    <a:cubicBezTo>
                      <a:pt x="1233" y="162"/>
                      <a:pt x="1235" y="176"/>
                      <a:pt x="1227" y="186"/>
                    </a:cubicBezTo>
                    <a:cubicBezTo>
                      <a:pt x="1220" y="197"/>
                      <a:pt x="1205" y="199"/>
                      <a:pt x="1195" y="191"/>
                    </a:cubicBezTo>
                    <a:lnTo>
                      <a:pt x="1121" y="137"/>
                    </a:lnTo>
                    <a:cubicBezTo>
                      <a:pt x="1110" y="130"/>
                      <a:pt x="1108" y="115"/>
                      <a:pt x="1115" y="105"/>
                    </a:cubicBezTo>
                    <a:cubicBezTo>
                      <a:pt x="1123" y="95"/>
                      <a:pt x="1137" y="93"/>
                      <a:pt x="1148" y="100"/>
                    </a:cubicBezTo>
                    <a:close/>
                    <a:moveTo>
                      <a:pt x="1334" y="235"/>
                    </a:moveTo>
                    <a:lnTo>
                      <a:pt x="1396" y="280"/>
                    </a:lnTo>
                    <a:cubicBezTo>
                      <a:pt x="1406" y="288"/>
                      <a:pt x="1409" y="302"/>
                      <a:pt x="1401" y="312"/>
                    </a:cubicBezTo>
                    <a:cubicBezTo>
                      <a:pt x="1394" y="323"/>
                      <a:pt x="1379" y="325"/>
                      <a:pt x="1369" y="317"/>
                    </a:cubicBezTo>
                    <a:lnTo>
                      <a:pt x="1307" y="273"/>
                    </a:lnTo>
                    <a:cubicBezTo>
                      <a:pt x="1297" y="265"/>
                      <a:pt x="1295" y="251"/>
                      <a:pt x="1302" y="240"/>
                    </a:cubicBezTo>
                    <a:cubicBezTo>
                      <a:pt x="1309" y="230"/>
                      <a:pt x="1324" y="228"/>
                      <a:pt x="1334" y="235"/>
                    </a:cubicBezTo>
                    <a:close/>
                    <a:moveTo>
                      <a:pt x="1403" y="289"/>
                    </a:moveTo>
                    <a:lnTo>
                      <a:pt x="1410" y="303"/>
                    </a:lnTo>
                    <a:cubicBezTo>
                      <a:pt x="1415" y="315"/>
                      <a:pt x="1410" y="329"/>
                      <a:pt x="1399" y="334"/>
                    </a:cubicBezTo>
                    <a:cubicBezTo>
                      <a:pt x="1387" y="339"/>
                      <a:pt x="1374" y="334"/>
                      <a:pt x="1368" y="323"/>
                    </a:cubicBezTo>
                    <a:lnTo>
                      <a:pt x="1362" y="308"/>
                    </a:lnTo>
                    <a:cubicBezTo>
                      <a:pt x="1356" y="297"/>
                      <a:pt x="1361" y="283"/>
                      <a:pt x="1373" y="278"/>
                    </a:cubicBezTo>
                    <a:cubicBezTo>
                      <a:pt x="1384" y="273"/>
                      <a:pt x="1398" y="278"/>
                      <a:pt x="1403" y="289"/>
                    </a:cubicBezTo>
                    <a:close/>
                    <a:moveTo>
                      <a:pt x="1468" y="429"/>
                    </a:moveTo>
                    <a:lnTo>
                      <a:pt x="1507" y="513"/>
                    </a:lnTo>
                    <a:cubicBezTo>
                      <a:pt x="1512" y="524"/>
                      <a:pt x="1507" y="538"/>
                      <a:pt x="1495" y="543"/>
                    </a:cubicBezTo>
                    <a:cubicBezTo>
                      <a:pt x="1484" y="549"/>
                      <a:pt x="1470" y="543"/>
                      <a:pt x="1465" y="532"/>
                    </a:cubicBezTo>
                    <a:lnTo>
                      <a:pt x="1426" y="448"/>
                    </a:lnTo>
                    <a:cubicBezTo>
                      <a:pt x="1421" y="437"/>
                      <a:pt x="1426" y="423"/>
                      <a:pt x="1437" y="418"/>
                    </a:cubicBezTo>
                    <a:cubicBezTo>
                      <a:pt x="1449" y="412"/>
                      <a:pt x="1463" y="417"/>
                      <a:pt x="1468" y="429"/>
                    </a:cubicBezTo>
                    <a:close/>
                    <a:moveTo>
                      <a:pt x="1565" y="633"/>
                    </a:moveTo>
                    <a:lnTo>
                      <a:pt x="1618" y="709"/>
                    </a:lnTo>
                    <a:cubicBezTo>
                      <a:pt x="1625" y="719"/>
                      <a:pt x="1623" y="733"/>
                      <a:pt x="1612" y="741"/>
                    </a:cubicBezTo>
                    <a:cubicBezTo>
                      <a:pt x="1602" y="748"/>
                      <a:pt x="1587" y="745"/>
                      <a:pt x="1580" y="735"/>
                    </a:cubicBezTo>
                    <a:lnTo>
                      <a:pt x="1527" y="659"/>
                    </a:lnTo>
                    <a:cubicBezTo>
                      <a:pt x="1520" y="649"/>
                      <a:pt x="1523" y="635"/>
                      <a:pt x="1533" y="627"/>
                    </a:cubicBezTo>
                    <a:cubicBezTo>
                      <a:pt x="1544" y="620"/>
                      <a:pt x="1558" y="623"/>
                      <a:pt x="1565" y="633"/>
                    </a:cubicBezTo>
                    <a:close/>
                    <a:moveTo>
                      <a:pt x="1697" y="822"/>
                    </a:moveTo>
                    <a:lnTo>
                      <a:pt x="1709" y="839"/>
                    </a:lnTo>
                    <a:cubicBezTo>
                      <a:pt x="1716" y="849"/>
                      <a:pt x="1713" y="863"/>
                      <a:pt x="1703" y="871"/>
                    </a:cubicBezTo>
                    <a:cubicBezTo>
                      <a:pt x="1692" y="878"/>
                      <a:pt x="1678" y="875"/>
                      <a:pt x="1671" y="865"/>
                    </a:cubicBezTo>
                    <a:lnTo>
                      <a:pt x="1659" y="848"/>
                    </a:lnTo>
                    <a:cubicBezTo>
                      <a:pt x="1652" y="838"/>
                      <a:pt x="1655" y="824"/>
                      <a:pt x="1665" y="816"/>
                    </a:cubicBezTo>
                    <a:cubicBezTo>
                      <a:pt x="1675" y="809"/>
                      <a:pt x="1690" y="812"/>
                      <a:pt x="1697" y="822"/>
                    </a:cubicBezTo>
                    <a:close/>
                    <a:moveTo>
                      <a:pt x="1710" y="841"/>
                    </a:moveTo>
                    <a:lnTo>
                      <a:pt x="1744" y="904"/>
                    </a:lnTo>
                    <a:cubicBezTo>
                      <a:pt x="1750" y="915"/>
                      <a:pt x="1746" y="929"/>
                      <a:pt x="1735" y="935"/>
                    </a:cubicBezTo>
                    <a:cubicBezTo>
                      <a:pt x="1724" y="941"/>
                      <a:pt x="1710" y="937"/>
                      <a:pt x="1704" y="926"/>
                    </a:cubicBezTo>
                    <a:lnTo>
                      <a:pt x="1669" y="863"/>
                    </a:lnTo>
                    <a:cubicBezTo>
                      <a:pt x="1663" y="852"/>
                      <a:pt x="1668" y="838"/>
                      <a:pt x="1679" y="831"/>
                    </a:cubicBezTo>
                    <a:cubicBezTo>
                      <a:pt x="1690" y="825"/>
                      <a:pt x="1704" y="830"/>
                      <a:pt x="1710" y="841"/>
                    </a:cubicBezTo>
                    <a:close/>
                    <a:moveTo>
                      <a:pt x="1810" y="1026"/>
                    </a:moveTo>
                    <a:lnTo>
                      <a:pt x="1853" y="1107"/>
                    </a:lnTo>
                    <a:cubicBezTo>
                      <a:pt x="1859" y="1118"/>
                      <a:pt x="1855" y="1132"/>
                      <a:pt x="1844" y="1138"/>
                    </a:cubicBezTo>
                    <a:cubicBezTo>
                      <a:pt x="1833" y="1144"/>
                      <a:pt x="1819" y="1140"/>
                      <a:pt x="1813" y="1129"/>
                    </a:cubicBezTo>
                    <a:lnTo>
                      <a:pt x="1769" y="1048"/>
                    </a:lnTo>
                    <a:cubicBezTo>
                      <a:pt x="1763" y="1037"/>
                      <a:pt x="1767" y="1023"/>
                      <a:pt x="1778" y="1017"/>
                    </a:cubicBezTo>
                    <a:cubicBezTo>
                      <a:pt x="1790" y="1011"/>
                      <a:pt x="1804" y="1015"/>
                      <a:pt x="1810" y="1026"/>
                    </a:cubicBezTo>
                    <a:close/>
                    <a:moveTo>
                      <a:pt x="1919" y="1229"/>
                    </a:moveTo>
                    <a:lnTo>
                      <a:pt x="1962" y="1310"/>
                    </a:lnTo>
                    <a:cubicBezTo>
                      <a:pt x="1968" y="1321"/>
                      <a:pt x="1964" y="1335"/>
                      <a:pt x="1953" y="1341"/>
                    </a:cubicBezTo>
                    <a:cubicBezTo>
                      <a:pt x="1942" y="1347"/>
                      <a:pt x="1928" y="1343"/>
                      <a:pt x="1922" y="1332"/>
                    </a:cubicBezTo>
                    <a:lnTo>
                      <a:pt x="1878" y="1251"/>
                    </a:lnTo>
                    <a:cubicBezTo>
                      <a:pt x="1872" y="1239"/>
                      <a:pt x="1876" y="1225"/>
                      <a:pt x="1888" y="1219"/>
                    </a:cubicBezTo>
                    <a:cubicBezTo>
                      <a:pt x="1899" y="1213"/>
                      <a:pt x="1913" y="1218"/>
                      <a:pt x="1919" y="1229"/>
                    </a:cubicBezTo>
                    <a:close/>
                    <a:moveTo>
                      <a:pt x="2029" y="1424"/>
                    </a:moveTo>
                    <a:lnTo>
                      <a:pt x="2091" y="1493"/>
                    </a:lnTo>
                    <a:cubicBezTo>
                      <a:pt x="2099" y="1502"/>
                      <a:pt x="2098" y="1517"/>
                      <a:pt x="2089" y="1525"/>
                    </a:cubicBezTo>
                    <a:cubicBezTo>
                      <a:pt x="2079" y="1534"/>
                      <a:pt x="2065" y="1533"/>
                      <a:pt x="2056" y="1524"/>
                    </a:cubicBezTo>
                    <a:lnTo>
                      <a:pt x="1995" y="1455"/>
                    </a:lnTo>
                    <a:cubicBezTo>
                      <a:pt x="1986" y="1445"/>
                      <a:pt x="1987" y="1431"/>
                      <a:pt x="1997" y="1422"/>
                    </a:cubicBezTo>
                    <a:cubicBezTo>
                      <a:pt x="2006" y="1414"/>
                      <a:pt x="2021" y="1415"/>
                      <a:pt x="2029" y="1424"/>
                    </a:cubicBezTo>
                    <a:close/>
                    <a:moveTo>
                      <a:pt x="2183" y="1596"/>
                    </a:moveTo>
                    <a:lnTo>
                      <a:pt x="2244" y="1664"/>
                    </a:lnTo>
                    <a:cubicBezTo>
                      <a:pt x="2253" y="1674"/>
                      <a:pt x="2252" y="1689"/>
                      <a:pt x="2243" y="1697"/>
                    </a:cubicBezTo>
                    <a:cubicBezTo>
                      <a:pt x="2233" y="1705"/>
                      <a:pt x="2219" y="1705"/>
                      <a:pt x="2210" y="1695"/>
                    </a:cubicBezTo>
                    <a:lnTo>
                      <a:pt x="2149" y="1627"/>
                    </a:lnTo>
                    <a:cubicBezTo>
                      <a:pt x="2140" y="1617"/>
                      <a:pt x="2141" y="1603"/>
                      <a:pt x="2150" y="1594"/>
                    </a:cubicBezTo>
                    <a:cubicBezTo>
                      <a:pt x="2160" y="1586"/>
                      <a:pt x="2174" y="1586"/>
                      <a:pt x="2183" y="1596"/>
                    </a:cubicBezTo>
                    <a:close/>
                    <a:moveTo>
                      <a:pt x="2336" y="1772"/>
                    </a:moveTo>
                    <a:lnTo>
                      <a:pt x="2388" y="1848"/>
                    </a:lnTo>
                    <a:cubicBezTo>
                      <a:pt x="2395" y="1859"/>
                      <a:pt x="2392" y="1873"/>
                      <a:pt x="2381" y="1880"/>
                    </a:cubicBezTo>
                    <a:cubicBezTo>
                      <a:pt x="2371" y="1887"/>
                      <a:pt x="2357" y="1885"/>
                      <a:pt x="2349" y="1874"/>
                    </a:cubicBezTo>
                    <a:lnTo>
                      <a:pt x="2298" y="1798"/>
                    </a:lnTo>
                    <a:cubicBezTo>
                      <a:pt x="2291" y="1787"/>
                      <a:pt x="2294" y="1773"/>
                      <a:pt x="2304" y="1766"/>
                    </a:cubicBezTo>
                    <a:cubicBezTo>
                      <a:pt x="2315" y="1759"/>
                      <a:pt x="2329" y="1761"/>
                      <a:pt x="2336" y="1772"/>
                    </a:cubicBezTo>
                    <a:close/>
                    <a:moveTo>
                      <a:pt x="2465" y="1963"/>
                    </a:moveTo>
                    <a:lnTo>
                      <a:pt x="2477" y="1981"/>
                    </a:lnTo>
                    <a:cubicBezTo>
                      <a:pt x="2484" y="1991"/>
                      <a:pt x="2481" y="2006"/>
                      <a:pt x="2471" y="2013"/>
                    </a:cubicBezTo>
                    <a:cubicBezTo>
                      <a:pt x="2460" y="2020"/>
                      <a:pt x="2446" y="2017"/>
                      <a:pt x="2439" y="2006"/>
                    </a:cubicBezTo>
                    <a:lnTo>
                      <a:pt x="2427" y="1989"/>
                    </a:lnTo>
                    <a:cubicBezTo>
                      <a:pt x="2420" y="1978"/>
                      <a:pt x="2422" y="1964"/>
                      <a:pt x="2433" y="1957"/>
                    </a:cubicBezTo>
                    <a:cubicBezTo>
                      <a:pt x="2443" y="1950"/>
                      <a:pt x="2458" y="1952"/>
                      <a:pt x="2465" y="1963"/>
                    </a:cubicBezTo>
                    <a:close/>
                    <a:moveTo>
                      <a:pt x="2474" y="1977"/>
                    </a:moveTo>
                    <a:lnTo>
                      <a:pt x="2524" y="2027"/>
                    </a:lnTo>
                    <a:cubicBezTo>
                      <a:pt x="2533" y="2036"/>
                      <a:pt x="2533" y="2051"/>
                      <a:pt x="2524" y="2060"/>
                    </a:cubicBezTo>
                    <a:cubicBezTo>
                      <a:pt x="2515" y="2069"/>
                      <a:pt x="2500" y="2069"/>
                      <a:pt x="2491" y="2060"/>
                    </a:cubicBezTo>
                    <a:lnTo>
                      <a:pt x="2441" y="2010"/>
                    </a:lnTo>
                    <a:cubicBezTo>
                      <a:pt x="2432" y="2001"/>
                      <a:pt x="2432" y="1986"/>
                      <a:pt x="2441" y="1977"/>
                    </a:cubicBezTo>
                    <a:cubicBezTo>
                      <a:pt x="2450" y="1968"/>
                      <a:pt x="2465" y="1968"/>
                      <a:pt x="2474" y="1977"/>
                    </a:cubicBezTo>
                    <a:close/>
                    <a:moveTo>
                      <a:pt x="2622" y="2125"/>
                    </a:moveTo>
                    <a:lnTo>
                      <a:pt x="2628" y="2131"/>
                    </a:lnTo>
                    <a:cubicBezTo>
                      <a:pt x="2637" y="2140"/>
                      <a:pt x="2637" y="2154"/>
                      <a:pt x="2628" y="2163"/>
                    </a:cubicBezTo>
                    <a:cubicBezTo>
                      <a:pt x="2619" y="2172"/>
                      <a:pt x="2604" y="2172"/>
                      <a:pt x="2595" y="2163"/>
                    </a:cubicBezTo>
                    <a:lnTo>
                      <a:pt x="2589" y="2158"/>
                    </a:lnTo>
                    <a:cubicBezTo>
                      <a:pt x="2580" y="2149"/>
                      <a:pt x="2580" y="2134"/>
                      <a:pt x="2589" y="2125"/>
                    </a:cubicBezTo>
                    <a:cubicBezTo>
                      <a:pt x="2598" y="2116"/>
                      <a:pt x="2613" y="2116"/>
                      <a:pt x="2622" y="2125"/>
                    </a:cubicBezTo>
                    <a:close/>
                    <a:moveTo>
                      <a:pt x="2630" y="2134"/>
                    </a:moveTo>
                    <a:lnTo>
                      <a:pt x="2677" y="2204"/>
                    </a:lnTo>
                    <a:cubicBezTo>
                      <a:pt x="2684" y="2214"/>
                      <a:pt x="2682" y="2229"/>
                      <a:pt x="2671" y="2236"/>
                    </a:cubicBezTo>
                    <a:cubicBezTo>
                      <a:pt x="2661" y="2243"/>
                      <a:pt x="2646" y="2240"/>
                      <a:pt x="2639" y="2230"/>
                    </a:cubicBezTo>
                    <a:lnTo>
                      <a:pt x="2592" y="2160"/>
                    </a:lnTo>
                    <a:cubicBezTo>
                      <a:pt x="2585" y="2149"/>
                      <a:pt x="2588" y="2135"/>
                      <a:pt x="2598" y="2128"/>
                    </a:cubicBezTo>
                    <a:cubicBezTo>
                      <a:pt x="2609" y="2121"/>
                      <a:pt x="2623" y="2124"/>
                      <a:pt x="2630" y="2134"/>
                    </a:cubicBezTo>
                    <a:close/>
                    <a:moveTo>
                      <a:pt x="2755" y="2318"/>
                    </a:moveTo>
                    <a:lnTo>
                      <a:pt x="2806" y="2395"/>
                    </a:lnTo>
                    <a:cubicBezTo>
                      <a:pt x="2813" y="2405"/>
                      <a:pt x="2810" y="2420"/>
                      <a:pt x="2800" y="2427"/>
                    </a:cubicBezTo>
                    <a:cubicBezTo>
                      <a:pt x="2789" y="2434"/>
                      <a:pt x="2775" y="2431"/>
                      <a:pt x="2768" y="2421"/>
                    </a:cubicBezTo>
                    <a:lnTo>
                      <a:pt x="2716" y="2344"/>
                    </a:lnTo>
                    <a:cubicBezTo>
                      <a:pt x="2709" y="2334"/>
                      <a:pt x="2712" y="2319"/>
                      <a:pt x="2723" y="2312"/>
                    </a:cubicBezTo>
                    <a:cubicBezTo>
                      <a:pt x="2733" y="2305"/>
                      <a:pt x="2748" y="2308"/>
                      <a:pt x="2755" y="2318"/>
                    </a:cubicBezTo>
                    <a:close/>
                    <a:moveTo>
                      <a:pt x="2883" y="2510"/>
                    </a:moveTo>
                    <a:lnTo>
                      <a:pt x="2935" y="2586"/>
                    </a:lnTo>
                    <a:cubicBezTo>
                      <a:pt x="2942" y="2596"/>
                      <a:pt x="2939" y="2611"/>
                      <a:pt x="2929" y="2618"/>
                    </a:cubicBezTo>
                    <a:cubicBezTo>
                      <a:pt x="2918" y="2625"/>
                      <a:pt x="2904" y="2622"/>
                      <a:pt x="2897" y="2612"/>
                    </a:cubicBezTo>
                    <a:lnTo>
                      <a:pt x="2845" y="2535"/>
                    </a:lnTo>
                    <a:cubicBezTo>
                      <a:pt x="2838" y="2525"/>
                      <a:pt x="2841" y="2510"/>
                      <a:pt x="2851" y="2503"/>
                    </a:cubicBezTo>
                    <a:cubicBezTo>
                      <a:pt x="2862" y="2496"/>
                      <a:pt x="2876" y="2499"/>
                      <a:pt x="2883" y="2510"/>
                    </a:cubicBezTo>
                    <a:close/>
                    <a:moveTo>
                      <a:pt x="3027" y="2684"/>
                    </a:moveTo>
                    <a:lnTo>
                      <a:pt x="3090" y="2751"/>
                    </a:lnTo>
                    <a:cubicBezTo>
                      <a:pt x="3099" y="2760"/>
                      <a:pt x="3099" y="2775"/>
                      <a:pt x="3089" y="2784"/>
                    </a:cubicBezTo>
                    <a:cubicBezTo>
                      <a:pt x="3080" y="2792"/>
                      <a:pt x="3065" y="2792"/>
                      <a:pt x="3057" y="2783"/>
                    </a:cubicBezTo>
                    <a:lnTo>
                      <a:pt x="2993" y="2716"/>
                    </a:lnTo>
                    <a:cubicBezTo>
                      <a:pt x="2985" y="2706"/>
                      <a:pt x="2985" y="2692"/>
                      <a:pt x="2994" y="2683"/>
                    </a:cubicBezTo>
                    <a:cubicBezTo>
                      <a:pt x="3004" y="2674"/>
                      <a:pt x="3018" y="2675"/>
                      <a:pt x="3027" y="2684"/>
                    </a:cubicBezTo>
                    <a:close/>
                    <a:moveTo>
                      <a:pt x="3185" y="2851"/>
                    </a:moveTo>
                    <a:lnTo>
                      <a:pt x="3242" y="2912"/>
                    </a:lnTo>
                    <a:cubicBezTo>
                      <a:pt x="3251" y="2921"/>
                      <a:pt x="3251" y="2936"/>
                      <a:pt x="3242" y="2945"/>
                    </a:cubicBezTo>
                    <a:cubicBezTo>
                      <a:pt x="3232" y="2953"/>
                      <a:pt x="3218" y="2953"/>
                      <a:pt x="3209" y="2944"/>
                    </a:cubicBezTo>
                    <a:lnTo>
                      <a:pt x="3152" y="2883"/>
                    </a:lnTo>
                    <a:cubicBezTo>
                      <a:pt x="3143" y="2874"/>
                      <a:pt x="3143" y="2859"/>
                      <a:pt x="3153" y="2851"/>
                    </a:cubicBezTo>
                    <a:cubicBezTo>
                      <a:pt x="3162" y="2842"/>
                      <a:pt x="3176" y="2842"/>
                      <a:pt x="3185" y="2851"/>
                    </a:cubicBezTo>
                    <a:close/>
                    <a:moveTo>
                      <a:pt x="3233" y="2906"/>
                    </a:moveTo>
                    <a:lnTo>
                      <a:pt x="3241" y="2908"/>
                    </a:lnTo>
                    <a:cubicBezTo>
                      <a:pt x="3253" y="2912"/>
                      <a:pt x="3260" y="2925"/>
                      <a:pt x="3256" y="2937"/>
                    </a:cubicBezTo>
                    <a:cubicBezTo>
                      <a:pt x="3252" y="2949"/>
                      <a:pt x="3239" y="2956"/>
                      <a:pt x="3227" y="2953"/>
                    </a:cubicBezTo>
                    <a:lnTo>
                      <a:pt x="3219" y="2950"/>
                    </a:lnTo>
                    <a:cubicBezTo>
                      <a:pt x="3207" y="2946"/>
                      <a:pt x="3200" y="2933"/>
                      <a:pt x="3204" y="2921"/>
                    </a:cubicBezTo>
                    <a:cubicBezTo>
                      <a:pt x="3207" y="2909"/>
                      <a:pt x="3220" y="2902"/>
                      <a:pt x="3233" y="2906"/>
                    </a:cubicBezTo>
                    <a:close/>
                    <a:moveTo>
                      <a:pt x="3373" y="2949"/>
                    </a:moveTo>
                    <a:lnTo>
                      <a:pt x="3461" y="2976"/>
                    </a:lnTo>
                    <a:cubicBezTo>
                      <a:pt x="3473" y="2980"/>
                      <a:pt x="3480" y="2993"/>
                      <a:pt x="3476" y="3005"/>
                    </a:cubicBezTo>
                    <a:cubicBezTo>
                      <a:pt x="3472" y="3017"/>
                      <a:pt x="3460" y="3024"/>
                      <a:pt x="3447" y="3020"/>
                    </a:cubicBezTo>
                    <a:lnTo>
                      <a:pt x="3359" y="2993"/>
                    </a:lnTo>
                    <a:cubicBezTo>
                      <a:pt x="3347" y="2989"/>
                      <a:pt x="3340" y="2977"/>
                      <a:pt x="3344" y="2964"/>
                    </a:cubicBezTo>
                    <a:cubicBezTo>
                      <a:pt x="3348" y="2952"/>
                      <a:pt x="3361" y="2945"/>
                      <a:pt x="3373" y="2949"/>
                    </a:cubicBezTo>
                    <a:close/>
                    <a:moveTo>
                      <a:pt x="3592" y="3009"/>
                    </a:moveTo>
                    <a:lnTo>
                      <a:pt x="3683" y="3024"/>
                    </a:lnTo>
                    <a:cubicBezTo>
                      <a:pt x="3695" y="3026"/>
                      <a:pt x="3704" y="3038"/>
                      <a:pt x="3702" y="3051"/>
                    </a:cubicBezTo>
                    <a:cubicBezTo>
                      <a:pt x="3700" y="3063"/>
                      <a:pt x="3688" y="3072"/>
                      <a:pt x="3675" y="3070"/>
                    </a:cubicBezTo>
                    <a:lnTo>
                      <a:pt x="3584" y="3055"/>
                    </a:lnTo>
                    <a:cubicBezTo>
                      <a:pt x="3572" y="3052"/>
                      <a:pt x="3563" y="3041"/>
                      <a:pt x="3565" y="3028"/>
                    </a:cubicBezTo>
                    <a:cubicBezTo>
                      <a:pt x="3567" y="3016"/>
                      <a:pt x="3579" y="3007"/>
                      <a:pt x="3592" y="3009"/>
                    </a:cubicBezTo>
                    <a:close/>
                    <a:moveTo>
                      <a:pt x="3819" y="3047"/>
                    </a:moveTo>
                    <a:lnTo>
                      <a:pt x="3844" y="3051"/>
                    </a:lnTo>
                    <a:cubicBezTo>
                      <a:pt x="3856" y="3053"/>
                      <a:pt x="3865" y="3065"/>
                      <a:pt x="3863" y="3078"/>
                    </a:cubicBezTo>
                    <a:cubicBezTo>
                      <a:pt x="3861" y="3090"/>
                      <a:pt x="3849" y="3099"/>
                      <a:pt x="3836" y="3097"/>
                    </a:cubicBezTo>
                    <a:lnTo>
                      <a:pt x="3811" y="3092"/>
                    </a:lnTo>
                    <a:cubicBezTo>
                      <a:pt x="3799" y="3090"/>
                      <a:pt x="3790" y="3078"/>
                      <a:pt x="3793" y="3066"/>
                    </a:cubicBezTo>
                    <a:cubicBezTo>
                      <a:pt x="3795" y="3053"/>
                      <a:pt x="3807" y="3045"/>
                      <a:pt x="3819" y="3047"/>
                    </a:cubicBezTo>
                    <a:close/>
                    <a:moveTo>
                      <a:pt x="3842" y="3051"/>
                    </a:moveTo>
                    <a:lnTo>
                      <a:pt x="3909" y="3056"/>
                    </a:lnTo>
                    <a:cubicBezTo>
                      <a:pt x="3921" y="3057"/>
                      <a:pt x="3931" y="3068"/>
                      <a:pt x="3930" y="3081"/>
                    </a:cubicBezTo>
                    <a:cubicBezTo>
                      <a:pt x="3929" y="3093"/>
                      <a:pt x="3918" y="3103"/>
                      <a:pt x="3905" y="3102"/>
                    </a:cubicBezTo>
                    <a:lnTo>
                      <a:pt x="3838" y="3097"/>
                    </a:lnTo>
                    <a:cubicBezTo>
                      <a:pt x="3826" y="3096"/>
                      <a:pt x="3816" y="3085"/>
                      <a:pt x="3817" y="3072"/>
                    </a:cubicBezTo>
                    <a:cubicBezTo>
                      <a:pt x="3818" y="3059"/>
                      <a:pt x="3829" y="3050"/>
                      <a:pt x="3842" y="3051"/>
                    </a:cubicBezTo>
                    <a:close/>
                    <a:moveTo>
                      <a:pt x="4046" y="3066"/>
                    </a:moveTo>
                    <a:lnTo>
                      <a:pt x="4138" y="3073"/>
                    </a:lnTo>
                    <a:lnTo>
                      <a:pt x="4135" y="3119"/>
                    </a:lnTo>
                    <a:lnTo>
                      <a:pt x="4043" y="3112"/>
                    </a:lnTo>
                    <a:cubicBezTo>
                      <a:pt x="4030" y="3111"/>
                      <a:pt x="4021" y="3100"/>
                      <a:pt x="4022" y="3087"/>
                    </a:cubicBezTo>
                    <a:cubicBezTo>
                      <a:pt x="4023" y="3075"/>
                      <a:pt x="4034" y="3065"/>
                      <a:pt x="4046" y="3066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3" name="Freeform 119"/>
              <p:cNvSpPr>
                <a:spLocks noEditPoints="1"/>
              </p:cNvSpPr>
              <p:nvPr/>
            </p:nvSpPr>
            <p:spPr bwMode="auto">
              <a:xfrm>
                <a:off x="1296" y="575"/>
                <a:ext cx="1048" cy="762"/>
              </a:xfrm>
              <a:custGeom>
                <a:avLst/>
                <a:gdLst>
                  <a:gd name="T0" fmla="*/ 92 w 4291"/>
                  <a:gd name="T1" fmla="*/ 48 h 3115"/>
                  <a:gd name="T2" fmla="*/ 323 w 4291"/>
                  <a:gd name="T3" fmla="*/ 2 h 3115"/>
                  <a:gd name="T4" fmla="*/ 208 w 4291"/>
                  <a:gd name="T5" fmla="*/ 25 h 3115"/>
                  <a:gd name="T6" fmla="*/ 576 w 4291"/>
                  <a:gd name="T7" fmla="*/ 25 h 3115"/>
                  <a:gd name="T8" fmla="*/ 461 w 4291"/>
                  <a:gd name="T9" fmla="*/ 2 h 3115"/>
                  <a:gd name="T10" fmla="*/ 768 w 4291"/>
                  <a:gd name="T11" fmla="*/ 48 h 3115"/>
                  <a:gd name="T12" fmla="*/ 773 w 4291"/>
                  <a:gd name="T13" fmla="*/ 2 h 3115"/>
                  <a:gd name="T14" fmla="*/ 764 w 4291"/>
                  <a:gd name="T15" fmla="*/ 48 h 3115"/>
                  <a:gd name="T16" fmla="*/ 1014 w 4291"/>
                  <a:gd name="T17" fmla="*/ 51 h 3115"/>
                  <a:gd name="T18" fmla="*/ 896 w 4291"/>
                  <a:gd name="T19" fmla="*/ 51 h 3115"/>
                  <a:gd name="T20" fmla="*/ 1257 w 4291"/>
                  <a:gd name="T21" fmla="*/ 127 h 3115"/>
                  <a:gd name="T22" fmla="*/ 1149 w 4291"/>
                  <a:gd name="T23" fmla="*/ 79 h 3115"/>
                  <a:gd name="T24" fmla="*/ 1377 w 4291"/>
                  <a:gd name="T25" fmla="*/ 178 h 3115"/>
                  <a:gd name="T26" fmla="*/ 1398 w 4291"/>
                  <a:gd name="T27" fmla="*/ 138 h 3115"/>
                  <a:gd name="T28" fmla="*/ 1367 w 4291"/>
                  <a:gd name="T29" fmla="*/ 173 h 3115"/>
                  <a:gd name="T30" fmla="*/ 1623 w 4291"/>
                  <a:gd name="T31" fmla="*/ 352 h 3115"/>
                  <a:gd name="T32" fmla="*/ 1527 w 4291"/>
                  <a:gd name="T33" fmla="*/ 284 h 3115"/>
                  <a:gd name="T34" fmla="*/ 1786 w 4291"/>
                  <a:gd name="T35" fmla="*/ 547 h 3115"/>
                  <a:gd name="T36" fmla="*/ 1717 w 4291"/>
                  <a:gd name="T37" fmla="*/ 451 h 3115"/>
                  <a:gd name="T38" fmla="*/ 1921 w 4291"/>
                  <a:gd name="T39" fmla="*/ 705 h 3115"/>
                  <a:gd name="T40" fmla="*/ 2055 w 4291"/>
                  <a:gd name="T41" fmla="*/ 764 h 3115"/>
                  <a:gd name="T42" fmla="*/ 2025 w 4291"/>
                  <a:gd name="T43" fmla="*/ 799 h 3115"/>
                  <a:gd name="T44" fmla="*/ 2299 w 4291"/>
                  <a:gd name="T45" fmla="*/ 974 h 3115"/>
                  <a:gd name="T46" fmla="*/ 2197 w 4291"/>
                  <a:gd name="T47" fmla="*/ 916 h 3115"/>
                  <a:gd name="T48" fmla="*/ 2475 w 4291"/>
                  <a:gd name="T49" fmla="*/ 1156 h 3115"/>
                  <a:gd name="T50" fmla="*/ 2404 w 4291"/>
                  <a:gd name="T51" fmla="*/ 1064 h 3115"/>
                  <a:gd name="T52" fmla="*/ 2436 w 4291"/>
                  <a:gd name="T53" fmla="*/ 1150 h 3115"/>
                  <a:gd name="T54" fmla="*/ 2524 w 4291"/>
                  <a:gd name="T55" fmla="*/ 1266 h 3115"/>
                  <a:gd name="T56" fmla="*/ 2480 w 4291"/>
                  <a:gd name="T57" fmla="*/ 1281 h 3115"/>
                  <a:gd name="T58" fmla="*/ 2626 w 4291"/>
                  <a:gd name="T59" fmla="*/ 1572 h 3115"/>
                  <a:gd name="T60" fmla="*/ 2567 w 4291"/>
                  <a:gd name="T61" fmla="*/ 1470 h 3115"/>
                  <a:gd name="T62" fmla="*/ 2739 w 4291"/>
                  <a:gd name="T63" fmla="*/ 1793 h 3115"/>
                  <a:gd name="T64" fmla="*/ 2694 w 4291"/>
                  <a:gd name="T65" fmla="*/ 1684 h 3115"/>
                  <a:gd name="T66" fmla="*/ 2835 w 4291"/>
                  <a:gd name="T67" fmla="*/ 1978 h 3115"/>
                  <a:gd name="T68" fmla="*/ 2950 w 4291"/>
                  <a:gd name="T69" fmla="*/ 2059 h 3115"/>
                  <a:gd name="T70" fmla="*/ 2920 w 4291"/>
                  <a:gd name="T71" fmla="*/ 2094 h 3115"/>
                  <a:gd name="T72" fmla="*/ 3194 w 4291"/>
                  <a:gd name="T73" fmla="*/ 2271 h 3115"/>
                  <a:gd name="T74" fmla="*/ 3092 w 4291"/>
                  <a:gd name="T75" fmla="*/ 2213 h 3115"/>
                  <a:gd name="T76" fmla="*/ 3357 w 4291"/>
                  <a:gd name="T77" fmla="*/ 2468 h 3115"/>
                  <a:gd name="T78" fmla="*/ 3295 w 4291"/>
                  <a:gd name="T79" fmla="*/ 2368 h 3115"/>
                  <a:gd name="T80" fmla="*/ 3483 w 4291"/>
                  <a:gd name="T81" fmla="*/ 2634 h 3115"/>
                  <a:gd name="T82" fmla="*/ 3614 w 4291"/>
                  <a:gd name="T83" fmla="*/ 2698 h 3115"/>
                  <a:gd name="T84" fmla="*/ 3583 w 4291"/>
                  <a:gd name="T85" fmla="*/ 2732 h 3115"/>
                  <a:gd name="T86" fmla="*/ 3850 w 4291"/>
                  <a:gd name="T87" fmla="*/ 2918 h 3115"/>
                  <a:gd name="T88" fmla="*/ 3750 w 4291"/>
                  <a:gd name="T89" fmla="*/ 2856 h 3115"/>
                  <a:gd name="T90" fmla="*/ 4067 w 4291"/>
                  <a:gd name="T91" fmla="*/ 3033 h 3115"/>
                  <a:gd name="T92" fmla="*/ 3969 w 4291"/>
                  <a:gd name="T93" fmla="*/ 2969 h 3115"/>
                  <a:gd name="T94" fmla="*/ 4261 w 4291"/>
                  <a:gd name="T95" fmla="*/ 3112 h 3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</a:cxnLst>
                <a:rect l="0" t="0" r="r" b="b"/>
                <a:pathLst>
                  <a:path w="4291" h="3115">
                    <a:moveTo>
                      <a:pt x="0" y="2"/>
                    </a:moveTo>
                    <a:lnTo>
                      <a:pt x="92" y="2"/>
                    </a:lnTo>
                    <a:cubicBezTo>
                      <a:pt x="105" y="2"/>
                      <a:pt x="115" y="12"/>
                      <a:pt x="115" y="25"/>
                    </a:cubicBezTo>
                    <a:cubicBezTo>
                      <a:pt x="115" y="38"/>
                      <a:pt x="105" y="48"/>
                      <a:pt x="92" y="48"/>
                    </a:cubicBezTo>
                    <a:lnTo>
                      <a:pt x="0" y="48"/>
                    </a:lnTo>
                    <a:lnTo>
                      <a:pt x="0" y="2"/>
                    </a:lnTo>
                    <a:close/>
                    <a:moveTo>
                      <a:pt x="231" y="2"/>
                    </a:moveTo>
                    <a:lnTo>
                      <a:pt x="323" y="2"/>
                    </a:lnTo>
                    <a:cubicBezTo>
                      <a:pt x="335" y="2"/>
                      <a:pt x="346" y="12"/>
                      <a:pt x="346" y="25"/>
                    </a:cubicBezTo>
                    <a:cubicBezTo>
                      <a:pt x="346" y="38"/>
                      <a:pt x="335" y="48"/>
                      <a:pt x="323" y="48"/>
                    </a:cubicBezTo>
                    <a:lnTo>
                      <a:pt x="231" y="48"/>
                    </a:lnTo>
                    <a:cubicBezTo>
                      <a:pt x="218" y="48"/>
                      <a:pt x="208" y="38"/>
                      <a:pt x="208" y="25"/>
                    </a:cubicBezTo>
                    <a:cubicBezTo>
                      <a:pt x="208" y="12"/>
                      <a:pt x="218" y="2"/>
                      <a:pt x="231" y="2"/>
                    </a:cubicBezTo>
                    <a:close/>
                    <a:moveTo>
                      <a:pt x="461" y="2"/>
                    </a:moveTo>
                    <a:lnTo>
                      <a:pt x="553" y="2"/>
                    </a:lnTo>
                    <a:cubicBezTo>
                      <a:pt x="566" y="2"/>
                      <a:pt x="576" y="12"/>
                      <a:pt x="576" y="25"/>
                    </a:cubicBezTo>
                    <a:cubicBezTo>
                      <a:pt x="576" y="38"/>
                      <a:pt x="566" y="48"/>
                      <a:pt x="553" y="48"/>
                    </a:cubicBezTo>
                    <a:lnTo>
                      <a:pt x="461" y="48"/>
                    </a:lnTo>
                    <a:cubicBezTo>
                      <a:pt x="448" y="48"/>
                      <a:pt x="438" y="38"/>
                      <a:pt x="438" y="25"/>
                    </a:cubicBezTo>
                    <a:cubicBezTo>
                      <a:pt x="438" y="12"/>
                      <a:pt x="448" y="2"/>
                      <a:pt x="461" y="2"/>
                    </a:cubicBezTo>
                    <a:close/>
                    <a:moveTo>
                      <a:pt x="691" y="2"/>
                    </a:moveTo>
                    <a:lnTo>
                      <a:pt x="768" y="2"/>
                    </a:lnTo>
                    <a:cubicBezTo>
                      <a:pt x="781" y="2"/>
                      <a:pt x="791" y="12"/>
                      <a:pt x="791" y="25"/>
                    </a:cubicBezTo>
                    <a:cubicBezTo>
                      <a:pt x="791" y="38"/>
                      <a:pt x="781" y="48"/>
                      <a:pt x="768" y="48"/>
                    </a:cubicBezTo>
                    <a:lnTo>
                      <a:pt x="691" y="48"/>
                    </a:lnTo>
                    <a:cubicBezTo>
                      <a:pt x="679" y="48"/>
                      <a:pt x="668" y="38"/>
                      <a:pt x="668" y="25"/>
                    </a:cubicBezTo>
                    <a:cubicBezTo>
                      <a:pt x="668" y="12"/>
                      <a:pt x="679" y="2"/>
                      <a:pt x="691" y="2"/>
                    </a:cubicBezTo>
                    <a:close/>
                    <a:moveTo>
                      <a:pt x="773" y="2"/>
                    </a:moveTo>
                    <a:lnTo>
                      <a:pt x="788" y="5"/>
                    </a:lnTo>
                    <a:cubicBezTo>
                      <a:pt x="800" y="8"/>
                      <a:pt x="808" y="20"/>
                      <a:pt x="806" y="32"/>
                    </a:cubicBezTo>
                    <a:cubicBezTo>
                      <a:pt x="803" y="45"/>
                      <a:pt x="791" y="53"/>
                      <a:pt x="779" y="51"/>
                    </a:cubicBezTo>
                    <a:lnTo>
                      <a:pt x="764" y="48"/>
                    </a:lnTo>
                    <a:cubicBezTo>
                      <a:pt x="751" y="45"/>
                      <a:pt x="743" y="33"/>
                      <a:pt x="746" y="20"/>
                    </a:cubicBezTo>
                    <a:cubicBezTo>
                      <a:pt x="748" y="8"/>
                      <a:pt x="760" y="0"/>
                      <a:pt x="773" y="2"/>
                    </a:cubicBezTo>
                    <a:close/>
                    <a:moveTo>
                      <a:pt x="923" y="32"/>
                    </a:moveTo>
                    <a:lnTo>
                      <a:pt x="1014" y="51"/>
                    </a:lnTo>
                    <a:cubicBezTo>
                      <a:pt x="1026" y="53"/>
                      <a:pt x="1034" y="65"/>
                      <a:pt x="1032" y="78"/>
                    </a:cubicBezTo>
                    <a:cubicBezTo>
                      <a:pt x="1029" y="90"/>
                      <a:pt x="1017" y="98"/>
                      <a:pt x="1005" y="96"/>
                    </a:cubicBezTo>
                    <a:lnTo>
                      <a:pt x="914" y="78"/>
                    </a:lnTo>
                    <a:cubicBezTo>
                      <a:pt x="902" y="75"/>
                      <a:pt x="894" y="63"/>
                      <a:pt x="896" y="51"/>
                    </a:cubicBezTo>
                    <a:cubicBezTo>
                      <a:pt x="899" y="38"/>
                      <a:pt x="911" y="30"/>
                      <a:pt x="923" y="32"/>
                    </a:cubicBezTo>
                    <a:close/>
                    <a:moveTo>
                      <a:pt x="1149" y="79"/>
                    </a:moveTo>
                    <a:lnTo>
                      <a:pt x="1239" y="100"/>
                    </a:lnTo>
                    <a:cubicBezTo>
                      <a:pt x="1252" y="102"/>
                      <a:pt x="1260" y="115"/>
                      <a:pt x="1257" y="127"/>
                    </a:cubicBezTo>
                    <a:cubicBezTo>
                      <a:pt x="1254" y="140"/>
                      <a:pt x="1242" y="147"/>
                      <a:pt x="1229" y="145"/>
                    </a:cubicBezTo>
                    <a:lnTo>
                      <a:pt x="1139" y="124"/>
                    </a:lnTo>
                    <a:cubicBezTo>
                      <a:pt x="1127" y="122"/>
                      <a:pt x="1119" y="109"/>
                      <a:pt x="1122" y="97"/>
                    </a:cubicBezTo>
                    <a:cubicBezTo>
                      <a:pt x="1125" y="84"/>
                      <a:pt x="1137" y="77"/>
                      <a:pt x="1149" y="79"/>
                    </a:cubicBezTo>
                    <a:close/>
                    <a:moveTo>
                      <a:pt x="1374" y="130"/>
                    </a:moveTo>
                    <a:lnTo>
                      <a:pt x="1388" y="133"/>
                    </a:lnTo>
                    <a:cubicBezTo>
                      <a:pt x="1400" y="136"/>
                      <a:pt x="1408" y="148"/>
                      <a:pt x="1405" y="161"/>
                    </a:cubicBezTo>
                    <a:cubicBezTo>
                      <a:pt x="1402" y="173"/>
                      <a:pt x="1390" y="181"/>
                      <a:pt x="1377" y="178"/>
                    </a:cubicBezTo>
                    <a:lnTo>
                      <a:pt x="1364" y="175"/>
                    </a:lnTo>
                    <a:cubicBezTo>
                      <a:pt x="1352" y="172"/>
                      <a:pt x="1344" y="160"/>
                      <a:pt x="1347" y="147"/>
                    </a:cubicBezTo>
                    <a:cubicBezTo>
                      <a:pt x="1349" y="135"/>
                      <a:pt x="1362" y="127"/>
                      <a:pt x="1374" y="130"/>
                    </a:cubicBezTo>
                    <a:close/>
                    <a:moveTo>
                      <a:pt x="1398" y="138"/>
                    </a:moveTo>
                    <a:lnTo>
                      <a:pt x="1456" y="191"/>
                    </a:lnTo>
                    <a:cubicBezTo>
                      <a:pt x="1466" y="199"/>
                      <a:pt x="1466" y="214"/>
                      <a:pt x="1458" y="223"/>
                    </a:cubicBezTo>
                    <a:cubicBezTo>
                      <a:pt x="1449" y="233"/>
                      <a:pt x="1435" y="234"/>
                      <a:pt x="1425" y="225"/>
                    </a:cubicBezTo>
                    <a:lnTo>
                      <a:pt x="1367" y="173"/>
                    </a:lnTo>
                    <a:cubicBezTo>
                      <a:pt x="1358" y="164"/>
                      <a:pt x="1357" y="150"/>
                      <a:pt x="1365" y="140"/>
                    </a:cubicBezTo>
                    <a:cubicBezTo>
                      <a:pt x="1374" y="131"/>
                      <a:pt x="1389" y="130"/>
                      <a:pt x="1398" y="138"/>
                    </a:cubicBezTo>
                    <a:close/>
                    <a:moveTo>
                      <a:pt x="1560" y="285"/>
                    </a:moveTo>
                    <a:lnTo>
                      <a:pt x="1623" y="352"/>
                    </a:lnTo>
                    <a:cubicBezTo>
                      <a:pt x="1632" y="362"/>
                      <a:pt x="1631" y="376"/>
                      <a:pt x="1622" y="385"/>
                    </a:cubicBezTo>
                    <a:cubicBezTo>
                      <a:pt x="1612" y="394"/>
                      <a:pt x="1598" y="393"/>
                      <a:pt x="1589" y="384"/>
                    </a:cubicBezTo>
                    <a:lnTo>
                      <a:pt x="1526" y="317"/>
                    </a:lnTo>
                    <a:cubicBezTo>
                      <a:pt x="1517" y="307"/>
                      <a:pt x="1518" y="293"/>
                      <a:pt x="1527" y="284"/>
                    </a:cubicBezTo>
                    <a:cubicBezTo>
                      <a:pt x="1537" y="275"/>
                      <a:pt x="1551" y="276"/>
                      <a:pt x="1560" y="285"/>
                    </a:cubicBezTo>
                    <a:close/>
                    <a:moveTo>
                      <a:pt x="1717" y="451"/>
                    </a:moveTo>
                    <a:lnTo>
                      <a:pt x="1784" y="514"/>
                    </a:lnTo>
                    <a:cubicBezTo>
                      <a:pt x="1794" y="523"/>
                      <a:pt x="1794" y="538"/>
                      <a:pt x="1786" y="547"/>
                    </a:cubicBezTo>
                    <a:cubicBezTo>
                      <a:pt x="1777" y="556"/>
                      <a:pt x="1762" y="557"/>
                      <a:pt x="1753" y="548"/>
                    </a:cubicBezTo>
                    <a:lnTo>
                      <a:pt x="1686" y="485"/>
                    </a:lnTo>
                    <a:cubicBezTo>
                      <a:pt x="1676" y="476"/>
                      <a:pt x="1676" y="462"/>
                      <a:pt x="1684" y="453"/>
                    </a:cubicBezTo>
                    <a:cubicBezTo>
                      <a:pt x="1693" y="443"/>
                      <a:pt x="1708" y="443"/>
                      <a:pt x="1717" y="451"/>
                    </a:cubicBezTo>
                    <a:close/>
                    <a:moveTo>
                      <a:pt x="1885" y="609"/>
                    </a:moveTo>
                    <a:lnTo>
                      <a:pt x="1953" y="672"/>
                    </a:lnTo>
                    <a:cubicBezTo>
                      <a:pt x="1962" y="680"/>
                      <a:pt x="1963" y="695"/>
                      <a:pt x="1954" y="704"/>
                    </a:cubicBezTo>
                    <a:cubicBezTo>
                      <a:pt x="1945" y="713"/>
                      <a:pt x="1931" y="714"/>
                      <a:pt x="1921" y="705"/>
                    </a:cubicBezTo>
                    <a:lnTo>
                      <a:pt x="1854" y="642"/>
                    </a:lnTo>
                    <a:cubicBezTo>
                      <a:pt x="1845" y="634"/>
                      <a:pt x="1844" y="619"/>
                      <a:pt x="1853" y="610"/>
                    </a:cubicBezTo>
                    <a:cubicBezTo>
                      <a:pt x="1862" y="601"/>
                      <a:pt x="1876" y="600"/>
                      <a:pt x="1885" y="609"/>
                    </a:cubicBezTo>
                    <a:close/>
                    <a:moveTo>
                      <a:pt x="2055" y="764"/>
                    </a:moveTo>
                    <a:lnTo>
                      <a:pt x="2125" y="824"/>
                    </a:lnTo>
                    <a:cubicBezTo>
                      <a:pt x="2134" y="832"/>
                      <a:pt x="2135" y="847"/>
                      <a:pt x="2127" y="856"/>
                    </a:cubicBezTo>
                    <a:cubicBezTo>
                      <a:pt x="2119" y="866"/>
                      <a:pt x="2104" y="867"/>
                      <a:pt x="2094" y="859"/>
                    </a:cubicBezTo>
                    <a:lnTo>
                      <a:pt x="2025" y="799"/>
                    </a:lnTo>
                    <a:cubicBezTo>
                      <a:pt x="2015" y="790"/>
                      <a:pt x="2014" y="776"/>
                      <a:pt x="2022" y="766"/>
                    </a:cubicBezTo>
                    <a:cubicBezTo>
                      <a:pt x="2031" y="756"/>
                      <a:pt x="2045" y="755"/>
                      <a:pt x="2055" y="764"/>
                    </a:cubicBezTo>
                    <a:close/>
                    <a:moveTo>
                      <a:pt x="2229" y="914"/>
                    </a:moveTo>
                    <a:lnTo>
                      <a:pt x="2299" y="974"/>
                    </a:lnTo>
                    <a:cubicBezTo>
                      <a:pt x="2309" y="982"/>
                      <a:pt x="2310" y="997"/>
                      <a:pt x="2302" y="1007"/>
                    </a:cubicBezTo>
                    <a:cubicBezTo>
                      <a:pt x="2293" y="1016"/>
                      <a:pt x="2279" y="1017"/>
                      <a:pt x="2269" y="1009"/>
                    </a:cubicBezTo>
                    <a:lnTo>
                      <a:pt x="2199" y="949"/>
                    </a:lnTo>
                    <a:cubicBezTo>
                      <a:pt x="2190" y="941"/>
                      <a:pt x="2189" y="926"/>
                      <a:pt x="2197" y="916"/>
                    </a:cubicBezTo>
                    <a:cubicBezTo>
                      <a:pt x="2205" y="907"/>
                      <a:pt x="2220" y="906"/>
                      <a:pt x="2229" y="914"/>
                    </a:cubicBezTo>
                    <a:close/>
                    <a:moveTo>
                      <a:pt x="2404" y="1064"/>
                    </a:moveTo>
                    <a:lnTo>
                      <a:pt x="2473" y="1124"/>
                    </a:lnTo>
                    <a:cubicBezTo>
                      <a:pt x="2482" y="1132"/>
                      <a:pt x="2484" y="1146"/>
                      <a:pt x="2475" y="1156"/>
                    </a:cubicBezTo>
                    <a:cubicBezTo>
                      <a:pt x="2467" y="1166"/>
                      <a:pt x="2452" y="1167"/>
                      <a:pt x="2443" y="1159"/>
                    </a:cubicBezTo>
                    <a:lnTo>
                      <a:pt x="2374" y="1099"/>
                    </a:lnTo>
                    <a:cubicBezTo>
                      <a:pt x="2364" y="1091"/>
                      <a:pt x="2363" y="1076"/>
                      <a:pt x="2371" y="1067"/>
                    </a:cubicBezTo>
                    <a:cubicBezTo>
                      <a:pt x="2380" y="1057"/>
                      <a:pt x="2394" y="1056"/>
                      <a:pt x="2404" y="1064"/>
                    </a:cubicBezTo>
                    <a:close/>
                    <a:moveTo>
                      <a:pt x="2480" y="1134"/>
                    </a:moveTo>
                    <a:lnTo>
                      <a:pt x="2480" y="1135"/>
                    </a:lnTo>
                    <a:cubicBezTo>
                      <a:pt x="2484" y="1147"/>
                      <a:pt x="2477" y="1160"/>
                      <a:pt x="2465" y="1164"/>
                    </a:cubicBezTo>
                    <a:cubicBezTo>
                      <a:pt x="2453" y="1168"/>
                      <a:pt x="2440" y="1162"/>
                      <a:pt x="2436" y="1150"/>
                    </a:cubicBezTo>
                    <a:lnTo>
                      <a:pt x="2436" y="1148"/>
                    </a:lnTo>
                    <a:cubicBezTo>
                      <a:pt x="2432" y="1136"/>
                      <a:pt x="2438" y="1123"/>
                      <a:pt x="2450" y="1119"/>
                    </a:cubicBezTo>
                    <a:cubicBezTo>
                      <a:pt x="2463" y="1115"/>
                      <a:pt x="2476" y="1122"/>
                      <a:pt x="2480" y="1134"/>
                    </a:cubicBezTo>
                    <a:close/>
                    <a:moveTo>
                      <a:pt x="2524" y="1266"/>
                    </a:moveTo>
                    <a:lnTo>
                      <a:pt x="2553" y="1354"/>
                    </a:lnTo>
                    <a:cubicBezTo>
                      <a:pt x="2557" y="1366"/>
                      <a:pt x="2550" y="1379"/>
                      <a:pt x="2538" y="1383"/>
                    </a:cubicBezTo>
                    <a:cubicBezTo>
                      <a:pt x="2526" y="1387"/>
                      <a:pt x="2513" y="1380"/>
                      <a:pt x="2509" y="1368"/>
                    </a:cubicBezTo>
                    <a:lnTo>
                      <a:pt x="2480" y="1281"/>
                    </a:lnTo>
                    <a:cubicBezTo>
                      <a:pt x="2476" y="1269"/>
                      <a:pt x="2482" y="1256"/>
                      <a:pt x="2495" y="1252"/>
                    </a:cubicBezTo>
                    <a:cubicBezTo>
                      <a:pt x="2507" y="1248"/>
                      <a:pt x="2520" y="1254"/>
                      <a:pt x="2524" y="1266"/>
                    </a:cubicBezTo>
                    <a:close/>
                    <a:moveTo>
                      <a:pt x="2597" y="1485"/>
                    </a:moveTo>
                    <a:lnTo>
                      <a:pt x="2626" y="1572"/>
                    </a:lnTo>
                    <a:cubicBezTo>
                      <a:pt x="2630" y="1584"/>
                      <a:pt x="2623" y="1597"/>
                      <a:pt x="2611" y="1601"/>
                    </a:cubicBezTo>
                    <a:cubicBezTo>
                      <a:pt x="2599" y="1605"/>
                      <a:pt x="2586" y="1599"/>
                      <a:pt x="2582" y="1587"/>
                    </a:cubicBezTo>
                    <a:lnTo>
                      <a:pt x="2553" y="1499"/>
                    </a:lnTo>
                    <a:cubicBezTo>
                      <a:pt x="2549" y="1487"/>
                      <a:pt x="2555" y="1474"/>
                      <a:pt x="2567" y="1470"/>
                    </a:cubicBezTo>
                    <a:cubicBezTo>
                      <a:pt x="2580" y="1466"/>
                      <a:pt x="2593" y="1473"/>
                      <a:pt x="2597" y="1485"/>
                    </a:cubicBezTo>
                    <a:close/>
                    <a:moveTo>
                      <a:pt x="2694" y="1684"/>
                    </a:moveTo>
                    <a:lnTo>
                      <a:pt x="2745" y="1761"/>
                    </a:lnTo>
                    <a:cubicBezTo>
                      <a:pt x="2752" y="1772"/>
                      <a:pt x="2749" y="1786"/>
                      <a:pt x="2739" y="1793"/>
                    </a:cubicBezTo>
                    <a:cubicBezTo>
                      <a:pt x="2728" y="1800"/>
                      <a:pt x="2714" y="1797"/>
                      <a:pt x="2707" y="1787"/>
                    </a:cubicBezTo>
                    <a:lnTo>
                      <a:pt x="2656" y="1710"/>
                    </a:lnTo>
                    <a:cubicBezTo>
                      <a:pt x="2649" y="1699"/>
                      <a:pt x="2652" y="1685"/>
                      <a:pt x="2662" y="1678"/>
                    </a:cubicBezTo>
                    <a:cubicBezTo>
                      <a:pt x="2673" y="1671"/>
                      <a:pt x="2687" y="1674"/>
                      <a:pt x="2694" y="1684"/>
                    </a:cubicBezTo>
                    <a:close/>
                    <a:moveTo>
                      <a:pt x="2822" y="1876"/>
                    </a:moveTo>
                    <a:lnTo>
                      <a:pt x="2873" y="1953"/>
                    </a:lnTo>
                    <a:cubicBezTo>
                      <a:pt x="2880" y="1963"/>
                      <a:pt x="2877" y="1978"/>
                      <a:pt x="2867" y="1985"/>
                    </a:cubicBezTo>
                    <a:cubicBezTo>
                      <a:pt x="2856" y="1992"/>
                      <a:pt x="2842" y="1989"/>
                      <a:pt x="2835" y="1978"/>
                    </a:cubicBezTo>
                    <a:lnTo>
                      <a:pt x="2784" y="1902"/>
                    </a:lnTo>
                    <a:cubicBezTo>
                      <a:pt x="2776" y="1891"/>
                      <a:pt x="2779" y="1877"/>
                      <a:pt x="2790" y="1870"/>
                    </a:cubicBezTo>
                    <a:cubicBezTo>
                      <a:pt x="2801" y="1863"/>
                      <a:pt x="2815" y="1866"/>
                      <a:pt x="2822" y="1876"/>
                    </a:cubicBezTo>
                    <a:close/>
                    <a:moveTo>
                      <a:pt x="2950" y="2059"/>
                    </a:moveTo>
                    <a:lnTo>
                      <a:pt x="3020" y="2120"/>
                    </a:lnTo>
                    <a:cubicBezTo>
                      <a:pt x="3029" y="2128"/>
                      <a:pt x="3030" y="2143"/>
                      <a:pt x="3022" y="2152"/>
                    </a:cubicBezTo>
                    <a:cubicBezTo>
                      <a:pt x="3014" y="2162"/>
                      <a:pt x="2999" y="2163"/>
                      <a:pt x="2989" y="2155"/>
                    </a:cubicBezTo>
                    <a:lnTo>
                      <a:pt x="2920" y="2094"/>
                    </a:lnTo>
                    <a:cubicBezTo>
                      <a:pt x="2910" y="2086"/>
                      <a:pt x="2909" y="2071"/>
                      <a:pt x="2917" y="2062"/>
                    </a:cubicBezTo>
                    <a:cubicBezTo>
                      <a:pt x="2926" y="2052"/>
                      <a:pt x="2940" y="2051"/>
                      <a:pt x="2950" y="2059"/>
                    </a:cubicBezTo>
                    <a:close/>
                    <a:moveTo>
                      <a:pt x="3124" y="2210"/>
                    </a:moveTo>
                    <a:lnTo>
                      <a:pt x="3194" y="2271"/>
                    </a:lnTo>
                    <a:cubicBezTo>
                      <a:pt x="3203" y="2279"/>
                      <a:pt x="3204" y="2294"/>
                      <a:pt x="3196" y="2303"/>
                    </a:cubicBezTo>
                    <a:cubicBezTo>
                      <a:pt x="3188" y="2313"/>
                      <a:pt x="3173" y="2314"/>
                      <a:pt x="3164" y="2305"/>
                    </a:cubicBezTo>
                    <a:lnTo>
                      <a:pt x="3094" y="2245"/>
                    </a:lnTo>
                    <a:cubicBezTo>
                      <a:pt x="3084" y="2237"/>
                      <a:pt x="3083" y="2222"/>
                      <a:pt x="3092" y="2213"/>
                    </a:cubicBezTo>
                    <a:cubicBezTo>
                      <a:pt x="3100" y="2203"/>
                      <a:pt x="3114" y="2202"/>
                      <a:pt x="3124" y="2210"/>
                    </a:cubicBezTo>
                    <a:close/>
                    <a:moveTo>
                      <a:pt x="3295" y="2368"/>
                    </a:moveTo>
                    <a:lnTo>
                      <a:pt x="3358" y="2435"/>
                    </a:lnTo>
                    <a:cubicBezTo>
                      <a:pt x="3367" y="2444"/>
                      <a:pt x="3366" y="2459"/>
                      <a:pt x="3357" y="2468"/>
                    </a:cubicBezTo>
                    <a:cubicBezTo>
                      <a:pt x="3348" y="2477"/>
                      <a:pt x="3333" y="2476"/>
                      <a:pt x="3324" y="2467"/>
                    </a:cubicBezTo>
                    <a:lnTo>
                      <a:pt x="3261" y="2400"/>
                    </a:lnTo>
                    <a:cubicBezTo>
                      <a:pt x="3252" y="2391"/>
                      <a:pt x="3253" y="2376"/>
                      <a:pt x="3262" y="2367"/>
                    </a:cubicBezTo>
                    <a:cubicBezTo>
                      <a:pt x="3271" y="2359"/>
                      <a:pt x="3286" y="2359"/>
                      <a:pt x="3295" y="2368"/>
                    </a:cubicBezTo>
                    <a:close/>
                    <a:moveTo>
                      <a:pt x="3453" y="2536"/>
                    </a:moveTo>
                    <a:lnTo>
                      <a:pt x="3516" y="2603"/>
                    </a:lnTo>
                    <a:cubicBezTo>
                      <a:pt x="3525" y="2612"/>
                      <a:pt x="3524" y="2626"/>
                      <a:pt x="3515" y="2635"/>
                    </a:cubicBezTo>
                    <a:cubicBezTo>
                      <a:pt x="3506" y="2644"/>
                      <a:pt x="3491" y="2644"/>
                      <a:pt x="3483" y="2634"/>
                    </a:cubicBezTo>
                    <a:lnTo>
                      <a:pt x="3419" y="2567"/>
                    </a:lnTo>
                    <a:cubicBezTo>
                      <a:pt x="3411" y="2558"/>
                      <a:pt x="3411" y="2543"/>
                      <a:pt x="3420" y="2535"/>
                    </a:cubicBezTo>
                    <a:cubicBezTo>
                      <a:pt x="3429" y="2526"/>
                      <a:pt x="3444" y="2526"/>
                      <a:pt x="3453" y="2536"/>
                    </a:cubicBezTo>
                    <a:close/>
                    <a:moveTo>
                      <a:pt x="3614" y="2698"/>
                    </a:moveTo>
                    <a:lnTo>
                      <a:pt x="3681" y="2761"/>
                    </a:lnTo>
                    <a:cubicBezTo>
                      <a:pt x="3691" y="2770"/>
                      <a:pt x="3691" y="2784"/>
                      <a:pt x="3682" y="2794"/>
                    </a:cubicBezTo>
                    <a:cubicBezTo>
                      <a:pt x="3674" y="2803"/>
                      <a:pt x="3659" y="2803"/>
                      <a:pt x="3650" y="2795"/>
                    </a:cubicBezTo>
                    <a:lnTo>
                      <a:pt x="3583" y="2732"/>
                    </a:lnTo>
                    <a:cubicBezTo>
                      <a:pt x="3573" y="2723"/>
                      <a:pt x="3573" y="2709"/>
                      <a:pt x="3581" y="2699"/>
                    </a:cubicBezTo>
                    <a:cubicBezTo>
                      <a:pt x="3590" y="2690"/>
                      <a:pt x="3605" y="2689"/>
                      <a:pt x="3614" y="2698"/>
                    </a:cubicBezTo>
                    <a:close/>
                    <a:moveTo>
                      <a:pt x="3782" y="2855"/>
                    </a:moveTo>
                    <a:lnTo>
                      <a:pt x="3850" y="2918"/>
                    </a:lnTo>
                    <a:cubicBezTo>
                      <a:pt x="3859" y="2927"/>
                      <a:pt x="3860" y="2941"/>
                      <a:pt x="3851" y="2951"/>
                    </a:cubicBezTo>
                    <a:cubicBezTo>
                      <a:pt x="3842" y="2960"/>
                      <a:pt x="3828" y="2961"/>
                      <a:pt x="3818" y="2952"/>
                    </a:cubicBezTo>
                    <a:lnTo>
                      <a:pt x="3751" y="2889"/>
                    </a:lnTo>
                    <a:cubicBezTo>
                      <a:pt x="3742" y="2880"/>
                      <a:pt x="3741" y="2866"/>
                      <a:pt x="3750" y="2856"/>
                    </a:cubicBezTo>
                    <a:cubicBezTo>
                      <a:pt x="3759" y="2847"/>
                      <a:pt x="3773" y="2847"/>
                      <a:pt x="3782" y="2855"/>
                    </a:cubicBezTo>
                    <a:close/>
                    <a:moveTo>
                      <a:pt x="3969" y="2969"/>
                    </a:moveTo>
                    <a:lnTo>
                      <a:pt x="4054" y="3003"/>
                    </a:lnTo>
                    <a:cubicBezTo>
                      <a:pt x="4066" y="3008"/>
                      <a:pt x="4072" y="3022"/>
                      <a:pt x="4067" y="3033"/>
                    </a:cubicBezTo>
                    <a:cubicBezTo>
                      <a:pt x="4062" y="3045"/>
                      <a:pt x="4049" y="3051"/>
                      <a:pt x="4037" y="3046"/>
                    </a:cubicBezTo>
                    <a:lnTo>
                      <a:pt x="3952" y="3011"/>
                    </a:lnTo>
                    <a:cubicBezTo>
                      <a:pt x="3940" y="3006"/>
                      <a:pt x="3934" y="2993"/>
                      <a:pt x="3939" y="2981"/>
                    </a:cubicBezTo>
                    <a:cubicBezTo>
                      <a:pt x="3944" y="2969"/>
                      <a:pt x="3957" y="2964"/>
                      <a:pt x="3969" y="2969"/>
                    </a:cubicBezTo>
                    <a:close/>
                    <a:moveTo>
                      <a:pt x="4180" y="3049"/>
                    </a:moveTo>
                    <a:lnTo>
                      <a:pt x="4270" y="3067"/>
                    </a:lnTo>
                    <a:cubicBezTo>
                      <a:pt x="4283" y="3070"/>
                      <a:pt x="4291" y="3082"/>
                      <a:pt x="4288" y="3094"/>
                    </a:cubicBezTo>
                    <a:cubicBezTo>
                      <a:pt x="4286" y="3107"/>
                      <a:pt x="4274" y="3115"/>
                      <a:pt x="4261" y="3112"/>
                    </a:cubicBezTo>
                    <a:lnTo>
                      <a:pt x="4171" y="3094"/>
                    </a:lnTo>
                    <a:cubicBezTo>
                      <a:pt x="4158" y="3092"/>
                      <a:pt x="4150" y="3080"/>
                      <a:pt x="4153" y="3067"/>
                    </a:cubicBezTo>
                    <a:cubicBezTo>
                      <a:pt x="4155" y="3055"/>
                      <a:pt x="4167" y="3047"/>
                      <a:pt x="4180" y="3049"/>
                    </a:cubicBezTo>
                    <a:close/>
                  </a:path>
                </a:pathLst>
              </a:custGeom>
              <a:solidFill>
                <a:srgbClr val="FF0000"/>
              </a:solidFill>
              <a:ln w="1588" cap="flat">
                <a:solidFill>
                  <a:srgbClr val="FF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4" name="Rectangle 120"/>
              <p:cNvSpPr>
                <a:spLocks noChangeArrowheads="1"/>
              </p:cNvSpPr>
              <p:nvPr/>
            </p:nvSpPr>
            <p:spPr bwMode="auto">
              <a:xfrm>
                <a:off x="2029" y="434"/>
                <a:ext cx="9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2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5" name="Line 121"/>
              <p:cNvSpPr>
                <a:spLocks noChangeShapeType="1"/>
              </p:cNvSpPr>
              <p:nvPr/>
            </p:nvSpPr>
            <p:spPr bwMode="auto">
              <a:xfrm>
                <a:off x="1905" y="474"/>
                <a:ext cx="80" cy="0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6" name="Rectangle 122"/>
              <p:cNvSpPr>
                <a:spLocks noChangeArrowheads="1"/>
              </p:cNvSpPr>
              <p:nvPr/>
            </p:nvSpPr>
            <p:spPr bwMode="auto">
              <a:xfrm>
                <a:off x="2029" y="524"/>
                <a:ext cx="5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2;</a:t>
                </a:r>
                <a:r>
                  <a:rPr kumimoji="0" lang="en-US" altLang="el-GR" sz="9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RNAi)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8" name="Line 124"/>
              <p:cNvSpPr>
                <a:spLocks noChangeShapeType="1"/>
              </p:cNvSpPr>
              <p:nvPr/>
            </p:nvSpPr>
            <p:spPr bwMode="auto">
              <a:xfrm>
                <a:off x="1905" y="562"/>
                <a:ext cx="80" cy="0"/>
              </a:xfrm>
              <a:prstGeom prst="line">
                <a:avLst/>
              </a:prstGeom>
              <a:noFill/>
              <a:ln w="17463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9" name="Rectangle 125"/>
              <p:cNvSpPr>
                <a:spLocks noChangeArrowheads="1"/>
              </p:cNvSpPr>
              <p:nvPr/>
            </p:nvSpPr>
            <p:spPr bwMode="auto">
              <a:xfrm>
                <a:off x="2029" y="611"/>
                <a:ext cx="51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2;</a:t>
                </a:r>
                <a:r>
                  <a:rPr kumimoji="0" lang="en-US" altLang="el-GR" sz="9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d-9(RNAi)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1" name="Freeform 127"/>
              <p:cNvSpPr>
                <a:spLocks noEditPoints="1"/>
              </p:cNvSpPr>
              <p:nvPr/>
            </p:nvSpPr>
            <p:spPr bwMode="auto">
              <a:xfrm>
                <a:off x="1905" y="643"/>
                <a:ext cx="79" cy="11"/>
              </a:xfrm>
              <a:custGeom>
                <a:avLst/>
                <a:gdLst>
                  <a:gd name="T0" fmla="*/ 0 w 322"/>
                  <a:gd name="T1" fmla="*/ 0 h 46"/>
                  <a:gd name="T2" fmla="*/ 92 w 322"/>
                  <a:gd name="T3" fmla="*/ 0 h 46"/>
                  <a:gd name="T4" fmla="*/ 115 w 322"/>
                  <a:gd name="T5" fmla="*/ 23 h 46"/>
                  <a:gd name="T6" fmla="*/ 92 w 322"/>
                  <a:gd name="T7" fmla="*/ 46 h 46"/>
                  <a:gd name="T8" fmla="*/ 0 w 322"/>
                  <a:gd name="T9" fmla="*/ 46 h 46"/>
                  <a:gd name="T10" fmla="*/ 0 w 322"/>
                  <a:gd name="T11" fmla="*/ 0 h 46"/>
                  <a:gd name="T12" fmla="*/ 230 w 322"/>
                  <a:gd name="T13" fmla="*/ 0 h 46"/>
                  <a:gd name="T14" fmla="*/ 322 w 322"/>
                  <a:gd name="T15" fmla="*/ 0 h 46"/>
                  <a:gd name="T16" fmla="*/ 322 w 322"/>
                  <a:gd name="T17" fmla="*/ 46 h 46"/>
                  <a:gd name="T18" fmla="*/ 230 w 322"/>
                  <a:gd name="T19" fmla="*/ 46 h 46"/>
                  <a:gd name="T20" fmla="*/ 207 w 322"/>
                  <a:gd name="T21" fmla="*/ 23 h 46"/>
                  <a:gd name="T22" fmla="*/ 230 w 322"/>
                  <a:gd name="T2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22" h="46">
                    <a:moveTo>
                      <a:pt x="0" y="0"/>
                    </a:moveTo>
                    <a:lnTo>
                      <a:pt x="92" y="0"/>
                    </a:lnTo>
                    <a:cubicBezTo>
                      <a:pt x="104" y="0"/>
                      <a:pt x="115" y="10"/>
                      <a:pt x="115" y="23"/>
                    </a:cubicBezTo>
                    <a:cubicBezTo>
                      <a:pt x="115" y="36"/>
                      <a:pt x="104" y="46"/>
                      <a:pt x="92" y="46"/>
                    </a:cubicBezTo>
                    <a:lnTo>
                      <a:pt x="0" y="46"/>
                    </a:lnTo>
                    <a:lnTo>
                      <a:pt x="0" y="0"/>
                    </a:lnTo>
                    <a:close/>
                    <a:moveTo>
                      <a:pt x="230" y="0"/>
                    </a:moveTo>
                    <a:lnTo>
                      <a:pt x="322" y="0"/>
                    </a:lnTo>
                    <a:lnTo>
                      <a:pt x="322" y="46"/>
                    </a:lnTo>
                    <a:lnTo>
                      <a:pt x="230" y="46"/>
                    </a:lnTo>
                    <a:cubicBezTo>
                      <a:pt x="217" y="46"/>
                      <a:pt x="207" y="36"/>
                      <a:pt x="207" y="23"/>
                    </a:cubicBezTo>
                    <a:cubicBezTo>
                      <a:pt x="207" y="10"/>
                      <a:pt x="217" y="0"/>
                      <a:pt x="230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2" name="Rectangle 128"/>
              <p:cNvSpPr>
                <a:spLocks noChangeArrowheads="1"/>
              </p:cNvSpPr>
              <p:nvPr/>
            </p:nvSpPr>
            <p:spPr bwMode="auto">
              <a:xfrm>
                <a:off x="2029" y="697"/>
                <a:ext cx="40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2;</a:t>
                </a:r>
                <a:r>
                  <a:rPr kumimoji="0" lang="en-US" altLang="el-GR" sz="9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;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9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d-9(RNAi)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6" name="Freeform 132"/>
              <p:cNvSpPr>
                <a:spLocks noEditPoints="1"/>
              </p:cNvSpPr>
              <p:nvPr/>
            </p:nvSpPr>
            <p:spPr bwMode="auto">
              <a:xfrm>
                <a:off x="1905" y="778"/>
                <a:ext cx="79" cy="12"/>
              </a:xfrm>
              <a:custGeom>
                <a:avLst/>
                <a:gdLst>
                  <a:gd name="T0" fmla="*/ 0 w 322"/>
                  <a:gd name="T1" fmla="*/ 0 h 46"/>
                  <a:gd name="T2" fmla="*/ 92 w 322"/>
                  <a:gd name="T3" fmla="*/ 0 h 46"/>
                  <a:gd name="T4" fmla="*/ 115 w 322"/>
                  <a:gd name="T5" fmla="*/ 23 h 46"/>
                  <a:gd name="T6" fmla="*/ 92 w 322"/>
                  <a:gd name="T7" fmla="*/ 46 h 46"/>
                  <a:gd name="T8" fmla="*/ 0 w 322"/>
                  <a:gd name="T9" fmla="*/ 46 h 46"/>
                  <a:gd name="T10" fmla="*/ 0 w 322"/>
                  <a:gd name="T11" fmla="*/ 0 h 46"/>
                  <a:gd name="T12" fmla="*/ 230 w 322"/>
                  <a:gd name="T13" fmla="*/ 0 h 46"/>
                  <a:gd name="T14" fmla="*/ 322 w 322"/>
                  <a:gd name="T15" fmla="*/ 0 h 46"/>
                  <a:gd name="T16" fmla="*/ 322 w 322"/>
                  <a:gd name="T17" fmla="*/ 46 h 46"/>
                  <a:gd name="T18" fmla="*/ 230 w 322"/>
                  <a:gd name="T19" fmla="*/ 46 h 46"/>
                  <a:gd name="T20" fmla="*/ 207 w 322"/>
                  <a:gd name="T21" fmla="*/ 23 h 46"/>
                  <a:gd name="T22" fmla="*/ 230 w 322"/>
                  <a:gd name="T2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22" h="46">
                    <a:moveTo>
                      <a:pt x="0" y="0"/>
                    </a:moveTo>
                    <a:lnTo>
                      <a:pt x="92" y="0"/>
                    </a:lnTo>
                    <a:cubicBezTo>
                      <a:pt x="104" y="0"/>
                      <a:pt x="115" y="11"/>
                      <a:pt x="115" y="23"/>
                    </a:cubicBezTo>
                    <a:cubicBezTo>
                      <a:pt x="115" y="36"/>
                      <a:pt x="104" y="46"/>
                      <a:pt x="92" y="46"/>
                    </a:cubicBezTo>
                    <a:lnTo>
                      <a:pt x="0" y="46"/>
                    </a:lnTo>
                    <a:lnTo>
                      <a:pt x="0" y="0"/>
                    </a:lnTo>
                    <a:close/>
                    <a:moveTo>
                      <a:pt x="230" y="0"/>
                    </a:moveTo>
                    <a:lnTo>
                      <a:pt x="322" y="0"/>
                    </a:lnTo>
                    <a:lnTo>
                      <a:pt x="322" y="46"/>
                    </a:lnTo>
                    <a:lnTo>
                      <a:pt x="230" y="46"/>
                    </a:lnTo>
                    <a:cubicBezTo>
                      <a:pt x="217" y="46"/>
                      <a:pt x="207" y="36"/>
                      <a:pt x="207" y="23"/>
                    </a:cubicBezTo>
                    <a:cubicBezTo>
                      <a:pt x="207" y="11"/>
                      <a:pt x="217" y="0"/>
                      <a:pt x="230" y="0"/>
                    </a:cubicBezTo>
                    <a:close/>
                  </a:path>
                </a:pathLst>
              </a:custGeom>
              <a:solidFill>
                <a:srgbClr val="FF0000"/>
              </a:solidFill>
              <a:ln w="1588" cap="flat">
                <a:solidFill>
                  <a:srgbClr val="FF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7" name="Rectangle 133"/>
              <p:cNvSpPr>
                <a:spLocks noChangeArrowheads="1"/>
              </p:cNvSpPr>
              <p:nvPr/>
            </p:nvSpPr>
            <p:spPr bwMode="auto">
              <a:xfrm>
                <a:off x="1545" y="1443"/>
                <a:ext cx="71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ays</a:t>
                </a:r>
                <a:r>
                  <a:rPr kumimoji="0" lang="el-GR" altLang="el-G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f </a:t>
                </a:r>
                <a:r>
                  <a:rPr kumimoji="0" lang="el-GR" altLang="el-G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dulthood</a:t>
                </a:r>
                <a:endParaRPr kumimoji="0" lang="el-GR" altLang="el-GR" sz="2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98" name="TextBox 97"/>
            <p:cNvSpPr txBox="1"/>
            <p:nvPr/>
          </p:nvSpPr>
          <p:spPr>
            <a:xfrm rot="16200000">
              <a:off x="-185641" y="1351599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AutoShape 135"/>
            <p:cNvSpPr>
              <a:spLocks noChangeAspect="1" noChangeArrowheads="1" noTextEdit="1"/>
            </p:cNvSpPr>
            <p:nvPr/>
          </p:nvSpPr>
          <p:spPr bwMode="auto">
            <a:xfrm>
              <a:off x="3521417" y="582572"/>
              <a:ext cx="1443037" cy="1833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04" name="Rectangle 137"/>
            <p:cNvSpPr>
              <a:spLocks noChangeArrowheads="1"/>
            </p:cNvSpPr>
            <p:nvPr/>
          </p:nvSpPr>
          <p:spPr bwMode="auto">
            <a:xfrm>
              <a:off x="4343742" y="1877972"/>
              <a:ext cx="141287" cy="250825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06" name="Rectangle 139"/>
            <p:cNvSpPr>
              <a:spLocks noChangeArrowheads="1"/>
            </p:cNvSpPr>
            <p:nvPr/>
          </p:nvSpPr>
          <p:spPr bwMode="auto">
            <a:xfrm>
              <a:off x="4104029" y="2012910"/>
              <a:ext cx="141287" cy="115888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08" name="Rectangle 141"/>
            <p:cNvSpPr>
              <a:spLocks noChangeArrowheads="1"/>
            </p:cNvSpPr>
            <p:nvPr/>
          </p:nvSpPr>
          <p:spPr bwMode="auto">
            <a:xfrm>
              <a:off x="3864317" y="1341397"/>
              <a:ext cx="141287" cy="787400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10" name="Freeform 143"/>
            <p:cNvSpPr>
              <a:spLocks noEditPoints="1"/>
            </p:cNvSpPr>
            <p:nvPr/>
          </p:nvSpPr>
          <p:spPr bwMode="auto">
            <a:xfrm>
              <a:off x="3770654" y="2128797"/>
              <a:ext cx="808037" cy="50800"/>
            </a:xfrm>
            <a:custGeom>
              <a:avLst/>
              <a:gdLst>
                <a:gd name="T0" fmla="*/ 0 w 509"/>
                <a:gd name="T1" fmla="*/ 0 h 32"/>
                <a:gd name="T2" fmla="*/ 509 w 509"/>
                <a:gd name="T3" fmla="*/ 0 h 32"/>
                <a:gd name="T4" fmla="*/ 104 w 509"/>
                <a:gd name="T5" fmla="*/ 32 h 32"/>
                <a:gd name="T6" fmla="*/ 104 w 509"/>
                <a:gd name="T7" fmla="*/ 0 h 32"/>
                <a:gd name="T8" fmla="*/ 254 w 509"/>
                <a:gd name="T9" fmla="*/ 32 h 32"/>
                <a:gd name="T10" fmla="*/ 254 w 509"/>
                <a:gd name="T11" fmla="*/ 0 h 32"/>
                <a:gd name="T12" fmla="*/ 405 w 509"/>
                <a:gd name="T13" fmla="*/ 32 h 32"/>
                <a:gd name="T14" fmla="*/ 405 w 509"/>
                <a:gd name="T1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09" h="32">
                  <a:moveTo>
                    <a:pt x="0" y="0"/>
                  </a:moveTo>
                  <a:lnTo>
                    <a:pt x="509" y="0"/>
                  </a:lnTo>
                  <a:moveTo>
                    <a:pt x="104" y="32"/>
                  </a:moveTo>
                  <a:lnTo>
                    <a:pt x="104" y="0"/>
                  </a:lnTo>
                  <a:moveTo>
                    <a:pt x="254" y="32"/>
                  </a:moveTo>
                  <a:lnTo>
                    <a:pt x="254" y="0"/>
                  </a:lnTo>
                  <a:moveTo>
                    <a:pt x="405" y="32"/>
                  </a:moveTo>
                  <a:lnTo>
                    <a:pt x="40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11" name="Rectangle 144"/>
            <p:cNvSpPr>
              <a:spLocks noChangeArrowheads="1"/>
            </p:cNvSpPr>
            <p:nvPr/>
          </p:nvSpPr>
          <p:spPr bwMode="auto">
            <a:xfrm>
              <a:off x="3583329" y="207482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el-GR" altLang="el-GR" sz="2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145"/>
            <p:cNvSpPr>
              <a:spLocks noChangeArrowheads="1"/>
            </p:cNvSpPr>
            <p:nvPr/>
          </p:nvSpPr>
          <p:spPr bwMode="auto">
            <a:xfrm>
              <a:off x="3583329" y="1676360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el-GR" altLang="el-GR" sz="2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146"/>
            <p:cNvSpPr>
              <a:spLocks noChangeArrowheads="1"/>
            </p:cNvSpPr>
            <p:nvPr/>
          </p:nvSpPr>
          <p:spPr bwMode="auto">
            <a:xfrm>
              <a:off x="3583329" y="1279485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el-GR" altLang="el-GR" sz="2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147"/>
            <p:cNvSpPr>
              <a:spLocks noChangeArrowheads="1"/>
            </p:cNvSpPr>
            <p:nvPr/>
          </p:nvSpPr>
          <p:spPr bwMode="auto">
            <a:xfrm>
              <a:off x="3583329" y="88102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el-GR" altLang="el-GR" sz="2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Freeform 148"/>
            <p:cNvSpPr>
              <a:spLocks noEditPoints="1"/>
            </p:cNvSpPr>
            <p:nvPr/>
          </p:nvSpPr>
          <p:spPr bwMode="auto">
            <a:xfrm>
              <a:off x="3724617" y="928647"/>
              <a:ext cx="50800" cy="1206500"/>
            </a:xfrm>
            <a:custGeom>
              <a:avLst/>
              <a:gdLst>
                <a:gd name="T0" fmla="*/ 32 w 32"/>
                <a:gd name="T1" fmla="*/ 760 h 760"/>
                <a:gd name="T2" fmla="*/ 32 w 32"/>
                <a:gd name="T3" fmla="*/ 0 h 760"/>
                <a:gd name="T4" fmla="*/ 32 w 32"/>
                <a:gd name="T5" fmla="*/ 756 h 760"/>
                <a:gd name="T6" fmla="*/ 0 w 32"/>
                <a:gd name="T7" fmla="*/ 756 h 760"/>
                <a:gd name="T8" fmla="*/ 32 w 32"/>
                <a:gd name="T9" fmla="*/ 505 h 760"/>
                <a:gd name="T10" fmla="*/ 0 w 32"/>
                <a:gd name="T11" fmla="*/ 505 h 760"/>
                <a:gd name="T12" fmla="*/ 32 w 32"/>
                <a:gd name="T13" fmla="*/ 255 h 760"/>
                <a:gd name="T14" fmla="*/ 0 w 32"/>
                <a:gd name="T15" fmla="*/ 255 h 760"/>
                <a:gd name="T16" fmla="*/ 32 w 32"/>
                <a:gd name="T17" fmla="*/ 4 h 760"/>
                <a:gd name="T18" fmla="*/ 0 w 32"/>
                <a:gd name="T19" fmla="*/ 4 h 7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" h="760">
                  <a:moveTo>
                    <a:pt x="32" y="760"/>
                  </a:moveTo>
                  <a:lnTo>
                    <a:pt x="32" y="0"/>
                  </a:lnTo>
                  <a:moveTo>
                    <a:pt x="32" y="756"/>
                  </a:moveTo>
                  <a:lnTo>
                    <a:pt x="0" y="756"/>
                  </a:lnTo>
                  <a:moveTo>
                    <a:pt x="32" y="505"/>
                  </a:moveTo>
                  <a:lnTo>
                    <a:pt x="0" y="505"/>
                  </a:lnTo>
                  <a:moveTo>
                    <a:pt x="32" y="255"/>
                  </a:moveTo>
                  <a:lnTo>
                    <a:pt x="0" y="255"/>
                  </a:lnTo>
                  <a:moveTo>
                    <a:pt x="32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19" name="Rectangle 152"/>
            <p:cNvSpPr>
              <a:spLocks noChangeArrowheads="1"/>
            </p:cNvSpPr>
            <p:nvPr/>
          </p:nvSpPr>
          <p:spPr bwMode="auto">
            <a:xfrm>
              <a:off x="4000842" y="668297"/>
              <a:ext cx="30777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isd-1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Freeform 153"/>
            <p:cNvSpPr>
              <a:spLocks/>
            </p:cNvSpPr>
            <p:nvPr/>
          </p:nvSpPr>
          <p:spPr bwMode="auto">
            <a:xfrm>
              <a:off x="3938587" y="1158855"/>
              <a:ext cx="351276" cy="584200"/>
            </a:xfrm>
            <a:custGeom>
              <a:avLst/>
              <a:gdLst>
                <a:gd name="T0" fmla="*/ 0 w 212"/>
                <a:gd name="T1" fmla="*/ 38 h 368"/>
                <a:gd name="T2" fmla="*/ 0 w 212"/>
                <a:gd name="T3" fmla="*/ 0 h 368"/>
                <a:gd name="T4" fmla="*/ 212 w 212"/>
                <a:gd name="T5" fmla="*/ 0 h 368"/>
                <a:gd name="T6" fmla="*/ 212 w 212"/>
                <a:gd name="T7" fmla="*/ 368 h 3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2" h="368">
                  <a:moveTo>
                    <a:pt x="0" y="38"/>
                  </a:moveTo>
                  <a:lnTo>
                    <a:pt x="0" y="0"/>
                  </a:lnTo>
                  <a:lnTo>
                    <a:pt x="212" y="0"/>
                  </a:lnTo>
                  <a:lnTo>
                    <a:pt x="212" y="368"/>
                  </a:lnTo>
                </a:path>
              </a:pathLst>
            </a:cu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21" name="Rectangle 154"/>
            <p:cNvSpPr>
              <a:spLocks noChangeArrowheads="1"/>
            </p:cNvSpPr>
            <p:nvPr/>
          </p:nvSpPr>
          <p:spPr bwMode="auto">
            <a:xfrm>
              <a:off x="3959567" y="998497"/>
              <a:ext cx="2825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***</a:t>
              </a:r>
              <a:endParaRPr kumimoji="0" lang="el-GR" altLang="el-GR" sz="4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2" name="Line 155"/>
            <p:cNvSpPr>
              <a:spLocks noChangeShapeType="1"/>
            </p:cNvSpPr>
            <p:nvPr/>
          </p:nvSpPr>
          <p:spPr bwMode="auto">
            <a:xfrm>
              <a:off x="4168774" y="1746190"/>
              <a:ext cx="24561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23" name="TextBox 122"/>
            <p:cNvSpPr txBox="1"/>
            <p:nvPr/>
          </p:nvSpPr>
          <p:spPr>
            <a:xfrm rot="16200000">
              <a:off x="2713131" y="1274092"/>
              <a:ext cx="135485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ized mRNA</a:t>
              </a:r>
            </a:p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 rot="19800000">
              <a:off x="3543560" y="2186491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l-G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9" name="Ομάδα 128"/>
            <p:cNvGrpSpPr/>
            <p:nvPr/>
          </p:nvGrpSpPr>
          <p:grpSpPr>
            <a:xfrm>
              <a:off x="3895360" y="1260336"/>
              <a:ext cx="79200" cy="75600"/>
              <a:chOff x="4084394" y="1257260"/>
              <a:chExt cx="79200" cy="75600"/>
            </a:xfrm>
          </p:grpSpPr>
          <p:cxnSp>
            <p:nvCxnSpPr>
              <p:cNvPr id="126" name="Ευθεία γραμμή σύνδεσης 125"/>
              <p:cNvCxnSpPr/>
              <p:nvPr/>
            </p:nvCxnSpPr>
            <p:spPr>
              <a:xfrm flipV="1">
                <a:off x="4123994" y="1257260"/>
                <a:ext cx="0" cy="75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Ευθεία γραμμή σύνδεσης 127"/>
              <p:cNvCxnSpPr/>
              <p:nvPr/>
            </p:nvCxnSpPr>
            <p:spPr>
              <a:xfrm>
                <a:off x="4084394" y="1260395"/>
                <a:ext cx="79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2" name="Ομάδα 131"/>
            <p:cNvGrpSpPr/>
            <p:nvPr/>
          </p:nvGrpSpPr>
          <p:grpSpPr>
            <a:xfrm>
              <a:off x="4135072" y="1976073"/>
              <a:ext cx="79200" cy="32400"/>
              <a:chOff x="4084394" y="1257260"/>
              <a:chExt cx="79200" cy="32400"/>
            </a:xfrm>
          </p:grpSpPr>
          <p:cxnSp>
            <p:nvCxnSpPr>
              <p:cNvPr id="133" name="Ευθεία γραμμή σύνδεσης 132"/>
              <p:cNvCxnSpPr/>
              <p:nvPr/>
            </p:nvCxnSpPr>
            <p:spPr>
              <a:xfrm flipV="1">
                <a:off x="4123994" y="1257260"/>
                <a:ext cx="0" cy="324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Ευθεία γραμμή σύνδεσης 133"/>
              <p:cNvCxnSpPr/>
              <p:nvPr/>
            </p:nvCxnSpPr>
            <p:spPr>
              <a:xfrm>
                <a:off x="4084394" y="1260395"/>
                <a:ext cx="79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" name="Ομάδα 134"/>
            <p:cNvGrpSpPr/>
            <p:nvPr/>
          </p:nvGrpSpPr>
          <p:grpSpPr>
            <a:xfrm>
              <a:off x="4374785" y="1849040"/>
              <a:ext cx="79200" cy="28800"/>
              <a:chOff x="4084394" y="1257260"/>
              <a:chExt cx="79200" cy="28800"/>
            </a:xfrm>
          </p:grpSpPr>
          <p:cxnSp>
            <p:nvCxnSpPr>
              <p:cNvPr id="136" name="Ευθεία γραμμή σύνδεσης 135"/>
              <p:cNvCxnSpPr/>
              <p:nvPr/>
            </p:nvCxnSpPr>
            <p:spPr>
              <a:xfrm flipV="1">
                <a:off x="4123994" y="1257260"/>
                <a:ext cx="0" cy="288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Ευθεία γραμμή σύνδεσης 136"/>
              <p:cNvCxnSpPr/>
              <p:nvPr/>
            </p:nvCxnSpPr>
            <p:spPr>
              <a:xfrm>
                <a:off x="4084394" y="1260395"/>
                <a:ext cx="79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8" name="TextBox 137"/>
            <p:cNvSpPr txBox="1"/>
            <p:nvPr/>
          </p:nvSpPr>
          <p:spPr>
            <a:xfrm rot="19800000">
              <a:off x="3489623" y="2278408"/>
              <a:ext cx="8643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sd-1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 rot="19800000">
              <a:off x="3785656" y="2254348"/>
              <a:ext cx="8194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sd-1;</a:t>
              </a:r>
            </a:p>
            <a:p>
              <a:pPr algn="r"/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d-9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AutoShape 172"/>
            <p:cNvSpPr>
              <a:spLocks noChangeAspect="1" noChangeArrowheads="1" noTextEdit="1"/>
            </p:cNvSpPr>
            <p:nvPr/>
          </p:nvSpPr>
          <p:spPr bwMode="auto">
            <a:xfrm>
              <a:off x="5381610" y="583525"/>
              <a:ext cx="1443038" cy="1831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43" name="Rectangle 174"/>
            <p:cNvSpPr>
              <a:spLocks noChangeArrowheads="1"/>
            </p:cNvSpPr>
            <p:nvPr/>
          </p:nvSpPr>
          <p:spPr bwMode="auto">
            <a:xfrm>
              <a:off x="6203935" y="1815425"/>
              <a:ext cx="141288" cy="312738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45" name="Rectangle 176"/>
            <p:cNvSpPr>
              <a:spLocks noChangeArrowheads="1"/>
            </p:cNvSpPr>
            <p:nvPr/>
          </p:nvSpPr>
          <p:spPr bwMode="auto">
            <a:xfrm>
              <a:off x="5964223" y="1793200"/>
              <a:ext cx="141288" cy="334963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47" name="Rectangle 178"/>
            <p:cNvSpPr>
              <a:spLocks noChangeArrowheads="1"/>
            </p:cNvSpPr>
            <p:nvPr/>
          </p:nvSpPr>
          <p:spPr bwMode="auto">
            <a:xfrm>
              <a:off x="5724510" y="1342350"/>
              <a:ext cx="141288" cy="785813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49" name="Freeform 180"/>
            <p:cNvSpPr>
              <a:spLocks noEditPoints="1"/>
            </p:cNvSpPr>
            <p:nvPr/>
          </p:nvSpPr>
          <p:spPr bwMode="auto">
            <a:xfrm>
              <a:off x="5630848" y="2128163"/>
              <a:ext cx="808038" cy="50800"/>
            </a:xfrm>
            <a:custGeom>
              <a:avLst/>
              <a:gdLst>
                <a:gd name="T0" fmla="*/ 0 w 509"/>
                <a:gd name="T1" fmla="*/ 0 h 32"/>
                <a:gd name="T2" fmla="*/ 509 w 509"/>
                <a:gd name="T3" fmla="*/ 0 h 32"/>
                <a:gd name="T4" fmla="*/ 104 w 509"/>
                <a:gd name="T5" fmla="*/ 32 h 32"/>
                <a:gd name="T6" fmla="*/ 104 w 509"/>
                <a:gd name="T7" fmla="*/ 0 h 32"/>
                <a:gd name="T8" fmla="*/ 254 w 509"/>
                <a:gd name="T9" fmla="*/ 32 h 32"/>
                <a:gd name="T10" fmla="*/ 254 w 509"/>
                <a:gd name="T11" fmla="*/ 0 h 32"/>
                <a:gd name="T12" fmla="*/ 405 w 509"/>
                <a:gd name="T13" fmla="*/ 32 h 32"/>
                <a:gd name="T14" fmla="*/ 405 w 509"/>
                <a:gd name="T1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09" h="32">
                  <a:moveTo>
                    <a:pt x="0" y="0"/>
                  </a:moveTo>
                  <a:lnTo>
                    <a:pt x="509" y="0"/>
                  </a:lnTo>
                  <a:moveTo>
                    <a:pt x="104" y="32"/>
                  </a:moveTo>
                  <a:lnTo>
                    <a:pt x="104" y="0"/>
                  </a:lnTo>
                  <a:moveTo>
                    <a:pt x="254" y="32"/>
                  </a:moveTo>
                  <a:lnTo>
                    <a:pt x="254" y="0"/>
                  </a:lnTo>
                  <a:moveTo>
                    <a:pt x="405" y="32"/>
                  </a:moveTo>
                  <a:lnTo>
                    <a:pt x="40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50" name="Rectangle 181"/>
            <p:cNvSpPr>
              <a:spLocks noChangeArrowheads="1"/>
            </p:cNvSpPr>
            <p:nvPr/>
          </p:nvSpPr>
          <p:spPr bwMode="auto">
            <a:xfrm>
              <a:off x="5443523" y="2074188"/>
              <a:ext cx="1444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el-GR" altLang="el-GR" sz="2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Rectangle 182"/>
            <p:cNvSpPr>
              <a:spLocks noChangeArrowheads="1"/>
            </p:cNvSpPr>
            <p:nvPr/>
          </p:nvSpPr>
          <p:spPr bwMode="auto">
            <a:xfrm>
              <a:off x="5443523" y="1677313"/>
              <a:ext cx="1444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el-GR" altLang="el-GR" sz="2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Rectangle 183"/>
            <p:cNvSpPr>
              <a:spLocks noChangeArrowheads="1"/>
            </p:cNvSpPr>
            <p:nvPr/>
          </p:nvSpPr>
          <p:spPr bwMode="auto">
            <a:xfrm>
              <a:off x="5443523" y="1278850"/>
              <a:ext cx="1444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el-GR" altLang="el-GR" sz="2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Rectangle 184"/>
            <p:cNvSpPr>
              <a:spLocks noChangeArrowheads="1"/>
            </p:cNvSpPr>
            <p:nvPr/>
          </p:nvSpPr>
          <p:spPr bwMode="auto">
            <a:xfrm>
              <a:off x="5443523" y="881975"/>
              <a:ext cx="1444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el-GR" altLang="el-GR" sz="2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" name="Freeform 185"/>
            <p:cNvSpPr>
              <a:spLocks noEditPoints="1"/>
            </p:cNvSpPr>
            <p:nvPr/>
          </p:nvSpPr>
          <p:spPr bwMode="auto">
            <a:xfrm>
              <a:off x="5584810" y="929600"/>
              <a:ext cx="50800" cy="1204913"/>
            </a:xfrm>
            <a:custGeom>
              <a:avLst/>
              <a:gdLst>
                <a:gd name="T0" fmla="*/ 32 w 32"/>
                <a:gd name="T1" fmla="*/ 759 h 759"/>
                <a:gd name="T2" fmla="*/ 32 w 32"/>
                <a:gd name="T3" fmla="*/ 0 h 759"/>
                <a:gd name="T4" fmla="*/ 32 w 32"/>
                <a:gd name="T5" fmla="*/ 755 h 759"/>
                <a:gd name="T6" fmla="*/ 0 w 32"/>
                <a:gd name="T7" fmla="*/ 755 h 759"/>
                <a:gd name="T8" fmla="*/ 32 w 32"/>
                <a:gd name="T9" fmla="*/ 505 h 759"/>
                <a:gd name="T10" fmla="*/ 0 w 32"/>
                <a:gd name="T11" fmla="*/ 505 h 759"/>
                <a:gd name="T12" fmla="*/ 32 w 32"/>
                <a:gd name="T13" fmla="*/ 254 h 759"/>
                <a:gd name="T14" fmla="*/ 0 w 32"/>
                <a:gd name="T15" fmla="*/ 254 h 759"/>
                <a:gd name="T16" fmla="*/ 32 w 32"/>
                <a:gd name="T17" fmla="*/ 4 h 759"/>
                <a:gd name="T18" fmla="*/ 0 w 32"/>
                <a:gd name="T19" fmla="*/ 4 h 7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" h="759">
                  <a:moveTo>
                    <a:pt x="32" y="759"/>
                  </a:moveTo>
                  <a:lnTo>
                    <a:pt x="32" y="0"/>
                  </a:lnTo>
                  <a:moveTo>
                    <a:pt x="32" y="755"/>
                  </a:moveTo>
                  <a:lnTo>
                    <a:pt x="0" y="755"/>
                  </a:lnTo>
                  <a:moveTo>
                    <a:pt x="32" y="505"/>
                  </a:moveTo>
                  <a:lnTo>
                    <a:pt x="0" y="505"/>
                  </a:lnTo>
                  <a:moveTo>
                    <a:pt x="32" y="254"/>
                  </a:moveTo>
                  <a:lnTo>
                    <a:pt x="0" y="254"/>
                  </a:lnTo>
                  <a:moveTo>
                    <a:pt x="32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58" name="Rectangle 189"/>
            <p:cNvSpPr>
              <a:spLocks noChangeArrowheads="1"/>
            </p:cNvSpPr>
            <p:nvPr/>
          </p:nvSpPr>
          <p:spPr bwMode="auto">
            <a:xfrm>
              <a:off x="5880085" y="668297"/>
              <a:ext cx="28854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ed-9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Freeform 190"/>
            <p:cNvSpPr>
              <a:spLocks/>
            </p:cNvSpPr>
            <p:nvPr/>
          </p:nvSpPr>
          <p:spPr bwMode="auto">
            <a:xfrm>
              <a:off x="5799602" y="1234400"/>
              <a:ext cx="358306" cy="452438"/>
            </a:xfrm>
            <a:custGeom>
              <a:avLst/>
              <a:gdLst>
                <a:gd name="T0" fmla="*/ 0 w 220"/>
                <a:gd name="T1" fmla="*/ 15 h 285"/>
                <a:gd name="T2" fmla="*/ 0 w 220"/>
                <a:gd name="T3" fmla="*/ 0 h 285"/>
                <a:gd name="T4" fmla="*/ 220 w 220"/>
                <a:gd name="T5" fmla="*/ 0 h 285"/>
                <a:gd name="T6" fmla="*/ 220 w 220"/>
                <a:gd name="T7" fmla="*/ 285 h 2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0" h="285">
                  <a:moveTo>
                    <a:pt x="0" y="15"/>
                  </a:moveTo>
                  <a:lnTo>
                    <a:pt x="0" y="0"/>
                  </a:lnTo>
                  <a:lnTo>
                    <a:pt x="220" y="0"/>
                  </a:lnTo>
                  <a:lnTo>
                    <a:pt x="220" y="285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60" name="Rectangle 191"/>
            <p:cNvSpPr>
              <a:spLocks noChangeArrowheads="1"/>
            </p:cNvSpPr>
            <p:nvPr/>
          </p:nvSpPr>
          <p:spPr bwMode="auto">
            <a:xfrm>
              <a:off x="5837223" y="1082263"/>
              <a:ext cx="2825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***</a:t>
              </a:r>
              <a:endParaRPr kumimoji="0" lang="el-GR" altLang="el-G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1" name="Line 192"/>
            <p:cNvSpPr>
              <a:spLocks noChangeShapeType="1"/>
            </p:cNvSpPr>
            <p:nvPr/>
          </p:nvSpPr>
          <p:spPr bwMode="auto">
            <a:xfrm>
              <a:off x="6034867" y="1690975"/>
              <a:ext cx="23971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62" name="TextBox 161"/>
            <p:cNvSpPr txBox="1"/>
            <p:nvPr/>
          </p:nvSpPr>
          <p:spPr>
            <a:xfrm rot="19800000">
              <a:off x="5397159" y="2183503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l-G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 rot="19800000">
              <a:off x="5365664" y="2275420"/>
              <a:ext cx="8194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d-9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 rot="19800000">
              <a:off x="5639255" y="2251360"/>
              <a:ext cx="8194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sd-1;</a:t>
              </a:r>
            </a:p>
            <a:p>
              <a:pPr algn="r"/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d-9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5" name="Ομάδα 164"/>
            <p:cNvGrpSpPr/>
            <p:nvPr/>
          </p:nvGrpSpPr>
          <p:grpSpPr>
            <a:xfrm>
              <a:off x="5755554" y="1310370"/>
              <a:ext cx="79200" cy="27217"/>
              <a:chOff x="4084394" y="1255243"/>
              <a:chExt cx="79200" cy="27217"/>
            </a:xfrm>
          </p:grpSpPr>
          <p:cxnSp>
            <p:nvCxnSpPr>
              <p:cNvPr id="166" name="Ευθεία γραμμή σύνδεσης 165"/>
              <p:cNvCxnSpPr/>
              <p:nvPr/>
            </p:nvCxnSpPr>
            <p:spPr>
              <a:xfrm flipV="1">
                <a:off x="4123994" y="1257260"/>
                <a:ext cx="0" cy="252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Ευθεία γραμμή σύνδεσης 166"/>
              <p:cNvCxnSpPr/>
              <p:nvPr/>
            </p:nvCxnSpPr>
            <p:spPr>
              <a:xfrm>
                <a:off x="4084394" y="1255243"/>
                <a:ext cx="79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8" name="Ομάδα 167"/>
            <p:cNvGrpSpPr/>
            <p:nvPr/>
          </p:nvGrpSpPr>
          <p:grpSpPr>
            <a:xfrm>
              <a:off x="5995267" y="1764821"/>
              <a:ext cx="79200" cy="23617"/>
              <a:chOff x="4084394" y="1255243"/>
              <a:chExt cx="79200" cy="23617"/>
            </a:xfrm>
          </p:grpSpPr>
          <p:cxnSp>
            <p:nvCxnSpPr>
              <p:cNvPr id="169" name="Ευθεία γραμμή σύνδεσης 168"/>
              <p:cNvCxnSpPr/>
              <p:nvPr/>
            </p:nvCxnSpPr>
            <p:spPr>
              <a:xfrm flipV="1">
                <a:off x="4123994" y="1257260"/>
                <a:ext cx="0" cy="21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Ευθεία γραμμή σύνδεσης 169"/>
              <p:cNvCxnSpPr/>
              <p:nvPr/>
            </p:nvCxnSpPr>
            <p:spPr>
              <a:xfrm>
                <a:off x="4084394" y="1255243"/>
                <a:ext cx="79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1" name="Ομάδα 170"/>
            <p:cNvGrpSpPr/>
            <p:nvPr/>
          </p:nvGrpSpPr>
          <p:grpSpPr>
            <a:xfrm>
              <a:off x="6234979" y="1799212"/>
              <a:ext cx="79200" cy="13376"/>
              <a:chOff x="4084394" y="1249610"/>
              <a:chExt cx="79200" cy="29250"/>
            </a:xfrm>
          </p:grpSpPr>
          <p:cxnSp>
            <p:nvCxnSpPr>
              <p:cNvPr id="172" name="Ευθεία γραμμή σύνδεσης 171"/>
              <p:cNvCxnSpPr/>
              <p:nvPr/>
            </p:nvCxnSpPr>
            <p:spPr>
              <a:xfrm flipV="1">
                <a:off x="4123994" y="1257260"/>
                <a:ext cx="0" cy="21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Ευθεία γραμμή σύνδεσης 172"/>
              <p:cNvCxnSpPr/>
              <p:nvPr/>
            </p:nvCxnSpPr>
            <p:spPr>
              <a:xfrm>
                <a:off x="4084394" y="1249610"/>
                <a:ext cx="79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4" name="TextBox 173"/>
            <p:cNvSpPr txBox="1"/>
            <p:nvPr/>
          </p:nvSpPr>
          <p:spPr>
            <a:xfrm rot="16200000">
              <a:off x="4566113" y="1274092"/>
              <a:ext cx="135485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ized mRNA</a:t>
              </a:r>
            </a:p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AutoShape 198"/>
            <p:cNvSpPr>
              <a:spLocks noChangeAspect="1" noChangeArrowheads="1" noTextEdit="1"/>
            </p:cNvSpPr>
            <p:nvPr/>
          </p:nvSpPr>
          <p:spPr bwMode="auto">
            <a:xfrm>
              <a:off x="419574" y="2897188"/>
              <a:ext cx="2557463" cy="1763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78" name="Rectangle 200"/>
            <p:cNvSpPr>
              <a:spLocks noChangeArrowheads="1"/>
            </p:cNvSpPr>
            <p:nvPr/>
          </p:nvSpPr>
          <p:spPr bwMode="auto">
            <a:xfrm>
              <a:off x="692624" y="4313238"/>
              <a:ext cx="571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Rectangle 201"/>
            <p:cNvSpPr>
              <a:spLocks noChangeArrowheads="1"/>
            </p:cNvSpPr>
            <p:nvPr/>
          </p:nvSpPr>
          <p:spPr bwMode="auto">
            <a:xfrm>
              <a:off x="989487" y="4313238"/>
              <a:ext cx="571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0" name="Rectangle 202"/>
            <p:cNvSpPr>
              <a:spLocks noChangeArrowheads="1"/>
            </p:cNvSpPr>
            <p:nvPr/>
          </p:nvSpPr>
          <p:spPr bwMode="auto">
            <a:xfrm>
              <a:off x="1262537" y="4313238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" name="Rectangle 203"/>
            <p:cNvSpPr>
              <a:spLocks noChangeArrowheads="1"/>
            </p:cNvSpPr>
            <p:nvPr/>
          </p:nvSpPr>
          <p:spPr bwMode="auto">
            <a:xfrm>
              <a:off x="1560987" y="4313238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2" name="Rectangle 204"/>
            <p:cNvSpPr>
              <a:spLocks noChangeArrowheads="1"/>
            </p:cNvSpPr>
            <p:nvPr/>
          </p:nvSpPr>
          <p:spPr bwMode="auto">
            <a:xfrm>
              <a:off x="1857849" y="4313238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Rectangle 205"/>
            <p:cNvSpPr>
              <a:spLocks noChangeArrowheads="1"/>
            </p:cNvSpPr>
            <p:nvPr/>
          </p:nvSpPr>
          <p:spPr bwMode="auto">
            <a:xfrm>
              <a:off x="2156299" y="4313238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4" name="Rectangle 206"/>
            <p:cNvSpPr>
              <a:spLocks noChangeArrowheads="1"/>
            </p:cNvSpPr>
            <p:nvPr/>
          </p:nvSpPr>
          <p:spPr bwMode="auto">
            <a:xfrm>
              <a:off x="2453162" y="4313238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Freeform 207"/>
            <p:cNvSpPr>
              <a:spLocks noEditPoints="1"/>
            </p:cNvSpPr>
            <p:nvPr/>
          </p:nvSpPr>
          <p:spPr bwMode="auto">
            <a:xfrm>
              <a:off x="714849" y="4264025"/>
              <a:ext cx="1797050" cy="34925"/>
            </a:xfrm>
            <a:custGeom>
              <a:avLst/>
              <a:gdLst>
                <a:gd name="T0" fmla="*/ 0 w 1132"/>
                <a:gd name="T1" fmla="*/ 0 h 22"/>
                <a:gd name="T2" fmla="*/ 1132 w 1132"/>
                <a:gd name="T3" fmla="*/ 0 h 22"/>
                <a:gd name="T4" fmla="*/ 3 w 1132"/>
                <a:gd name="T5" fmla="*/ 0 h 22"/>
                <a:gd name="T6" fmla="*/ 3 w 1132"/>
                <a:gd name="T7" fmla="*/ 22 h 22"/>
                <a:gd name="T8" fmla="*/ 191 w 1132"/>
                <a:gd name="T9" fmla="*/ 0 h 22"/>
                <a:gd name="T10" fmla="*/ 191 w 1132"/>
                <a:gd name="T11" fmla="*/ 22 h 22"/>
                <a:gd name="T12" fmla="*/ 378 w 1132"/>
                <a:gd name="T13" fmla="*/ 0 h 22"/>
                <a:gd name="T14" fmla="*/ 378 w 1132"/>
                <a:gd name="T15" fmla="*/ 22 h 22"/>
                <a:gd name="T16" fmla="*/ 566 w 1132"/>
                <a:gd name="T17" fmla="*/ 0 h 22"/>
                <a:gd name="T18" fmla="*/ 566 w 1132"/>
                <a:gd name="T19" fmla="*/ 22 h 22"/>
                <a:gd name="T20" fmla="*/ 753 w 1132"/>
                <a:gd name="T21" fmla="*/ 0 h 22"/>
                <a:gd name="T22" fmla="*/ 753 w 1132"/>
                <a:gd name="T23" fmla="*/ 22 h 22"/>
                <a:gd name="T24" fmla="*/ 941 w 1132"/>
                <a:gd name="T25" fmla="*/ 0 h 22"/>
                <a:gd name="T26" fmla="*/ 941 w 1132"/>
                <a:gd name="T27" fmla="*/ 22 h 22"/>
                <a:gd name="T28" fmla="*/ 1128 w 1132"/>
                <a:gd name="T29" fmla="*/ 0 h 22"/>
                <a:gd name="T30" fmla="*/ 1128 w 1132"/>
                <a:gd name="T31" fmla="*/ 22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132" h="22">
                  <a:moveTo>
                    <a:pt x="0" y="0"/>
                  </a:moveTo>
                  <a:lnTo>
                    <a:pt x="1132" y="0"/>
                  </a:lnTo>
                  <a:moveTo>
                    <a:pt x="3" y="0"/>
                  </a:moveTo>
                  <a:lnTo>
                    <a:pt x="3" y="22"/>
                  </a:lnTo>
                  <a:moveTo>
                    <a:pt x="191" y="0"/>
                  </a:moveTo>
                  <a:lnTo>
                    <a:pt x="191" y="22"/>
                  </a:lnTo>
                  <a:moveTo>
                    <a:pt x="378" y="0"/>
                  </a:moveTo>
                  <a:lnTo>
                    <a:pt x="378" y="22"/>
                  </a:lnTo>
                  <a:moveTo>
                    <a:pt x="566" y="0"/>
                  </a:moveTo>
                  <a:lnTo>
                    <a:pt x="566" y="22"/>
                  </a:lnTo>
                  <a:moveTo>
                    <a:pt x="753" y="0"/>
                  </a:moveTo>
                  <a:lnTo>
                    <a:pt x="753" y="22"/>
                  </a:lnTo>
                  <a:moveTo>
                    <a:pt x="941" y="0"/>
                  </a:moveTo>
                  <a:lnTo>
                    <a:pt x="941" y="22"/>
                  </a:lnTo>
                  <a:moveTo>
                    <a:pt x="1128" y="0"/>
                  </a:moveTo>
                  <a:lnTo>
                    <a:pt x="1128" y="22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86" name="Rectangle 208"/>
            <p:cNvSpPr>
              <a:spLocks noChangeArrowheads="1"/>
            </p:cNvSpPr>
            <p:nvPr/>
          </p:nvSpPr>
          <p:spPr bwMode="auto">
            <a:xfrm>
              <a:off x="618012" y="4208463"/>
              <a:ext cx="571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7" name="Rectangle 209"/>
            <p:cNvSpPr>
              <a:spLocks noChangeArrowheads="1"/>
            </p:cNvSpPr>
            <p:nvPr/>
          </p:nvSpPr>
          <p:spPr bwMode="auto">
            <a:xfrm>
              <a:off x="562449" y="3965575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Rectangle 210"/>
            <p:cNvSpPr>
              <a:spLocks noChangeArrowheads="1"/>
            </p:cNvSpPr>
            <p:nvPr/>
          </p:nvSpPr>
          <p:spPr bwMode="auto">
            <a:xfrm>
              <a:off x="562449" y="3729038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9" name="Rectangle 211"/>
            <p:cNvSpPr>
              <a:spLocks noChangeArrowheads="1"/>
            </p:cNvSpPr>
            <p:nvPr/>
          </p:nvSpPr>
          <p:spPr bwMode="auto">
            <a:xfrm>
              <a:off x="562449" y="3494088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0" name="Rectangle 212"/>
            <p:cNvSpPr>
              <a:spLocks noChangeArrowheads="1"/>
            </p:cNvSpPr>
            <p:nvPr/>
          </p:nvSpPr>
          <p:spPr bwMode="auto">
            <a:xfrm>
              <a:off x="562449" y="3251200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1" name="Rectangle 213"/>
            <p:cNvSpPr>
              <a:spLocks noChangeArrowheads="1"/>
            </p:cNvSpPr>
            <p:nvPr/>
          </p:nvSpPr>
          <p:spPr bwMode="auto">
            <a:xfrm>
              <a:off x="506887" y="3014663"/>
              <a:ext cx="1730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Freeform 214"/>
            <p:cNvSpPr>
              <a:spLocks noEditPoints="1"/>
            </p:cNvSpPr>
            <p:nvPr/>
          </p:nvSpPr>
          <p:spPr bwMode="auto">
            <a:xfrm>
              <a:off x="684687" y="3063875"/>
              <a:ext cx="34925" cy="1204912"/>
            </a:xfrm>
            <a:custGeom>
              <a:avLst/>
              <a:gdLst>
                <a:gd name="T0" fmla="*/ 22 w 22"/>
                <a:gd name="T1" fmla="*/ 759 h 759"/>
                <a:gd name="T2" fmla="*/ 22 w 22"/>
                <a:gd name="T3" fmla="*/ 0 h 759"/>
                <a:gd name="T4" fmla="*/ 22 w 22"/>
                <a:gd name="T5" fmla="*/ 756 h 759"/>
                <a:gd name="T6" fmla="*/ 0 w 22"/>
                <a:gd name="T7" fmla="*/ 756 h 759"/>
                <a:gd name="T8" fmla="*/ 22 w 22"/>
                <a:gd name="T9" fmla="*/ 606 h 759"/>
                <a:gd name="T10" fmla="*/ 0 w 22"/>
                <a:gd name="T11" fmla="*/ 606 h 759"/>
                <a:gd name="T12" fmla="*/ 22 w 22"/>
                <a:gd name="T13" fmla="*/ 455 h 759"/>
                <a:gd name="T14" fmla="*/ 0 w 22"/>
                <a:gd name="T15" fmla="*/ 455 h 759"/>
                <a:gd name="T16" fmla="*/ 22 w 22"/>
                <a:gd name="T17" fmla="*/ 305 h 759"/>
                <a:gd name="T18" fmla="*/ 0 w 22"/>
                <a:gd name="T19" fmla="*/ 305 h 759"/>
                <a:gd name="T20" fmla="*/ 22 w 22"/>
                <a:gd name="T21" fmla="*/ 154 h 759"/>
                <a:gd name="T22" fmla="*/ 0 w 22"/>
                <a:gd name="T23" fmla="*/ 154 h 759"/>
                <a:gd name="T24" fmla="*/ 22 w 22"/>
                <a:gd name="T25" fmla="*/ 4 h 759"/>
                <a:gd name="T26" fmla="*/ 0 w 22"/>
                <a:gd name="T27" fmla="*/ 4 h 7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2" h="759">
                  <a:moveTo>
                    <a:pt x="22" y="759"/>
                  </a:moveTo>
                  <a:lnTo>
                    <a:pt x="22" y="0"/>
                  </a:lnTo>
                  <a:moveTo>
                    <a:pt x="22" y="756"/>
                  </a:moveTo>
                  <a:lnTo>
                    <a:pt x="0" y="756"/>
                  </a:lnTo>
                  <a:moveTo>
                    <a:pt x="22" y="606"/>
                  </a:moveTo>
                  <a:lnTo>
                    <a:pt x="0" y="606"/>
                  </a:lnTo>
                  <a:moveTo>
                    <a:pt x="22" y="455"/>
                  </a:moveTo>
                  <a:lnTo>
                    <a:pt x="0" y="455"/>
                  </a:lnTo>
                  <a:moveTo>
                    <a:pt x="22" y="305"/>
                  </a:moveTo>
                  <a:lnTo>
                    <a:pt x="0" y="305"/>
                  </a:lnTo>
                  <a:moveTo>
                    <a:pt x="22" y="154"/>
                  </a:moveTo>
                  <a:lnTo>
                    <a:pt x="0" y="154"/>
                  </a:lnTo>
                  <a:moveTo>
                    <a:pt x="22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3" name="Freeform 215"/>
            <p:cNvSpPr>
              <a:spLocks/>
            </p:cNvSpPr>
            <p:nvPr/>
          </p:nvSpPr>
          <p:spPr bwMode="auto">
            <a:xfrm>
              <a:off x="719612" y="3070225"/>
              <a:ext cx="1547813" cy="1193800"/>
            </a:xfrm>
            <a:custGeom>
              <a:avLst/>
              <a:gdLst>
                <a:gd name="T0" fmla="*/ 0 w 975"/>
                <a:gd name="T1" fmla="*/ 0 h 752"/>
                <a:gd name="T2" fmla="*/ 0 w 975"/>
                <a:gd name="T3" fmla="*/ 0 h 752"/>
                <a:gd name="T4" fmla="*/ 0 w 975"/>
                <a:gd name="T5" fmla="*/ 0 h 752"/>
                <a:gd name="T6" fmla="*/ 113 w 975"/>
                <a:gd name="T7" fmla="*/ 0 h 752"/>
                <a:gd name="T8" fmla="*/ 113 w 975"/>
                <a:gd name="T9" fmla="*/ 0 h 752"/>
                <a:gd name="T10" fmla="*/ 188 w 975"/>
                <a:gd name="T11" fmla="*/ 0 h 752"/>
                <a:gd name="T12" fmla="*/ 188 w 975"/>
                <a:gd name="T13" fmla="*/ 0 h 752"/>
                <a:gd name="T14" fmla="*/ 263 w 975"/>
                <a:gd name="T15" fmla="*/ 0 h 752"/>
                <a:gd name="T16" fmla="*/ 263 w 975"/>
                <a:gd name="T17" fmla="*/ 0 h 752"/>
                <a:gd name="T18" fmla="*/ 300 w 975"/>
                <a:gd name="T19" fmla="*/ 7 h 752"/>
                <a:gd name="T20" fmla="*/ 300 w 975"/>
                <a:gd name="T21" fmla="*/ 7 h 752"/>
                <a:gd name="T22" fmla="*/ 338 w 975"/>
                <a:gd name="T23" fmla="*/ 18 h 752"/>
                <a:gd name="T24" fmla="*/ 338 w 975"/>
                <a:gd name="T25" fmla="*/ 18 h 752"/>
                <a:gd name="T26" fmla="*/ 375 w 975"/>
                <a:gd name="T27" fmla="*/ 41 h 752"/>
                <a:gd name="T28" fmla="*/ 375 w 975"/>
                <a:gd name="T29" fmla="*/ 41 h 752"/>
                <a:gd name="T30" fmla="*/ 413 w 975"/>
                <a:gd name="T31" fmla="*/ 76 h 752"/>
                <a:gd name="T32" fmla="*/ 413 w 975"/>
                <a:gd name="T33" fmla="*/ 76 h 752"/>
                <a:gd name="T34" fmla="*/ 450 w 975"/>
                <a:gd name="T35" fmla="*/ 130 h 752"/>
                <a:gd name="T36" fmla="*/ 450 w 975"/>
                <a:gd name="T37" fmla="*/ 130 h 752"/>
                <a:gd name="T38" fmla="*/ 488 w 975"/>
                <a:gd name="T39" fmla="*/ 204 h 752"/>
                <a:gd name="T40" fmla="*/ 488 w 975"/>
                <a:gd name="T41" fmla="*/ 204 h 752"/>
                <a:gd name="T42" fmla="*/ 526 w 975"/>
                <a:gd name="T43" fmla="*/ 249 h 752"/>
                <a:gd name="T44" fmla="*/ 526 w 975"/>
                <a:gd name="T45" fmla="*/ 249 h 752"/>
                <a:gd name="T46" fmla="*/ 563 w 975"/>
                <a:gd name="T47" fmla="*/ 308 h 752"/>
                <a:gd name="T48" fmla="*/ 563 w 975"/>
                <a:gd name="T49" fmla="*/ 308 h 752"/>
                <a:gd name="T50" fmla="*/ 600 w 975"/>
                <a:gd name="T51" fmla="*/ 353 h 752"/>
                <a:gd name="T52" fmla="*/ 600 w 975"/>
                <a:gd name="T53" fmla="*/ 353 h 752"/>
                <a:gd name="T54" fmla="*/ 638 w 975"/>
                <a:gd name="T55" fmla="*/ 391 h 752"/>
                <a:gd name="T56" fmla="*/ 638 w 975"/>
                <a:gd name="T57" fmla="*/ 391 h 752"/>
                <a:gd name="T58" fmla="*/ 675 w 975"/>
                <a:gd name="T59" fmla="*/ 443 h 752"/>
                <a:gd name="T60" fmla="*/ 675 w 975"/>
                <a:gd name="T61" fmla="*/ 443 h 752"/>
                <a:gd name="T62" fmla="*/ 713 w 975"/>
                <a:gd name="T63" fmla="*/ 531 h 752"/>
                <a:gd name="T64" fmla="*/ 713 w 975"/>
                <a:gd name="T65" fmla="*/ 531 h 752"/>
                <a:gd name="T66" fmla="*/ 750 w 975"/>
                <a:gd name="T67" fmla="*/ 610 h 752"/>
                <a:gd name="T68" fmla="*/ 750 w 975"/>
                <a:gd name="T69" fmla="*/ 610 h 752"/>
                <a:gd name="T70" fmla="*/ 788 w 975"/>
                <a:gd name="T71" fmla="*/ 690 h 752"/>
                <a:gd name="T72" fmla="*/ 788 w 975"/>
                <a:gd name="T73" fmla="*/ 690 h 752"/>
                <a:gd name="T74" fmla="*/ 825 w 975"/>
                <a:gd name="T75" fmla="*/ 707 h 752"/>
                <a:gd name="T76" fmla="*/ 825 w 975"/>
                <a:gd name="T77" fmla="*/ 707 h 752"/>
                <a:gd name="T78" fmla="*/ 863 w 975"/>
                <a:gd name="T79" fmla="*/ 734 h 752"/>
                <a:gd name="T80" fmla="*/ 863 w 975"/>
                <a:gd name="T81" fmla="*/ 734 h 752"/>
                <a:gd name="T82" fmla="*/ 901 w 975"/>
                <a:gd name="T83" fmla="*/ 743 h 752"/>
                <a:gd name="T84" fmla="*/ 901 w 975"/>
                <a:gd name="T85" fmla="*/ 743 h 752"/>
                <a:gd name="T86" fmla="*/ 975 w 975"/>
                <a:gd name="T87" fmla="*/ 752 h 7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975" h="752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88" y="0"/>
                  </a:lnTo>
                  <a:lnTo>
                    <a:pt x="188" y="0"/>
                  </a:lnTo>
                  <a:lnTo>
                    <a:pt x="263" y="0"/>
                  </a:lnTo>
                  <a:lnTo>
                    <a:pt x="263" y="0"/>
                  </a:lnTo>
                  <a:lnTo>
                    <a:pt x="300" y="7"/>
                  </a:lnTo>
                  <a:lnTo>
                    <a:pt x="300" y="7"/>
                  </a:lnTo>
                  <a:lnTo>
                    <a:pt x="338" y="18"/>
                  </a:lnTo>
                  <a:lnTo>
                    <a:pt x="338" y="18"/>
                  </a:lnTo>
                  <a:lnTo>
                    <a:pt x="375" y="41"/>
                  </a:lnTo>
                  <a:lnTo>
                    <a:pt x="375" y="41"/>
                  </a:lnTo>
                  <a:lnTo>
                    <a:pt x="413" y="76"/>
                  </a:lnTo>
                  <a:lnTo>
                    <a:pt x="413" y="76"/>
                  </a:lnTo>
                  <a:lnTo>
                    <a:pt x="450" y="130"/>
                  </a:lnTo>
                  <a:lnTo>
                    <a:pt x="450" y="130"/>
                  </a:lnTo>
                  <a:lnTo>
                    <a:pt x="488" y="204"/>
                  </a:lnTo>
                  <a:lnTo>
                    <a:pt x="488" y="204"/>
                  </a:lnTo>
                  <a:lnTo>
                    <a:pt x="526" y="249"/>
                  </a:lnTo>
                  <a:lnTo>
                    <a:pt x="526" y="249"/>
                  </a:lnTo>
                  <a:lnTo>
                    <a:pt x="563" y="308"/>
                  </a:lnTo>
                  <a:lnTo>
                    <a:pt x="563" y="308"/>
                  </a:lnTo>
                  <a:lnTo>
                    <a:pt x="600" y="353"/>
                  </a:lnTo>
                  <a:lnTo>
                    <a:pt x="600" y="353"/>
                  </a:lnTo>
                  <a:lnTo>
                    <a:pt x="638" y="391"/>
                  </a:lnTo>
                  <a:lnTo>
                    <a:pt x="638" y="391"/>
                  </a:lnTo>
                  <a:lnTo>
                    <a:pt x="675" y="443"/>
                  </a:lnTo>
                  <a:lnTo>
                    <a:pt x="675" y="443"/>
                  </a:lnTo>
                  <a:lnTo>
                    <a:pt x="713" y="531"/>
                  </a:lnTo>
                  <a:lnTo>
                    <a:pt x="713" y="531"/>
                  </a:lnTo>
                  <a:lnTo>
                    <a:pt x="750" y="610"/>
                  </a:lnTo>
                  <a:lnTo>
                    <a:pt x="750" y="610"/>
                  </a:lnTo>
                  <a:lnTo>
                    <a:pt x="788" y="690"/>
                  </a:lnTo>
                  <a:lnTo>
                    <a:pt x="788" y="690"/>
                  </a:lnTo>
                  <a:lnTo>
                    <a:pt x="825" y="707"/>
                  </a:lnTo>
                  <a:lnTo>
                    <a:pt x="825" y="707"/>
                  </a:lnTo>
                  <a:lnTo>
                    <a:pt x="863" y="734"/>
                  </a:lnTo>
                  <a:lnTo>
                    <a:pt x="863" y="734"/>
                  </a:lnTo>
                  <a:lnTo>
                    <a:pt x="901" y="743"/>
                  </a:lnTo>
                  <a:lnTo>
                    <a:pt x="901" y="743"/>
                  </a:lnTo>
                  <a:lnTo>
                    <a:pt x="975" y="752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4" name="Freeform 216"/>
            <p:cNvSpPr>
              <a:spLocks/>
            </p:cNvSpPr>
            <p:nvPr/>
          </p:nvSpPr>
          <p:spPr bwMode="auto">
            <a:xfrm>
              <a:off x="719612" y="3070225"/>
              <a:ext cx="1489075" cy="1193800"/>
            </a:xfrm>
            <a:custGeom>
              <a:avLst/>
              <a:gdLst>
                <a:gd name="T0" fmla="*/ 0 w 938"/>
                <a:gd name="T1" fmla="*/ 0 h 752"/>
                <a:gd name="T2" fmla="*/ 0 w 938"/>
                <a:gd name="T3" fmla="*/ 0 h 752"/>
                <a:gd name="T4" fmla="*/ 0 w 938"/>
                <a:gd name="T5" fmla="*/ 0 h 752"/>
                <a:gd name="T6" fmla="*/ 113 w 938"/>
                <a:gd name="T7" fmla="*/ 0 h 752"/>
                <a:gd name="T8" fmla="*/ 113 w 938"/>
                <a:gd name="T9" fmla="*/ 0 h 752"/>
                <a:gd name="T10" fmla="*/ 188 w 938"/>
                <a:gd name="T11" fmla="*/ 0 h 752"/>
                <a:gd name="T12" fmla="*/ 188 w 938"/>
                <a:gd name="T13" fmla="*/ 0 h 752"/>
                <a:gd name="T14" fmla="*/ 263 w 938"/>
                <a:gd name="T15" fmla="*/ 7 h 752"/>
                <a:gd name="T16" fmla="*/ 263 w 938"/>
                <a:gd name="T17" fmla="*/ 7 h 752"/>
                <a:gd name="T18" fmla="*/ 300 w 938"/>
                <a:gd name="T19" fmla="*/ 19 h 752"/>
                <a:gd name="T20" fmla="*/ 300 w 938"/>
                <a:gd name="T21" fmla="*/ 19 h 752"/>
                <a:gd name="T22" fmla="*/ 338 w 938"/>
                <a:gd name="T23" fmla="*/ 33 h 752"/>
                <a:gd name="T24" fmla="*/ 338 w 938"/>
                <a:gd name="T25" fmla="*/ 33 h 752"/>
                <a:gd name="T26" fmla="*/ 375 w 938"/>
                <a:gd name="T27" fmla="*/ 78 h 752"/>
                <a:gd name="T28" fmla="*/ 375 w 938"/>
                <a:gd name="T29" fmla="*/ 78 h 752"/>
                <a:gd name="T30" fmla="*/ 413 w 938"/>
                <a:gd name="T31" fmla="*/ 149 h 752"/>
                <a:gd name="T32" fmla="*/ 413 w 938"/>
                <a:gd name="T33" fmla="*/ 149 h 752"/>
                <a:gd name="T34" fmla="*/ 450 w 938"/>
                <a:gd name="T35" fmla="*/ 241 h 752"/>
                <a:gd name="T36" fmla="*/ 450 w 938"/>
                <a:gd name="T37" fmla="*/ 241 h 752"/>
                <a:gd name="T38" fmla="*/ 488 w 938"/>
                <a:gd name="T39" fmla="*/ 327 h 752"/>
                <a:gd name="T40" fmla="*/ 488 w 938"/>
                <a:gd name="T41" fmla="*/ 327 h 752"/>
                <a:gd name="T42" fmla="*/ 526 w 938"/>
                <a:gd name="T43" fmla="*/ 422 h 752"/>
                <a:gd name="T44" fmla="*/ 526 w 938"/>
                <a:gd name="T45" fmla="*/ 422 h 752"/>
                <a:gd name="T46" fmla="*/ 563 w 938"/>
                <a:gd name="T47" fmla="*/ 502 h 752"/>
                <a:gd name="T48" fmla="*/ 563 w 938"/>
                <a:gd name="T49" fmla="*/ 502 h 752"/>
                <a:gd name="T50" fmla="*/ 600 w 938"/>
                <a:gd name="T51" fmla="*/ 529 h 752"/>
                <a:gd name="T52" fmla="*/ 600 w 938"/>
                <a:gd name="T53" fmla="*/ 529 h 752"/>
                <a:gd name="T54" fmla="*/ 638 w 938"/>
                <a:gd name="T55" fmla="*/ 597 h 752"/>
                <a:gd name="T56" fmla="*/ 638 w 938"/>
                <a:gd name="T57" fmla="*/ 597 h 752"/>
                <a:gd name="T58" fmla="*/ 675 w 938"/>
                <a:gd name="T59" fmla="*/ 644 h 752"/>
                <a:gd name="T60" fmla="*/ 675 w 938"/>
                <a:gd name="T61" fmla="*/ 644 h 752"/>
                <a:gd name="T62" fmla="*/ 713 w 938"/>
                <a:gd name="T63" fmla="*/ 692 h 752"/>
                <a:gd name="T64" fmla="*/ 713 w 938"/>
                <a:gd name="T65" fmla="*/ 692 h 752"/>
                <a:gd name="T66" fmla="*/ 750 w 938"/>
                <a:gd name="T67" fmla="*/ 725 h 752"/>
                <a:gd name="T68" fmla="*/ 750 w 938"/>
                <a:gd name="T69" fmla="*/ 725 h 752"/>
                <a:gd name="T70" fmla="*/ 825 w 938"/>
                <a:gd name="T71" fmla="*/ 732 h 752"/>
                <a:gd name="T72" fmla="*/ 825 w 938"/>
                <a:gd name="T73" fmla="*/ 732 h 752"/>
                <a:gd name="T74" fmla="*/ 863 w 938"/>
                <a:gd name="T75" fmla="*/ 739 h 752"/>
                <a:gd name="T76" fmla="*/ 863 w 938"/>
                <a:gd name="T77" fmla="*/ 739 h 752"/>
                <a:gd name="T78" fmla="*/ 901 w 938"/>
                <a:gd name="T79" fmla="*/ 745 h 752"/>
                <a:gd name="T80" fmla="*/ 901 w 938"/>
                <a:gd name="T81" fmla="*/ 745 h 752"/>
                <a:gd name="T82" fmla="*/ 938 w 938"/>
                <a:gd name="T83" fmla="*/ 752 h 7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938" h="752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88" y="0"/>
                  </a:lnTo>
                  <a:lnTo>
                    <a:pt x="188" y="0"/>
                  </a:lnTo>
                  <a:lnTo>
                    <a:pt x="263" y="7"/>
                  </a:lnTo>
                  <a:lnTo>
                    <a:pt x="263" y="7"/>
                  </a:lnTo>
                  <a:lnTo>
                    <a:pt x="300" y="19"/>
                  </a:lnTo>
                  <a:lnTo>
                    <a:pt x="300" y="19"/>
                  </a:lnTo>
                  <a:lnTo>
                    <a:pt x="338" y="33"/>
                  </a:lnTo>
                  <a:lnTo>
                    <a:pt x="338" y="33"/>
                  </a:lnTo>
                  <a:lnTo>
                    <a:pt x="375" y="78"/>
                  </a:lnTo>
                  <a:lnTo>
                    <a:pt x="375" y="78"/>
                  </a:lnTo>
                  <a:lnTo>
                    <a:pt x="413" y="149"/>
                  </a:lnTo>
                  <a:lnTo>
                    <a:pt x="413" y="149"/>
                  </a:lnTo>
                  <a:lnTo>
                    <a:pt x="450" y="241"/>
                  </a:lnTo>
                  <a:lnTo>
                    <a:pt x="450" y="241"/>
                  </a:lnTo>
                  <a:lnTo>
                    <a:pt x="488" y="327"/>
                  </a:lnTo>
                  <a:lnTo>
                    <a:pt x="488" y="327"/>
                  </a:lnTo>
                  <a:lnTo>
                    <a:pt x="526" y="422"/>
                  </a:lnTo>
                  <a:lnTo>
                    <a:pt x="526" y="422"/>
                  </a:lnTo>
                  <a:lnTo>
                    <a:pt x="563" y="502"/>
                  </a:lnTo>
                  <a:lnTo>
                    <a:pt x="563" y="502"/>
                  </a:lnTo>
                  <a:lnTo>
                    <a:pt x="600" y="529"/>
                  </a:lnTo>
                  <a:lnTo>
                    <a:pt x="600" y="529"/>
                  </a:lnTo>
                  <a:lnTo>
                    <a:pt x="638" y="597"/>
                  </a:lnTo>
                  <a:lnTo>
                    <a:pt x="638" y="597"/>
                  </a:lnTo>
                  <a:lnTo>
                    <a:pt x="675" y="644"/>
                  </a:lnTo>
                  <a:lnTo>
                    <a:pt x="675" y="644"/>
                  </a:lnTo>
                  <a:lnTo>
                    <a:pt x="713" y="692"/>
                  </a:lnTo>
                  <a:lnTo>
                    <a:pt x="713" y="692"/>
                  </a:lnTo>
                  <a:lnTo>
                    <a:pt x="750" y="725"/>
                  </a:lnTo>
                  <a:lnTo>
                    <a:pt x="750" y="725"/>
                  </a:lnTo>
                  <a:lnTo>
                    <a:pt x="825" y="732"/>
                  </a:lnTo>
                  <a:lnTo>
                    <a:pt x="825" y="732"/>
                  </a:lnTo>
                  <a:lnTo>
                    <a:pt x="863" y="739"/>
                  </a:lnTo>
                  <a:lnTo>
                    <a:pt x="863" y="739"/>
                  </a:lnTo>
                  <a:lnTo>
                    <a:pt x="901" y="745"/>
                  </a:lnTo>
                  <a:lnTo>
                    <a:pt x="901" y="745"/>
                  </a:lnTo>
                  <a:lnTo>
                    <a:pt x="938" y="752"/>
                  </a:lnTo>
                </a:path>
              </a:pathLst>
            </a:custGeom>
            <a:noFill/>
            <a:ln w="17463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5" name="Freeform 217"/>
            <p:cNvSpPr>
              <a:spLocks noEditPoints="1"/>
            </p:cNvSpPr>
            <p:nvPr/>
          </p:nvSpPr>
          <p:spPr bwMode="auto">
            <a:xfrm>
              <a:off x="719612" y="3060700"/>
              <a:ext cx="1271588" cy="1192212"/>
            </a:xfrm>
            <a:custGeom>
              <a:avLst/>
              <a:gdLst>
                <a:gd name="T0" fmla="*/ 92 w 3281"/>
                <a:gd name="T1" fmla="*/ 48 h 3071"/>
                <a:gd name="T2" fmla="*/ 323 w 3281"/>
                <a:gd name="T3" fmla="*/ 2 h 3071"/>
                <a:gd name="T4" fmla="*/ 208 w 3281"/>
                <a:gd name="T5" fmla="*/ 25 h 3071"/>
                <a:gd name="T6" fmla="*/ 575 w 3281"/>
                <a:gd name="T7" fmla="*/ 41 h 3071"/>
                <a:gd name="T8" fmla="*/ 464 w 3281"/>
                <a:gd name="T9" fmla="*/ 2 h 3071"/>
                <a:gd name="T10" fmla="*/ 765 w 3281"/>
                <a:gd name="T11" fmla="*/ 91 h 3071"/>
                <a:gd name="T12" fmla="*/ 774 w 3281"/>
                <a:gd name="T13" fmla="*/ 46 h 3071"/>
                <a:gd name="T14" fmla="*/ 762 w 3281"/>
                <a:gd name="T15" fmla="*/ 91 h 3071"/>
                <a:gd name="T16" fmla="*/ 1009 w 3281"/>
                <a:gd name="T17" fmla="*/ 107 h 3071"/>
                <a:gd name="T18" fmla="*/ 892 w 3281"/>
                <a:gd name="T19" fmla="*/ 100 h 3071"/>
                <a:gd name="T20" fmla="*/ 1222 w 3281"/>
                <a:gd name="T21" fmla="*/ 250 h 3071"/>
                <a:gd name="T22" fmla="*/ 1141 w 3281"/>
                <a:gd name="T23" fmla="*/ 165 h 3071"/>
                <a:gd name="T24" fmla="*/ 1383 w 3281"/>
                <a:gd name="T25" fmla="*/ 278 h 3071"/>
                <a:gd name="T26" fmla="*/ 1403 w 3281"/>
                <a:gd name="T27" fmla="*/ 244 h 3071"/>
                <a:gd name="T28" fmla="*/ 1362 w 3281"/>
                <a:gd name="T29" fmla="*/ 266 h 3071"/>
                <a:gd name="T30" fmla="*/ 1535 w 3281"/>
                <a:gd name="T31" fmla="*/ 486 h 3071"/>
                <a:gd name="T32" fmla="*/ 1459 w 3281"/>
                <a:gd name="T33" fmla="*/ 396 h 3071"/>
                <a:gd name="T34" fmla="*/ 1711 w 3281"/>
                <a:gd name="T35" fmla="*/ 601 h 3071"/>
                <a:gd name="T36" fmla="*/ 1631 w 3281"/>
                <a:gd name="T37" fmla="*/ 547 h 3071"/>
                <a:gd name="T38" fmla="*/ 1678 w 3281"/>
                <a:gd name="T39" fmla="*/ 623 h 3071"/>
                <a:gd name="T40" fmla="*/ 1779 w 3281"/>
                <a:gd name="T41" fmla="*/ 728 h 3071"/>
                <a:gd name="T42" fmla="*/ 1737 w 3281"/>
                <a:gd name="T43" fmla="*/ 748 h 3071"/>
                <a:gd name="T44" fmla="*/ 1904 w 3281"/>
                <a:gd name="T45" fmla="*/ 1027 h 3071"/>
                <a:gd name="T46" fmla="*/ 1846 w 3281"/>
                <a:gd name="T47" fmla="*/ 926 h 3071"/>
                <a:gd name="T48" fmla="*/ 1964 w 3281"/>
                <a:gd name="T49" fmla="*/ 1275 h 3071"/>
                <a:gd name="T50" fmla="*/ 1949 w 3281"/>
                <a:gd name="T51" fmla="*/ 1158 h 3071"/>
                <a:gd name="T52" fmla="*/ 2047 w 3281"/>
                <a:gd name="T53" fmla="*/ 1467 h 3071"/>
                <a:gd name="T54" fmla="*/ 2174 w 3281"/>
                <a:gd name="T55" fmla="*/ 1547 h 3071"/>
                <a:gd name="T56" fmla="*/ 2132 w 3281"/>
                <a:gd name="T57" fmla="*/ 1566 h 3071"/>
                <a:gd name="T58" fmla="*/ 2307 w 3281"/>
                <a:gd name="T59" fmla="*/ 1841 h 3071"/>
                <a:gd name="T60" fmla="*/ 2239 w 3281"/>
                <a:gd name="T61" fmla="*/ 1746 h 3071"/>
                <a:gd name="T62" fmla="*/ 2391 w 3281"/>
                <a:gd name="T63" fmla="*/ 2082 h 3071"/>
                <a:gd name="T64" fmla="*/ 2364 w 3281"/>
                <a:gd name="T65" fmla="*/ 1967 h 3071"/>
                <a:gd name="T66" fmla="*/ 2437 w 3281"/>
                <a:gd name="T67" fmla="*/ 2239 h 3071"/>
                <a:gd name="T68" fmla="*/ 2473 w 3281"/>
                <a:gd name="T69" fmla="*/ 2212 h 3071"/>
                <a:gd name="T70" fmla="*/ 2442 w 3281"/>
                <a:gd name="T71" fmla="*/ 2246 h 3071"/>
                <a:gd name="T72" fmla="*/ 2627 w 3281"/>
                <a:gd name="T73" fmla="*/ 2356 h 3071"/>
                <a:gd name="T74" fmla="*/ 2575 w 3281"/>
                <a:gd name="T75" fmla="*/ 2339 h 3071"/>
                <a:gd name="T76" fmla="*/ 2644 w 3281"/>
                <a:gd name="T77" fmla="*/ 2455 h 3071"/>
                <a:gd name="T78" fmla="*/ 2633 w 3281"/>
                <a:gd name="T79" fmla="*/ 2364 h 3071"/>
                <a:gd name="T80" fmla="*/ 2699 w 3281"/>
                <a:gd name="T81" fmla="*/ 2656 h 3071"/>
                <a:gd name="T82" fmla="*/ 2792 w 3281"/>
                <a:gd name="T83" fmla="*/ 2746 h 3071"/>
                <a:gd name="T84" fmla="*/ 2772 w 3281"/>
                <a:gd name="T85" fmla="*/ 2788 h 3071"/>
                <a:gd name="T86" fmla="*/ 3082 w 3281"/>
                <a:gd name="T87" fmla="*/ 2884 h 3071"/>
                <a:gd name="T88" fmla="*/ 2969 w 3281"/>
                <a:gd name="T89" fmla="*/ 2856 h 3071"/>
                <a:gd name="T90" fmla="*/ 3091 w 3281"/>
                <a:gd name="T91" fmla="*/ 2920 h 3071"/>
                <a:gd name="T92" fmla="*/ 3087 w 3281"/>
                <a:gd name="T93" fmla="*/ 2887 h 3071"/>
                <a:gd name="T94" fmla="*/ 3211 w 3281"/>
                <a:gd name="T95" fmla="*/ 3051 h 3071"/>
                <a:gd name="T96" fmla="*/ 3235 w 3281"/>
                <a:gd name="T97" fmla="*/ 3012 h 3071"/>
                <a:gd name="T98" fmla="*/ 3217 w 3281"/>
                <a:gd name="T99" fmla="*/ 3054 h 30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3281" h="3071">
                  <a:moveTo>
                    <a:pt x="0" y="2"/>
                  </a:moveTo>
                  <a:lnTo>
                    <a:pt x="92" y="2"/>
                  </a:lnTo>
                  <a:cubicBezTo>
                    <a:pt x="105" y="2"/>
                    <a:pt x="115" y="12"/>
                    <a:pt x="115" y="25"/>
                  </a:cubicBezTo>
                  <a:cubicBezTo>
                    <a:pt x="115" y="38"/>
                    <a:pt x="105" y="48"/>
                    <a:pt x="92" y="48"/>
                  </a:cubicBezTo>
                  <a:lnTo>
                    <a:pt x="0" y="48"/>
                  </a:lnTo>
                  <a:lnTo>
                    <a:pt x="0" y="2"/>
                  </a:lnTo>
                  <a:close/>
                  <a:moveTo>
                    <a:pt x="231" y="2"/>
                  </a:moveTo>
                  <a:lnTo>
                    <a:pt x="323" y="2"/>
                  </a:lnTo>
                  <a:cubicBezTo>
                    <a:pt x="335" y="2"/>
                    <a:pt x="346" y="12"/>
                    <a:pt x="346" y="25"/>
                  </a:cubicBezTo>
                  <a:cubicBezTo>
                    <a:pt x="346" y="38"/>
                    <a:pt x="335" y="48"/>
                    <a:pt x="323" y="48"/>
                  </a:cubicBezTo>
                  <a:lnTo>
                    <a:pt x="231" y="48"/>
                  </a:lnTo>
                  <a:cubicBezTo>
                    <a:pt x="218" y="48"/>
                    <a:pt x="208" y="38"/>
                    <a:pt x="208" y="25"/>
                  </a:cubicBezTo>
                  <a:cubicBezTo>
                    <a:pt x="208" y="12"/>
                    <a:pt x="218" y="2"/>
                    <a:pt x="231" y="2"/>
                  </a:cubicBezTo>
                  <a:close/>
                  <a:moveTo>
                    <a:pt x="464" y="2"/>
                  </a:moveTo>
                  <a:lnTo>
                    <a:pt x="555" y="15"/>
                  </a:lnTo>
                  <a:cubicBezTo>
                    <a:pt x="568" y="17"/>
                    <a:pt x="577" y="28"/>
                    <a:pt x="575" y="41"/>
                  </a:cubicBezTo>
                  <a:cubicBezTo>
                    <a:pt x="573" y="54"/>
                    <a:pt x="562" y="62"/>
                    <a:pt x="549" y="61"/>
                  </a:cubicBezTo>
                  <a:lnTo>
                    <a:pt x="458" y="48"/>
                  </a:lnTo>
                  <a:cubicBezTo>
                    <a:pt x="445" y="46"/>
                    <a:pt x="436" y="34"/>
                    <a:pt x="438" y="22"/>
                  </a:cubicBezTo>
                  <a:cubicBezTo>
                    <a:pt x="440" y="9"/>
                    <a:pt x="452" y="0"/>
                    <a:pt x="464" y="2"/>
                  </a:cubicBezTo>
                  <a:close/>
                  <a:moveTo>
                    <a:pt x="692" y="34"/>
                  </a:moveTo>
                  <a:lnTo>
                    <a:pt x="771" y="46"/>
                  </a:lnTo>
                  <a:cubicBezTo>
                    <a:pt x="784" y="47"/>
                    <a:pt x="793" y="59"/>
                    <a:pt x="791" y="72"/>
                  </a:cubicBezTo>
                  <a:cubicBezTo>
                    <a:pt x="789" y="84"/>
                    <a:pt x="778" y="93"/>
                    <a:pt x="765" y="91"/>
                  </a:cubicBezTo>
                  <a:lnTo>
                    <a:pt x="686" y="80"/>
                  </a:lnTo>
                  <a:cubicBezTo>
                    <a:pt x="673" y="78"/>
                    <a:pt x="664" y="67"/>
                    <a:pt x="666" y="54"/>
                  </a:cubicBezTo>
                  <a:cubicBezTo>
                    <a:pt x="668" y="41"/>
                    <a:pt x="680" y="33"/>
                    <a:pt x="692" y="34"/>
                  </a:cubicBezTo>
                  <a:close/>
                  <a:moveTo>
                    <a:pt x="774" y="46"/>
                  </a:moveTo>
                  <a:lnTo>
                    <a:pt x="786" y="49"/>
                  </a:lnTo>
                  <a:cubicBezTo>
                    <a:pt x="798" y="52"/>
                    <a:pt x="806" y="65"/>
                    <a:pt x="802" y="77"/>
                  </a:cubicBezTo>
                  <a:cubicBezTo>
                    <a:pt x="799" y="90"/>
                    <a:pt x="787" y="97"/>
                    <a:pt x="774" y="94"/>
                  </a:cubicBezTo>
                  <a:lnTo>
                    <a:pt x="762" y="91"/>
                  </a:lnTo>
                  <a:cubicBezTo>
                    <a:pt x="750" y="88"/>
                    <a:pt x="743" y="75"/>
                    <a:pt x="746" y="63"/>
                  </a:cubicBezTo>
                  <a:cubicBezTo>
                    <a:pt x="749" y="50"/>
                    <a:pt x="762" y="43"/>
                    <a:pt x="774" y="46"/>
                  </a:cubicBezTo>
                  <a:close/>
                  <a:moveTo>
                    <a:pt x="920" y="84"/>
                  </a:moveTo>
                  <a:lnTo>
                    <a:pt x="1009" y="107"/>
                  </a:lnTo>
                  <a:cubicBezTo>
                    <a:pt x="1021" y="110"/>
                    <a:pt x="1029" y="123"/>
                    <a:pt x="1025" y="135"/>
                  </a:cubicBezTo>
                  <a:cubicBezTo>
                    <a:pt x="1022" y="147"/>
                    <a:pt x="1010" y="155"/>
                    <a:pt x="997" y="151"/>
                  </a:cubicBezTo>
                  <a:lnTo>
                    <a:pt x="908" y="128"/>
                  </a:lnTo>
                  <a:cubicBezTo>
                    <a:pt x="896" y="125"/>
                    <a:pt x="888" y="113"/>
                    <a:pt x="892" y="100"/>
                  </a:cubicBezTo>
                  <a:cubicBezTo>
                    <a:pt x="895" y="88"/>
                    <a:pt x="907" y="81"/>
                    <a:pt x="920" y="84"/>
                  </a:cubicBezTo>
                  <a:close/>
                  <a:moveTo>
                    <a:pt x="1141" y="165"/>
                  </a:moveTo>
                  <a:lnTo>
                    <a:pt x="1216" y="218"/>
                  </a:lnTo>
                  <a:cubicBezTo>
                    <a:pt x="1227" y="226"/>
                    <a:pt x="1229" y="240"/>
                    <a:pt x="1222" y="250"/>
                  </a:cubicBezTo>
                  <a:cubicBezTo>
                    <a:pt x="1215" y="261"/>
                    <a:pt x="1200" y="263"/>
                    <a:pt x="1190" y="256"/>
                  </a:cubicBezTo>
                  <a:lnTo>
                    <a:pt x="1114" y="203"/>
                  </a:lnTo>
                  <a:cubicBezTo>
                    <a:pt x="1104" y="196"/>
                    <a:pt x="1101" y="181"/>
                    <a:pt x="1109" y="171"/>
                  </a:cubicBezTo>
                  <a:cubicBezTo>
                    <a:pt x="1116" y="161"/>
                    <a:pt x="1130" y="158"/>
                    <a:pt x="1141" y="165"/>
                  </a:cubicBezTo>
                  <a:close/>
                  <a:moveTo>
                    <a:pt x="1336" y="232"/>
                  </a:moveTo>
                  <a:lnTo>
                    <a:pt x="1383" y="232"/>
                  </a:lnTo>
                  <a:cubicBezTo>
                    <a:pt x="1395" y="232"/>
                    <a:pt x="1406" y="243"/>
                    <a:pt x="1406" y="255"/>
                  </a:cubicBezTo>
                  <a:cubicBezTo>
                    <a:pt x="1406" y="268"/>
                    <a:pt x="1395" y="278"/>
                    <a:pt x="1383" y="278"/>
                  </a:cubicBezTo>
                  <a:lnTo>
                    <a:pt x="1336" y="278"/>
                  </a:lnTo>
                  <a:cubicBezTo>
                    <a:pt x="1323" y="278"/>
                    <a:pt x="1312" y="268"/>
                    <a:pt x="1312" y="255"/>
                  </a:cubicBezTo>
                  <a:cubicBezTo>
                    <a:pt x="1312" y="243"/>
                    <a:pt x="1323" y="232"/>
                    <a:pt x="1336" y="232"/>
                  </a:cubicBezTo>
                  <a:close/>
                  <a:moveTo>
                    <a:pt x="1403" y="244"/>
                  </a:moveTo>
                  <a:lnTo>
                    <a:pt x="1424" y="284"/>
                  </a:lnTo>
                  <a:cubicBezTo>
                    <a:pt x="1430" y="295"/>
                    <a:pt x="1426" y="309"/>
                    <a:pt x="1415" y="315"/>
                  </a:cubicBezTo>
                  <a:cubicBezTo>
                    <a:pt x="1404" y="321"/>
                    <a:pt x="1390" y="317"/>
                    <a:pt x="1384" y="306"/>
                  </a:cubicBezTo>
                  <a:lnTo>
                    <a:pt x="1362" y="266"/>
                  </a:lnTo>
                  <a:cubicBezTo>
                    <a:pt x="1356" y="255"/>
                    <a:pt x="1360" y="241"/>
                    <a:pt x="1372" y="235"/>
                  </a:cubicBezTo>
                  <a:cubicBezTo>
                    <a:pt x="1383" y="229"/>
                    <a:pt x="1397" y="233"/>
                    <a:pt x="1403" y="244"/>
                  </a:cubicBezTo>
                  <a:close/>
                  <a:moveTo>
                    <a:pt x="1491" y="405"/>
                  </a:moveTo>
                  <a:lnTo>
                    <a:pt x="1535" y="486"/>
                  </a:lnTo>
                  <a:cubicBezTo>
                    <a:pt x="1541" y="497"/>
                    <a:pt x="1537" y="511"/>
                    <a:pt x="1526" y="517"/>
                  </a:cubicBezTo>
                  <a:cubicBezTo>
                    <a:pt x="1514" y="524"/>
                    <a:pt x="1500" y="519"/>
                    <a:pt x="1494" y="508"/>
                  </a:cubicBezTo>
                  <a:lnTo>
                    <a:pt x="1450" y="427"/>
                  </a:lnTo>
                  <a:cubicBezTo>
                    <a:pt x="1444" y="416"/>
                    <a:pt x="1448" y="402"/>
                    <a:pt x="1459" y="396"/>
                  </a:cubicBezTo>
                  <a:cubicBezTo>
                    <a:pt x="1470" y="390"/>
                    <a:pt x="1484" y="394"/>
                    <a:pt x="1491" y="405"/>
                  </a:cubicBezTo>
                  <a:close/>
                  <a:moveTo>
                    <a:pt x="1631" y="547"/>
                  </a:moveTo>
                  <a:lnTo>
                    <a:pt x="1698" y="572"/>
                  </a:lnTo>
                  <a:cubicBezTo>
                    <a:pt x="1710" y="576"/>
                    <a:pt x="1716" y="589"/>
                    <a:pt x="1711" y="601"/>
                  </a:cubicBezTo>
                  <a:cubicBezTo>
                    <a:pt x="1707" y="613"/>
                    <a:pt x="1694" y="619"/>
                    <a:pt x="1682" y="615"/>
                  </a:cubicBezTo>
                  <a:lnTo>
                    <a:pt x="1616" y="591"/>
                  </a:lnTo>
                  <a:cubicBezTo>
                    <a:pt x="1604" y="586"/>
                    <a:pt x="1597" y="573"/>
                    <a:pt x="1602" y="561"/>
                  </a:cubicBezTo>
                  <a:cubicBezTo>
                    <a:pt x="1606" y="549"/>
                    <a:pt x="1619" y="543"/>
                    <a:pt x="1631" y="547"/>
                  </a:cubicBezTo>
                  <a:close/>
                  <a:moveTo>
                    <a:pt x="1711" y="583"/>
                  </a:moveTo>
                  <a:lnTo>
                    <a:pt x="1720" y="603"/>
                  </a:lnTo>
                  <a:cubicBezTo>
                    <a:pt x="1725" y="614"/>
                    <a:pt x="1720" y="628"/>
                    <a:pt x="1709" y="634"/>
                  </a:cubicBezTo>
                  <a:cubicBezTo>
                    <a:pt x="1697" y="639"/>
                    <a:pt x="1684" y="634"/>
                    <a:pt x="1678" y="623"/>
                  </a:cubicBezTo>
                  <a:lnTo>
                    <a:pt x="1669" y="603"/>
                  </a:lnTo>
                  <a:cubicBezTo>
                    <a:pt x="1663" y="592"/>
                    <a:pt x="1668" y="578"/>
                    <a:pt x="1680" y="572"/>
                  </a:cubicBezTo>
                  <a:cubicBezTo>
                    <a:pt x="1691" y="567"/>
                    <a:pt x="1705" y="572"/>
                    <a:pt x="1711" y="583"/>
                  </a:cubicBezTo>
                  <a:close/>
                  <a:moveTo>
                    <a:pt x="1779" y="728"/>
                  </a:moveTo>
                  <a:lnTo>
                    <a:pt x="1818" y="811"/>
                  </a:lnTo>
                  <a:cubicBezTo>
                    <a:pt x="1824" y="823"/>
                    <a:pt x="1819" y="836"/>
                    <a:pt x="1807" y="842"/>
                  </a:cubicBezTo>
                  <a:cubicBezTo>
                    <a:pt x="1796" y="847"/>
                    <a:pt x="1782" y="842"/>
                    <a:pt x="1777" y="831"/>
                  </a:cubicBezTo>
                  <a:lnTo>
                    <a:pt x="1737" y="748"/>
                  </a:lnTo>
                  <a:cubicBezTo>
                    <a:pt x="1732" y="736"/>
                    <a:pt x="1737" y="722"/>
                    <a:pt x="1748" y="717"/>
                  </a:cubicBezTo>
                  <a:cubicBezTo>
                    <a:pt x="1760" y="711"/>
                    <a:pt x="1773" y="716"/>
                    <a:pt x="1779" y="728"/>
                  </a:cubicBezTo>
                  <a:close/>
                  <a:moveTo>
                    <a:pt x="1875" y="940"/>
                  </a:moveTo>
                  <a:lnTo>
                    <a:pt x="1904" y="1027"/>
                  </a:lnTo>
                  <a:cubicBezTo>
                    <a:pt x="1908" y="1039"/>
                    <a:pt x="1902" y="1052"/>
                    <a:pt x="1890" y="1057"/>
                  </a:cubicBezTo>
                  <a:cubicBezTo>
                    <a:pt x="1878" y="1061"/>
                    <a:pt x="1865" y="1054"/>
                    <a:pt x="1861" y="1042"/>
                  </a:cubicBezTo>
                  <a:lnTo>
                    <a:pt x="1831" y="955"/>
                  </a:lnTo>
                  <a:cubicBezTo>
                    <a:pt x="1827" y="943"/>
                    <a:pt x="1834" y="930"/>
                    <a:pt x="1846" y="926"/>
                  </a:cubicBezTo>
                  <a:cubicBezTo>
                    <a:pt x="1858" y="921"/>
                    <a:pt x="1871" y="928"/>
                    <a:pt x="1875" y="940"/>
                  </a:cubicBezTo>
                  <a:close/>
                  <a:moveTo>
                    <a:pt x="1949" y="1158"/>
                  </a:moveTo>
                  <a:lnTo>
                    <a:pt x="1978" y="1246"/>
                  </a:lnTo>
                  <a:cubicBezTo>
                    <a:pt x="1982" y="1258"/>
                    <a:pt x="1976" y="1271"/>
                    <a:pt x="1964" y="1275"/>
                  </a:cubicBezTo>
                  <a:cubicBezTo>
                    <a:pt x="1951" y="1279"/>
                    <a:pt x="1938" y="1272"/>
                    <a:pt x="1934" y="1260"/>
                  </a:cubicBezTo>
                  <a:lnTo>
                    <a:pt x="1905" y="1173"/>
                  </a:lnTo>
                  <a:cubicBezTo>
                    <a:pt x="1901" y="1161"/>
                    <a:pt x="1907" y="1148"/>
                    <a:pt x="1919" y="1144"/>
                  </a:cubicBezTo>
                  <a:cubicBezTo>
                    <a:pt x="1931" y="1140"/>
                    <a:pt x="1944" y="1146"/>
                    <a:pt x="1949" y="1158"/>
                  </a:cubicBezTo>
                  <a:close/>
                  <a:moveTo>
                    <a:pt x="2021" y="1367"/>
                  </a:moveTo>
                  <a:lnTo>
                    <a:pt x="2082" y="1436"/>
                  </a:lnTo>
                  <a:cubicBezTo>
                    <a:pt x="2090" y="1446"/>
                    <a:pt x="2089" y="1461"/>
                    <a:pt x="2079" y="1469"/>
                  </a:cubicBezTo>
                  <a:cubicBezTo>
                    <a:pt x="2070" y="1477"/>
                    <a:pt x="2055" y="1476"/>
                    <a:pt x="2047" y="1467"/>
                  </a:cubicBezTo>
                  <a:lnTo>
                    <a:pt x="1986" y="1397"/>
                  </a:lnTo>
                  <a:cubicBezTo>
                    <a:pt x="1978" y="1387"/>
                    <a:pt x="1979" y="1373"/>
                    <a:pt x="1989" y="1365"/>
                  </a:cubicBezTo>
                  <a:cubicBezTo>
                    <a:pt x="1998" y="1356"/>
                    <a:pt x="2013" y="1357"/>
                    <a:pt x="2021" y="1367"/>
                  </a:cubicBezTo>
                  <a:close/>
                  <a:moveTo>
                    <a:pt x="2174" y="1547"/>
                  </a:moveTo>
                  <a:lnTo>
                    <a:pt x="2212" y="1631"/>
                  </a:lnTo>
                  <a:cubicBezTo>
                    <a:pt x="2217" y="1643"/>
                    <a:pt x="2212" y="1657"/>
                    <a:pt x="2201" y="1662"/>
                  </a:cubicBezTo>
                  <a:cubicBezTo>
                    <a:pt x="2189" y="1667"/>
                    <a:pt x="2175" y="1662"/>
                    <a:pt x="2170" y="1650"/>
                  </a:cubicBezTo>
                  <a:lnTo>
                    <a:pt x="2132" y="1566"/>
                  </a:lnTo>
                  <a:cubicBezTo>
                    <a:pt x="2127" y="1555"/>
                    <a:pt x="2132" y="1541"/>
                    <a:pt x="2144" y="1536"/>
                  </a:cubicBezTo>
                  <a:cubicBezTo>
                    <a:pt x="2155" y="1531"/>
                    <a:pt x="2169" y="1536"/>
                    <a:pt x="2174" y="1547"/>
                  </a:cubicBezTo>
                  <a:close/>
                  <a:moveTo>
                    <a:pt x="2269" y="1757"/>
                  </a:moveTo>
                  <a:lnTo>
                    <a:pt x="2307" y="1841"/>
                  </a:lnTo>
                  <a:cubicBezTo>
                    <a:pt x="2312" y="1853"/>
                    <a:pt x="2307" y="1867"/>
                    <a:pt x="2295" y="1872"/>
                  </a:cubicBezTo>
                  <a:cubicBezTo>
                    <a:pt x="2284" y="1877"/>
                    <a:pt x="2270" y="1872"/>
                    <a:pt x="2265" y="1860"/>
                  </a:cubicBezTo>
                  <a:lnTo>
                    <a:pt x="2227" y="1776"/>
                  </a:lnTo>
                  <a:cubicBezTo>
                    <a:pt x="2222" y="1765"/>
                    <a:pt x="2227" y="1751"/>
                    <a:pt x="2239" y="1746"/>
                  </a:cubicBezTo>
                  <a:cubicBezTo>
                    <a:pt x="2250" y="1741"/>
                    <a:pt x="2264" y="1746"/>
                    <a:pt x="2269" y="1757"/>
                  </a:cubicBezTo>
                  <a:close/>
                  <a:moveTo>
                    <a:pt x="2364" y="1967"/>
                  </a:moveTo>
                  <a:lnTo>
                    <a:pt x="2402" y="2051"/>
                  </a:lnTo>
                  <a:cubicBezTo>
                    <a:pt x="2407" y="2063"/>
                    <a:pt x="2402" y="2076"/>
                    <a:pt x="2391" y="2082"/>
                  </a:cubicBezTo>
                  <a:cubicBezTo>
                    <a:pt x="2379" y="2087"/>
                    <a:pt x="2366" y="2082"/>
                    <a:pt x="2360" y="2070"/>
                  </a:cubicBezTo>
                  <a:lnTo>
                    <a:pt x="2322" y="1986"/>
                  </a:lnTo>
                  <a:cubicBezTo>
                    <a:pt x="2317" y="1975"/>
                    <a:pt x="2322" y="1961"/>
                    <a:pt x="2334" y="1956"/>
                  </a:cubicBezTo>
                  <a:cubicBezTo>
                    <a:pt x="2345" y="1951"/>
                    <a:pt x="2359" y="1956"/>
                    <a:pt x="2364" y="1967"/>
                  </a:cubicBezTo>
                  <a:close/>
                  <a:moveTo>
                    <a:pt x="2459" y="2177"/>
                  </a:moveTo>
                  <a:lnTo>
                    <a:pt x="2479" y="2220"/>
                  </a:lnTo>
                  <a:cubicBezTo>
                    <a:pt x="2484" y="2231"/>
                    <a:pt x="2479" y="2245"/>
                    <a:pt x="2467" y="2250"/>
                  </a:cubicBezTo>
                  <a:cubicBezTo>
                    <a:pt x="2456" y="2255"/>
                    <a:pt x="2442" y="2250"/>
                    <a:pt x="2437" y="2239"/>
                  </a:cubicBezTo>
                  <a:lnTo>
                    <a:pt x="2417" y="2196"/>
                  </a:lnTo>
                  <a:cubicBezTo>
                    <a:pt x="2412" y="2185"/>
                    <a:pt x="2417" y="2171"/>
                    <a:pt x="2429" y="2166"/>
                  </a:cubicBezTo>
                  <a:cubicBezTo>
                    <a:pt x="2440" y="2160"/>
                    <a:pt x="2454" y="2165"/>
                    <a:pt x="2459" y="2177"/>
                  </a:cubicBezTo>
                  <a:close/>
                  <a:moveTo>
                    <a:pt x="2473" y="2212"/>
                  </a:moveTo>
                  <a:lnTo>
                    <a:pt x="2507" y="2243"/>
                  </a:lnTo>
                  <a:cubicBezTo>
                    <a:pt x="2516" y="2252"/>
                    <a:pt x="2517" y="2267"/>
                    <a:pt x="2508" y="2276"/>
                  </a:cubicBezTo>
                  <a:cubicBezTo>
                    <a:pt x="2499" y="2285"/>
                    <a:pt x="2485" y="2286"/>
                    <a:pt x="2475" y="2277"/>
                  </a:cubicBezTo>
                  <a:lnTo>
                    <a:pt x="2442" y="2246"/>
                  </a:lnTo>
                  <a:cubicBezTo>
                    <a:pt x="2433" y="2237"/>
                    <a:pt x="2432" y="2223"/>
                    <a:pt x="2441" y="2213"/>
                  </a:cubicBezTo>
                  <a:cubicBezTo>
                    <a:pt x="2450" y="2204"/>
                    <a:pt x="2464" y="2204"/>
                    <a:pt x="2473" y="2212"/>
                  </a:cubicBezTo>
                  <a:close/>
                  <a:moveTo>
                    <a:pt x="2608" y="2338"/>
                  </a:moveTo>
                  <a:lnTo>
                    <a:pt x="2627" y="2356"/>
                  </a:lnTo>
                  <a:cubicBezTo>
                    <a:pt x="2636" y="2364"/>
                    <a:pt x="2637" y="2379"/>
                    <a:pt x="2628" y="2388"/>
                  </a:cubicBezTo>
                  <a:cubicBezTo>
                    <a:pt x="2620" y="2397"/>
                    <a:pt x="2605" y="2398"/>
                    <a:pt x="2596" y="2389"/>
                  </a:cubicBezTo>
                  <a:lnTo>
                    <a:pt x="2576" y="2371"/>
                  </a:lnTo>
                  <a:cubicBezTo>
                    <a:pt x="2567" y="2363"/>
                    <a:pt x="2567" y="2348"/>
                    <a:pt x="2575" y="2339"/>
                  </a:cubicBezTo>
                  <a:cubicBezTo>
                    <a:pt x="2584" y="2329"/>
                    <a:pt x="2598" y="2329"/>
                    <a:pt x="2608" y="2338"/>
                  </a:cubicBezTo>
                  <a:close/>
                  <a:moveTo>
                    <a:pt x="2633" y="2364"/>
                  </a:moveTo>
                  <a:lnTo>
                    <a:pt x="2657" y="2425"/>
                  </a:lnTo>
                  <a:cubicBezTo>
                    <a:pt x="2662" y="2437"/>
                    <a:pt x="2656" y="2450"/>
                    <a:pt x="2644" y="2455"/>
                  </a:cubicBezTo>
                  <a:cubicBezTo>
                    <a:pt x="2632" y="2460"/>
                    <a:pt x="2619" y="2454"/>
                    <a:pt x="2614" y="2442"/>
                  </a:cubicBezTo>
                  <a:lnTo>
                    <a:pt x="2590" y="2381"/>
                  </a:lnTo>
                  <a:cubicBezTo>
                    <a:pt x="2585" y="2369"/>
                    <a:pt x="2591" y="2356"/>
                    <a:pt x="2603" y="2351"/>
                  </a:cubicBezTo>
                  <a:cubicBezTo>
                    <a:pt x="2615" y="2346"/>
                    <a:pt x="2628" y="2352"/>
                    <a:pt x="2633" y="2364"/>
                  </a:cubicBezTo>
                  <a:close/>
                  <a:moveTo>
                    <a:pt x="2708" y="2554"/>
                  </a:moveTo>
                  <a:lnTo>
                    <a:pt x="2742" y="2639"/>
                  </a:lnTo>
                  <a:cubicBezTo>
                    <a:pt x="2747" y="2651"/>
                    <a:pt x="2741" y="2664"/>
                    <a:pt x="2729" y="2669"/>
                  </a:cubicBezTo>
                  <a:cubicBezTo>
                    <a:pt x="2717" y="2674"/>
                    <a:pt x="2704" y="2668"/>
                    <a:pt x="2699" y="2656"/>
                  </a:cubicBezTo>
                  <a:lnTo>
                    <a:pt x="2665" y="2571"/>
                  </a:lnTo>
                  <a:cubicBezTo>
                    <a:pt x="2661" y="2559"/>
                    <a:pt x="2666" y="2545"/>
                    <a:pt x="2678" y="2541"/>
                  </a:cubicBezTo>
                  <a:cubicBezTo>
                    <a:pt x="2690" y="2536"/>
                    <a:pt x="2703" y="2542"/>
                    <a:pt x="2708" y="2554"/>
                  </a:cubicBezTo>
                  <a:close/>
                  <a:moveTo>
                    <a:pt x="2792" y="2746"/>
                  </a:moveTo>
                  <a:lnTo>
                    <a:pt x="2875" y="2786"/>
                  </a:lnTo>
                  <a:cubicBezTo>
                    <a:pt x="2886" y="2791"/>
                    <a:pt x="2891" y="2805"/>
                    <a:pt x="2886" y="2816"/>
                  </a:cubicBezTo>
                  <a:cubicBezTo>
                    <a:pt x="2880" y="2828"/>
                    <a:pt x="2866" y="2833"/>
                    <a:pt x="2855" y="2827"/>
                  </a:cubicBezTo>
                  <a:lnTo>
                    <a:pt x="2772" y="2788"/>
                  </a:lnTo>
                  <a:cubicBezTo>
                    <a:pt x="2760" y="2782"/>
                    <a:pt x="2755" y="2769"/>
                    <a:pt x="2761" y="2757"/>
                  </a:cubicBezTo>
                  <a:cubicBezTo>
                    <a:pt x="2766" y="2746"/>
                    <a:pt x="2780" y="2741"/>
                    <a:pt x="2792" y="2746"/>
                  </a:cubicBezTo>
                  <a:close/>
                  <a:moveTo>
                    <a:pt x="3000" y="2845"/>
                  </a:moveTo>
                  <a:lnTo>
                    <a:pt x="3082" y="2884"/>
                  </a:lnTo>
                  <a:cubicBezTo>
                    <a:pt x="3094" y="2890"/>
                    <a:pt x="3098" y="2903"/>
                    <a:pt x="3093" y="2915"/>
                  </a:cubicBezTo>
                  <a:cubicBezTo>
                    <a:pt x="3087" y="2926"/>
                    <a:pt x="3074" y="2931"/>
                    <a:pt x="3062" y="2926"/>
                  </a:cubicBezTo>
                  <a:lnTo>
                    <a:pt x="2980" y="2887"/>
                  </a:lnTo>
                  <a:cubicBezTo>
                    <a:pt x="2968" y="2881"/>
                    <a:pt x="2963" y="2867"/>
                    <a:pt x="2969" y="2856"/>
                  </a:cubicBezTo>
                  <a:cubicBezTo>
                    <a:pt x="2974" y="2844"/>
                    <a:pt x="2988" y="2839"/>
                    <a:pt x="3000" y="2845"/>
                  </a:cubicBezTo>
                  <a:close/>
                  <a:moveTo>
                    <a:pt x="3087" y="2887"/>
                  </a:moveTo>
                  <a:lnTo>
                    <a:pt x="3088" y="2888"/>
                  </a:lnTo>
                  <a:cubicBezTo>
                    <a:pt x="3097" y="2896"/>
                    <a:pt x="3099" y="2910"/>
                    <a:pt x="3091" y="2920"/>
                  </a:cubicBezTo>
                  <a:cubicBezTo>
                    <a:pt x="3082" y="2930"/>
                    <a:pt x="3068" y="2931"/>
                    <a:pt x="3058" y="2923"/>
                  </a:cubicBezTo>
                  <a:lnTo>
                    <a:pt x="3057" y="2923"/>
                  </a:lnTo>
                  <a:cubicBezTo>
                    <a:pt x="3048" y="2914"/>
                    <a:pt x="3046" y="2900"/>
                    <a:pt x="3054" y="2890"/>
                  </a:cubicBezTo>
                  <a:cubicBezTo>
                    <a:pt x="3063" y="2880"/>
                    <a:pt x="3077" y="2879"/>
                    <a:pt x="3087" y="2887"/>
                  </a:cubicBezTo>
                  <a:close/>
                  <a:moveTo>
                    <a:pt x="3194" y="2976"/>
                  </a:moveTo>
                  <a:lnTo>
                    <a:pt x="3240" y="3015"/>
                  </a:lnTo>
                  <a:cubicBezTo>
                    <a:pt x="3250" y="3023"/>
                    <a:pt x="3252" y="3038"/>
                    <a:pt x="3243" y="3048"/>
                  </a:cubicBezTo>
                  <a:cubicBezTo>
                    <a:pt x="3235" y="3057"/>
                    <a:pt x="3221" y="3059"/>
                    <a:pt x="3211" y="3051"/>
                  </a:cubicBezTo>
                  <a:lnTo>
                    <a:pt x="3164" y="3012"/>
                  </a:lnTo>
                  <a:cubicBezTo>
                    <a:pt x="3155" y="3004"/>
                    <a:pt x="3153" y="2989"/>
                    <a:pt x="3161" y="2979"/>
                  </a:cubicBezTo>
                  <a:cubicBezTo>
                    <a:pt x="3170" y="2969"/>
                    <a:pt x="3184" y="2968"/>
                    <a:pt x="3194" y="2976"/>
                  </a:cubicBezTo>
                  <a:close/>
                  <a:moveTo>
                    <a:pt x="3235" y="3012"/>
                  </a:moveTo>
                  <a:lnTo>
                    <a:pt x="3264" y="3024"/>
                  </a:lnTo>
                  <a:cubicBezTo>
                    <a:pt x="3275" y="3029"/>
                    <a:pt x="3281" y="3042"/>
                    <a:pt x="3276" y="3054"/>
                  </a:cubicBezTo>
                  <a:cubicBezTo>
                    <a:pt x="3271" y="3066"/>
                    <a:pt x="3258" y="3071"/>
                    <a:pt x="3246" y="3066"/>
                  </a:cubicBezTo>
                  <a:lnTo>
                    <a:pt x="3217" y="3054"/>
                  </a:lnTo>
                  <a:cubicBezTo>
                    <a:pt x="3205" y="3049"/>
                    <a:pt x="3200" y="3036"/>
                    <a:pt x="3204" y="3024"/>
                  </a:cubicBezTo>
                  <a:cubicBezTo>
                    <a:pt x="3209" y="3012"/>
                    <a:pt x="3223" y="3007"/>
                    <a:pt x="3235" y="3012"/>
                  </a:cubicBez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6" name="Freeform 218"/>
            <p:cNvSpPr>
              <a:spLocks noEditPoints="1"/>
            </p:cNvSpPr>
            <p:nvPr/>
          </p:nvSpPr>
          <p:spPr bwMode="auto">
            <a:xfrm>
              <a:off x="719612" y="3060700"/>
              <a:ext cx="1284288" cy="1208087"/>
            </a:xfrm>
            <a:custGeom>
              <a:avLst/>
              <a:gdLst>
                <a:gd name="T0" fmla="*/ 115 w 3311"/>
                <a:gd name="T1" fmla="*/ 25 h 3110"/>
                <a:gd name="T2" fmla="*/ 0 w 3311"/>
                <a:gd name="T3" fmla="*/ 2 h 3110"/>
                <a:gd name="T4" fmla="*/ 346 w 3311"/>
                <a:gd name="T5" fmla="*/ 25 h 3110"/>
                <a:gd name="T6" fmla="*/ 208 w 3311"/>
                <a:gd name="T7" fmla="*/ 25 h 3110"/>
                <a:gd name="T8" fmla="*/ 556 w 3311"/>
                <a:gd name="T9" fmla="*/ 23 h 3110"/>
                <a:gd name="T10" fmla="*/ 456 w 3311"/>
                <a:gd name="T11" fmla="*/ 47 h 3110"/>
                <a:gd name="T12" fmla="*/ 691 w 3311"/>
                <a:gd name="T13" fmla="*/ 55 h 3110"/>
                <a:gd name="T14" fmla="*/ 763 w 3311"/>
                <a:gd name="T15" fmla="*/ 119 h 3110"/>
                <a:gd name="T16" fmla="*/ 691 w 3311"/>
                <a:gd name="T17" fmla="*/ 55 h 3110"/>
                <a:gd name="T18" fmla="*/ 796 w 3311"/>
                <a:gd name="T19" fmla="*/ 109 h 3110"/>
                <a:gd name="T20" fmla="*/ 747 w 3311"/>
                <a:gd name="T21" fmla="*/ 87 h 3110"/>
                <a:gd name="T22" fmla="*/ 995 w 3311"/>
                <a:gd name="T23" fmla="*/ 171 h 3110"/>
                <a:gd name="T24" fmla="*/ 892 w 3311"/>
                <a:gd name="T25" fmla="*/ 176 h 3110"/>
                <a:gd name="T26" fmla="*/ 1119 w 3311"/>
                <a:gd name="T27" fmla="*/ 246 h 3110"/>
                <a:gd name="T28" fmla="*/ 1149 w 3311"/>
                <a:gd name="T29" fmla="*/ 344 h 3110"/>
                <a:gd name="T30" fmla="*/ 1119 w 3311"/>
                <a:gd name="T31" fmla="*/ 246 h 3110"/>
                <a:gd name="T32" fmla="*/ 1377 w 3311"/>
                <a:gd name="T33" fmla="*/ 460 h 3110"/>
                <a:gd name="T34" fmla="*/ 1250 w 3311"/>
                <a:gd name="T35" fmla="*/ 405 h 3110"/>
                <a:gd name="T36" fmla="*/ 1482 w 3311"/>
                <a:gd name="T37" fmla="*/ 639 h 3110"/>
                <a:gd name="T38" fmla="*/ 1403 w 3311"/>
                <a:gd name="T39" fmla="*/ 572 h 3110"/>
                <a:gd name="T40" fmla="*/ 1535 w 3311"/>
                <a:gd name="T41" fmla="*/ 766 h 3110"/>
                <a:gd name="T42" fmla="*/ 1515 w 3311"/>
                <a:gd name="T43" fmla="*/ 838 h 3110"/>
                <a:gd name="T44" fmla="*/ 1535 w 3311"/>
                <a:gd name="T45" fmla="*/ 766 h 3110"/>
                <a:gd name="T46" fmla="*/ 1562 w 3311"/>
                <a:gd name="T47" fmla="*/ 880 h 3110"/>
                <a:gd name="T48" fmla="*/ 1526 w 3311"/>
                <a:gd name="T49" fmla="*/ 808 h 3110"/>
                <a:gd name="T50" fmla="*/ 1677 w 3311"/>
                <a:gd name="T51" fmla="*/ 1054 h 3110"/>
                <a:gd name="T52" fmla="*/ 1594 w 3311"/>
                <a:gd name="T53" fmla="*/ 993 h 3110"/>
                <a:gd name="T54" fmla="*/ 1730 w 3311"/>
                <a:gd name="T55" fmla="*/ 1186 h 3110"/>
                <a:gd name="T56" fmla="*/ 1711 w 3311"/>
                <a:gd name="T57" fmla="*/ 1287 h 3110"/>
                <a:gd name="T58" fmla="*/ 1730 w 3311"/>
                <a:gd name="T59" fmla="*/ 1186 h 3110"/>
                <a:gd name="T60" fmla="*/ 1803 w 3311"/>
                <a:gd name="T61" fmla="*/ 1524 h 3110"/>
                <a:gd name="T62" fmla="*/ 1765 w 3311"/>
                <a:gd name="T63" fmla="*/ 1392 h 3110"/>
                <a:gd name="T64" fmla="*/ 1865 w 3311"/>
                <a:gd name="T65" fmla="*/ 1657 h 3110"/>
                <a:gd name="T66" fmla="*/ 1813 w 3311"/>
                <a:gd name="T67" fmla="*/ 1642 h 3110"/>
                <a:gd name="T68" fmla="*/ 1865 w 3311"/>
                <a:gd name="T69" fmla="*/ 1654 h 3110"/>
                <a:gd name="T70" fmla="*/ 1846 w 3311"/>
                <a:gd name="T71" fmla="*/ 1730 h 3110"/>
                <a:gd name="T72" fmla="*/ 1865 w 3311"/>
                <a:gd name="T73" fmla="*/ 1654 h 3110"/>
                <a:gd name="T74" fmla="*/ 1966 w 3311"/>
                <a:gd name="T75" fmla="*/ 1955 h 3110"/>
                <a:gd name="T76" fmla="*/ 1912 w 3311"/>
                <a:gd name="T77" fmla="*/ 1827 h 3110"/>
                <a:gd name="T78" fmla="*/ 2085 w 3311"/>
                <a:gd name="T79" fmla="*/ 2123 h 3110"/>
                <a:gd name="T80" fmla="*/ 1996 w 3311"/>
                <a:gd name="T81" fmla="*/ 2071 h 3110"/>
                <a:gd name="T82" fmla="*/ 2161 w 3311"/>
                <a:gd name="T83" fmla="*/ 2239 h 3110"/>
                <a:gd name="T84" fmla="*/ 2131 w 3311"/>
                <a:gd name="T85" fmla="*/ 2277 h 3110"/>
                <a:gd name="T86" fmla="*/ 2161 w 3311"/>
                <a:gd name="T87" fmla="*/ 2239 h 3110"/>
                <a:gd name="T88" fmla="*/ 2218 w 3311"/>
                <a:gd name="T89" fmla="*/ 2338 h 3110"/>
                <a:gd name="T90" fmla="*/ 2135 w 3311"/>
                <a:gd name="T91" fmla="*/ 2248 h 3110"/>
                <a:gd name="T92" fmla="*/ 2321 w 3311"/>
                <a:gd name="T93" fmla="*/ 2416 h 3110"/>
                <a:gd name="T94" fmla="*/ 2279 w 3311"/>
                <a:gd name="T95" fmla="*/ 2438 h 3110"/>
                <a:gd name="T96" fmla="*/ 2317 w 3311"/>
                <a:gd name="T97" fmla="*/ 2412 h 3110"/>
                <a:gd name="T98" fmla="*/ 2358 w 3311"/>
                <a:gd name="T99" fmla="*/ 2494 h 3110"/>
                <a:gd name="T100" fmla="*/ 2317 w 3311"/>
                <a:gd name="T101" fmla="*/ 2412 h 3110"/>
                <a:gd name="T102" fmla="*/ 2560 w 3311"/>
                <a:gd name="T103" fmla="*/ 2641 h 3110"/>
                <a:gd name="T104" fmla="*/ 2466 w 3311"/>
                <a:gd name="T105" fmla="*/ 2540 h 3110"/>
                <a:gd name="T106" fmla="*/ 2709 w 3311"/>
                <a:gd name="T107" fmla="*/ 2787 h 3110"/>
                <a:gd name="T108" fmla="*/ 2617 w 3311"/>
                <a:gd name="T109" fmla="*/ 2742 h 3110"/>
                <a:gd name="T110" fmla="*/ 2793 w 3311"/>
                <a:gd name="T111" fmla="*/ 2890 h 3110"/>
                <a:gd name="T112" fmla="*/ 2837 w 3311"/>
                <a:gd name="T113" fmla="*/ 2983 h 3110"/>
                <a:gd name="T114" fmla="*/ 2793 w 3311"/>
                <a:gd name="T115" fmla="*/ 2890 h 3110"/>
                <a:gd name="T116" fmla="*/ 3081 w 3311"/>
                <a:gd name="T117" fmla="*/ 3061 h 3110"/>
                <a:gd name="T118" fmla="*/ 2947 w 3311"/>
                <a:gd name="T119" fmla="*/ 3025 h 3110"/>
                <a:gd name="T120" fmla="*/ 3289 w 3311"/>
                <a:gd name="T121" fmla="*/ 3062 h 3110"/>
                <a:gd name="T122" fmla="*/ 3192 w 3311"/>
                <a:gd name="T123" fmla="*/ 3097 h 3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311" h="3110">
                  <a:moveTo>
                    <a:pt x="0" y="2"/>
                  </a:moveTo>
                  <a:lnTo>
                    <a:pt x="92" y="2"/>
                  </a:lnTo>
                  <a:cubicBezTo>
                    <a:pt x="105" y="2"/>
                    <a:pt x="115" y="12"/>
                    <a:pt x="115" y="25"/>
                  </a:cubicBezTo>
                  <a:cubicBezTo>
                    <a:pt x="115" y="38"/>
                    <a:pt x="105" y="48"/>
                    <a:pt x="92" y="48"/>
                  </a:cubicBezTo>
                  <a:lnTo>
                    <a:pt x="0" y="48"/>
                  </a:lnTo>
                  <a:lnTo>
                    <a:pt x="0" y="2"/>
                  </a:lnTo>
                  <a:close/>
                  <a:moveTo>
                    <a:pt x="231" y="2"/>
                  </a:moveTo>
                  <a:lnTo>
                    <a:pt x="323" y="2"/>
                  </a:lnTo>
                  <a:cubicBezTo>
                    <a:pt x="335" y="2"/>
                    <a:pt x="346" y="12"/>
                    <a:pt x="346" y="25"/>
                  </a:cubicBezTo>
                  <a:cubicBezTo>
                    <a:pt x="346" y="38"/>
                    <a:pt x="335" y="48"/>
                    <a:pt x="323" y="48"/>
                  </a:cubicBezTo>
                  <a:lnTo>
                    <a:pt x="231" y="48"/>
                  </a:lnTo>
                  <a:cubicBezTo>
                    <a:pt x="218" y="48"/>
                    <a:pt x="208" y="38"/>
                    <a:pt x="208" y="25"/>
                  </a:cubicBezTo>
                  <a:cubicBezTo>
                    <a:pt x="208" y="12"/>
                    <a:pt x="218" y="2"/>
                    <a:pt x="231" y="2"/>
                  </a:cubicBezTo>
                  <a:close/>
                  <a:moveTo>
                    <a:pt x="466" y="2"/>
                  </a:moveTo>
                  <a:lnTo>
                    <a:pt x="556" y="23"/>
                  </a:lnTo>
                  <a:cubicBezTo>
                    <a:pt x="568" y="26"/>
                    <a:pt x="576" y="39"/>
                    <a:pt x="573" y="51"/>
                  </a:cubicBezTo>
                  <a:cubicBezTo>
                    <a:pt x="570" y="63"/>
                    <a:pt x="558" y="71"/>
                    <a:pt x="545" y="68"/>
                  </a:cubicBezTo>
                  <a:lnTo>
                    <a:pt x="456" y="47"/>
                  </a:lnTo>
                  <a:cubicBezTo>
                    <a:pt x="443" y="44"/>
                    <a:pt x="436" y="32"/>
                    <a:pt x="439" y="20"/>
                  </a:cubicBezTo>
                  <a:cubicBezTo>
                    <a:pt x="441" y="7"/>
                    <a:pt x="454" y="0"/>
                    <a:pt x="466" y="2"/>
                  </a:cubicBezTo>
                  <a:close/>
                  <a:moveTo>
                    <a:pt x="691" y="55"/>
                  </a:moveTo>
                  <a:lnTo>
                    <a:pt x="773" y="74"/>
                  </a:lnTo>
                  <a:cubicBezTo>
                    <a:pt x="786" y="77"/>
                    <a:pt x="793" y="89"/>
                    <a:pt x="791" y="102"/>
                  </a:cubicBezTo>
                  <a:cubicBezTo>
                    <a:pt x="788" y="114"/>
                    <a:pt x="775" y="122"/>
                    <a:pt x="763" y="119"/>
                  </a:cubicBezTo>
                  <a:lnTo>
                    <a:pt x="680" y="100"/>
                  </a:lnTo>
                  <a:cubicBezTo>
                    <a:pt x="668" y="97"/>
                    <a:pt x="660" y="84"/>
                    <a:pt x="663" y="72"/>
                  </a:cubicBezTo>
                  <a:cubicBezTo>
                    <a:pt x="666" y="60"/>
                    <a:pt x="678" y="52"/>
                    <a:pt x="691" y="55"/>
                  </a:cubicBezTo>
                  <a:close/>
                  <a:moveTo>
                    <a:pt x="777" y="76"/>
                  </a:moveTo>
                  <a:lnTo>
                    <a:pt x="784" y="78"/>
                  </a:lnTo>
                  <a:cubicBezTo>
                    <a:pt x="796" y="84"/>
                    <a:pt x="801" y="97"/>
                    <a:pt x="796" y="109"/>
                  </a:cubicBezTo>
                  <a:cubicBezTo>
                    <a:pt x="791" y="120"/>
                    <a:pt x="777" y="126"/>
                    <a:pt x="765" y="121"/>
                  </a:cubicBezTo>
                  <a:lnTo>
                    <a:pt x="759" y="118"/>
                  </a:lnTo>
                  <a:cubicBezTo>
                    <a:pt x="747" y="113"/>
                    <a:pt x="742" y="99"/>
                    <a:pt x="747" y="87"/>
                  </a:cubicBezTo>
                  <a:cubicBezTo>
                    <a:pt x="752" y="76"/>
                    <a:pt x="766" y="70"/>
                    <a:pt x="777" y="76"/>
                  </a:cubicBezTo>
                  <a:close/>
                  <a:moveTo>
                    <a:pt x="910" y="134"/>
                  </a:moveTo>
                  <a:lnTo>
                    <a:pt x="995" y="171"/>
                  </a:lnTo>
                  <a:cubicBezTo>
                    <a:pt x="1006" y="177"/>
                    <a:pt x="1012" y="190"/>
                    <a:pt x="1006" y="202"/>
                  </a:cubicBezTo>
                  <a:cubicBezTo>
                    <a:pt x="1001" y="213"/>
                    <a:pt x="988" y="219"/>
                    <a:pt x="976" y="214"/>
                  </a:cubicBezTo>
                  <a:lnTo>
                    <a:pt x="892" y="176"/>
                  </a:lnTo>
                  <a:cubicBezTo>
                    <a:pt x="880" y="171"/>
                    <a:pt x="875" y="158"/>
                    <a:pt x="880" y="146"/>
                  </a:cubicBezTo>
                  <a:cubicBezTo>
                    <a:pt x="885" y="134"/>
                    <a:pt x="899" y="129"/>
                    <a:pt x="910" y="134"/>
                  </a:cubicBezTo>
                  <a:close/>
                  <a:moveTo>
                    <a:pt x="1119" y="246"/>
                  </a:moveTo>
                  <a:lnTo>
                    <a:pt x="1182" y="313"/>
                  </a:lnTo>
                  <a:cubicBezTo>
                    <a:pt x="1191" y="322"/>
                    <a:pt x="1191" y="337"/>
                    <a:pt x="1181" y="345"/>
                  </a:cubicBezTo>
                  <a:cubicBezTo>
                    <a:pt x="1172" y="354"/>
                    <a:pt x="1158" y="354"/>
                    <a:pt x="1149" y="344"/>
                  </a:cubicBezTo>
                  <a:lnTo>
                    <a:pt x="1086" y="277"/>
                  </a:lnTo>
                  <a:cubicBezTo>
                    <a:pt x="1077" y="268"/>
                    <a:pt x="1078" y="253"/>
                    <a:pt x="1087" y="245"/>
                  </a:cubicBezTo>
                  <a:cubicBezTo>
                    <a:pt x="1096" y="236"/>
                    <a:pt x="1111" y="236"/>
                    <a:pt x="1119" y="246"/>
                  </a:cubicBezTo>
                  <a:close/>
                  <a:moveTo>
                    <a:pt x="1280" y="393"/>
                  </a:moveTo>
                  <a:lnTo>
                    <a:pt x="1365" y="430"/>
                  </a:lnTo>
                  <a:cubicBezTo>
                    <a:pt x="1376" y="435"/>
                    <a:pt x="1382" y="448"/>
                    <a:pt x="1377" y="460"/>
                  </a:cubicBezTo>
                  <a:cubicBezTo>
                    <a:pt x="1372" y="472"/>
                    <a:pt x="1358" y="477"/>
                    <a:pt x="1346" y="472"/>
                  </a:cubicBezTo>
                  <a:lnTo>
                    <a:pt x="1262" y="435"/>
                  </a:lnTo>
                  <a:cubicBezTo>
                    <a:pt x="1250" y="430"/>
                    <a:pt x="1245" y="417"/>
                    <a:pt x="1250" y="405"/>
                  </a:cubicBezTo>
                  <a:cubicBezTo>
                    <a:pt x="1255" y="393"/>
                    <a:pt x="1268" y="388"/>
                    <a:pt x="1280" y="393"/>
                  </a:cubicBezTo>
                  <a:close/>
                  <a:moveTo>
                    <a:pt x="1446" y="554"/>
                  </a:moveTo>
                  <a:lnTo>
                    <a:pt x="1482" y="639"/>
                  </a:lnTo>
                  <a:cubicBezTo>
                    <a:pt x="1486" y="651"/>
                    <a:pt x="1481" y="664"/>
                    <a:pt x="1469" y="669"/>
                  </a:cubicBezTo>
                  <a:cubicBezTo>
                    <a:pt x="1457" y="674"/>
                    <a:pt x="1444" y="669"/>
                    <a:pt x="1439" y="657"/>
                  </a:cubicBezTo>
                  <a:lnTo>
                    <a:pt x="1403" y="572"/>
                  </a:lnTo>
                  <a:cubicBezTo>
                    <a:pt x="1398" y="560"/>
                    <a:pt x="1404" y="547"/>
                    <a:pt x="1416" y="542"/>
                  </a:cubicBezTo>
                  <a:cubicBezTo>
                    <a:pt x="1427" y="537"/>
                    <a:pt x="1441" y="542"/>
                    <a:pt x="1446" y="554"/>
                  </a:cubicBezTo>
                  <a:close/>
                  <a:moveTo>
                    <a:pt x="1535" y="766"/>
                  </a:moveTo>
                  <a:lnTo>
                    <a:pt x="1557" y="820"/>
                  </a:lnTo>
                  <a:cubicBezTo>
                    <a:pt x="1562" y="832"/>
                    <a:pt x="1557" y="845"/>
                    <a:pt x="1545" y="850"/>
                  </a:cubicBezTo>
                  <a:cubicBezTo>
                    <a:pt x="1533" y="855"/>
                    <a:pt x="1520" y="849"/>
                    <a:pt x="1515" y="838"/>
                  </a:cubicBezTo>
                  <a:lnTo>
                    <a:pt x="1493" y="784"/>
                  </a:lnTo>
                  <a:cubicBezTo>
                    <a:pt x="1488" y="773"/>
                    <a:pt x="1493" y="759"/>
                    <a:pt x="1505" y="754"/>
                  </a:cubicBezTo>
                  <a:cubicBezTo>
                    <a:pt x="1517" y="749"/>
                    <a:pt x="1530" y="755"/>
                    <a:pt x="1535" y="766"/>
                  </a:cubicBezTo>
                  <a:close/>
                  <a:moveTo>
                    <a:pt x="1557" y="818"/>
                  </a:moveTo>
                  <a:lnTo>
                    <a:pt x="1572" y="849"/>
                  </a:lnTo>
                  <a:cubicBezTo>
                    <a:pt x="1578" y="860"/>
                    <a:pt x="1573" y="874"/>
                    <a:pt x="1562" y="880"/>
                  </a:cubicBezTo>
                  <a:cubicBezTo>
                    <a:pt x="1551" y="886"/>
                    <a:pt x="1537" y="881"/>
                    <a:pt x="1531" y="870"/>
                  </a:cubicBezTo>
                  <a:lnTo>
                    <a:pt x="1516" y="839"/>
                  </a:lnTo>
                  <a:cubicBezTo>
                    <a:pt x="1510" y="828"/>
                    <a:pt x="1514" y="814"/>
                    <a:pt x="1526" y="808"/>
                  </a:cubicBezTo>
                  <a:cubicBezTo>
                    <a:pt x="1537" y="802"/>
                    <a:pt x="1551" y="807"/>
                    <a:pt x="1557" y="818"/>
                  </a:cubicBezTo>
                  <a:close/>
                  <a:moveTo>
                    <a:pt x="1635" y="972"/>
                  </a:moveTo>
                  <a:lnTo>
                    <a:pt x="1677" y="1054"/>
                  </a:lnTo>
                  <a:cubicBezTo>
                    <a:pt x="1682" y="1066"/>
                    <a:pt x="1678" y="1079"/>
                    <a:pt x="1667" y="1085"/>
                  </a:cubicBezTo>
                  <a:cubicBezTo>
                    <a:pt x="1655" y="1091"/>
                    <a:pt x="1641" y="1086"/>
                    <a:pt x="1636" y="1075"/>
                  </a:cubicBezTo>
                  <a:lnTo>
                    <a:pt x="1594" y="993"/>
                  </a:lnTo>
                  <a:cubicBezTo>
                    <a:pt x="1588" y="982"/>
                    <a:pt x="1593" y="968"/>
                    <a:pt x="1604" y="962"/>
                  </a:cubicBezTo>
                  <a:cubicBezTo>
                    <a:pt x="1615" y="956"/>
                    <a:pt x="1629" y="961"/>
                    <a:pt x="1635" y="972"/>
                  </a:cubicBezTo>
                  <a:close/>
                  <a:moveTo>
                    <a:pt x="1730" y="1186"/>
                  </a:moveTo>
                  <a:lnTo>
                    <a:pt x="1755" y="1275"/>
                  </a:lnTo>
                  <a:cubicBezTo>
                    <a:pt x="1759" y="1287"/>
                    <a:pt x="1752" y="1300"/>
                    <a:pt x="1739" y="1303"/>
                  </a:cubicBezTo>
                  <a:cubicBezTo>
                    <a:pt x="1727" y="1307"/>
                    <a:pt x="1714" y="1300"/>
                    <a:pt x="1711" y="1287"/>
                  </a:cubicBezTo>
                  <a:lnTo>
                    <a:pt x="1685" y="1199"/>
                  </a:lnTo>
                  <a:cubicBezTo>
                    <a:pt x="1682" y="1187"/>
                    <a:pt x="1689" y="1174"/>
                    <a:pt x="1701" y="1170"/>
                  </a:cubicBezTo>
                  <a:cubicBezTo>
                    <a:pt x="1713" y="1167"/>
                    <a:pt x="1726" y="1174"/>
                    <a:pt x="1730" y="1186"/>
                  </a:cubicBezTo>
                  <a:close/>
                  <a:moveTo>
                    <a:pt x="1793" y="1407"/>
                  </a:moveTo>
                  <a:lnTo>
                    <a:pt x="1819" y="1496"/>
                  </a:lnTo>
                  <a:cubicBezTo>
                    <a:pt x="1823" y="1508"/>
                    <a:pt x="1816" y="1521"/>
                    <a:pt x="1803" y="1524"/>
                  </a:cubicBezTo>
                  <a:cubicBezTo>
                    <a:pt x="1791" y="1528"/>
                    <a:pt x="1778" y="1521"/>
                    <a:pt x="1775" y="1509"/>
                  </a:cubicBezTo>
                  <a:lnTo>
                    <a:pt x="1749" y="1420"/>
                  </a:lnTo>
                  <a:cubicBezTo>
                    <a:pt x="1746" y="1408"/>
                    <a:pt x="1753" y="1395"/>
                    <a:pt x="1765" y="1392"/>
                  </a:cubicBezTo>
                  <a:cubicBezTo>
                    <a:pt x="1777" y="1388"/>
                    <a:pt x="1790" y="1395"/>
                    <a:pt x="1793" y="1407"/>
                  </a:cubicBezTo>
                  <a:close/>
                  <a:moveTo>
                    <a:pt x="1857" y="1629"/>
                  </a:moveTo>
                  <a:lnTo>
                    <a:pt x="1865" y="1657"/>
                  </a:lnTo>
                  <a:cubicBezTo>
                    <a:pt x="1869" y="1669"/>
                    <a:pt x="1862" y="1682"/>
                    <a:pt x="1850" y="1685"/>
                  </a:cubicBezTo>
                  <a:cubicBezTo>
                    <a:pt x="1838" y="1689"/>
                    <a:pt x="1825" y="1682"/>
                    <a:pt x="1821" y="1670"/>
                  </a:cubicBezTo>
                  <a:lnTo>
                    <a:pt x="1813" y="1642"/>
                  </a:lnTo>
                  <a:cubicBezTo>
                    <a:pt x="1810" y="1629"/>
                    <a:pt x="1817" y="1617"/>
                    <a:pt x="1829" y="1613"/>
                  </a:cubicBezTo>
                  <a:cubicBezTo>
                    <a:pt x="1841" y="1609"/>
                    <a:pt x="1854" y="1617"/>
                    <a:pt x="1857" y="1629"/>
                  </a:cubicBezTo>
                  <a:close/>
                  <a:moveTo>
                    <a:pt x="1865" y="1654"/>
                  </a:moveTo>
                  <a:lnTo>
                    <a:pt x="1889" y="1712"/>
                  </a:lnTo>
                  <a:cubicBezTo>
                    <a:pt x="1894" y="1724"/>
                    <a:pt x="1888" y="1738"/>
                    <a:pt x="1877" y="1742"/>
                  </a:cubicBezTo>
                  <a:cubicBezTo>
                    <a:pt x="1865" y="1747"/>
                    <a:pt x="1851" y="1742"/>
                    <a:pt x="1846" y="1730"/>
                  </a:cubicBezTo>
                  <a:lnTo>
                    <a:pt x="1822" y="1672"/>
                  </a:lnTo>
                  <a:cubicBezTo>
                    <a:pt x="1817" y="1660"/>
                    <a:pt x="1823" y="1647"/>
                    <a:pt x="1834" y="1642"/>
                  </a:cubicBezTo>
                  <a:cubicBezTo>
                    <a:pt x="1846" y="1637"/>
                    <a:pt x="1860" y="1643"/>
                    <a:pt x="1865" y="1654"/>
                  </a:cubicBezTo>
                  <a:close/>
                  <a:moveTo>
                    <a:pt x="1942" y="1840"/>
                  </a:moveTo>
                  <a:lnTo>
                    <a:pt x="1978" y="1925"/>
                  </a:lnTo>
                  <a:cubicBezTo>
                    <a:pt x="1983" y="1937"/>
                    <a:pt x="1977" y="1950"/>
                    <a:pt x="1966" y="1955"/>
                  </a:cubicBezTo>
                  <a:cubicBezTo>
                    <a:pt x="1954" y="1960"/>
                    <a:pt x="1940" y="1954"/>
                    <a:pt x="1936" y="1943"/>
                  </a:cubicBezTo>
                  <a:lnTo>
                    <a:pt x="1900" y="1858"/>
                  </a:lnTo>
                  <a:cubicBezTo>
                    <a:pt x="1895" y="1846"/>
                    <a:pt x="1900" y="1832"/>
                    <a:pt x="1912" y="1827"/>
                  </a:cubicBezTo>
                  <a:cubicBezTo>
                    <a:pt x="1924" y="1823"/>
                    <a:pt x="1937" y="1828"/>
                    <a:pt x="1942" y="1840"/>
                  </a:cubicBezTo>
                  <a:close/>
                  <a:moveTo>
                    <a:pt x="2035" y="2046"/>
                  </a:moveTo>
                  <a:lnTo>
                    <a:pt x="2085" y="2123"/>
                  </a:lnTo>
                  <a:cubicBezTo>
                    <a:pt x="2092" y="2134"/>
                    <a:pt x="2089" y="2148"/>
                    <a:pt x="2079" y="2155"/>
                  </a:cubicBezTo>
                  <a:cubicBezTo>
                    <a:pt x="2068" y="2162"/>
                    <a:pt x="2054" y="2159"/>
                    <a:pt x="2047" y="2148"/>
                  </a:cubicBezTo>
                  <a:lnTo>
                    <a:pt x="1996" y="2071"/>
                  </a:lnTo>
                  <a:cubicBezTo>
                    <a:pt x="1990" y="2060"/>
                    <a:pt x="1993" y="2046"/>
                    <a:pt x="2003" y="2039"/>
                  </a:cubicBezTo>
                  <a:cubicBezTo>
                    <a:pt x="2014" y="2032"/>
                    <a:pt x="2028" y="2035"/>
                    <a:pt x="2035" y="2046"/>
                  </a:cubicBezTo>
                  <a:close/>
                  <a:moveTo>
                    <a:pt x="2161" y="2239"/>
                  </a:moveTo>
                  <a:lnTo>
                    <a:pt x="2170" y="2252"/>
                  </a:lnTo>
                  <a:cubicBezTo>
                    <a:pt x="2177" y="2263"/>
                    <a:pt x="2174" y="2277"/>
                    <a:pt x="2163" y="2284"/>
                  </a:cubicBezTo>
                  <a:cubicBezTo>
                    <a:pt x="2152" y="2291"/>
                    <a:pt x="2138" y="2288"/>
                    <a:pt x="2131" y="2277"/>
                  </a:cubicBezTo>
                  <a:lnTo>
                    <a:pt x="2122" y="2264"/>
                  </a:lnTo>
                  <a:cubicBezTo>
                    <a:pt x="2115" y="2253"/>
                    <a:pt x="2118" y="2239"/>
                    <a:pt x="2129" y="2232"/>
                  </a:cubicBezTo>
                  <a:cubicBezTo>
                    <a:pt x="2140" y="2225"/>
                    <a:pt x="2154" y="2228"/>
                    <a:pt x="2161" y="2239"/>
                  </a:cubicBezTo>
                  <a:close/>
                  <a:moveTo>
                    <a:pt x="2167" y="2249"/>
                  </a:moveTo>
                  <a:lnTo>
                    <a:pt x="2219" y="2305"/>
                  </a:lnTo>
                  <a:cubicBezTo>
                    <a:pt x="2228" y="2314"/>
                    <a:pt x="2227" y="2329"/>
                    <a:pt x="2218" y="2338"/>
                  </a:cubicBezTo>
                  <a:cubicBezTo>
                    <a:pt x="2208" y="2346"/>
                    <a:pt x="2194" y="2346"/>
                    <a:pt x="2185" y="2336"/>
                  </a:cubicBezTo>
                  <a:lnTo>
                    <a:pt x="2134" y="2281"/>
                  </a:lnTo>
                  <a:cubicBezTo>
                    <a:pt x="2125" y="2271"/>
                    <a:pt x="2126" y="2257"/>
                    <a:pt x="2135" y="2248"/>
                  </a:cubicBezTo>
                  <a:cubicBezTo>
                    <a:pt x="2144" y="2239"/>
                    <a:pt x="2159" y="2240"/>
                    <a:pt x="2167" y="2249"/>
                  </a:cubicBezTo>
                  <a:close/>
                  <a:moveTo>
                    <a:pt x="2313" y="2407"/>
                  </a:moveTo>
                  <a:lnTo>
                    <a:pt x="2321" y="2416"/>
                  </a:lnTo>
                  <a:cubicBezTo>
                    <a:pt x="2330" y="2425"/>
                    <a:pt x="2329" y="2440"/>
                    <a:pt x="2320" y="2448"/>
                  </a:cubicBezTo>
                  <a:cubicBezTo>
                    <a:pt x="2310" y="2457"/>
                    <a:pt x="2296" y="2456"/>
                    <a:pt x="2287" y="2447"/>
                  </a:cubicBezTo>
                  <a:lnTo>
                    <a:pt x="2279" y="2438"/>
                  </a:lnTo>
                  <a:cubicBezTo>
                    <a:pt x="2270" y="2428"/>
                    <a:pt x="2271" y="2414"/>
                    <a:pt x="2280" y="2405"/>
                  </a:cubicBezTo>
                  <a:cubicBezTo>
                    <a:pt x="2289" y="2397"/>
                    <a:pt x="2304" y="2397"/>
                    <a:pt x="2313" y="2407"/>
                  </a:cubicBezTo>
                  <a:close/>
                  <a:moveTo>
                    <a:pt x="2317" y="2412"/>
                  </a:moveTo>
                  <a:lnTo>
                    <a:pt x="2384" y="2455"/>
                  </a:lnTo>
                  <a:cubicBezTo>
                    <a:pt x="2394" y="2462"/>
                    <a:pt x="2397" y="2477"/>
                    <a:pt x="2390" y="2487"/>
                  </a:cubicBezTo>
                  <a:cubicBezTo>
                    <a:pt x="2383" y="2498"/>
                    <a:pt x="2369" y="2501"/>
                    <a:pt x="2358" y="2494"/>
                  </a:cubicBezTo>
                  <a:lnTo>
                    <a:pt x="2292" y="2451"/>
                  </a:lnTo>
                  <a:cubicBezTo>
                    <a:pt x="2281" y="2444"/>
                    <a:pt x="2278" y="2429"/>
                    <a:pt x="2285" y="2419"/>
                  </a:cubicBezTo>
                  <a:cubicBezTo>
                    <a:pt x="2292" y="2408"/>
                    <a:pt x="2306" y="2405"/>
                    <a:pt x="2317" y="2412"/>
                  </a:cubicBezTo>
                  <a:close/>
                  <a:moveTo>
                    <a:pt x="2498" y="2541"/>
                  </a:moveTo>
                  <a:lnTo>
                    <a:pt x="2561" y="2609"/>
                  </a:lnTo>
                  <a:cubicBezTo>
                    <a:pt x="2569" y="2618"/>
                    <a:pt x="2569" y="2633"/>
                    <a:pt x="2560" y="2641"/>
                  </a:cubicBezTo>
                  <a:cubicBezTo>
                    <a:pt x="2550" y="2650"/>
                    <a:pt x="2536" y="2649"/>
                    <a:pt x="2527" y="2640"/>
                  </a:cubicBezTo>
                  <a:lnTo>
                    <a:pt x="2464" y="2572"/>
                  </a:lnTo>
                  <a:cubicBezTo>
                    <a:pt x="2456" y="2563"/>
                    <a:pt x="2456" y="2548"/>
                    <a:pt x="2466" y="2540"/>
                  </a:cubicBezTo>
                  <a:cubicBezTo>
                    <a:pt x="2475" y="2531"/>
                    <a:pt x="2490" y="2532"/>
                    <a:pt x="2498" y="2541"/>
                  </a:cubicBezTo>
                  <a:close/>
                  <a:moveTo>
                    <a:pt x="2653" y="2714"/>
                  </a:moveTo>
                  <a:lnTo>
                    <a:pt x="2709" y="2787"/>
                  </a:lnTo>
                  <a:cubicBezTo>
                    <a:pt x="2717" y="2797"/>
                    <a:pt x="2715" y="2812"/>
                    <a:pt x="2705" y="2820"/>
                  </a:cubicBezTo>
                  <a:cubicBezTo>
                    <a:pt x="2695" y="2827"/>
                    <a:pt x="2681" y="2825"/>
                    <a:pt x="2673" y="2815"/>
                  </a:cubicBezTo>
                  <a:lnTo>
                    <a:pt x="2617" y="2742"/>
                  </a:lnTo>
                  <a:cubicBezTo>
                    <a:pt x="2609" y="2732"/>
                    <a:pt x="2611" y="2718"/>
                    <a:pt x="2621" y="2710"/>
                  </a:cubicBezTo>
                  <a:cubicBezTo>
                    <a:pt x="2631" y="2702"/>
                    <a:pt x="2645" y="2704"/>
                    <a:pt x="2653" y="2714"/>
                  </a:cubicBezTo>
                  <a:close/>
                  <a:moveTo>
                    <a:pt x="2793" y="2890"/>
                  </a:moveTo>
                  <a:lnTo>
                    <a:pt x="2865" y="2947"/>
                  </a:lnTo>
                  <a:cubicBezTo>
                    <a:pt x="2875" y="2954"/>
                    <a:pt x="2877" y="2969"/>
                    <a:pt x="2869" y="2979"/>
                  </a:cubicBezTo>
                  <a:cubicBezTo>
                    <a:pt x="2861" y="2989"/>
                    <a:pt x="2847" y="2991"/>
                    <a:pt x="2837" y="2983"/>
                  </a:cubicBezTo>
                  <a:lnTo>
                    <a:pt x="2764" y="2926"/>
                  </a:lnTo>
                  <a:cubicBezTo>
                    <a:pt x="2754" y="2918"/>
                    <a:pt x="2753" y="2904"/>
                    <a:pt x="2760" y="2894"/>
                  </a:cubicBezTo>
                  <a:cubicBezTo>
                    <a:pt x="2768" y="2884"/>
                    <a:pt x="2783" y="2882"/>
                    <a:pt x="2793" y="2890"/>
                  </a:cubicBezTo>
                  <a:close/>
                  <a:moveTo>
                    <a:pt x="2975" y="3009"/>
                  </a:moveTo>
                  <a:lnTo>
                    <a:pt x="3064" y="3033"/>
                  </a:lnTo>
                  <a:cubicBezTo>
                    <a:pt x="3077" y="3036"/>
                    <a:pt x="3084" y="3048"/>
                    <a:pt x="3081" y="3061"/>
                  </a:cubicBezTo>
                  <a:cubicBezTo>
                    <a:pt x="3077" y="3073"/>
                    <a:pt x="3065" y="3080"/>
                    <a:pt x="3052" y="3077"/>
                  </a:cubicBezTo>
                  <a:lnTo>
                    <a:pt x="2963" y="3053"/>
                  </a:lnTo>
                  <a:cubicBezTo>
                    <a:pt x="2951" y="3050"/>
                    <a:pt x="2944" y="3037"/>
                    <a:pt x="2947" y="3025"/>
                  </a:cubicBezTo>
                  <a:cubicBezTo>
                    <a:pt x="2950" y="3013"/>
                    <a:pt x="2963" y="3006"/>
                    <a:pt x="2975" y="3009"/>
                  </a:cubicBezTo>
                  <a:close/>
                  <a:moveTo>
                    <a:pt x="3198" y="3051"/>
                  </a:moveTo>
                  <a:lnTo>
                    <a:pt x="3289" y="3062"/>
                  </a:lnTo>
                  <a:cubicBezTo>
                    <a:pt x="3302" y="3064"/>
                    <a:pt x="3311" y="3076"/>
                    <a:pt x="3309" y="3088"/>
                  </a:cubicBezTo>
                  <a:cubicBezTo>
                    <a:pt x="3308" y="3101"/>
                    <a:pt x="3296" y="3110"/>
                    <a:pt x="3284" y="3108"/>
                  </a:cubicBezTo>
                  <a:lnTo>
                    <a:pt x="3192" y="3097"/>
                  </a:lnTo>
                  <a:cubicBezTo>
                    <a:pt x="3180" y="3095"/>
                    <a:pt x="3171" y="3084"/>
                    <a:pt x="3172" y="3071"/>
                  </a:cubicBezTo>
                  <a:cubicBezTo>
                    <a:pt x="3174" y="3058"/>
                    <a:pt x="3185" y="3049"/>
                    <a:pt x="3198" y="3051"/>
                  </a:cubicBezTo>
                  <a:close/>
                </a:path>
              </a:pathLst>
            </a:custGeom>
            <a:solidFill>
              <a:srgbClr val="FF0000"/>
            </a:solidFill>
            <a:ln w="1588" cap="flat">
              <a:solidFill>
                <a:srgbClr val="FF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7" name="Rectangle 219"/>
            <p:cNvSpPr>
              <a:spLocks noChangeArrowheads="1"/>
            </p:cNvSpPr>
            <p:nvPr/>
          </p:nvSpPr>
          <p:spPr bwMode="auto">
            <a:xfrm>
              <a:off x="1834037" y="3012601"/>
              <a:ext cx="14747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8" name="Line 220"/>
            <p:cNvSpPr>
              <a:spLocks noChangeShapeType="1"/>
            </p:cNvSpPr>
            <p:nvPr/>
          </p:nvSpPr>
          <p:spPr bwMode="auto">
            <a:xfrm>
              <a:off x="1635599" y="3072926"/>
              <a:ext cx="127000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9" name="Rectangle 221"/>
            <p:cNvSpPr>
              <a:spLocks noChangeArrowheads="1"/>
            </p:cNvSpPr>
            <p:nvPr/>
          </p:nvSpPr>
          <p:spPr bwMode="auto">
            <a:xfrm>
              <a:off x="1834037" y="3168176"/>
              <a:ext cx="101951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;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isd-1(RNAi)</a:t>
              </a:r>
              <a:r>
                <a:rPr kumimoji="0" lang="en-US" altLang="el-GR" sz="9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EV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2" name="Line 224"/>
            <p:cNvSpPr>
              <a:spLocks noChangeShapeType="1"/>
            </p:cNvSpPr>
            <p:nvPr/>
          </p:nvSpPr>
          <p:spPr bwMode="auto">
            <a:xfrm>
              <a:off x="1635599" y="3225326"/>
              <a:ext cx="127000" cy="0"/>
            </a:xfrm>
            <a:prstGeom prst="line">
              <a:avLst/>
            </a:prstGeom>
            <a:noFill/>
            <a:ln w="17463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03" name="Rectangle 225"/>
            <p:cNvSpPr>
              <a:spLocks noChangeArrowheads="1"/>
            </p:cNvSpPr>
            <p:nvPr/>
          </p:nvSpPr>
          <p:spPr bwMode="auto">
            <a:xfrm>
              <a:off x="1834037" y="3315814"/>
              <a:ext cx="106439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;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nc-51(RNAi)</a:t>
              </a:r>
              <a:r>
                <a:rPr kumimoji="0" lang="en-US" altLang="el-GR" sz="9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EV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6" name="Freeform 228"/>
            <p:cNvSpPr>
              <a:spLocks noEditPoints="1"/>
            </p:cNvSpPr>
            <p:nvPr/>
          </p:nvSpPr>
          <p:spPr bwMode="auto">
            <a:xfrm>
              <a:off x="1635599" y="3365026"/>
              <a:ext cx="123825" cy="17462"/>
            </a:xfrm>
            <a:custGeom>
              <a:avLst/>
              <a:gdLst>
                <a:gd name="T0" fmla="*/ 0 w 323"/>
                <a:gd name="T1" fmla="*/ 0 h 46"/>
                <a:gd name="T2" fmla="*/ 93 w 323"/>
                <a:gd name="T3" fmla="*/ 0 h 46"/>
                <a:gd name="T4" fmla="*/ 116 w 323"/>
                <a:gd name="T5" fmla="*/ 23 h 46"/>
                <a:gd name="T6" fmla="*/ 93 w 323"/>
                <a:gd name="T7" fmla="*/ 46 h 46"/>
                <a:gd name="T8" fmla="*/ 0 w 323"/>
                <a:gd name="T9" fmla="*/ 46 h 46"/>
                <a:gd name="T10" fmla="*/ 0 w 323"/>
                <a:gd name="T11" fmla="*/ 0 h 46"/>
                <a:gd name="T12" fmla="*/ 231 w 323"/>
                <a:gd name="T13" fmla="*/ 0 h 46"/>
                <a:gd name="T14" fmla="*/ 323 w 323"/>
                <a:gd name="T15" fmla="*/ 0 h 46"/>
                <a:gd name="T16" fmla="*/ 323 w 323"/>
                <a:gd name="T17" fmla="*/ 46 h 46"/>
                <a:gd name="T18" fmla="*/ 231 w 323"/>
                <a:gd name="T19" fmla="*/ 46 h 46"/>
                <a:gd name="T20" fmla="*/ 208 w 323"/>
                <a:gd name="T21" fmla="*/ 23 h 46"/>
                <a:gd name="T22" fmla="*/ 231 w 323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3" h="46">
                  <a:moveTo>
                    <a:pt x="0" y="0"/>
                  </a:moveTo>
                  <a:lnTo>
                    <a:pt x="93" y="0"/>
                  </a:lnTo>
                  <a:cubicBezTo>
                    <a:pt x="105" y="0"/>
                    <a:pt x="116" y="10"/>
                    <a:pt x="116" y="23"/>
                  </a:cubicBezTo>
                  <a:cubicBezTo>
                    <a:pt x="116" y="35"/>
                    <a:pt x="105" y="46"/>
                    <a:pt x="93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1" y="0"/>
                  </a:moveTo>
                  <a:lnTo>
                    <a:pt x="323" y="0"/>
                  </a:lnTo>
                  <a:lnTo>
                    <a:pt x="323" y="46"/>
                  </a:lnTo>
                  <a:lnTo>
                    <a:pt x="231" y="46"/>
                  </a:lnTo>
                  <a:cubicBezTo>
                    <a:pt x="218" y="46"/>
                    <a:pt x="208" y="35"/>
                    <a:pt x="208" y="23"/>
                  </a:cubicBezTo>
                  <a:cubicBezTo>
                    <a:pt x="208" y="10"/>
                    <a:pt x="218" y="0"/>
                    <a:pt x="231" y="0"/>
                  </a:cubicBez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07" name="Rectangle 229"/>
            <p:cNvSpPr>
              <a:spLocks noChangeArrowheads="1"/>
            </p:cNvSpPr>
            <p:nvPr/>
          </p:nvSpPr>
          <p:spPr bwMode="auto">
            <a:xfrm>
              <a:off x="1834037" y="3465039"/>
              <a:ext cx="121828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;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nc-51</a:t>
              </a:r>
              <a:r>
                <a:rPr kumimoji="0" lang="en-US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;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isd-1(RNAi)</a:t>
              </a:r>
              <a:endParaRPr kumimoji="0" lang="el-GR" altLang="el-GR" sz="2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Freeform 233"/>
            <p:cNvSpPr>
              <a:spLocks noEditPoints="1"/>
            </p:cNvSpPr>
            <p:nvPr/>
          </p:nvSpPr>
          <p:spPr bwMode="auto">
            <a:xfrm>
              <a:off x="1635599" y="3514251"/>
              <a:ext cx="123825" cy="17462"/>
            </a:xfrm>
            <a:custGeom>
              <a:avLst/>
              <a:gdLst>
                <a:gd name="T0" fmla="*/ 0 w 323"/>
                <a:gd name="T1" fmla="*/ 0 h 46"/>
                <a:gd name="T2" fmla="*/ 93 w 323"/>
                <a:gd name="T3" fmla="*/ 0 h 46"/>
                <a:gd name="T4" fmla="*/ 116 w 323"/>
                <a:gd name="T5" fmla="*/ 23 h 46"/>
                <a:gd name="T6" fmla="*/ 93 w 323"/>
                <a:gd name="T7" fmla="*/ 46 h 46"/>
                <a:gd name="T8" fmla="*/ 0 w 323"/>
                <a:gd name="T9" fmla="*/ 46 h 46"/>
                <a:gd name="T10" fmla="*/ 0 w 323"/>
                <a:gd name="T11" fmla="*/ 0 h 46"/>
                <a:gd name="T12" fmla="*/ 231 w 323"/>
                <a:gd name="T13" fmla="*/ 0 h 46"/>
                <a:gd name="T14" fmla="*/ 323 w 323"/>
                <a:gd name="T15" fmla="*/ 0 h 46"/>
                <a:gd name="T16" fmla="*/ 323 w 323"/>
                <a:gd name="T17" fmla="*/ 46 h 46"/>
                <a:gd name="T18" fmla="*/ 231 w 323"/>
                <a:gd name="T19" fmla="*/ 46 h 46"/>
                <a:gd name="T20" fmla="*/ 208 w 323"/>
                <a:gd name="T21" fmla="*/ 23 h 46"/>
                <a:gd name="T22" fmla="*/ 231 w 323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3" h="46">
                  <a:moveTo>
                    <a:pt x="0" y="0"/>
                  </a:moveTo>
                  <a:lnTo>
                    <a:pt x="93" y="0"/>
                  </a:lnTo>
                  <a:cubicBezTo>
                    <a:pt x="105" y="0"/>
                    <a:pt x="116" y="10"/>
                    <a:pt x="116" y="23"/>
                  </a:cubicBezTo>
                  <a:cubicBezTo>
                    <a:pt x="116" y="35"/>
                    <a:pt x="105" y="46"/>
                    <a:pt x="93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1" y="0"/>
                  </a:moveTo>
                  <a:lnTo>
                    <a:pt x="323" y="0"/>
                  </a:lnTo>
                  <a:lnTo>
                    <a:pt x="323" y="46"/>
                  </a:lnTo>
                  <a:lnTo>
                    <a:pt x="231" y="46"/>
                  </a:lnTo>
                  <a:cubicBezTo>
                    <a:pt x="218" y="46"/>
                    <a:pt x="208" y="35"/>
                    <a:pt x="208" y="23"/>
                  </a:cubicBezTo>
                  <a:cubicBezTo>
                    <a:pt x="208" y="10"/>
                    <a:pt x="218" y="0"/>
                    <a:pt x="231" y="0"/>
                  </a:cubicBezTo>
                  <a:close/>
                </a:path>
              </a:pathLst>
            </a:custGeom>
            <a:solidFill>
              <a:srgbClr val="FF0000"/>
            </a:solidFill>
            <a:ln w="1588" cap="flat">
              <a:solidFill>
                <a:srgbClr val="FF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12" name="Rectangle 234"/>
            <p:cNvSpPr>
              <a:spLocks noChangeArrowheads="1"/>
            </p:cNvSpPr>
            <p:nvPr/>
          </p:nvSpPr>
          <p:spPr bwMode="auto">
            <a:xfrm>
              <a:off x="1113312" y="4438650"/>
              <a:ext cx="1136650" cy="169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r>
                <a:rPr kumimoji="0" lang="el-GR" altLang="el-G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f </a:t>
              </a: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dulthood</a:t>
              </a:r>
              <a:endParaRPr kumimoji="0" lang="el-GR" altLang="el-GR" sz="2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5" name="TextBox 214"/>
            <p:cNvSpPr txBox="1"/>
            <p:nvPr/>
          </p:nvSpPr>
          <p:spPr>
            <a:xfrm rot="16200000">
              <a:off x="-185642" y="3506976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9" name="Group 241"/>
            <p:cNvGrpSpPr>
              <a:grpSpLocks noChangeAspect="1"/>
            </p:cNvGrpSpPr>
            <p:nvPr/>
          </p:nvGrpSpPr>
          <p:grpSpPr bwMode="auto">
            <a:xfrm>
              <a:off x="3468725" y="2898088"/>
              <a:ext cx="2666998" cy="1765303"/>
              <a:chOff x="1847" y="2054"/>
              <a:chExt cx="1680" cy="1112"/>
            </a:xfrm>
          </p:grpSpPr>
          <p:sp>
            <p:nvSpPr>
              <p:cNvPr id="220" name="AutoShape 240"/>
              <p:cNvSpPr>
                <a:spLocks noChangeAspect="1" noChangeArrowheads="1" noTextEdit="1"/>
              </p:cNvSpPr>
              <p:nvPr/>
            </p:nvSpPr>
            <p:spPr bwMode="auto">
              <a:xfrm>
                <a:off x="1847" y="2054"/>
                <a:ext cx="1641" cy="1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1" name="Rectangle 242"/>
              <p:cNvSpPr>
                <a:spLocks noChangeArrowheads="1"/>
              </p:cNvSpPr>
              <p:nvPr/>
            </p:nvSpPr>
            <p:spPr bwMode="auto">
              <a:xfrm>
                <a:off x="2019" y="2947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2" name="Rectangle 243"/>
              <p:cNvSpPr>
                <a:spLocks noChangeArrowheads="1"/>
              </p:cNvSpPr>
              <p:nvPr/>
            </p:nvSpPr>
            <p:spPr bwMode="auto">
              <a:xfrm>
                <a:off x="2206" y="2947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3" name="Rectangle 244"/>
              <p:cNvSpPr>
                <a:spLocks noChangeArrowheads="1"/>
              </p:cNvSpPr>
              <p:nvPr/>
            </p:nvSpPr>
            <p:spPr bwMode="auto">
              <a:xfrm>
                <a:off x="2378" y="2947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4" name="Rectangle 245"/>
              <p:cNvSpPr>
                <a:spLocks noChangeArrowheads="1"/>
              </p:cNvSpPr>
              <p:nvPr/>
            </p:nvSpPr>
            <p:spPr bwMode="auto">
              <a:xfrm>
                <a:off x="2566" y="2947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5" name="Rectangle 246"/>
              <p:cNvSpPr>
                <a:spLocks noChangeArrowheads="1"/>
              </p:cNvSpPr>
              <p:nvPr/>
            </p:nvSpPr>
            <p:spPr bwMode="auto">
              <a:xfrm>
                <a:off x="2754" y="2947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6" name="Rectangle 247"/>
              <p:cNvSpPr>
                <a:spLocks noChangeArrowheads="1"/>
              </p:cNvSpPr>
              <p:nvPr/>
            </p:nvSpPr>
            <p:spPr bwMode="auto">
              <a:xfrm>
                <a:off x="2941" y="2947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7" name="Rectangle 248"/>
              <p:cNvSpPr>
                <a:spLocks noChangeArrowheads="1"/>
              </p:cNvSpPr>
              <p:nvPr/>
            </p:nvSpPr>
            <p:spPr bwMode="auto">
              <a:xfrm>
                <a:off x="3129" y="2947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8" name="Freeform 249"/>
              <p:cNvSpPr>
                <a:spLocks noEditPoints="1"/>
              </p:cNvSpPr>
              <p:nvPr/>
            </p:nvSpPr>
            <p:spPr bwMode="auto">
              <a:xfrm>
                <a:off x="2033" y="2916"/>
                <a:ext cx="1133" cy="22"/>
              </a:xfrm>
              <a:custGeom>
                <a:avLst/>
                <a:gdLst>
                  <a:gd name="T0" fmla="*/ 0 w 1133"/>
                  <a:gd name="T1" fmla="*/ 0 h 22"/>
                  <a:gd name="T2" fmla="*/ 1133 w 1133"/>
                  <a:gd name="T3" fmla="*/ 0 h 22"/>
                  <a:gd name="T4" fmla="*/ 4 w 1133"/>
                  <a:gd name="T5" fmla="*/ 0 h 22"/>
                  <a:gd name="T6" fmla="*/ 4 w 1133"/>
                  <a:gd name="T7" fmla="*/ 22 h 22"/>
                  <a:gd name="T8" fmla="*/ 191 w 1133"/>
                  <a:gd name="T9" fmla="*/ 0 h 22"/>
                  <a:gd name="T10" fmla="*/ 191 w 1133"/>
                  <a:gd name="T11" fmla="*/ 22 h 22"/>
                  <a:gd name="T12" fmla="*/ 379 w 1133"/>
                  <a:gd name="T13" fmla="*/ 0 h 22"/>
                  <a:gd name="T14" fmla="*/ 379 w 1133"/>
                  <a:gd name="T15" fmla="*/ 22 h 22"/>
                  <a:gd name="T16" fmla="*/ 566 w 1133"/>
                  <a:gd name="T17" fmla="*/ 0 h 22"/>
                  <a:gd name="T18" fmla="*/ 566 w 1133"/>
                  <a:gd name="T19" fmla="*/ 22 h 22"/>
                  <a:gd name="T20" fmla="*/ 754 w 1133"/>
                  <a:gd name="T21" fmla="*/ 0 h 22"/>
                  <a:gd name="T22" fmla="*/ 754 w 1133"/>
                  <a:gd name="T23" fmla="*/ 22 h 22"/>
                  <a:gd name="T24" fmla="*/ 941 w 1133"/>
                  <a:gd name="T25" fmla="*/ 0 h 22"/>
                  <a:gd name="T26" fmla="*/ 941 w 1133"/>
                  <a:gd name="T27" fmla="*/ 22 h 22"/>
                  <a:gd name="T28" fmla="*/ 1129 w 1133"/>
                  <a:gd name="T29" fmla="*/ 0 h 22"/>
                  <a:gd name="T30" fmla="*/ 1129 w 1133"/>
                  <a:gd name="T31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1133" h="22">
                    <a:moveTo>
                      <a:pt x="0" y="0"/>
                    </a:moveTo>
                    <a:lnTo>
                      <a:pt x="1133" y="0"/>
                    </a:lnTo>
                    <a:moveTo>
                      <a:pt x="4" y="0"/>
                    </a:moveTo>
                    <a:lnTo>
                      <a:pt x="4" y="22"/>
                    </a:lnTo>
                    <a:moveTo>
                      <a:pt x="191" y="0"/>
                    </a:moveTo>
                    <a:lnTo>
                      <a:pt x="191" y="22"/>
                    </a:lnTo>
                    <a:moveTo>
                      <a:pt x="379" y="0"/>
                    </a:moveTo>
                    <a:lnTo>
                      <a:pt x="379" y="22"/>
                    </a:lnTo>
                    <a:moveTo>
                      <a:pt x="566" y="0"/>
                    </a:moveTo>
                    <a:lnTo>
                      <a:pt x="566" y="22"/>
                    </a:lnTo>
                    <a:moveTo>
                      <a:pt x="754" y="0"/>
                    </a:moveTo>
                    <a:lnTo>
                      <a:pt x="754" y="22"/>
                    </a:lnTo>
                    <a:moveTo>
                      <a:pt x="941" y="0"/>
                    </a:moveTo>
                    <a:lnTo>
                      <a:pt x="941" y="22"/>
                    </a:lnTo>
                    <a:moveTo>
                      <a:pt x="1129" y="0"/>
                    </a:moveTo>
                    <a:lnTo>
                      <a:pt x="1129" y="22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9" name="Rectangle 250"/>
              <p:cNvSpPr>
                <a:spLocks noChangeArrowheads="1"/>
              </p:cNvSpPr>
              <p:nvPr/>
            </p:nvSpPr>
            <p:spPr bwMode="auto">
              <a:xfrm>
                <a:off x="1972" y="2881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0" name="Rectangle 251"/>
              <p:cNvSpPr>
                <a:spLocks noChangeArrowheads="1"/>
              </p:cNvSpPr>
              <p:nvPr/>
            </p:nvSpPr>
            <p:spPr bwMode="auto">
              <a:xfrm>
                <a:off x="1937" y="2728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1" name="Rectangle 252"/>
              <p:cNvSpPr>
                <a:spLocks noChangeArrowheads="1"/>
              </p:cNvSpPr>
              <p:nvPr/>
            </p:nvSpPr>
            <p:spPr bwMode="auto">
              <a:xfrm>
                <a:off x="1937" y="2579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2" name="Rectangle 253"/>
              <p:cNvSpPr>
                <a:spLocks noChangeArrowheads="1"/>
              </p:cNvSpPr>
              <p:nvPr/>
            </p:nvSpPr>
            <p:spPr bwMode="auto">
              <a:xfrm>
                <a:off x="1937" y="2430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Rectangle 254"/>
              <p:cNvSpPr>
                <a:spLocks noChangeArrowheads="1"/>
              </p:cNvSpPr>
              <p:nvPr/>
            </p:nvSpPr>
            <p:spPr bwMode="auto">
              <a:xfrm>
                <a:off x="1937" y="2277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l-GR" altLang="el-GR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4" name="Rectangle 255"/>
              <p:cNvSpPr>
                <a:spLocks noChangeArrowheads="1"/>
              </p:cNvSpPr>
              <p:nvPr/>
            </p:nvSpPr>
            <p:spPr bwMode="auto">
              <a:xfrm>
                <a:off x="1902" y="2128"/>
                <a:ext cx="10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l-GR" altLang="el-GR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5" name="Freeform 256"/>
              <p:cNvSpPr>
                <a:spLocks noEditPoints="1"/>
              </p:cNvSpPr>
              <p:nvPr/>
            </p:nvSpPr>
            <p:spPr bwMode="auto">
              <a:xfrm>
                <a:off x="2014" y="2160"/>
                <a:ext cx="23" cy="759"/>
              </a:xfrm>
              <a:custGeom>
                <a:avLst/>
                <a:gdLst>
                  <a:gd name="T0" fmla="*/ 23 w 23"/>
                  <a:gd name="T1" fmla="*/ 759 h 759"/>
                  <a:gd name="T2" fmla="*/ 23 w 23"/>
                  <a:gd name="T3" fmla="*/ 0 h 759"/>
                  <a:gd name="T4" fmla="*/ 23 w 23"/>
                  <a:gd name="T5" fmla="*/ 756 h 759"/>
                  <a:gd name="T6" fmla="*/ 0 w 23"/>
                  <a:gd name="T7" fmla="*/ 756 h 759"/>
                  <a:gd name="T8" fmla="*/ 23 w 23"/>
                  <a:gd name="T9" fmla="*/ 605 h 759"/>
                  <a:gd name="T10" fmla="*/ 0 w 23"/>
                  <a:gd name="T11" fmla="*/ 605 h 759"/>
                  <a:gd name="T12" fmla="*/ 23 w 23"/>
                  <a:gd name="T13" fmla="*/ 455 h 759"/>
                  <a:gd name="T14" fmla="*/ 0 w 23"/>
                  <a:gd name="T15" fmla="*/ 455 h 759"/>
                  <a:gd name="T16" fmla="*/ 23 w 23"/>
                  <a:gd name="T17" fmla="*/ 304 h 759"/>
                  <a:gd name="T18" fmla="*/ 0 w 23"/>
                  <a:gd name="T19" fmla="*/ 304 h 759"/>
                  <a:gd name="T20" fmla="*/ 23 w 23"/>
                  <a:gd name="T21" fmla="*/ 154 h 759"/>
                  <a:gd name="T22" fmla="*/ 0 w 23"/>
                  <a:gd name="T23" fmla="*/ 154 h 759"/>
                  <a:gd name="T24" fmla="*/ 23 w 23"/>
                  <a:gd name="T25" fmla="*/ 3 h 759"/>
                  <a:gd name="T26" fmla="*/ 0 w 23"/>
                  <a:gd name="T27" fmla="*/ 3 h 7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23" h="759">
                    <a:moveTo>
                      <a:pt x="23" y="759"/>
                    </a:moveTo>
                    <a:lnTo>
                      <a:pt x="23" y="0"/>
                    </a:lnTo>
                    <a:moveTo>
                      <a:pt x="23" y="756"/>
                    </a:moveTo>
                    <a:lnTo>
                      <a:pt x="0" y="756"/>
                    </a:lnTo>
                    <a:moveTo>
                      <a:pt x="23" y="605"/>
                    </a:moveTo>
                    <a:lnTo>
                      <a:pt x="0" y="605"/>
                    </a:lnTo>
                    <a:moveTo>
                      <a:pt x="23" y="455"/>
                    </a:moveTo>
                    <a:lnTo>
                      <a:pt x="0" y="455"/>
                    </a:lnTo>
                    <a:moveTo>
                      <a:pt x="23" y="304"/>
                    </a:moveTo>
                    <a:lnTo>
                      <a:pt x="0" y="304"/>
                    </a:lnTo>
                    <a:moveTo>
                      <a:pt x="23" y="154"/>
                    </a:moveTo>
                    <a:lnTo>
                      <a:pt x="0" y="154"/>
                    </a:lnTo>
                    <a:moveTo>
                      <a:pt x="23" y="3"/>
                    </a:moveTo>
                    <a:lnTo>
                      <a:pt x="0" y="3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6" name="Freeform 257"/>
              <p:cNvSpPr>
                <a:spLocks/>
              </p:cNvSpPr>
              <p:nvPr/>
            </p:nvSpPr>
            <p:spPr bwMode="auto">
              <a:xfrm>
                <a:off x="2037" y="2163"/>
                <a:ext cx="975" cy="753"/>
              </a:xfrm>
              <a:custGeom>
                <a:avLst/>
                <a:gdLst>
                  <a:gd name="T0" fmla="*/ 0 w 975"/>
                  <a:gd name="T1" fmla="*/ 0 h 753"/>
                  <a:gd name="T2" fmla="*/ 0 w 975"/>
                  <a:gd name="T3" fmla="*/ 0 h 753"/>
                  <a:gd name="T4" fmla="*/ 0 w 975"/>
                  <a:gd name="T5" fmla="*/ 0 h 753"/>
                  <a:gd name="T6" fmla="*/ 112 w 975"/>
                  <a:gd name="T7" fmla="*/ 0 h 753"/>
                  <a:gd name="T8" fmla="*/ 112 w 975"/>
                  <a:gd name="T9" fmla="*/ 0 h 753"/>
                  <a:gd name="T10" fmla="*/ 187 w 975"/>
                  <a:gd name="T11" fmla="*/ 0 h 753"/>
                  <a:gd name="T12" fmla="*/ 187 w 975"/>
                  <a:gd name="T13" fmla="*/ 0 h 753"/>
                  <a:gd name="T14" fmla="*/ 262 w 975"/>
                  <a:gd name="T15" fmla="*/ 0 h 753"/>
                  <a:gd name="T16" fmla="*/ 262 w 975"/>
                  <a:gd name="T17" fmla="*/ 0 h 753"/>
                  <a:gd name="T18" fmla="*/ 300 w 975"/>
                  <a:gd name="T19" fmla="*/ 7 h 753"/>
                  <a:gd name="T20" fmla="*/ 300 w 975"/>
                  <a:gd name="T21" fmla="*/ 7 h 753"/>
                  <a:gd name="T22" fmla="*/ 337 w 975"/>
                  <a:gd name="T23" fmla="*/ 18 h 753"/>
                  <a:gd name="T24" fmla="*/ 337 w 975"/>
                  <a:gd name="T25" fmla="*/ 18 h 753"/>
                  <a:gd name="T26" fmla="*/ 375 w 975"/>
                  <a:gd name="T27" fmla="*/ 41 h 753"/>
                  <a:gd name="T28" fmla="*/ 375 w 975"/>
                  <a:gd name="T29" fmla="*/ 41 h 753"/>
                  <a:gd name="T30" fmla="*/ 412 w 975"/>
                  <a:gd name="T31" fmla="*/ 76 h 753"/>
                  <a:gd name="T32" fmla="*/ 412 w 975"/>
                  <a:gd name="T33" fmla="*/ 76 h 753"/>
                  <a:gd name="T34" fmla="*/ 450 w 975"/>
                  <a:gd name="T35" fmla="*/ 131 h 753"/>
                  <a:gd name="T36" fmla="*/ 450 w 975"/>
                  <a:gd name="T37" fmla="*/ 131 h 753"/>
                  <a:gd name="T38" fmla="*/ 487 w 975"/>
                  <a:gd name="T39" fmla="*/ 204 h 753"/>
                  <a:gd name="T40" fmla="*/ 487 w 975"/>
                  <a:gd name="T41" fmla="*/ 204 h 753"/>
                  <a:gd name="T42" fmla="*/ 525 w 975"/>
                  <a:gd name="T43" fmla="*/ 249 h 753"/>
                  <a:gd name="T44" fmla="*/ 525 w 975"/>
                  <a:gd name="T45" fmla="*/ 249 h 753"/>
                  <a:gd name="T46" fmla="*/ 562 w 975"/>
                  <a:gd name="T47" fmla="*/ 309 h 753"/>
                  <a:gd name="T48" fmla="*/ 562 w 975"/>
                  <a:gd name="T49" fmla="*/ 309 h 753"/>
                  <a:gd name="T50" fmla="*/ 600 w 975"/>
                  <a:gd name="T51" fmla="*/ 354 h 753"/>
                  <a:gd name="T52" fmla="*/ 600 w 975"/>
                  <a:gd name="T53" fmla="*/ 354 h 753"/>
                  <a:gd name="T54" fmla="*/ 637 w 975"/>
                  <a:gd name="T55" fmla="*/ 391 h 753"/>
                  <a:gd name="T56" fmla="*/ 637 w 975"/>
                  <a:gd name="T57" fmla="*/ 391 h 753"/>
                  <a:gd name="T58" fmla="*/ 675 w 975"/>
                  <a:gd name="T59" fmla="*/ 444 h 753"/>
                  <a:gd name="T60" fmla="*/ 675 w 975"/>
                  <a:gd name="T61" fmla="*/ 444 h 753"/>
                  <a:gd name="T62" fmla="*/ 712 w 975"/>
                  <a:gd name="T63" fmla="*/ 531 h 753"/>
                  <a:gd name="T64" fmla="*/ 712 w 975"/>
                  <a:gd name="T65" fmla="*/ 531 h 753"/>
                  <a:gd name="T66" fmla="*/ 750 w 975"/>
                  <a:gd name="T67" fmla="*/ 610 h 753"/>
                  <a:gd name="T68" fmla="*/ 750 w 975"/>
                  <a:gd name="T69" fmla="*/ 610 h 753"/>
                  <a:gd name="T70" fmla="*/ 787 w 975"/>
                  <a:gd name="T71" fmla="*/ 690 h 753"/>
                  <a:gd name="T72" fmla="*/ 787 w 975"/>
                  <a:gd name="T73" fmla="*/ 690 h 753"/>
                  <a:gd name="T74" fmla="*/ 825 w 975"/>
                  <a:gd name="T75" fmla="*/ 708 h 753"/>
                  <a:gd name="T76" fmla="*/ 825 w 975"/>
                  <a:gd name="T77" fmla="*/ 708 h 753"/>
                  <a:gd name="T78" fmla="*/ 862 w 975"/>
                  <a:gd name="T79" fmla="*/ 735 h 753"/>
                  <a:gd name="T80" fmla="*/ 862 w 975"/>
                  <a:gd name="T81" fmla="*/ 735 h 753"/>
                  <a:gd name="T82" fmla="*/ 900 w 975"/>
                  <a:gd name="T83" fmla="*/ 744 h 753"/>
                  <a:gd name="T84" fmla="*/ 900 w 975"/>
                  <a:gd name="T85" fmla="*/ 744 h 753"/>
                  <a:gd name="T86" fmla="*/ 975 w 975"/>
                  <a:gd name="T87" fmla="*/ 753 h 7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</a:cxnLst>
                <a:rect l="0" t="0" r="r" b="b"/>
                <a:pathLst>
                  <a:path w="975" h="753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12" y="0"/>
                    </a:lnTo>
                    <a:lnTo>
                      <a:pt x="112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262" y="0"/>
                    </a:lnTo>
                    <a:lnTo>
                      <a:pt x="262" y="0"/>
                    </a:lnTo>
                    <a:lnTo>
                      <a:pt x="300" y="7"/>
                    </a:lnTo>
                    <a:lnTo>
                      <a:pt x="300" y="7"/>
                    </a:lnTo>
                    <a:lnTo>
                      <a:pt x="337" y="18"/>
                    </a:lnTo>
                    <a:lnTo>
                      <a:pt x="337" y="18"/>
                    </a:lnTo>
                    <a:lnTo>
                      <a:pt x="375" y="41"/>
                    </a:lnTo>
                    <a:lnTo>
                      <a:pt x="375" y="41"/>
                    </a:lnTo>
                    <a:lnTo>
                      <a:pt x="412" y="76"/>
                    </a:lnTo>
                    <a:lnTo>
                      <a:pt x="412" y="76"/>
                    </a:lnTo>
                    <a:lnTo>
                      <a:pt x="450" y="131"/>
                    </a:lnTo>
                    <a:lnTo>
                      <a:pt x="450" y="131"/>
                    </a:lnTo>
                    <a:lnTo>
                      <a:pt x="487" y="204"/>
                    </a:lnTo>
                    <a:lnTo>
                      <a:pt x="487" y="204"/>
                    </a:lnTo>
                    <a:lnTo>
                      <a:pt x="525" y="249"/>
                    </a:lnTo>
                    <a:lnTo>
                      <a:pt x="525" y="249"/>
                    </a:lnTo>
                    <a:lnTo>
                      <a:pt x="562" y="309"/>
                    </a:lnTo>
                    <a:lnTo>
                      <a:pt x="562" y="309"/>
                    </a:lnTo>
                    <a:lnTo>
                      <a:pt x="600" y="354"/>
                    </a:lnTo>
                    <a:lnTo>
                      <a:pt x="600" y="354"/>
                    </a:lnTo>
                    <a:lnTo>
                      <a:pt x="637" y="391"/>
                    </a:lnTo>
                    <a:lnTo>
                      <a:pt x="637" y="391"/>
                    </a:lnTo>
                    <a:lnTo>
                      <a:pt x="675" y="444"/>
                    </a:lnTo>
                    <a:lnTo>
                      <a:pt x="675" y="444"/>
                    </a:lnTo>
                    <a:lnTo>
                      <a:pt x="712" y="531"/>
                    </a:lnTo>
                    <a:lnTo>
                      <a:pt x="712" y="531"/>
                    </a:lnTo>
                    <a:lnTo>
                      <a:pt x="750" y="610"/>
                    </a:lnTo>
                    <a:lnTo>
                      <a:pt x="750" y="610"/>
                    </a:lnTo>
                    <a:lnTo>
                      <a:pt x="787" y="690"/>
                    </a:lnTo>
                    <a:lnTo>
                      <a:pt x="787" y="690"/>
                    </a:lnTo>
                    <a:lnTo>
                      <a:pt x="825" y="708"/>
                    </a:lnTo>
                    <a:lnTo>
                      <a:pt x="825" y="708"/>
                    </a:lnTo>
                    <a:lnTo>
                      <a:pt x="862" y="735"/>
                    </a:lnTo>
                    <a:lnTo>
                      <a:pt x="862" y="735"/>
                    </a:lnTo>
                    <a:lnTo>
                      <a:pt x="900" y="744"/>
                    </a:lnTo>
                    <a:lnTo>
                      <a:pt x="900" y="744"/>
                    </a:lnTo>
                    <a:lnTo>
                      <a:pt x="975" y="753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7" name="Freeform 258"/>
              <p:cNvSpPr>
                <a:spLocks/>
              </p:cNvSpPr>
              <p:nvPr/>
            </p:nvSpPr>
            <p:spPr bwMode="auto">
              <a:xfrm>
                <a:off x="2037" y="2163"/>
                <a:ext cx="937" cy="753"/>
              </a:xfrm>
              <a:custGeom>
                <a:avLst/>
                <a:gdLst>
                  <a:gd name="T0" fmla="*/ 0 w 937"/>
                  <a:gd name="T1" fmla="*/ 0 h 753"/>
                  <a:gd name="T2" fmla="*/ 0 w 937"/>
                  <a:gd name="T3" fmla="*/ 0 h 753"/>
                  <a:gd name="T4" fmla="*/ 0 w 937"/>
                  <a:gd name="T5" fmla="*/ 0 h 753"/>
                  <a:gd name="T6" fmla="*/ 112 w 937"/>
                  <a:gd name="T7" fmla="*/ 0 h 753"/>
                  <a:gd name="T8" fmla="*/ 112 w 937"/>
                  <a:gd name="T9" fmla="*/ 0 h 753"/>
                  <a:gd name="T10" fmla="*/ 187 w 937"/>
                  <a:gd name="T11" fmla="*/ 0 h 753"/>
                  <a:gd name="T12" fmla="*/ 187 w 937"/>
                  <a:gd name="T13" fmla="*/ 0 h 753"/>
                  <a:gd name="T14" fmla="*/ 262 w 937"/>
                  <a:gd name="T15" fmla="*/ 7 h 753"/>
                  <a:gd name="T16" fmla="*/ 262 w 937"/>
                  <a:gd name="T17" fmla="*/ 7 h 753"/>
                  <a:gd name="T18" fmla="*/ 300 w 937"/>
                  <a:gd name="T19" fmla="*/ 20 h 753"/>
                  <a:gd name="T20" fmla="*/ 300 w 937"/>
                  <a:gd name="T21" fmla="*/ 20 h 753"/>
                  <a:gd name="T22" fmla="*/ 337 w 937"/>
                  <a:gd name="T23" fmla="*/ 33 h 753"/>
                  <a:gd name="T24" fmla="*/ 337 w 937"/>
                  <a:gd name="T25" fmla="*/ 33 h 753"/>
                  <a:gd name="T26" fmla="*/ 375 w 937"/>
                  <a:gd name="T27" fmla="*/ 78 h 753"/>
                  <a:gd name="T28" fmla="*/ 375 w 937"/>
                  <a:gd name="T29" fmla="*/ 78 h 753"/>
                  <a:gd name="T30" fmla="*/ 412 w 937"/>
                  <a:gd name="T31" fmla="*/ 149 h 753"/>
                  <a:gd name="T32" fmla="*/ 412 w 937"/>
                  <a:gd name="T33" fmla="*/ 149 h 753"/>
                  <a:gd name="T34" fmla="*/ 450 w 937"/>
                  <a:gd name="T35" fmla="*/ 242 h 753"/>
                  <a:gd name="T36" fmla="*/ 450 w 937"/>
                  <a:gd name="T37" fmla="*/ 242 h 753"/>
                  <a:gd name="T38" fmla="*/ 487 w 937"/>
                  <a:gd name="T39" fmla="*/ 327 h 753"/>
                  <a:gd name="T40" fmla="*/ 487 w 937"/>
                  <a:gd name="T41" fmla="*/ 327 h 753"/>
                  <a:gd name="T42" fmla="*/ 525 w 937"/>
                  <a:gd name="T43" fmla="*/ 422 h 753"/>
                  <a:gd name="T44" fmla="*/ 525 w 937"/>
                  <a:gd name="T45" fmla="*/ 422 h 753"/>
                  <a:gd name="T46" fmla="*/ 562 w 937"/>
                  <a:gd name="T47" fmla="*/ 503 h 753"/>
                  <a:gd name="T48" fmla="*/ 562 w 937"/>
                  <a:gd name="T49" fmla="*/ 503 h 753"/>
                  <a:gd name="T50" fmla="*/ 600 w 937"/>
                  <a:gd name="T51" fmla="*/ 530 h 753"/>
                  <a:gd name="T52" fmla="*/ 600 w 937"/>
                  <a:gd name="T53" fmla="*/ 530 h 753"/>
                  <a:gd name="T54" fmla="*/ 637 w 937"/>
                  <a:gd name="T55" fmla="*/ 598 h 753"/>
                  <a:gd name="T56" fmla="*/ 637 w 937"/>
                  <a:gd name="T57" fmla="*/ 598 h 753"/>
                  <a:gd name="T58" fmla="*/ 675 w 937"/>
                  <a:gd name="T59" fmla="*/ 645 h 753"/>
                  <a:gd name="T60" fmla="*/ 675 w 937"/>
                  <a:gd name="T61" fmla="*/ 645 h 753"/>
                  <a:gd name="T62" fmla="*/ 712 w 937"/>
                  <a:gd name="T63" fmla="*/ 692 h 753"/>
                  <a:gd name="T64" fmla="*/ 712 w 937"/>
                  <a:gd name="T65" fmla="*/ 692 h 753"/>
                  <a:gd name="T66" fmla="*/ 750 w 937"/>
                  <a:gd name="T67" fmla="*/ 726 h 753"/>
                  <a:gd name="T68" fmla="*/ 750 w 937"/>
                  <a:gd name="T69" fmla="*/ 726 h 753"/>
                  <a:gd name="T70" fmla="*/ 825 w 937"/>
                  <a:gd name="T71" fmla="*/ 732 h 753"/>
                  <a:gd name="T72" fmla="*/ 825 w 937"/>
                  <a:gd name="T73" fmla="*/ 732 h 753"/>
                  <a:gd name="T74" fmla="*/ 862 w 937"/>
                  <a:gd name="T75" fmla="*/ 739 h 753"/>
                  <a:gd name="T76" fmla="*/ 862 w 937"/>
                  <a:gd name="T77" fmla="*/ 739 h 753"/>
                  <a:gd name="T78" fmla="*/ 900 w 937"/>
                  <a:gd name="T79" fmla="*/ 746 h 753"/>
                  <a:gd name="T80" fmla="*/ 900 w 937"/>
                  <a:gd name="T81" fmla="*/ 746 h 753"/>
                  <a:gd name="T82" fmla="*/ 937 w 937"/>
                  <a:gd name="T83" fmla="*/ 753 h 7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</a:cxnLst>
                <a:rect l="0" t="0" r="r" b="b"/>
                <a:pathLst>
                  <a:path w="937" h="753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12" y="0"/>
                    </a:lnTo>
                    <a:lnTo>
                      <a:pt x="112" y="0"/>
                    </a:lnTo>
                    <a:lnTo>
                      <a:pt x="187" y="0"/>
                    </a:lnTo>
                    <a:lnTo>
                      <a:pt x="187" y="0"/>
                    </a:lnTo>
                    <a:lnTo>
                      <a:pt x="262" y="7"/>
                    </a:lnTo>
                    <a:lnTo>
                      <a:pt x="262" y="7"/>
                    </a:lnTo>
                    <a:lnTo>
                      <a:pt x="300" y="20"/>
                    </a:lnTo>
                    <a:lnTo>
                      <a:pt x="300" y="20"/>
                    </a:lnTo>
                    <a:lnTo>
                      <a:pt x="337" y="33"/>
                    </a:lnTo>
                    <a:lnTo>
                      <a:pt x="337" y="33"/>
                    </a:lnTo>
                    <a:lnTo>
                      <a:pt x="375" y="78"/>
                    </a:lnTo>
                    <a:lnTo>
                      <a:pt x="375" y="78"/>
                    </a:lnTo>
                    <a:lnTo>
                      <a:pt x="412" y="149"/>
                    </a:lnTo>
                    <a:lnTo>
                      <a:pt x="412" y="149"/>
                    </a:lnTo>
                    <a:lnTo>
                      <a:pt x="450" y="242"/>
                    </a:lnTo>
                    <a:lnTo>
                      <a:pt x="450" y="242"/>
                    </a:lnTo>
                    <a:lnTo>
                      <a:pt x="487" y="327"/>
                    </a:lnTo>
                    <a:lnTo>
                      <a:pt x="487" y="327"/>
                    </a:lnTo>
                    <a:lnTo>
                      <a:pt x="525" y="422"/>
                    </a:lnTo>
                    <a:lnTo>
                      <a:pt x="525" y="422"/>
                    </a:lnTo>
                    <a:lnTo>
                      <a:pt x="562" y="503"/>
                    </a:lnTo>
                    <a:lnTo>
                      <a:pt x="562" y="503"/>
                    </a:lnTo>
                    <a:lnTo>
                      <a:pt x="600" y="530"/>
                    </a:lnTo>
                    <a:lnTo>
                      <a:pt x="600" y="530"/>
                    </a:lnTo>
                    <a:lnTo>
                      <a:pt x="637" y="598"/>
                    </a:lnTo>
                    <a:lnTo>
                      <a:pt x="637" y="598"/>
                    </a:lnTo>
                    <a:lnTo>
                      <a:pt x="675" y="645"/>
                    </a:lnTo>
                    <a:lnTo>
                      <a:pt x="675" y="645"/>
                    </a:lnTo>
                    <a:lnTo>
                      <a:pt x="712" y="692"/>
                    </a:lnTo>
                    <a:lnTo>
                      <a:pt x="712" y="692"/>
                    </a:lnTo>
                    <a:lnTo>
                      <a:pt x="750" y="726"/>
                    </a:lnTo>
                    <a:lnTo>
                      <a:pt x="750" y="726"/>
                    </a:lnTo>
                    <a:lnTo>
                      <a:pt x="825" y="732"/>
                    </a:lnTo>
                    <a:lnTo>
                      <a:pt x="825" y="732"/>
                    </a:lnTo>
                    <a:lnTo>
                      <a:pt x="862" y="739"/>
                    </a:lnTo>
                    <a:lnTo>
                      <a:pt x="862" y="739"/>
                    </a:lnTo>
                    <a:lnTo>
                      <a:pt x="900" y="746"/>
                    </a:lnTo>
                    <a:lnTo>
                      <a:pt x="900" y="746"/>
                    </a:lnTo>
                    <a:lnTo>
                      <a:pt x="937" y="753"/>
                    </a:lnTo>
                  </a:path>
                </a:pathLst>
              </a:custGeom>
              <a:noFill/>
              <a:ln w="17463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8" name="Freeform 259"/>
              <p:cNvSpPr>
                <a:spLocks noEditPoints="1"/>
              </p:cNvSpPr>
              <p:nvPr/>
            </p:nvSpPr>
            <p:spPr bwMode="auto">
              <a:xfrm>
                <a:off x="2037" y="2157"/>
                <a:ext cx="752" cy="764"/>
              </a:xfrm>
              <a:custGeom>
                <a:avLst/>
                <a:gdLst>
                  <a:gd name="T0" fmla="*/ 92 w 3080"/>
                  <a:gd name="T1" fmla="*/ 48 h 3119"/>
                  <a:gd name="T2" fmla="*/ 323 w 3080"/>
                  <a:gd name="T3" fmla="*/ 2 h 3119"/>
                  <a:gd name="T4" fmla="*/ 208 w 3080"/>
                  <a:gd name="T5" fmla="*/ 25 h 3119"/>
                  <a:gd name="T6" fmla="*/ 576 w 3080"/>
                  <a:gd name="T7" fmla="*/ 25 h 3119"/>
                  <a:gd name="T8" fmla="*/ 461 w 3080"/>
                  <a:gd name="T9" fmla="*/ 2 h 3119"/>
                  <a:gd name="T10" fmla="*/ 768 w 3080"/>
                  <a:gd name="T11" fmla="*/ 48 h 3119"/>
                  <a:gd name="T12" fmla="*/ 772 w 3080"/>
                  <a:gd name="T13" fmla="*/ 2 h 3119"/>
                  <a:gd name="T14" fmla="*/ 764 w 3080"/>
                  <a:gd name="T15" fmla="*/ 48 h 3119"/>
                  <a:gd name="T16" fmla="*/ 1014 w 3080"/>
                  <a:gd name="T17" fmla="*/ 45 h 3119"/>
                  <a:gd name="T18" fmla="*/ 897 w 3080"/>
                  <a:gd name="T19" fmla="*/ 47 h 3119"/>
                  <a:gd name="T20" fmla="*/ 1251 w 3080"/>
                  <a:gd name="T21" fmla="*/ 137 h 3119"/>
                  <a:gd name="T22" fmla="*/ 1151 w 3080"/>
                  <a:gd name="T23" fmla="*/ 80 h 3119"/>
                  <a:gd name="T24" fmla="*/ 1218 w 3080"/>
                  <a:gd name="T25" fmla="*/ 150 h 3119"/>
                  <a:gd name="T26" fmla="*/ 1357 w 3080"/>
                  <a:gd name="T27" fmla="*/ 192 h 3119"/>
                  <a:gd name="T28" fmla="*/ 1331 w 3080"/>
                  <a:gd name="T29" fmla="*/ 229 h 3119"/>
                  <a:gd name="T30" fmla="*/ 1419 w 3080"/>
                  <a:gd name="T31" fmla="*/ 273 h 3119"/>
                  <a:gd name="T32" fmla="*/ 1375 w 3080"/>
                  <a:gd name="T33" fmla="*/ 216 h 3119"/>
                  <a:gd name="T34" fmla="*/ 1477 w 3080"/>
                  <a:gd name="T35" fmla="*/ 521 h 3119"/>
                  <a:gd name="T36" fmla="*/ 1463 w 3080"/>
                  <a:gd name="T37" fmla="*/ 404 h 3119"/>
                  <a:gd name="T38" fmla="*/ 1514 w 3080"/>
                  <a:gd name="T39" fmla="*/ 703 h 3119"/>
                  <a:gd name="T40" fmla="*/ 1557 w 3080"/>
                  <a:gd name="T41" fmla="*/ 686 h 3119"/>
                  <a:gd name="T42" fmla="*/ 1515 w 3080"/>
                  <a:gd name="T43" fmla="*/ 705 h 3119"/>
                  <a:gd name="T44" fmla="*/ 1659 w 3080"/>
                  <a:gd name="T45" fmla="*/ 918 h 3119"/>
                  <a:gd name="T46" fmla="*/ 1592 w 3080"/>
                  <a:gd name="T47" fmla="*/ 822 h 3119"/>
                  <a:gd name="T48" fmla="*/ 1739 w 3080"/>
                  <a:gd name="T49" fmla="*/ 1160 h 3119"/>
                  <a:gd name="T50" fmla="*/ 1714 w 3080"/>
                  <a:gd name="T51" fmla="*/ 1045 h 3119"/>
                  <a:gd name="T52" fmla="*/ 1801 w 3080"/>
                  <a:gd name="T53" fmla="*/ 1359 h 3119"/>
                  <a:gd name="T54" fmla="*/ 1893 w 3080"/>
                  <a:gd name="T55" fmla="*/ 1472 h 3119"/>
                  <a:gd name="T56" fmla="*/ 1849 w 3080"/>
                  <a:gd name="T57" fmla="*/ 1486 h 3119"/>
                  <a:gd name="T58" fmla="*/ 1995 w 3080"/>
                  <a:gd name="T59" fmla="*/ 1778 h 3119"/>
                  <a:gd name="T60" fmla="*/ 1936 w 3080"/>
                  <a:gd name="T61" fmla="*/ 1676 h 3119"/>
                  <a:gd name="T62" fmla="*/ 2064 w 3080"/>
                  <a:gd name="T63" fmla="*/ 2022 h 3119"/>
                  <a:gd name="T64" fmla="*/ 2042 w 3080"/>
                  <a:gd name="T65" fmla="*/ 1906 h 3119"/>
                  <a:gd name="T66" fmla="*/ 2121 w 3080"/>
                  <a:gd name="T67" fmla="*/ 2222 h 3119"/>
                  <a:gd name="T68" fmla="*/ 2218 w 3080"/>
                  <a:gd name="T69" fmla="*/ 2331 h 3119"/>
                  <a:gd name="T70" fmla="*/ 2176 w 3080"/>
                  <a:gd name="T71" fmla="*/ 2350 h 3119"/>
                  <a:gd name="T72" fmla="*/ 2325 w 3080"/>
                  <a:gd name="T73" fmla="*/ 2576 h 3119"/>
                  <a:gd name="T74" fmla="*/ 2280 w 3080"/>
                  <a:gd name="T75" fmla="*/ 2530 h 3119"/>
                  <a:gd name="T76" fmla="*/ 2363 w 3080"/>
                  <a:gd name="T77" fmla="*/ 2637 h 3119"/>
                  <a:gd name="T78" fmla="*/ 2319 w 3080"/>
                  <a:gd name="T79" fmla="*/ 2568 h 3119"/>
                  <a:gd name="T80" fmla="*/ 2442 w 3080"/>
                  <a:gd name="T81" fmla="*/ 2738 h 3119"/>
                  <a:gd name="T82" fmla="*/ 2476 w 3080"/>
                  <a:gd name="T83" fmla="*/ 2707 h 3119"/>
                  <a:gd name="T84" fmla="*/ 2439 w 3080"/>
                  <a:gd name="T85" fmla="*/ 2734 h 3119"/>
                  <a:gd name="T86" fmla="*/ 2630 w 3080"/>
                  <a:gd name="T87" fmla="*/ 2922 h 3119"/>
                  <a:gd name="T88" fmla="*/ 2572 w 3080"/>
                  <a:gd name="T89" fmla="*/ 2880 h 3119"/>
                  <a:gd name="T90" fmla="*/ 2680 w 3080"/>
                  <a:gd name="T91" fmla="*/ 2948 h 3119"/>
                  <a:gd name="T92" fmla="*/ 2616 w 3080"/>
                  <a:gd name="T93" fmla="*/ 2913 h 3119"/>
                  <a:gd name="T94" fmla="*/ 2862 w 3080"/>
                  <a:gd name="T95" fmla="*/ 3040 h 3119"/>
                  <a:gd name="T96" fmla="*/ 3008 w 3080"/>
                  <a:gd name="T97" fmla="*/ 3050 h 3119"/>
                  <a:gd name="T98" fmla="*/ 2979 w 3080"/>
                  <a:gd name="T99" fmla="*/ 3064 h 3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3080" h="3119">
                    <a:moveTo>
                      <a:pt x="0" y="2"/>
                    </a:moveTo>
                    <a:lnTo>
                      <a:pt x="92" y="2"/>
                    </a:lnTo>
                    <a:cubicBezTo>
                      <a:pt x="105" y="2"/>
                      <a:pt x="115" y="12"/>
                      <a:pt x="115" y="25"/>
                    </a:cubicBezTo>
                    <a:cubicBezTo>
                      <a:pt x="115" y="38"/>
                      <a:pt x="105" y="48"/>
                      <a:pt x="92" y="48"/>
                    </a:cubicBezTo>
                    <a:lnTo>
                      <a:pt x="0" y="48"/>
                    </a:lnTo>
                    <a:lnTo>
                      <a:pt x="0" y="2"/>
                    </a:lnTo>
                    <a:close/>
                    <a:moveTo>
                      <a:pt x="231" y="2"/>
                    </a:moveTo>
                    <a:lnTo>
                      <a:pt x="323" y="2"/>
                    </a:lnTo>
                    <a:cubicBezTo>
                      <a:pt x="335" y="2"/>
                      <a:pt x="346" y="12"/>
                      <a:pt x="346" y="25"/>
                    </a:cubicBezTo>
                    <a:cubicBezTo>
                      <a:pt x="346" y="38"/>
                      <a:pt x="335" y="48"/>
                      <a:pt x="323" y="48"/>
                    </a:cubicBezTo>
                    <a:lnTo>
                      <a:pt x="231" y="48"/>
                    </a:lnTo>
                    <a:cubicBezTo>
                      <a:pt x="218" y="48"/>
                      <a:pt x="208" y="38"/>
                      <a:pt x="208" y="25"/>
                    </a:cubicBezTo>
                    <a:cubicBezTo>
                      <a:pt x="208" y="12"/>
                      <a:pt x="218" y="2"/>
                      <a:pt x="231" y="2"/>
                    </a:cubicBezTo>
                    <a:close/>
                    <a:moveTo>
                      <a:pt x="461" y="2"/>
                    </a:moveTo>
                    <a:lnTo>
                      <a:pt x="553" y="2"/>
                    </a:lnTo>
                    <a:cubicBezTo>
                      <a:pt x="566" y="2"/>
                      <a:pt x="576" y="12"/>
                      <a:pt x="576" y="25"/>
                    </a:cubicBezTo>
                    <a:cubicBezTo>
                      <a:pt x="576" y="38"/>
                      <a:pt x="566" y="48"/>
                      <a:pt x="553" y="48"/>
                    </a:cubicBezTo>
                    <a:lnTo>
                      <a:pt x="461" y="48"/>
                    </a:lnTo>
                    <a:cubicBezTo>
                      <a:pt x="448" y="48"/>
                      <a:pt x="438" y="38"/>
                      <a:pt x="438" y="25"/>
                    </a:cubicBezTo>
                    <a:cubicBezTo>
                      <a:pt x="438" y="12"/>
                      <a:pt x="448" y="2"/>
                      <a:pt x="461" y="2"/>
                    </a:cubicBezTo>
                    <a:close/>
                    <a:moveTo>
                      <a:pt x="691" y="2"/>
                    </a:moveTo>
                    <a:lnTo>
                      <a:pt x="768" y="2"/>
                    </a:lnTo>
                    <a:cubicBezTo>
                      <a:pt x="781" y="2"/>
                      <a:pt x="791" y="12"/>
                      <a:pt x="791" y="25"/>
                    </a:cubicBezTo>
                    <a:cubicBezTo>
                      <a:pt x="791" y="38"/>
                      <a:pt x="781" y="48"/>
                      <a:pt x="768" y="48"/>
                    </a:cubicBezTo>
                    <a:lnTo>
                      <a:pt x="691" y="48"/>
                    </a:lnTo>
                    <a:cubicBezTo>
                      <a:pt x="679" y="48"/>
                      <a:pt x="668" y="38"/>
                      <a:pt x="668" y="25"/>
                    </a:cubicBezTo>
                    <a:cubicBezTo>
                      <a:pt x="668" y="12"/>
                      <a:pt x="679" y="2"/>
                      <a:pt x="691" y="2"/>
                    </a:cubicBezTo>
                    <a:close/>
                    <a:moveTo>
                      <a:pt x="772" y="2"/>
                    </a:moveTo>
                    <a:lnTo>
                      <a:pt x="787" y="5"/>
                    </a:lnTo>
                    <a:cubicBezTo>
                      <a:pt x="800" y="7"/>
                      <a:pt x="808" y="19"/>
                      <a:pt x="806" y="32"/>
                    </a:cubicBezTo>
                    <a:cubicBezTo>
                      <a:pt x="804" y="44"/>
                      <a:pt x="792" y="52"/>
                      <a:pt x="779" y="50"/>
                    </a:cubicBezTo>
                    <a:lnTo>
                      <a:pt x="764" y="48"/>
                    </a:lnTo>
                    <a:cubicBezTo>
                      <a:pt x="752" y="45"/>
                      <a:pt x="743" y="33"/>
                      <a:pt x="745" y="21"/>
                    </a:cubicBezTo>
                    <a:cubicBezTo>
                      <a:pt x="748" y="8"/>
                      <a:pt x="760" y="0"/>
                      <a:pt x="772" y="2"/>
                    </a:cubicBezTo>
                    <a:close/>
                    <a:moveTo>
                      <a:pt x="923" y="29"/>
                    </a:moveTo>
                    <a:lnTo>
                      <a:pt x="1014" y="45"/>
                    </a:lnTo>
                    <a:cubicBezTo>
                      <a:pt x="1027" y="47"/>
                      <a:pt x="1035" y="59"/>
                      <a:pt x="1033" y="71"/>
                    </a:cubicBezTo>
                    <a:cubicBezTo>
                      <a:pt x="1031" y="84"/>
                      <a:pt x="1019" y="92"/>
                      <a:pt x="1006" y="90"/>
                    </a:cubicBezTo>
                    <a:lnTo>
                      <a:pt x="915" y="74"/>
                    </a:lnTo>
                    <a:cubicBezTo>
                      <a:pt x="903" y="72"/>
                      <a:pt x="895" y="60"/>
                      <a:pt x="897" y="47"/>
                    </a:cubicBezTo>
                    <a:cubicBezTo>
                      <a:pt x="899" y="35"/>
                      <a:pt x="911" y="26"/>
                      <a:pt x="923" y="29"/>
                    </a:cubicBezTo>
                    <a:close/>
                    <a:moveTo>
                      <a:pt x="1151" y="80"/>
                    </a:moveTo>
                    <a:lnTo>
                      <a:pt x="1236" y="108"/>
                    </a:lnTo>
                    <a:cubicBezTo>
                      <a:pt x="1248" y="112"/>
                      <a:pt x="1255" y="125"/>
                      <a:pt x="1251" y="137"/>
                    </a:cubicBezTo>
                    <a:cubicBezTo>
                      <a:pt x="1247" y="149"/>
                      <a:pt x="1234" y="156"/>
                      <a:pt x="1222" y="152"/>
                    </a:cubicBezTo>
                    <a:lnTo>
                      <a:pt x="1136" y="123"/>
                    </a:lnTo>
                    <a:cubicBezTo>
                      <a:pt x="1124" y="119"/>
                      <a:pt x="1118" y="106"/>
                      <a:pt x="1122" y="94"/>
                    </a:cubicBezTo>
                    <a:cubicBezTo>
                      <a:pt x="1126" y="82"/>
                      <a:pt x="1139" y="76"/>
                      <a:pt x="1151" y="80"/>
                    </a:cubicBezTo>
                    <a:close/>
                    <a:moveTo>
                      <a:pt x="1242" y="111"/>
                    </a:moveTo>
                    <a:lnTo>
                      <a:pt x="1244" y="112"/>
                    </a:lnTo>
                    <a:cubicBezTo>
                      <a:pt x="1255" y="120"/>
                      <a:pt x="1257" y="134"/>
                      <a:pt x="1250" y="144"/>
                    </a:cubicBezTo>
                    <a:cubicBezTo>
                      <a:pt x="1242" y="155"/>
                      <a:pt x="1228" y="157"/>
                      <a:pt x="1218" y="150"/>
                    </a:cubicBezTo>
                    <a:lnTo>
                      <a:pt x="1216" y="149"/>
                    </a:lnTo>
                    <a:cubicBezTo>
                      <a:pt x="1205" y="141"/>
                      <a:pt x="1203" y="127"/>
                      <a:pt x="1210" y="117"/>
                    </a:cubicBezTo>
                    <a:cubicBezTo>
                      <a:pt x="1217" y="106"/>
                      <a:pt x="1232" y="104"/>
                      <a:pt x="1242" y="111"/>
                    </a:cubicBezTo>
                    <a:close/>
                    <a:moveTo>
                      <a:pt x="1357" y="192"/>
                    </a:moveTo>
                    <a:lnTo>
                      <a:pt x="1396" y="219"/>
                    </a:lnTo>
                    <a:cubicBezTo>
                      <a:pt x="1406" y="226"/>
                      <a:pt x="1409" y="240"/>
                      <a:pt x="1401" y="251"/>
                    </a:cubicBezTo>
                    <a:cubicBezTo>
                      <a:pt x="1394" y="261"/>
                      <a:pt x="1380" y="264"/>
                      <a:pt x="1369" y="256"/>
                    </a:cubicBezTo>
                    <a:lnTo>
                      <a:pt x="1331" y="229"/>
                    </a:lnTo>
                    <a:cubicBezTo>
                      <a:pt x="1321" y="222"/>
                      <a:pt x="1318" y="208"/>
                      <a:pt x="1325" y="197"/>
                    </a:cubicBezTo>
                    <a:cubicBezTo>
                      <a:pt x="1333" y="187"/>
                      <a:pt x="1347" y="184"/>
                      <a:pt x="1357" y="192"/>
                    </a:cubicBezTo>
                    <a:close/>
                    <a:moveTo>
                      <a:pt x="1404" y="230"/>
                    </a:moveTo>
                    <a:lnTo>
                      <a:pt x="1419" y="273"/>
                    </a:lnTo>
                    <a:cubicBezTo>
                      <a:pt x="1423" y="285"/>
                      <a:pt x="1416" y="298"/>
                      <a:pt x="1404" y="302"/>
                    </a:cubicBezTo>
                    <a:cubicBezTo>
                      <a:pt x="1392" y="306"/>
                      <a:pt x="1379" y="300"/>
                      <a:pt x="1375" y="288"/>
                    </a:cubicBezTo>
                    <a:lnTo>
                      <a:pt x="1361" y="245"/>
                    </a:lnTo>
                    <a:cubicBezTo>
                      <a:pt x="1357" y="233"/>
                      <a:pt x="1363" y="220"/>
                      <a:pt x="1375" y="216"/>
                    </a:cubicBezTo>
                    <a:cubicBezTo>
                      <a:pt x="1387" y="211"/>
                      <a:pt x="1400" y="218"/>
                      <a:pt x="1404" y="230"/>
                    </a:cubicBezTo>
                    <a:close/>
                    <a:moveTo>
                      <a:pt x="1463" y="404"/>
                    </a:moveTo>
                    <a:lnTo>
                      <a:pt x="1492" y="491"/>
                    </a:lnTo>
                    <a:cubicBezTo>
                      <a:pt x="1496" y="504"/>
                      <a:pt x="1490" y="517"/>
                      <a:pt x="1477" y="521"/>
                    </a:cubicBezTo>
                    <a:cubicBezTo>
                      <a:pt x="1465" y="525"/>
                      <a:pt x="1452" y="518"/>
                      <a:pt x="1448" y="506"/>
                    </a:cubicBezTo>
                    <a:lnTo>
                      <a:pt x="1419" y="419"/>
                    </a:lnTo>
                    <a:cubicBezTo>
                      <a:pt x="1415" y="407"/>
                      <a:pt x="1421" y="394"/>
                      <a:pt x="1434" y="390"/>
                    </a:cubicBezTo>
                    <a:cubicBezTo>
                      <a:pt x="1446" y="386"/>
                      <a:pt x="1459" y="392"/>
                      <a:pt x="1463" y="404"/>
                    </a:cubicBezTo>
                    <a:close/>
                    <a:moveTo>
                      <a:pt x="1536" y="623"/>
                    </a:moveTo>
                    <a:lnTo>
                      <a:pt x="1558" y="688"/>
                    </a:lnTo>
                    <a:cubicBezTo>
                      <a:pt x="1562" y="700"/>
                      <a:pt x="1556" y="713"/>
                      <a:pt x="1543" y="717"/>
                    </a:cubicBezTo>
                    <a:cubicBezTo>
                      <a:pt x="1531" y="722"/>
                      <a:pt x="1518" y="715"/>
                      <a:pt x="1514" y="703"/>
                    </a:cubicBezTo>
                    <a:lnTo>
                      <a:pt x="1492" y="637"/>
                    </a:lnTo>
                    <a:cubicBezTo>
                      <a:pt x="1488" y="625"/>
                      <a:pt x="1495" y="612"/>
                      <a:pt x="1507" y="608"/>
                    </a:cubicBezTo>
                    <a:cubicBezTo>
                      <a:pt x="1519" y="604"/>
                      <a:pt x="1532" y="610"/>
                      <a:pt x="1536" y="623"/>
                    </a:cubicBezTo>
                    <a:close/>
                    <a:moveTo>
                      <a:pt x="1557" y="686"/>
                    </a:moveTo>
                    <a:lnTo>
                      <a:pt x="1566" y="707"/>
                    </a:lnTo>
                    <a:cubicBezTo>
                      <a:pt x="1571" y="719"/>
                      <a:pt x="1566" y="733"/>
                      <a:pt x="1555" y="738"/>
                    </a:cubicBezTo>
                    <a:cubicBezTo>
                      <a:pt x="1543" y="743"/>
                      <a:pt x="1529" y="737"/>
                      <a:pt x="1524" y="726"/>
                    </a:cubicBezTo>
                    <a:lnTo>
                      <a:pt x="1515" y="705"/>
                    </a:lnTo>
                    <a:cubicBezTo>
                      <a:pt x="1510" y="693"/>
                      <a:pt x="1515" y="680"/>
                      <a:pt x="1527" y="675"/>
                    </a:cubicBezTo>
                    <a:cubicBezTo>
                      <a:pt x="1539" y="669"/>
                      <a:pt x="1552" y="675"/>
                      <a:pt x="1557" y="686"/>
                    </a:cubicBezTo>
                    <a:close/>
                    <a:moveTo>
                      <a:pt x="1622" y="834"/>
                    </a:moveTo>
                    <a:lnTo>
                      <a:pt x="1659" y="918"/>
                    </a:lnTo>
                    <a:cubicBezTo>
                      <a:pt x="1664" y="930"/>
                      <a:pt x="1659" y="944"/>
                      <a:pt x="1647" y="949"/>
                    </a:cubicBezTo>
                    <a:cubicBezTo>
                      <a:pt x="1635" y="954"/>
                      <a:pt x="1622" y="948"/>
                      <a:pt x="1617" y="937"/>
                    </a:cubicBezTo>
                    <a:lnTo>
                      <a:pt x="1580" y="852"/>
                    </a:lnTo>
                    <a:cubicBezTo>
                      <a:pt x="1575" y="841"/>
                      <a:pt x="1580" y="827"/>
                      <a:pt x="1592" y="822"/>
                    </a:cubicBezTo>
                    <a:cubicBezTo>
                      <a:pt x="1603" y="817"/>
                      <a:pt x="1617" y="822"/>
                      <a:pt x="1622" y="834"/>
                    </a:cubicBezTo>
                    <a:close/>
                    <a:moveTo>
                      <a:pt x="1714" y="1045"/>
                    </a:moveTo>
                    <a:lnTo>
                      <a:pt x="1751" y="1129"/>
                    </a:lnTo>
                    <a:cubicBezTo>
                      <a:pt x="1756" y="1141"/>
                      <a:pt x="1751" y="1155"/>
                      <a:pt x="1739" y="1160"/>
                    </a:cubicBezTo>
                    <a:cubicBezTo>
                      <a:pt x="1728" y="1165"/>
                      <a:pt x="1714" y="1159"/>
                      <a:pt x="1709" y="1148"/>
                    </a:cubicBezTo>
                    <a:lnTo>
                      <a:pt x="1672" y="1063"/>
                    </a:lnTo>
                    <a:cubicBezTo>
                      <a:pt x="1667" y="1052"/>
                      <a:pt x="1672" y="1038"/>
                      <a:pt x="1684" y="1033"/>
                    </a:cubicBezTo>
                    <a:cubicBezTo>
                      <a:pt x="1696" y="1028"/>
                      <a:pt x="1709" y="1033"/>
                      <a:pt x="1714" y="1045"/>
                    </a:cubicBezTo>
                    <a:close/>
                    <a:moveTo>
                      <a:pt x="1807" y="1256"/>
                    </a:moveTo>
                    <a:lnTo>
                      <a:pt x="1844" y="1340"/>
                    </a:lnTo>
                    <a:cubicBezTo>
                      <a:pt x="1849" y="1352"/>
                      <a:pt x="1843" y="1366"/>
                      <a:pt x="1832" y="1371"/>
                    </a:cubicBezTo>
                    <a:cubicBezTo>
                      <a:pt x="1820" y="1376"/>
                      <a:pt x="1807" y="1371"/>
                      <a:pt x="1801" y="1359"/>
                    </a:cubicBezTo>
                    <a:lnTo>
                      <a:pt x="1765" y="1274"/>
                    </a:lnTo>
                    <a:cubicBezTo>
                      <a:pt x="1759" y="1263"/>
                      <a:pt x="1765" y="1249"/>
                      <a:pt x="1776" y="1244"/>
                    </a:cubicBezTo>
                    <a:cubicBezTo>
                      <a:pt x="1788" y="1239"/>
                      <a:pt x="1802" y="1244"/>
                      <a:pt x="1807" y="1256"/>
                    </a:cubicBezTo>
                    <a:close/>
                    <a:moveTo>
                      <a:pt x="1893" y="1472"/>
                    </a:moveTo>
                    <a:lnTo>
                      <a:pt x="1922" y="1559"/>
                    </a:lnTo>
                    <a:cubicBezTo>
                      <a:pt x="1926" y="1571"/>
                      <a:pt x="1919" y="1584"/>
                      <a:pt x="1907" y="1588"/>
                    </a:cubicBezTo>
                    <a:cubicBezTo>
                      <a:pt x="1895" y="1592"/>
                      <a:pt x="1882" y="1586"/>
                      <a:pt x="1878" y="1574"/>
                    </a:cubicBezTo>
                    <a:lnTo>
                      <a:pt x="1849" y="1486"/>
                    </a:lnTo>
                    <a:cubicBezTo>
                      <a:pt x="1845" y="1474"/>
                      <a:pt x="1851" y="1461"/>
                      <a:pt x="1863" y="1457"/>
                    </a:cubicBezTo>
                    <a:cubicBezTo>
                      <a:pt x="1875" y="1453"/>
                      <a:pt x="1889" y="1460"/>
                      <a:pt x="1893" y="1472"/>
                    </a:cubicBezTo>
                    <a:close/>
                    <a:moveTo>
                      <a:pt x="1965" y="1690"/>
                    </a:moveTo>
                    <a:lnTo>
                      <a:pt x="1995" y="1778"/>
                    </a:lnTo>
                    <a:cubicBezTo>
                      <a:pt x="1999" y="1790"/>
                      <a:pt x="1992" y="1803"/>
                      <a:pt x="1980" y="1807"/>
                    </a:cubicBezTo>
                    <a:cubicBezTo>
                      <a:pt x="1968" y="1811"/>
                      <a:pt x="1955" y="1804"/>
                      <a:pt x="1951" y="1792"/>
                    </a:cubicBezTo>
                    <a:lnTo>
                      <a:pt x="1922" y="1705"/>
                    </a:lnTo>
                    <a:cubicBezTo>
                      <a:pt x="1918" y="1693"/>
                      <a:pt x="1924" y="1680"/>
                      <a:pt x="1936" y="1676"/>
                    </a:cubicBezTo>
                    <a:cubicBezTo>
                      <a:pt x="1948" y="1672"/>
                      <a:pt x="1961" y="1678"/>
                      <a:pt x="1965" y="1690"/>
                    </a:cubicBezTo>
                    <a:close/>
                    <a:moveTo>
                      <a:pt x="2042" y="1906"/>
                    </a:moveTo>
                    <a:lnTo>
                      <a:pt x="2076" y="1991"/>
                    </a:lnTo>
                    <a:cubicBezTo>
                      <a:pt x="2081" y="2003"/>
                      <a:pt x="2076" y="2017"/>
                      <a:pt x="2064" y="2022"/>
                    </a:cubicBezTo>
                    <a:cubicBezTo>
                      <a:pt x="2052" y="2026"/>
                      <a:pt x="2039" y="2021"/>
                      <a:pt x="2034" y="2009"/>
                    </a:cubicBezTo>
                    <a:lnTo>
                      <a:pt x="1999" y="1924"/>
                    </a:lnTo>
                    <a:cubicBezTo>
                      <a:pt x="1994" y="1912"/>
                      <a:pt x="2000" y="1898"/>
                      <a:pt x="2011" y="1894"/>
                    </a:cubicBezTo>
                    <a:cubicBezTo>
                      <a:pt x="2023" y="1889"/>
                      <a:pt x="2037" y="1894"/>
                      <a:pt x="2042" y="1906"/>
                    </a:cubicBezTo>
                    <a:close/>
                    <a:moveTo>
                      <a:pt x="2129" y="2119"/>
                    </a:moveTo>
                    <a:lnTo>
                      <a:pt x="2163" y="2205"/>
                    </a:lnTo>
                    <a:cubicBezTo>
                      <a:pt x="2168" y="2217"/>
                      <a:pt x="2163" y="2230"/>
                      <a:pt x="2151" y="2235"/>
                    </a:cubicBezTo>
                    <a:cubicBezTo>
                      <a:pt x="2139" y="2240"/>
                      <a:pt x="2126" y="2234"/>
                      <a:pt x="2121" y="2222"/>
                    </a:cubicBezTo>
                    <a:lnTo>
                      <a:pt x="2086" y="2137"/>
                    </a:lnTo>
                    <a:cubicBezTo>
                      <a:pt x="2081" y="2125"/>
                      <a:pt x="2087" y="2112"/>
                      <a:pt x="2099" y="2107"/>
                    </a:cubicBezTo>
                    <a:cubicBezTo>
                      <a:pt x="2110" y="2102"/>
                      <a:pt x="2124" y="2108"/>
                      <a:pt x="2129" y="2119"/>
                    </a:cubicBezTo>
                    <a:close/>
                    <a:moveTo>
                      <a:pt x="2218" y="2331"/>
                    </a:moveTo>
                    <a:lnTo>
                      <a:pt x="2255" y="2416"/>
                    </a:lnTo>
                    <a:cubicBezTo>
                      <a:pt x="2260" y="2427"/>
                      <a:pt x="2255" y="2441"/>
                      <a:pt x="2243" y="2446"/>
                    </a:cubicBezTo>
                    <a:cubicBezTo>
                      <a:pt x="2232" y="2451"/>
                      <a:pt x="2218" y="2446"/>
                      <a:pt x="2213" y="2434"/>
                    </a:cubicBezTo>
                    <a:lnTo>
                      <a:pt x="2176" y="2350"/>
                    </a:lnTo>
                    <a:cubicBezTo>
                      <a:pt x="2171" y="2338"/>
                      <a:pt x="2176" y="2324"/>
                      <a:pt x="2188" y="2319"/>
                    </a:cubicBezTo>
                    <a:cubicBezTo>
                      <a:pt x="2199" y="2314"/>
                      <a:pt x="2213" y="2319"/>
                      <a:pt x="2218" y="2331"/>
                    </a:cubicBezTo>
                    <a:close/>
                    <a:moveTo>
                      <a:pt x="2311" y="2542"/>
                    </a:moveTo>
                    <a:lnTo>
                      <a:pt x="2325" y="2576"/>
                    </a:lnTo>
                    <a:cubicBezTo>
                      <a:pt x="2330" y="2587"/>
                      <a:pt x="2325" y="2601"/>
                      <a:pt x="2313" y="2606"/>
                    </a:cubicBezTo>
                    <a:cubicBezTo>
                      <a:pt x="2302" y="2611"/>
                      <a:pt x="2288" y="2606"/>
                      <a:pt x="2283" y="2594"/>
                    </a:cubicBezTo>
                    <a:lnTo>
                      <a:pt x="2268" y="2561"/>
                    </a:lnTo>
                    <a:cubicBezTo>
                      <a:pt x="2263" y="2549"/>
                      <a:pt x="2269" y="2535"/>
                      <a:pt x="2280" y="2530"/>
                    </a:cubicBezTo>
                    <a:cubicBezTo>
                      <a:pt x="2292" y="2525"/>
                      <a:pt x="2305" y="2530"/>
                      <a:pt x="2311" y="2542"/>
                    </a:cubicBezTo>
                    <a:close/>
                    <a:moveTo>
                      <a:pt x="2319" y="2568"/>
                    </a:moveTo>
                    <a:lnTo>
                      <a:pt x="2361" y="2604"/>
                    </a:lnTo>
                    <a:cubicBezTo>
                      <a:pt x="2371" y="2613"/>
                      <a:pt x="2371" y="2627"/>
                      <a:pt x="2363" y="2637"/>
                    </a:cubicBezTo>
                    <a:cubicBezTo>
                      <a:pt x="2355" y="2646"/>
                      <a:pt x="2340" y="2647"/>
                      <a:pt x="2331" y="2639"/>
                    </a:cubicBezTo>
                    <a:lnTo>
                      <a:pt x="2289" y="2602"/>
                    </a:lnTo>
                    <a:cubicBezTo>
                      <a:pt x="2279" y="2594"/>
                      <a:pt x="2278" y="2579"/>
                      <a:pt x="2287" y="2570"/>
                    </a:cubicBezTo>
                    <a:cubicBezTo>
                      <a:pt x="2295" y="2560"/>
                      <a:pt x="2310" y="2559"/>
                      <a:pt x="2319" y="2568"/>
                    </a:cubicBezTo>
                    <a:close/>
                    <a:moveTo>
                      <a:pt x="2465" y="2696"/>
                    </a:moveTo>
                    <a:lnTo>
                      <a:pt x="2473" y="2703"/>
                    </a:lnTo>
                    <a:cubicBezTo>
                      <a:pt x="2483" y="2712"/>
                      <a:pt x="2483" y="2726"/>
                      <a:pt x="2475" y="2736"/>
                    </a:cubicBezTo>
                    <a:cubicBezTo>
                      <a:pt x="2467" y="2745"/>
                      <a:pt x="2452" y="2746"/>
                      <a:pt x="2442" y="2738"/>
                    </a:cubicBezTo>
                    <a:lnTo>
                      <a:pt x="2434" y="2730"/>
                    </a:lnTo>
                    <a:cubicBezTo>
                      <a:pt x="2425" y="2722"/>
                      <a:pt x="2424" y="2707"/>
                      <a:pt x="2432" y="2698"/>
                    </a:cubicBezTo>
                    <a:cubicBezTo>
                      <a:pt x="2441" y="2688"/>
                      <a:pt x="2455" y="2688"/>
                      <a:pt x="2465" y="2696"/>
                    </a:cubicBezTo>
                    <a:close/>
                    <a:moveTo>
                      <a:pt x="2476" y="2707"/>
                    </a:moveTo>
                    <a:lnTo>
                      <a:pt x="2524" y="2773"/>
                    </a:lnTo>
                    <a:cubicBezTo>
                      <a:pt x="2531" y="2783"/>
                      <a:pt x="2529" y="2798"/>
                      <a:pt x="2518" y="2805"/>
                    </a:cubicBezTo>
                    <a:cubicBezTo>
                      <a:pt x="2508" y="2813"/>
                      <a:pt x="2493" y="2810"/>
                      <a:pt x="2486" y="2800"/>
                    </a:cubicBezTo>
                    <a:lnTo>
                      <a:pt x="2439" y="2734"/>
                    </a:lnTo>
                    <a:cubicBezTo>
                      <a:pt x="2432" y="2724"/>
                      <a:pt x="2434" y="2709"/>
                      <a:pt x="2444" y="2702"/>
                    </a:cubicBezTo>
                    <a:cubicBezTo>
                      <a:pt x="2455" y="2694"/>
                      <a:pt x="2469" y="2697"/>
                      <a:pt x="2476" y="2707"/>
                    </a:cubicBezTo>
                    <a:close/>
                    <a:moveTo>
                      <a:pt x="2604" y="2886"/>
                    </a:moveTo>
                    <a:lnTo>
                      <a:pt x="2630" y="2922"/>
                    </a:lnTo>
                    <a:cubicBezTo>
                      <a:pt x="2637" y="2933"/>
                      <a:pt x="2635" y="2947"/>
                      <a:pt x="2625" y="2954"/>
                    </a:cubicBezTo>
                    <a:cubicBezTo>
                      <a:pt x="2614" y="2962"/>
                      <a:pt x="2600" y="2959"/>
                      <a:pt x="2593" y="2949"/>
                    </a:cubicBezTo>
                    <a:lnTo>
                      <a:pt x="2566" y="2912"/>
                    </a:lnTo>
                    <a:cubicBezTo>
                      <a:pt x="2559" y="2902"/>
                      <a:pt x="2561" y="2888"/>
                      <a:pt x="2572" y="2880"/>
                    </a:cubicBezTo>
                    <a:cubicBezTo>
                      <a:pt x="2582" y="2873"/>
                      <a:pt x="2597" y="2875"/>
                      <a:pt x="2604" y="2886"/>
                    </a:cubicBezTo>
                    <a:close/>
                    <a:moveTo>
                      <a:pt x="2616" y="2913"/>
                    </a:moveTo>
                    <a:lnTo>
                      <a:pt x="2662" y="2921"/>
                    </a:lnTo>
                    <a:cubicBezTo>
                      <a:pt x="2674" y="2924"/>
                      <a:pt x="2683" y="2936"/>
                      <a:pt x="2680" y="2948"/>
                    </a:cubicBezTo>
                    <a:cubicBezTo>
                      <a:pt x="2678" y="2961"/>
                      <a:pt x="2666" y="2969"/>
                      <a:pt x="2654" y="2967"/>
                    </a:cubicBezTo>
                    <a:lnTo>
                      <a:pt x="2607" y="2958"/>
                    </a:lnTo>
                    <a:cubicBezTo>
                      <a:pt x="2595" y="2956"/>
                      <a:pt x="2586" y="2944"/>
                      <a:pt x="2589" y="2931"/>
                    </a:cubicBezTo>
                    <a:cubicBezTo>
                      <a:pt x="2591" y="2919"/>
                      <a:pt x="2603" y="2911"/>
                      <a:pt x="2616" y="2913"/>
                    </a:cubicBezTo>
                    <a:close/>
                    <a:moveTo>
                      <a:pt x="2801" y="2957"/>
                    </a:moveTo>
                    <a:lnTo>
                      <a:pt x="2883" y="2999"/>
                    </a:lnTo>
                    <a:cubicBezTo>
                      <a:pt x="2895" y="3005"/>
                      <a:pt x="2899" y="3019"/>
                      <a:pt x="2893" y="3030"/>
                    </a:cubicBezTo>
                    <a:cubicBezTo>
                      <a:pt x="2887" y="3041"/>
                      <a:pt x="2874" y="3046"/>
                      <a:pt x="2862" y="3040"/>
                    </a:cubicBezTo>
                    <a:lnTo>
                      <a:pt x="2780" y="2998"/>
                    </a:lnTo>
                    <a:cubicBezTo>
                      <a:pt x="2769" y="2992"/>
                      <a:pt x="2765" y="2978"/>
                      <a:pt x="2770" y="2967"/>
                    </a:cubicBezTo>
                    <a:cubicBezTo>
                      <a:pt x="2776" y="2955"/>
                      <a:pt x="2790" y="2951"/>
                      <a:pt x="2801" y="2957"/>
                    </a:cubicBezTo>
                    <a:close/>
                    <a:moveTo>
                      <a:pt x="3008" y="3050"/>
                    </a:moveTo>
                    <a:lnTo>
                      <a:pt x="3080" y="3075"/>
                    </a:lnTo>
                    <a:lnTo>
                      <a:pt x="3065" y="3119"/>
                    </a:lnTo>
                    <a:lnTo>
                      <a:pt x="2993" y="3094"/>
                    </a:lnTo>
                    <a:cubicBezTo>
                      <a:pt x="2981" y="3089"/>
                      <a:pt x="2974" y="3076"/>
                      <a:pt x="2979" y="3064"/>
                    </a:cubicBezTo>
                    <a:cubicBezTo>
                      <a:pt x="2983" y="3052"/>
                      <a:pt x="2996" y="3046"/>
                      <a:pt x="3008" y="305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9" name="Freeform 260"/>
              <p:cNvSpPr>
                <a:spLocks noEditPoints="1"/>
              </p:cNvSpPr>
              <p:nvPr/>
            </p:nvSpPr>
            <p:spPr bwMode="auto">
              <a:xfrm>
                <a:off x="2037" y="2157"/>
                <a:ext cx="827" cy="764"/>
              </a:xfrm>
              <a:custGeom>
                <a:avLst/>
                <a:gdLst>
                  <a:gd name="T0" fmla="*/ 92 w 3387"/>
                  <a:gd name="T1" fmla="*/ 49 h 3120"/>
                  <a:gd name="T2" fmla="*/ 323 w 3387"/>
                  <a:gd name="T3" fmla="*/ 3 h 3120"/>
                  <a:gd name="T4" fmla="*/ 208 w 3387"/>
                  <a:gd name="T5" fmla="*/ 26 h 3120"/>
                  <a:gd name="T6" fmla="*/ 576 w 3387"/>
                  <a:gd name="T7" fmla="*/ 26 h 3120"/>
                  <a:gd name="T8" fmla="*/ 461 w 3387"/>
                  <a:gd name="T9" fmla="*/ 3 h 3120"/>
                  <a:gd name="T10" fmla="*/ 768 w 3387"/>
                  <a:gd name="T11" fmla="*/ 49 h 3120"/>
                  <a:gd name="T12" fmla="*/ 776 w 3387"/>
                  <a:gd name="T13" fmla="*/ 4 h 3120"/>
                  <a:gd name="T14" fmla="*/ 760 w 3387"/>
                  <a:gd name="T15" fmla="*/ 47 h 3120"/>
                  <a:gd name="T16" fmla="*/ 1006 w 3387"/>
                  <a:gd name="T17" fmla="*/ 91 h 3120"/>
                  <a:gd name="T18" fmla="*/ 890 w 3387"/>
                  <a:gd name="T19" fmla="*/ 72 h 3120"/>
                  <a:gd name="T20" fmla="*/ 1236 w 3387"/>
                  <a:gd name="T21" fmla="*/ 200 h 3120"/>
                  <a:gd name="T22" fmla="*/ 1136 w 3387"/>
                  <a:gd name="T23" fmla="*/ 139 h 3120"/>
                  <a:gd name="T24" fmla="*/ 1375 w 3387"/>
                  <a:gd name="T25" fmla="*/ 275 h 3120"/>
                  <a:gd name="T26" fmla="*/ 1402 w 3387"/>
                  <a:gd name="T27" fmla="*/ 241 h 3120"/>
                  <a:gd name="T28" fmla="*/ 1363 w 3387"/>
                  <a:gd name="T29" fmla="*/ 267 h 3120"/>
                  <a:gd name="T30" fmla="*/ 1555 w 3387"/>
                  <a:gd name="T31" fmla="*/ 469 h 3120"/>
                  <a:gd name="T32" fmla="*/ 1476 w 3387"/>
                  <a:gd name="T33" fmla="*/ 392 h 3120"/>
                  <a:gd name="T34" fmla="*/ 1550 w 3387"/>
                  <a:gd name="T35" fmla="*/ 508 h 3120"/>
                  <a:gd name="T36" fmla="*/ 1556 w 3387"/>
                  <a:gd name="T37" fmla="*/ 471 h 3120"/>
                  <a:gd name="T38" fmla="*/ 1629 w 3387"/>
                  <a:gd name="T39" fmla="*/ 701 h 3120"/>
                  <a:gd name="T40" fmla="*/ 1731 w 3387"/>
                  <a:gd name="T41" fmla="*/ 805 h 3120"/>
                  <a:gd name="T42" fmla="*/ 1689 w 3387"/>
                  <a:gd name="T43" fmla="*/ 823 h 3120"/>
                  <a:gd name="T44" fmla="*/ 1854 w 3387"/>
                  <a:gd name="T45" fmla="*/ 1104 h 3120"/>
                  <a:gd name="T46" fmla="*/ 1789 w 3387"/>
                  <a:gd name="T47" fmla="*/ 1006 h 3120"/>
                  <a:gd name="T48" fmla="*/ 1925 w 3387"/>
                  <a:gd name="T49" fmla="*/ 1348 h 3120"/>
                  <a:gd name="T50" fmla="*/ 1905 w 3387"/>
                  <a:gd name="T51" fmla="*/ 1233 h 3120"/>
                  <a:gd name="T52" fmla="*/ 1975 w 3387"/>
                  <a:gd name="T53" fmla="*/ 1542 h 3120"/>
                  <a:gd name="T54" fmla="*/ 2016 w 3387"/>
                  <a:gd name="T55" fmla="*/ 1521 h 3120"/>
                  <a:gd name="T56" fmla="*/ 1978 w 3387"/>
                  <a:gd name="T57" fmla="*/ 1547 h 3120"/>
                  <a:gd name="T58" fmla="*/ 2150 w 3387"/>
                  <a:gd name="T59" fmla="*/ 1719 h 3120"/>
                  <a:gd name="T60" fmla="*/ 2066 w 3387"/>
                  <a:gd name="T61" fmla="*/ 1636 h 3120"/>
                  <a:gd name="T62" fmla="*/ 2210 w 3387"/>
                  <a:gd name="T63" fmla="*/ 1971 h 3120"/>
                  <a:gd name="T64" fmla="*/ 2201 w 3387"/>
                  <a:gd name="T65" fmla="*/ 1854 h 3120"/>
                  <a:gd name="T66" fmla="*/ 2245 w 3387"/>
                  <a:gd name="T67" fmla="*/ 2177 h 3120"/>
                  <a:gd name="T68" fmla="*/ 2325 w 3387"/>
                  <a:gd name="T69" fmla="*/ 2291 h 3120"/>
                  <a:gd name="T70" fmla="*/ 2285 w 3387"/>
                  <a:gd name="T71" fmla="*/ 2315 h 3120"/>
                  <a:gd name="T72" fmla="*/ 2478 w 3387"/>
                  <a:gd name="T73" fmla="*/ 2546 h 3120"/>
                  <a:gd name="T74" fmla="*/ 2412 w 3387"/>
                  <a:gd name="T75" fmla="*/ 2481 h 3120"/>
                  <a:gd name="T76" fmla="*/ 2503 w 3387"/>
                  <a:gd name="T77" fmla="*/ 2575 h 3120"/>
                  <a:gd name="T78" fmla="*/ 2466 w 3387"/>
                  <a:gd name="T79" fmla="*/ 2536 h 3120"/>
                  <a:gd name="T80" fmla="*/ 2603 w 3387"/>
                  <a:gd name="T81" fmla="*/ 2638 h 3120"/>
                  <a:gd name="T82" fmla="*/ 2627 w 3387"/>
                  <a:gd name="T83" fmla="*/ 2600 h 3120"/>
                  <a:gd name="T84" fmla="*/ 2596 w 3387"/>
                  <a:gd name="T85" fmla="*/ 2634 h 3120"/>
                  <a:gd name="T86" fmla="*/ 2876 w 3387"/>
                  <a:gd name="T87" fmla="*/ 2792 h 3120"/>
                  <a:gd name="T88" fmla="*/ 2764 w 3387"/>
                  <a:gd name="T89" fmla="*/ 2757 h 3120"/>
                  <a:gd name="T90" fmla="*/ 3047 w 3387"/>
                  <a:gd name="T91" fmla="*/ 2985 h 3120"/>
                  <a:gd name="T92" fmla="*/ 2987 w 3387"/>
                  <a:gd name="T93" fmla="*/ 2884 h 3120"/>
                  <a:gd name="T94" fmla="*/ 3222 w 3387"/>
                  <a:gd name="T95" fmla="*/ 3064 h 3120"/>
                  <a:gd name="T96" fmla="*/ 3234 w 3387"/>
                  <a:gd name="T97" fmla="*/ 3020 h 3120"/>
                  <a:gd name="T98" fmla="*/ 3218 w 3387"/>
                  <a:gd name="T99" fmla="*/ 3063 h 3120"/>
                  <a:gd name="T100" fmla="*/ 3387 w 3387"/>
                  <a:gd name="T101" fmla="*/ 3076 h 3120"/>
                  <a:gd name="T102" fmla="*/ 3375 w 3387"/>
                  <a:gd name="T103" fmla="*/ 3072 h 3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</a:cxnLst>
                <a:rect l="0" t="0" r="r" b="b"/>
                <a:pathLst>
                  <a:path w="3387" h="3120">
                    <a:moveTo>
                      <a:pt x="0" y="3"/>
                    </a:moveTo>
                    <a:lnTo>
                      <a:pt x="92" y="3"/>
                    </a:lnTo>
                    <a:cubicBezTo>
                      <a:pt x="105" y="3"/>
                      <a:pt x="115" y="13"/>
                      <a:pt x="115" y="26"/>
                    </a:cubicBezTo>
                    <a:cubicBezTo>
                      <a:pt x="115" y="39"/>
                      <a:pt x="105" y="49"/>
                      <a:pt x="92" y="49"/>
                    </a:cubicBezTo>
                    <a:lnTo>
                      <a:pt x="0" y="49"/>
                    </a:lnTo>
                    <a:lnTo>
                      <a:pt x="0" y="3"/>
                    </a:lnTo>
                    <a:close/>
                    <a:moveTo>
                      <a:pt x="231" y="3"/>
                    </a:moveTo>
                    <a:lnTo>
                      <a:pt x="323" y="3"/>
                    </a:lnTo>
                    <a:cubicBezTo>
                      <a:pt x="335" y="3"/>
                      <a:pt x="346" y="13"/>
                      <a:pt x="346" y="26"/>
                    </a:cubicBezTo>
                    <a:cubicBezTo>
                      <a:pt x="346" y="39"/>
                      <a:pt x="335" y="49"/>
                      <a:pt x="323" y="49"/>
                    </a:cubicBezTo>
                    <a:lnTo>
                      <a:pt x="231" y="49"/>
                    </a:lnTo>
                    <a:cubicBezTo>
                      <a:pt x="218" y="49"/>
                      <a:pt x="208" y="39"/>
                      <a:pt x="208" y="26"/>
                    </a:cubicBezTo>
                    <a:cubicBezTo>
                      <a:pt x="208" y="13"/>
                      <a:pt x="218" y="3"/>
                      <a:pt x="231" y="3"/>
                    </a:cubicBezTo>
                    <a:close/>
                    <a:moveTo>
                      <a:pt x="461" y="3"/>
                    </a:moveTo>
                    <a:lnTo>
                      <a:pt x="553" y="3"/>
                    </a:lnTo>
                    <a:cubicBezTo>
                      <a:pt x="566" y="3"/>
                      <a:pt x="576" y="13"/>
                      <a:pt x="576" y="26"/>
                    </a:cubicBezTo>
                    <a:cubicBezTo>
                      <a:pt x="576" y="39"/>
                      <a:pt x="566" y="49"/>
                      <a:pt x="553" y="49"/>
                    </a:cubicBezTo>
                    <a:lnTo>
                      <a:pt x="461" y="49"/>
                    </a:lnTo>
                    <a:cubicBezTo>
                      <a:pt x="448" y="49"/>
                      <a:pt x="438" y="39"/>
                      <a:pt x="438" y="26"/>
                    </a:cubicBezTo>
                    <a:cubicBezTo>
                      <a:pt x="438" y="13"/>
                      <a:pt x="448" y="3"/>
                      <a:pt x="461" y="3"/>
                    </a:cubicBezTo>
                    <a:close/>
                    <a:moveTo>
                      <a:pt x="691" y="3"/>
                    </a:moveTo>
                    <a:lnTo>
                      <a:pt x="768" y="3"/>
                    </a:lnTo>
                    <a:cubicBezTo>
                      <a:pt x="781" y="3"/>
                      <a:pt x="791" y="13"/>
                      <a:pt x="791" y="26"/>
                    </a:cubicBezTo>
                    <a:cubicBezTo>
                      <a:pt x="791" y="39"/>
                      <a:pt x="781" y="49"/>
                      <a:pt x="768" y="49"/>
                    </a:cubicBezTo>
                    <a:lnTo>
                      <a:pt x="691" y="49"/>
                    </a:lnTo>
                    <a:cubicBezTo>
                      <a:pt x="679" y="49"/>
                      <a:pt x="668" y="39"/>
                      <a:pt x="668" y="26"/>
                    </a:cubicBezTo>
                    <a:cubicBezTo>
                      <a:pt x="668" y="13"/>
                      <a:pt x="679" y="3"/>
                      <a:pt x="691" y="3"/>
                    </a:cubicBezTo>
                    <a:close/>
                    <a:moveTo>
                      <a:pt x="776" y="4"/>
                    </a:moveTo>
                    <a:lnTo>
                      <a:pt x="791" y="10"/>
                    </a:lnTo>
                    <a:cubicBezTo>
                      <a:pt x="803" y="14"/>
                      <a:pt x="809" y="27"/>
                      <a:pt x="804" y="39"/>
                    </a:cubicBezTo>
                    <a:cubicBezTo>
                      <a:pt x="800" y="51"/>
                      <a:pt x="786" y="57"/>
                      <a:pt x="774" y="53"/>
                    </a:cubicBezTo>
                    <a:lnTo>
                      <a:pt x="760" y="47"/>
                    </a:lnTo>
                    <a:cubicBezTo>
                      <a:pt x="748" y="43"/>
                      <a:pt x="742" y="30"/>
                      <a:pt x="747" y="18"/>
                    </a:cubicBezTo>
                    <a:cubicBezTo>
                      <a:pt x="751" y="6"/>
                      <a:pt x="764" y="0"/>
                      <a:pt x="776" y="4"/>
                    </a:cubicBezTo>
                    <a:close/>
                    <a:moveTo>
                      <a:pt x="920" y="58"/>
                    </a:moveTo>
                    <a:lnTo>
                      <a:pt x="1006" y="91"/>
                    </a:lnTo>
                    <a:cubicBezTo>
                      <a:pt x="1018" y="95"/>
                      <a:pt x="1024" y="108"/>
                      <a:pt x="1020" y="120"/>
                    </a:cubicBezTo>
                    <a:cubicBezTo>
                      <a:pt x="1015" y="132"/>
                      <a:pt x="1002" y="138"/>
                      <a:pt x="990" y="134"/>
                    </a:cubicBezTo>
                    <a:lnTo>
                      <a:pt x="904" y="101"/>
                    </a:lnTo>
                    <a:cubicBezTo>
                      <a:pt x="892" y="97"/>
                      <a:pt x="886" y="84"/>
                      <a:pt x="890" y="72"/>
                    </a:cubicBezTo>
                    <a:cubicBezTo>
                      <a:pt x="895" y="60"/>
                      <a:pt x="908" y="54"/>
                      <a:pt x="920" y="58"/>
                    </a:cubicBezTo>
                    <a:close/>
                    <a:moveTo>
                      <a:pt x="1136" y="139"/>
                    </a:moveTo>
                    <a:lnTo>
                      <a:pt x="1222" y="170"/>
                    </a:lnTo>
                    <a:cubicBezTo>
                      <a:pt x="1234" y="175"/>
                      <a:pt x="1240" y="188"/>
                      <a:pt x="1236" y="200"/>
                    </a:cubicBezTo>
                    <a:cubicBezTo>
                      <a:pt x="1232" y="212"/>
                      <a:pt x="1218" y="218"/>
                      <a:pt x="1206" y="214"/>
                    </a:cubicBezTo>
                    <a:lnTo>
                      <a:pt x="1120" y="182"/>
                    </a:lnTo>
                    <a:cubicBezTo>
                      <a:pt x="1108" y="178"/>
                      <a:pt x="1102" y="164"/>
                      <a:pt x="1106" y="152"/>
                    </a:cubicBezTo>
                    <a:cubicBezTo>
                      <a:pt x="1111" y="140"/>
                      <a:pt x="1124" y="134"/>
                      <a:pt x="1136" y="139"/>
                    </a:cubicBezTo>
                    <a:close/>
                    <a:moveTo>
                      <a:pt x="1352" y="218"/>
                    </a:moveTo>
                    <a:lnTo>
                      <a:pt x="1390" y="232"/>
                    </a:lnTo>
                    <a:cubicBezTo>
                      <a:pt x="1402" y="236"/>
                      <a:pt x="1409" y="250"/>
                      <a:pt x="1404" y="262"/>
                    </a:cubicBezTo>
                    <a:cubicBezTo>
                      <a:pt x="1400" y="274"/>
                      <a:pt x="1387" y="280"/>
                      <a:pt x="1375" y="275"/>
                    </a:cubicBezTo>
                    <a:lnTo>
                      <a:pt x="1336" y="261"/>
                    </a:lnTo>
                    <a:cubicBezTo>
                      <a:pt x="1324" y="257"/>
                      <a:pt x="1318" y="244"/>
                      <a:pt x="1323" y="232"/>
                    </a:cubicBezTo>
                    <a:cubicBezTo>
                      <a:pt x="1327" y="220"/>
                      <a:pt x="1340" y="214"/>
                      <a:pt x="1352" y="218"/>
                    </a:cubicBezTo>
                    <a:close/>
                    <a:moveTo>
                      <a:pt x="1402" y="241"/>
                    </a:moveTo>
                    <a:lnTo>
                      <a:pt x="1430" y="283"/>
                    </a:lnTo>
                    <a:cubicBezTo>
                      <a:pt x="1437" y="294"/>
                      <a:pt x="1435" y="308"/>
                      <a:pt x="1424" y="315"/>
                    </a:cubicBezTo>
                    <a:cubicBezTo>
                      <a:pt x="1414" y="322"/>
                      <a:pt x="1399" y="320"/>
                      <a:pt x="1392" y="309"/>
                    </a:cubicBezTo>
                    <a:lnTo>
                      <a:pt x="1363" y="267"/>
                    </a:lnTo>
                    <a:cubicBezTo>
                      <a:pt x="1356" y="256"/>
                      <a:pt x="1359" y="242"/>
                      <a:pt x="1370" y="235"/>
                    </a:cubicBezTo>
                    <a:cubicBezTo>
                      <a:pt x="1380" y="228"/>
                      <a:pt x="1395" y="230"/>
                      <a:pt x="1402" y="241"/>
                    </a:cubicBezTo>
                    <a:close/>
                    <a:moveTo>
                      <a:pt x="1508" y="398"/>
                    </a:moveTo>
                    <a:lnTo>
                      <a:pt x="1555" y="469"/>
                    </a:lnTo>
                    <a:cubicBezTo>
                      <a:pt x="1562" y="479"/>
                      <a:pt x="1560" y="494"/>
                      <a:pt x="1549" y="501"/>
                    </a:cubicBezTo>
                    <a:cubicBezTo>
                      <a:pt x="1538" y="508"/>
                      <a:pt x="1524" y="505"/>
                      <a:pt x="1517" y="494"/>
                    </a:cubicBezTo>
                    <a:lnTo>
                      <a:pt x="1469" y="424"/>
                    </a:lnTo>
                    <a:cubicBezTo>
                      <a:pt x="1462" y="413"/>
                      <a:pt x="1465" y="399"/>
                      <a:pt x="1476" y="392"/>
                    </a:cubicBezTo>
                    <a:cubicBezTo>
                      <a:pt x="1486" y="385"/>
                      <a:pt x="1500" y="387"/>
                      <a:pt x="1508" y="398"/>
                    </a:cubicBezTo>
                    <a:close/>
                    <a:moveTo>
                      <a:pt x="1556" y="471"/>
                    </a:moveTo>
                    <a:lnTo>
                      <a:pt x="1560" y="477"/>
                    </a:lnTo>
                    <a:cubicBezTo>
                      <a:pt x="1566" y="488"/>
                      <a:pt x="1562" y="502"/>
                      <a:pt x="1550" y="508"/>
                    </a:cubicBezTo>
                    <a:cubicBezTo>
                      <a:pt x="1539" y="514"/>
                      <a:pt x="1525" y="510"/>
                      <a:pt x="1519" y="499"/>
                    </a:cubicBezTo>
                    <a:lnTo>
                      <a:pt x="1516" y="493"/>
                    </a:lnTo>
                    <a:cubicBezTo>
                      <a:pt x="1510" y="481"/>
                      <a:pt x="1514" y="467"/>
                      <a:pt x="1525" y="461"/>
                    </a:cubicBezTo>
                    <a:cubicBezTo>
                      <a:pt x="1536" y="455"/>
                      <a:pt x="1550" y="459"/>
                      <a:pt x="1556" y="471"/>
                    </a:cubicBezTo>
                    <a:close/>
                    <a:moveTo>
                      <a:pt x="1625" y="598"/>
                    </a:moveTo>
                    <a:lnTo>
                      <a:pt x="1669" y="679"/>
                    </a:lnTo>
                    <a:cubicBezTo>
                      <a:pt x="1675" y="691"/>
                      <a:pt x="1671" y="705"/>
                      <a:pt x="1660" y="711"/>
                    </a:cubicBezTo>
                    <a:cubicBezTo>
                      <a:pt x="1649" y="717"/>
                      <a:pt x="1635" y="712"/>
                      <a:pt x="1629" y="701"/>
                    </a:cubicBezTo>
                    <a:lnTo>
                      <a:pt x="1585" y="620"/>
                    </a:lnTo>
                    <a:cubicBezTo>
                      <a:pt x="1579" y="609"/>
                      <a:pt x="1583" y="595"/>
                      <a:pt x="1594" y="589"/>
                    </a:cubicBezTo>
                    <a:cubicBezTo>
                      <a:pt x="1605" y="583"/>
                      <a:pt x="1619" y="587"/>
                      <a:pt x="1625" y="598"/>
                    </a:cubicBezTo>
                    <a:close/>
                    <a:moveTo>
                      <a:pt x="1731" y="805"/>
                    </a:moveTo>
                    <a:lnTo>
                      <a:pt x="1766" y="891"/>
                    </a:lnTo>
                    <a:cubicBezTo>
                      <a:pt x="1771" y="902"/>
                      <a:pt x="1766" y="916"/>
                      <a:pt x="1754" y="921"/>
                    </a:cubicBezTo>
                    <a:cubicBezTo>
                      <a:pt x="1742" y="926"/>
                      <a:pt x="1729" y="920"/>
                      <a:pt x="1724" y="908"/>
                    </a:cubicBezTo>
                    <a:lnTo>
                      <a:pt x="1689" y="823"/>
                    </a:lnTo>
                    <a:cubicBezTo>
                      <a:pt x="1684" y="811"/>
                      <a:pt x="1689" y="798"/>
                      <a:pt x="1701" y="793"/>
                    </a:cubicBezTo>
                    <a:cubicBezTo>
                      <a:pt x="1713" y="788"/>
                      <a:pt x="1726" y="794"/>
                      <a:pt x="1731" y="805"/>
                    </a:cubicBezTo>
                    <a:close/>
                    <a:moveTo>
                      <a:pt x="1819" y="1018"/>
                    </a:moveTo>
                    <a:lnTo>
                      <a:pt x="1854" y="1104"/>
                    </a:lnTo>
                    <a:cubicBezTo>
                      <a:pt x="1859" y="1115"/>
                      <a:pt x="1854" y="1129"/>
                      <a:pt x="1842" y="1134"/>
                    </a:cubicBezTo>
                    <a:cubicBezTo>
                      <a:pt x="1830" y="1138"/>
                      <a:pt x="1817" y="1133"/>
                      <a:pt x="1812" y="1121"/>
                    </a:cubicBezTo>
                    <a:lnTo>
                      <a:pt x="1777" y="1036"/>
                    </a:lnTo>
                    <a:cubicBezTo>
                      <a:pt x="1772" y="1024"/>
                      <a:pt x="1777" y="1011"/>
                      <a:pt x="1789" y="1006"/>
                    </a:cubicBezTo>
                    <a:cubicBezTo>
                      <a:pt x="1801" y="1001"/>
                      <a:pt x="1814" y="1007"/>
                      <a:pt x="1819" y="1018"/>
                    </a:cubicBezTo>
                    <a:close/>
                    <a:moveTo>
                      <a:pt x="1905" y="1233"/>
                    </a:moveTo>
                    <a:lnTo>
                      <a:pt x="1938" y="1319"/>
                    </a:lnTo>
                    <a:cubicBezTo>
                      <a:pt x="1943" y="1331"/>
                      <a:pt x="1937" y="1344"/>
                      <a:pt x="1925" y="1348"/>
                    </a:cubicBezTo>
                    <a:cubicBezTo>
                      <a:pt x="1913" y="1353"/>
                      <a:pt x="1900" y="1347"/>
                      <a:pt x="1895" y="1335"/>
                    </a:cubicBezTo>
                    <a:lnTo>
                      <a:pt x="1862" y="1249"/>
                    </a:lnTo>
                    <a:cubicBezTo>
                      <a:pt x="1858" y="1237"/>
                      <a:pt x="1863" y="1224"/>
                      <a:pt x="1875" y="1220"/>
                    </a:cubicBezTo>
                    <a:cubicBezTo>
                      <a:pt x="1887" y="1215"/>
                      <a:pt x="1901" y="1221"/>
                      <a:pt x="1905" y="1233"/>
                    </a:cubicBezTo>
                    <a:close/>
                    <a:moveTo>
                      <a:pt x="1988" y="1448"/>
                    </a:moveTo>
                    <a:lnTo>
                      <a:pt x="2018" y="1525"/>
                    </a:lnTo>
                    <a:cubicBezTo>
                      <a:pt x="2023" y="1537"/>
                      <a:pt x="2017" y="1551"/>
                      <a:pt x="2005" y="1555"/>
                    </a:cubicBezTo>
                    <a:cubicBezTo>
                      <a:pt x="1993" y="1560"/>
                      <a:pt x="1980" y="1554"/>
                      <a:pt x="1975" y="1542"/>
                    </a:cubicBezTo>
                    <a:lnTo>
                      <a:pt x="1945" y="1464"/>
                    </a:lnTo>
                    <a:cubicBezTo>
                      <a:pt x="1941" y="1452"/>
                      <a:pt x="1947" y="1439"/>
                      <a:pt x="1958" y="1434"/>
                    </a:cubicBezTo>
                    <a:cubicBezTo>
                      <a:pt x="1970" y="1430"/>
                      <a:pt x="1984" y="1436"/>
                      <a:pt x="1988" y="1448"/>
                    </a:cubicBezTo>
                    <a:close/>
                    <a:moveTo>
                      <a:pt x="2016" y="1521"/>
                    </a:moveTo>
                    <a:lnTo>
                      <a:pt x="2021" y="1528"/>
                    </a:lnTo>
                    <a:cubicBezTo>
                      <a:pt x="2028" y="1539"/>
                      <a:pt x="2025" y="1553"/>
                      <a:pt x="2015" y="1560"/>
                    </a:cubicBezTo>
                    <a:cubicBezTo>
                      <a:pt x="2004" y="1567"/>
                      <a:pt x="1990" y="1564"/>
                      <a:pt x="1983" y="1554"/>
                    </a:cubicBezTo>
                    <a:lnTo>
                      <a:pt x="1978" y="1547"/>
                    </a:lnTo>
                    <a:cubicBezTo>
                      <a:pt x="1971" y="1536"/>
                      <a:pt x="1974" y="1522"/>
                      <a:pt x="1984" y="1515"/>
                    </a:cubicBezTo>
                    <a:cubicBezTo>
                      <a:pt x="1995" y="1508"/>
                      <a:pt x="2009" y="1510"/>
                      <a:pt x="2016" y="1521"/>
                    </a:cubicBezTo>
                    <a:close/>
                    <a:moveTo>
                      <a:pt x="2098" y="1643"/>
                    </a:moveTo>
                    <a:lnTo>
                      <a:pt x="2150" y="1719"/>
                    </a:lnTo>
                    <a:cubicBezTo>
                      <a:pt x="2157" y="1730"/>
                      <a:pt x="2154" y="1744"/>
                      <a:pt x="2143" y="1751"/>
                    </a:cubicBezTo>
                    <a:cubicBezTo>
                      <a:pt x="2133" y="1758"/>
                      <a:pt x="2119" y="1755"/>
                      <a:pt x="2111" y="1745"/>
                    </a:cubicBezTo>
                    <a:lnTo>
                      <a:pt x="2060" y="1668"/>
                    </a:lnTo>
                    <a:cubicBezTo>
                      <a:pt x="2053" y="1658"/>
                      <a:pt x="2056" y="1644"/>
                      <a:pt x="2066" y="1636"/>
                    </a:cubicBezTo>
                    <a:cubicBezTo>
                      <a:pt x="2077" y="1629"/>
                      <a:pt x="2091" y="1632"/>
                      <a:pt x="2098" y="1643"/>
                    </a:cubicBezTo>
                    <a:close/>
                    <a:moveTo>
                      <a:pt x="2201" y="1854"/>
                    </a:moveTo>
                    <a:lnTo>
                      <a:pt x="2226" y="1943"/>
                    </a:lnTo>
                    <a:cubicBezTo>
                      <a:pt x="2229" y="1955"/>
                      <a:pt x="2222" y="1968"/>
                      <a:pt x="2210" y="1971"/>
                    </a:cubicBezTo>
                    <a:cubicBezTo>
                      <a:pt x="2198" y="1974"/>
                      <a:pt x="2185" y="1967"/>
                      <a:pt x="2182" y="1955"/>
                    </a:cubicBezTo>
                    <a:lnTo>
                      <a:pt x="2156" y="1866"/>
                    </a:lnTo>
                    <a:cubicBezTo>
                      <a:pt x="2153" y="1854"/>
                      <a:pt x="2160" y="1842"/>
                      <a:pt x="2172" y="1838"/>
                    </a:cubicBezTo>
                    <a:cubicBezTo>
                      <a:pt x="2185" y="1835"/>
                      <a:pt x="2197" y="1842"/>
                      <a:pt x="2201" y="1854"/>
                    </a:cubicBezTo>
                    <a:close/>
                    <a:moveTo>
                      <a:pt x="2264" y="2076"/>
                    </a:moveTo>
                    <a:lnTo>
                      <a:pt x="2289" y="2164"/>
                    </a:lnTo>
                    <a:cubicBezTo>
                      <a:pt x="2292" y="2176"/>
                      <a:pt x="2285" y="2189"/>
                      <a:pt x="2273" y="2193"/>
                    </a:cubicBezTo>
                    <a:cubicBezTo>
                      <a:pt x="2261" y="2196"/>
                      <a:pt x="2248" y="2189"/>
                      <a:pt x="2245" y="2177"/>
                    </a:cubicBezTo>
                    <a:lnTo>
                      <a:pt x="2219" y="2088"/>
                    </a:lnTo>
                    <a:cubicBezTo>
                      <a:pt x="2216" y="2076"/>
                      <a:pt x="2223" y="2063"/>
                      <a:pt x="2235" y="2060"/>
                    </a:cubicBezTo>
                    <a:cubicBezTo>
                      <a:pt x="2248" y="2056"/>
                      <a:pt x="2260" y="2063"/>
                      <a:pt x="2264" y="2076"/>
                    </a:cubicBezTo>
                    <a:close/>
                    <a:moveTo>
                      <a:pt x="2325" y="2291"/>
                    </a:moveTo>
                    <a:lnTo>
                      <a:pt x="2372" y="2370"/>
                    </a:lnTo>
                    <a:cubicBezTo>
                      <a:pt x="2379" y="2381"/>
                      <a:pt x="2375" y="2395"/>
                      <a:pt x="2364" y="2402"/>
                    </a:cubicBezTo>
                    <a:cubicBezTo>
                      <a:pt x="2353" y="2409"/>
                      <a:pt x="2339" y="2405"/>
                      <a:pt x="2333" y="2394"/>
                    </a:cubicBezTo>
                    <a:lnTo>
                      <a:pt x="2285" y="2315"/>
                    </a:lnTo>
                    <a:cubicBezTo>
                      <a:pt x="2279" y="2304"/>
                      <a:pt x="2282" y="2290"/>
                      <a:pt x="2293" y="2283"/>
                    </a:cubicBezTo>
                    <a:cubicBezTo>
                      <a:pt x="2304" y="2277"/>
                      <a:pt x="2318" y="2280"/>
                      <a:pt x="2325" y="2291"/>
                    </a:cubicBezTo>
                    <a:close/>
                    <a:moveTo>
                      <a:pt x="2443" y="2489"/>
                    </a:moveTo>
                    <a:lnTo>
                      <a:pt x="2478" y="2546"/>
                    </a:lnTo>
                    <a:cubicBezTo>
                      <a:pt x="2484" y="2557"/>
                      <a:pt x="2481" y="2571"/>
                      <a:pt x="2470" y="2578"/>
                    </a:cubicBezTo>
                    <a:cubicBezTo>
                      <a:pt x="2459" y="2584"/>
                      <a:pt x="2445" y="2581"/>
                      <a:pt x="2438" y="2570"/>
                    </a:cubicBezTo>
                    <a:lnTo>
                      <a:pt x="2404" y="2513"/>
                    </a:lnTo>
                    <a:cubicBezTo>
                      <a:pt x="2397" y="2502"/>
                      <a:pt x="2401" y="2488"/>
                      <a:pt x="2412" y="2481"/>
                    </a:cubicBezTo>
                    <a:cubicBezTo>
                      <a:pt x="2423" y="2475"/>
                      <a:pt x="2437" y="2478"/>
                      <a:pt x="2443" y="2489"/>
                    </a:cubicBezTo>
                    <a:close/>
                    <a:moveTo>
                      <a:pt x="2466" y="2536"/>
                    </a:moveTo>
                    <a:lnTo>
                      <a:pt x="2490" y="2545"/>
                    </a:lnTo>
                    <a:cubicBezTo>
                      <a:pt x="2502" y="2550"/>
                      <a:pt x="2508" y="2563"/>
                      <a:pt x="2503" y="2575"/>
                    </a:cubicBezTo>
                    <a:cubicBezTo>
                      <a:pt x="2499" y="2587"/>
                      <a:pt x="2485" y="2593"/>
                      <a:pt x="2474" y="2588"/>
                    </a:cubicBezTo>
                    <a:lnTo>
                      <a:pt x="2449" y="2579"/>
                    </a:lnTo>
                    <a:cubicBezTo>
                      <a:pt x="2438" y="2575"/>
                      <a:pt x="2432" y="2561"/>
                      <a:pt x="2436" y="2549"/>
                    </a:cubicBezTo>
                    <a:cubicBezTo>
                      <a:pt x="2441" y="2538"/>
                      <a:pt x="2454" y="2532"/>
                      <a:pt x="2466" y="2536"/>
                    </a:cubicBezTo>
                    <a:close/>
                    <a:moveTo>
                      <a:pt x="2619" y="2595"/>
                    </a:moveTo>
                    <a:lnTo>
                      <a:pt x="2620" y="2595"/>
                    </a:lnTo>
                    <a:cubicBezTo>
                      <a:pt x="2631" y="2600"/>
                      <a:pt x="2637" y="2613"/>
                      <a:pt x="2633" y="2625"/>
                    </a:cubicBezTo>
                    <a:cubicBezTo>
                      <a:pt x="2628" y="2637"/>
                      <a:pt x="2615" y="2643"/>
                      <a:pt x="2603" y="2638"/>
                    </a:cubicBezTo>
                    <a:lnTo>
                      <a:pt x="2603" y="2638"/>
                    </a:lnTo>
                    <a:cubicBezTo>
                      <a:pt x="2591" y="2633"/>
                      <a:pt x="2585" y="2620"/>
                      <a:pt x="2589" y="2608"/>
                    </a:cubicBezTo>
                    <a:cubicBezTo>
                      <a:pt x="2594" y="2596"/>
                      <a:pt x="2607" y="2590"/>
                      <a:pt x="2619" y="2595"/>
                    </a:cubicBezTo>
                    <a:close/>
                    <a:moveTo>
                      <a:pt x="2627" y="2600"/>
                    </a:moveTo>
                    <a:lnTo>
                      <a:pt x="2694" y="2662"/>
                    </a:lnTo>
                    <a:cubicBezTo>
                      <a:pt x="2704" y="2670"/>
                      <a:pt x="2704" y="2685"/>
                      <a:pt x="2696" y="2694"/>
                    </a:cubicBezTo>
                    <a:cubicBezTo>
                      <a:pt x="2687" y="2704"/>
                      <a:pt x="2673" y="2704"/>
                      <a:pt x="2663" y="2696"/>
                    </a:cubicBezTo>
                    <a:lnTo>
                      <a:pt x="2596" y="2634"/>
                    </a:lnTo>
                    <a:cubicBezTo>
                      <a:pt x="2586" y="2625"/>
                      <a:pt x="2586" y="2610"/>
                      <a:pt x="2594" y="2601"/>
                    </a:cubicBezTo>
                    <a:cubicBezTo>
                      <a:pt x="2603" y="2592"/>
                      <a:pt x="2618" y="2591"/>
                      <a:pt x="2627" y="2600"/>
                    </a:cubicBezTo>
                    <a:close/>
                    <a:moveTo>
                      <a:pt x="2795" y="2748"/>
                    </a:moveTo>
                    <a:lnTo>
                      <a:pt x="2876" y="2792"/>
                    </a:lnTo>
                    <a:cubicBezTo>
                      <a:pt x="2887" y="2798"/>
                      <a:pt x="2891" y="2812"/>
                      <a:pt x="2885" y="2823"/>
                    </a:cubicBezTo>
                    <a:cubicBezTo>
                      <a:pt x="2879" y="2834"/>
                      <a:pt x="2865" y="2839"/>
                      <a:pt x="2853" y="2832"/>
                    </a:cubicBezTo>
                    <a:lnTo>
                      <a:pt x="2773" y="2788"/>
                    </a:lnTo>
                    <a:cubicBezTo>
                      <a:pt x="2762" y="2782"/>
                      <a:pt x="2757" y="2768"/>
                      <a:pt x="2764" y="2757"/>
                    </a:cubicBezTo>
                    <a:cubicBezTo>
                      <a:pt x="2770" y="2746"/>
                      <a:pt x="2784" y="2741"/>
                      <a:pt x="2795" y="2748"/>
                    </a:cubicBezTo>
                    <a:close/>
                    <a:moveTo>
                      <a:pt x="2987" y="2884"/>
                    </a:moveTo>
                    <a:lnTo>
                      <a:pt x="3048" y="2952"/>
                    </a:lnTo>
                    <a:cubicBezTo>
                      <a:pt x="3057" y="2962"/>
                      <a:pt x="3056" y="2976"/>
                      <a:pt x="3047" y="2985"/>
                    </a:cubicBezTo>
                    <a:cubicBezTo>
                      <a:pt x="3037" y="2993"/>
                      <a:pt x="3022" y="2992"/>
                      <a:pt x="3014" y="2983"/>
                    </a:cubicBezTo>
                    <a:lnTo>
                      <a:pt x="2953" y="2914"/>
                    </a:lnTo>
                    <a:cubicBezTo>
                      <a:pt x="2944" y="2905"/>
                      <a:pt x="2945" y="2890"/>
                      <a:pt x="2954" y="2882"/>
                    </a:cubicBezTo>
                    <a:cubicBezTo>
                      <a:pt x="2964" y="2873"/>
                      <a:pt x="2978" y="2874"/>
                      <a:pt x="2987" y="2884"/>
                    </a:cubicBezTo>
                    <a:close/>
                    <a:moveTo>
                      <a:pt x="3152" y="3005"/>
                    </a:moveTo>
                    <a:lnTo>
                      <a:pt x="3230" y="3019"/>
                    </a:lnTo>
                    <a:cubicBezTo>
                      <a:pt x="3242" y="3021"/>
                      <a:pt x="3251" y="3033"/>
                      <a:pt x="3248" y="3046"/>
                    </a:cubicBezTo>
                    <a:cubicBezTo>
                      <a:pt x="3246" y="3058"/>
                      <a:pt x="3234" y="3067"/>
                      <a:pt x="3222" y="3064"/>
                    </a:cubicBezTo>
                    <a:lnTo>
                      <a:pt x="3144" y="3050"/>
                    </a:lnTo>
                    <a:cubicBezTo>
                      <a:pt x="3131" y="3048"/>
                      <a:pt x="3123" y="3036"/>
                      <a:pt x="3125" y="3023"/>
                    </a:cubicBezTo>
                    <a:cubicBezTo>
                      <a:pt x="3127" y="3011"/>
                      <a:pt x="3139" y="3002"/>
                      <a:pt x="3152" y="3005"/>
                    </a:cubicBezTo>
                    <a:close/>
                    <a:moveTo>
                      <a:pt x="3234" y="3020"/>
                    </a:moveTo>
                    <a:lnTo>
                      <a:pt x="3246" y="3024"/>
                    </a:lnTo>
                    <a:cubicBezTo>
                      <a:pt x="3258" y="3029"/>
                      <a:pt x="3264" y="3042"/>
                      <a:pt x="3259" y="3054"/>
                    </a:cubicBezTo>
                    <a:cubicBezTo>
                      <a:pt x="3255" y="3066"/>
                      <a:pt x="3242" y="3072"/>
                      <a:pt x="3230" y="3068"/>
                    </a:cubicBezTo>
                    <a:lnTo>
                      <a:pt x="3218" y="3063"/>
                    </a:lnTo>
                    <a:cubicBezTo>
                      <a:pt x="3206" y="3059"/>
                      <a:pt x="3200" y="3046"/>
                      <a:pt x="3204" y="3034"/>
                    </a:cubicBezTo>
                    <a:cubicBezTo>
                      <a:pt x="3208" y="3022"/>
                      <a:pt x="3222" y="3016"/>
                      <a:pt x="3234" y="3020"/>
                    </a:cubicBezTo>
                    <a:close/>
                    <a:moveTo>
                      <a:pt x="3375" y="3072"/>
                    </a:moveTo>
                    <a:lnTo>
                      <a:pt x="3387" y="3076"/>
                    </a:lnTo>
                    <a:lnTo>
                      <a:pt x="3371" y="3120"/>
                    </a:lnTo>
                    <a:lnTo>
                      <a:pt x="3360" y="3115"/>
                    </a:lnTo>
                    <a:cubicBezTo>
                      <a:pt x="3348" y="3111"/>
                      <a:pt x="3342" y="3098"/>
                      <a:pt x="3346" y="3086"/>
                    </a:cubicBezTo>
                    <a:cubicBezTo>
                      <a:pt x="3350" y="3074"/>
                      <a:pt x="3364" y="3068"/>
                      <a:pt x="3375" y="3072"/>
                    </a:cubicBezTo>
                    <a:close/>
                  </a:path>
                </a:pathLst>
              </a:custGeom>
              <a:solidFill>
                <a:srgbClr val="FF0000"/>
              </a:solidFill>
              <a:ln w="1588" cap="flat">
                <a:solidFill>
                  <a:srgbClr val="FF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0" name="Rectangle 261"/>
              <p:cNvSpPr>
                <a:spLocks noChangeArrowheads="1"/>
              </p:cNvSpPr>
              <p:nvPr/>
            </p:nvSpPr>
            <p:spPr bwMode="auto">
              <a:xfrm>
                <a:off x="2800" y="2122"/>
                <a:ext cx="9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2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1" name="Line 262"/>
              <p:cNvSpPr>
                <a:spLocks noChangeShapeType="1"/>
              </p:cNvSpPr>
              <p:nvPr/>
            </p:nvSpPr>
            <p:spPr bwMode="auto">
              <a:xfrm>
                <a:off x="2676" y="2160"/>
                <a:ext cx="80" cy="0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2" name="Rectangle 263"/>
              <p:cNvSpPr>
                <a:spLocks noChangeArrowheads="1"/>
              </p:cNvSpPr>
              <p:nvPr/>
            </p:nvSpPr>
            <p:spPr bwMode="auto">
              <a:xfrm>
                <a:off x="2800" y="2224"/>
                <a:ext cx="64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2;</a:t>
                </a:r>
                <a:r>
                  <a:rPr kumimoji="0" lang="en-US" altLang="el-GR" sz="9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RNAi)</a:t>
                </a:r>
                <a:r>
                  <a:rPr kumimoji="0" lang="en-US" altLang="el-GR" sz="900" b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/EV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5" name="Line 266"/>
              <p:cNvSpPr>
                <a:spLocks noChangeShapeType="1"/>
              </p:cNvSpPr>
              <p:nvPr/>
            </p:nvSpPr>
            <p:spPr bwMode="auto">
              <a:xfrm>
                <a:off x="2676" y="2259"/>
                <a:ext cx="80" cy="0"/>
              </a:xfrm>
              <a:prstGeom prst="line">
                <a:avLst/>
              </a:prstGeom>
              <a:noFill/>
              <a:ln w="17463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6" name="Rectangle 267"/>
              <p:cNvSpPr>
                <a:spLocks noChangeArrowheads="1"/>
              </p:cNvSpPr>
              <p:nvPr/>
            </p:nvSpPr>
            <p:spPr bwMode="auto">
              <a:xfrm>
                <a:off x="2800" y="2330"/>
                <a:ext cx="63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N2;</a:t>
                </a:r>
                <a:r>
                  <a:rPr kumimoji="0" lang="en-US" altLang="el-GR" sz="9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bec</a:t>
                </a:r>
                <a:r>
                  <a:rPr lang="en-US" altLang="el-GR" sz="900" i="1" dirty="0" smtClean="0">
                    <a:solidFill>
                      <a:srgbClr val="000000"/>
                    </a:solidFill>
                  </a:rPr>
                  <a:t>-1(RNAi)</a:t>
                </a:r>
                <a:r>
                  <a:rPr lang="en-US" altLang="el-GR" sz="900" dirty="0" smtClean="0">
                    <a:solidFill>
                      <a:srgbClr val="000000"/>
                    </a:solidFill>
                  </a:rPr>
                  <a:t>/EV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9" name="Freeform 270"/>
              <p:cNvSpPr>
                <a:spLocks noEditPoints="1"/>
              </p:cNvSpPr>
              <p:nvPr/>
            </p:nvSpPr>
            <p:spPr bwMode="auto">
              <a:xfrm>
                <a:off x="2676" y="2359"/>
                <a:ext cx="79" cy="11"/>
              </a:xfrm>
              <a:custGeom>
                <a:avLst/>
                <a:gdLst>
                  <a:gd name="T0" fmla="*/ 0 w 323"/>
                  <a:gd name="T1" fmla="*/ 0 h 46"/>
                  <a:gd name="T2" fmla="*/ 92 w 323"/>
                  <a:gd name="T3" fmla="*/ 0 h 46"/>
                  <a:gd name="T4" fmla="*/ 115 w 323"/>
                  <a:gd name="T5" fmla="*/ 23 h 46"/>
                  <a:gd name="T6" fmla="*/ 92 w 323"/>
                  <a:gd name="T7" fmla="*/ 46 h 46"/>
                  <a:gd name="T8" fmla="*/ 0 w 323"/>
                  <a:gd name="T9" fmla="*/ 46 h 46"/>
                  <a:gd name="T10" fmla="*/ 0 w 323"/>
                  <a:gd name="T11" fmla="*/ 0 h 46"/>
                  <a:gd name="T12" fmla="*/ 230 w 323"/>
                  <a:gd name="T13" fmla="*/ 0 h 46"/>
                  <a:gd name="T14" fmla="*/ 323 w 323"/>
                  <a:gd name="T15" fmla="*/ 0 h 46"/>
                  <a:gd name="T16" fmla="*/ 323 w 323"/>
                  <a:gd name="T17" fmla="*/ 46 h 46"/>
                  <a:gd name="T18" fmla="*/ 230 w 323"/>
                  <a:gd name="T19" fmla="*/ 46 h 46"/>
                  <a:gd name="T20" fmla="*/ 207 w 323"/>
                  <a:gd name="T21" fmla="*/ 23 h 46"/>
                  <a:gd name="T22" fmla="*/ 230 w 323"/>
                  <a:gd name="T2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23" h="46">
                    <a:moveTo>
                      <a:pt x="0" y="0"/>
                    </a:moveTo>
                    <a:lnTo>
                      <a:pt x="92" y="0"/>
                    </a:lnTo>
                    <a:cubicBezTo>
                      <a:pt x="105" y="0"/>
                      <a:pt x="115" y="10"/>
                      <a:pt x="115" y="23"/>
                    </a:cubicBezTo>
                    <a:cubicBezTo>
                      <a:pt x="115" y="36"/>
                      <a:pt x="105" y="46"/>
                      <a:pt x="92" y="46"/>
                    </a:cubicBezTo>
                    <a:lnTo>
                      <a:pt x="0" y="46"/>
                    </a:lnTo>
                    <a:lnTo>
                      <a:pt x="0" y="0"/>
                    </a:lnTo>
                    <a:close/>
                    <a:moveTo>
                      <a:pt x="230" y="0"/>
                    </a:moveTo>
                    <a:lnTo>
                      <a:pt x="323" y="0"/>
                    </a:lnTo>
                    <a:lnTo>
                      <a:pt x="323" y="46"/>
                    </a:lnTo>
                    <a:lnTo>
                      <a:pt x="230" y="46"/>
                    </a:lnTo>
                    <a:cubicBezTo>
                      <a:pt x="218" y="46"/>
                      <a:pt x="207" y="36"/>
                      <a:pt x="207" y="23"/>
                    </a:cubicBezTo>
                    <a:cubicBezTo>
                      <a:pt x="207" y="10"/>
                      <a:pt x="218" y="0"/>
                      <a:pt x="230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50" name="Rectangle 271"/>
              <p:cNvSpPr>
                <a:spLocks noChangeArrowheads="1"/>
              </p:cNvSpPr>
              <p:nvPr/>
            </p:nvSpPr>
            <p:spPr bwMode="auto">
              <a:xfrm>
                <a:off x="2800" y="2427"/>
                <a:ext cx="72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2;</a:t>
                </a:r>
                <a:r>
                  <a:rPr kumimoji="0" lang="en-US" altLang="el-GR" sz="9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bec-1</a:t>
                </a:r>
                <a:r>
                  <a:rPr kumimoji="0" lang="en-US" altLang="el-GR" sz="900" b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;</a:t>
                </a:r>
                <a:r>
                  <a:rPr kumimoji="0" lang="en-US" altLang="el-GR" sz="9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RNAi)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4" name="Freeform 275"/>
              <p:cNvSpPr>
                <a:spLocks noEditPoints="1"/>
              </p:cNvSpPr>
              <p:nvPr/>
            </p:nvSpPr>
            <p:spPr bwMode="auto">
              <a:xfrm>
                <a:off x="2676" y="2457"/>
                <a:ext cx="79" cy="11"/>
              </a:xfrm>
              <a:custGeom>
                <a:avLst/>
                <a:gdLst>
                  <a:gd name="T0" fmla="*/ 0 w 323"/>
                  <a:gd name="T1" fmla="*/ 0 h 46"/>
                  <a:gd name="T2" fmla="*/ 92 w 323"/>
                  <a:gd name="T3" fmla="*/ 0 h 46"/>
                  <a:gd name="T4" fmla="*/ 115 w 323"/>
                  <a:gd name="T5" fmla="*/ 23 h 46"/>
                  <a:gd name="T6" fmla="*/ 92 w 323"/>
                  <a:gd name="T7" fmla="*/ 46 h 46"/>
                  <a:gd name="T8" fmla="*/ 0 w 323"/>
                  <a:gd name="T9" fmla="*/ 46 h 46"/>
                  <a:gd name="T10" fmla="*/ 0 w 323"/>
                  <a:gd name="T11" fmla="*/ 0 h 46"/>
                  <a:gd name="T12" fmla="*/ 230 w 323"/>
                  <a:gd name="T13" fmla="*/ 0 h 46"/>
                  <a:gd name="T14" fmla="*/ 323 w 323"/>
                  <a:gd name="T15" fmla="*/ 0 h 46"/>
                  <a:gd name="T16" fmla="*/ 323 w 323"/>
                  <a:gd name="T17" fmla="*/ 46 h 46"/>
                  <a:gd name="T18" fmla="*/ 230 w 323"/>
                  <a:gd name="T19" fmla="*/ 46 h 46"/>
                  <a:gd name="T20" fmla="*/ 207 w 323"/>
                  <a:gd name="T21" fmla="*/ 23 h 46"/>
                  <a:gd name="T22" fmla="*/ 230 w 323"/>
                  <a:gd name="T2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23" h="46">
                    <a:moveTo>
                      <a:pt x="0" y="0"/>
                    </a:moveTo>
                    <a:lnTo>
                      <a:pt x="92" y="0"/>
                    </a:lnTo>
                    <a:cubicBezTo>
                      <a:pt x="105" y="0"/>
                      <a:pt x="115" y="10"/>
                      <a:pt x="115" y="23"/>
                    </a:cubicBezTo>
                    <a:cubicBezTo>
                      <a:pt x="115" y="35"/>
                      <a:pt x="105" y="46"/>
                      <a:pt x="92" y="46"/>
                    </a:cubicBezTo>
                    <a:lnTo>
                      <a:pt x="0" y="46"/>
                    </a:lnTo>
                    <a:lnTo>
                      <a:pt x="0" y="0"/>
                    </a:lnTo>
                    <a:close/>
                    <a:moveTo>
                      <a:pt x="230" y="0"/>
                    </a:moveTo>
                    <a:lnTo>
                      <a:pt x="323" y="0"/>
                    </a:lnTo>
                    <a:lnTo>
                      <a:pt x="323" y="46"/>
                    </a:lnTo>
                    <a:lnTo>
                      <a:pt x="230" y="46"/>
                    </a:lnTo>
                    <a:cubicBezTo>
                      <a:pt x="218" y="46"/>
                      <a:pt x="207" y="35"/>
                      <a:pt x="207" y="23"/>
                    </a:cubicBezTo>
                    <a:cubicBezTo>
                      <a:pt x="207" y="10"/>
                      <a:pt x="218" y="0"/>
                      <a:pt x="230" y="0"/>
                    </a:cubicBezTo>
                    <a:close/>
                  </a:path>
                </a:pathLst>
              </a:custGeom>
              <a:solidFill>
                <a:srgbClr val="FF0000"/>
              </a:solidFill>
              <a:ln w="1588" cap="flat">
                <a:solidFill>
                  <a:srgbClr val="FF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55" name="Rectangle 276"/>
              <p:cNvSpPr>
                <a:spLocks noChangeArrowheads="1"/>
              </p:cNvSpPr>
              <p:nvPr/>
            </p:nvSpPr>
            <p:spPr bwMode="auto">
              <a:xfrm>
                <a:off x="2285" y="3025"/>
                <a:ext cx="71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ays</a:t>
                </a:r>
                <a:r>
                  <a:rPr kumimoji="0" lang="el-GR" altLang="el-G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f </a:t>
                </a:r>
                <a:r>
                  <a:rPr kumimoji="0" lang="el-GR" altLang="el-G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dulthood</a:t>
                </a:r>
                <a:endParaRPr kumimoji="0" lang="el-GR" altLang="el-GR" sz="2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256" name="TextBox 255"/>
            <p:cNvSpPr txBox="1"/>
            <p:nvPr/>
          </p:nvSpPr>
          <p:spPr>
            <a:xfrm rot="16200000">
              <a:off x="2881126" y="3506976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 rot="16200000">
              <a:off x="2556037" y="6014514"/>
              <a:ext cx="166904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umber of GFP::LGG-1</a:t>
              </a:r>
            </a:p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uncta per seam cel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TextBox 258"/>
            <p:cNvSpPr txBox="1"/>
            <p:nvPr/>
          </p:nvSpPr>
          <p:spPr>
            <a:xfrm rot="19800000">
              <a:off x="3546114" y="7002430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l-G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TextBox 259"/>
            <p:cNvSpPr txBox="1"/>
            <p:nvPr/>
          </p:nvSpPr>
          <p:spPr>
            <a:xfrm rot="19800000">
              <a:off x="3606133" y="7081622"/>
              <a:ext cx="8643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sd-1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TextBox 260"/>
            <p:cNvSpPr txBox="1"/>
            <p:nvPr/>
          </p:nvSpPr>
          <p:spPr>
            <a:xfrm rot="19800000">
              <a:off x="3952233" y="7081621"/>
              <a:ext cx="8451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d-9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TextBox 261"/>
            <p:cNvSpPr txBox="1"/>
            <p:nvPr/>
          </p:nvSpPr>
          <p:spPr>
            <a:xfrm rot="19800000">
              <a:off x="4021782" y="7154399"/>
              <a:ext cx="11849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sd-1;ced-9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 rot="19800000">
              <a:off x="4701567" y="7085147"/>
              <a:ext cx="8194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c-1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012080" y="4931650"/>
              <a:ext cx="129715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f-2(e1370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; </a:t>
              </a:r>
              <a:endParaRPr lang="en-U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p</a:t>
              </a:r>
              <a:r>
                <a:rPr lang="en-US" sz="1000" b="1" i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g-1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::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G-1)</a:t>
              </a:r>
              <a:endParaRPr lang="el-G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97" name="Ομάδα 796"/>
            <p:cNvGrpSpPr/>
            <p:nvPr/>
          </p:nvGrpSpPr>
          <p:grpSpPr>
            <a:xfrm>
              <a:off x="3590475" y="5461852"/>
              <a:ext cx="1997075" cy="1518386"/>
              <a:chOff x="6359525" y="5488125"/>
              <a:chExt cx="1997075" cy="1518386"/>
            </a:xfrm>
          </p:grpSpPr>
          <p:sp>
            <p:nvSpPr>
              <p:cNvPr id="594" name="Rectangle 5"/>
              <p:cNvSpPr>
                <a:spLocks noChangeArrowheads="1"/>
              </p:cNvSpPr>
              <p:nvPr/>
            </p:nvSpPr>
            <p:spPr bwMode="auto">
              <a:xfrm>
                <a:off x="8048625" y="6748463"/>
                <a:ext cx="241300" cy="192087"/>
              </a:xfrm>
              <a:prstGeom prst="rect">
                <a:avLst/>
              </a:prstGeom>
              <a:solidFill>
                <a:srgbClr val="A0A0A4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96" name="Rectangle 7"/>
              <p:cNvSpPr>
                <a:spLocks noChangeArrowheads="1"/>
              </p:cNvSpPr>
              <p:nvPr/>
            </p:nvSpPr>
            <p:spPr bwMode="auto">
              <a:xfrm>
                <a:off x="7685088" y="6300788"/>
                <a:ext cx="241300" cy="639762"/>
              </a:xfrm>
              <a:prstGeom prst="rect">
                <a:avLst/>
              </a:prstGeom>
              <a:solidFill>
                <a:srgbClr val="A0A0A4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98" name="Rectangle 9"/>
              <p:cNvSpPr>
                <a:spLocks noChangeArrowheads="1"/>
              </p:cNvSpPr>
              <p:nvPr/>
            </p:nvSpPr>
            <p:spPr bwMode="auto">
              <a:xfrm>
                <a:off x="7323138" y="6478588"/>
                <a:ext cx="241300" cy="461962"/>
              </a:xfrm>
              <a:prstGeom prst="rect">
                <a:avLst/>
              </a:prstGeom>
              <a:solidFill>
                <a:srgbClr val="A0A0A4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00" name="Rectangle 11"/>
              <p:cNvSpPr>
                <a:spLocks noChangeArrowheads="1"/>
              </p:cNvSpPr>
              <p:nvPr/>
            </p:nvSpPr>
            <p:spPr bwMode="auto">
              <a:xfrm>
                <a:off x="6961188" y="6423025"/>
                <a:ext cx="241300" cy="517525"/>
              </a:xfrm>
              <a:prstGeom prst="rect">
                <a:avLst/>
              </a:prstGeom>
              <a:solidFill>
                <a:srgbClr val="A0A0A4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02" name="Rectangle 13"/>
              <p:cNvSpPr>
                <a:spLocks noChangeArrowheads="1"/>
              </p:cNvSpPr>
              <p:nvPr/>
            </p:nvSpPr>
            <p:spPr bwMode="auto">
              <a:xfrm>
                <a:off x="6597650" y="6538913"/>
                <a:ext cx="242888" cy="403225"/>
              </a:xfrm>
              <a:prstGeom prst="rect">
                <a:avLst/>
              </a:prstGeom>
              <a:solidFill>
                <a:srgbClr val="A0A0A4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3" name="Freeform 74"/>
              <p:cNvSpPr>
                <a:spLocks noEditPoints="1"/>
              </p:cNvSpPr>
              <p:nvPr/>
            </p:nvSpPr>
            <p:spPr bwMode="auto">
              <a:xfrm>
                <a:off x="6530975" y="6940550"/>
                <a:ext cx="1825625" cy="50800"/>
              </a:xfrm>
              <a:custGeom>
                <a:avLst/>
                <a:gdLst>
                  <a:gd name="T0" fmla="*/ 0 w 1150"/>
                  <a:gd name="T1" fmla="*/ 0 h 32"/>
                  <a:gd name="T2" fmla="*/ 1150 w 1150"/>
                  <a:gd name="T3" fmla="*/ 0 h 32"/>
                  <a:gd name="T4" fmla="*/ 118 w 1150"/>
                  <a:gd name="T5" fmla="*/ 32 h 32"/>
                  <a:gd name="T6" fmla="*/ 118 w 1150"/>
                  <a:gd name="T7" fmla="*/ 0 h 32"/>
                  <a:gd name="T8" fmla="*/ 347 w 1150"/>
                  <a:gd name="T9" fmla="*/ 32 h 32"/>
                  <a:gd name="T10" fmla="*/ 347 w 1150"/>
                  <a:gd name="T11" fmla="*/ 0 h 32"/>
                  <a:gd name="T12" fmla="*/ 575 w 1150"/>
                  <a:gd name="T13" fmla="*/ 32 h 32"/>
                  <a:gd name="T14" fmla="*/ 575 w 1150"/>
                  <a:gd name="T15" fmla="*/ 0 h 32"/>
                  <a:gd name="T16" fmla="*/ 803 w 1150"/>
                  <a:gd name="T17" fmla="*/ 32 h 32"/>
                  <a:gd name="T18" fmla="*/ 803 w 1150"/>
                  <a:gd name="T19" fmla="*/ 0 h 32"/>
                  <a:gd name="T20" fmla="*/ 1032 w 1150"/>
                  <a:gd name="T21" fmla="*/ 32 h 32"/>
                  <a:gd name="T22" fmla="*/ 1032 w 1150"/>
                  <a:gd name="T23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150" h="32">
                    <a:moveTo>
                      <a:pt x="0" y="0"/>
                    </a:moveTo>
                    <a:lnTo>
                      <a:pt x="1150" y="0"/>
                    </a:lnTo>
                    <a:moveTo>
                      <a:pt x="118" y="32"/>
                    </a:moveTo>
                    <a:lnTo>
                      <a:pt x="118" y="0"/>
                    </a:lnTo>
                    <a:moveTo>
                      <a:pt x="347" y="32"/>
                    </a:moveTo>
                    <a:lnTo>
                      <a:pt x="347" y="0"/>
                    </a:lnTo>
                    <a:moveTo>
                      <a:pt x="575" y="32"/>
                    </a:moveTo>
                    <a:lnTo>
                      <a:pt x="575" y="0"/>
                    </a:lnTo>
                    <a:moveTo>
                      <a:pt x="803" y="32"/>
                    </a:moveTo>
                    <a:lnTo>
                      <a:pt x="803" y="0"/>
                    </a:lnTo>
                    <a:moveTo>
                      <a:pt x="1032" y="32"/>
                    </a:moveTo>
                    <a:lnTo>
                      <a:pt x="1032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4" name="Rectangle 75"/>
              <p:cNvSpPr>
                <a:spLocks noChangeArrowheads="1"/>
              </p:cNvSpPr>
              <p:nvPr/>
            </p:nvSpPr>
            <p:spPr bwMode="auto">
              <a:xfrm>
                <a:off x="6416675" y="6883400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5" name="Rectangle 76"/>
              <p:cNvSpPr>
                <a:spLocks noChangeArrowheads="1"/>
              </p:cNvSpPr>
              <p:nvPr/>
            </p:nvSpPr>
            <p:spPr bwMode="auto">
              <a:xfrm>
                <a:off x="6359525" y="6580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6" name="Rectangle 77"/>
              <p:cNvSpPr>
                <a:spLocks noChangeArrowheads="1"/>
              </p:cNvSpPr>
              <p:nvPr/>
            </p:nvSpPr>
            <p:spPr bwMode="auto">
              <a:xfrm>
                <a:off x="6359525" y="6278563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7" name="Rectangle 78"/>
              <p:cNvSpPr>
                <a:spLocks noChangeArrowheads="1"/>
              </p:cNvSpPr>
              <p:nvPr/>
            </p:nvSpPr>
            <p:spPr bwMode="auto">
              <a:xfrm>
                <a:off x="6359525" y="5975350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8" name="Rectangle 79"/>
              <p:cNvSpPr>
                <a:spLocks noChangeArrowheads="1"/>
              </p:cNvSpPr>
              <p:nvPr/>
            </p:nvSpPr>
            <p:spPr bwMode="auto">
              <a:xfrm>
                <a:off x="6359525" y="567213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9" name="Freeform 80"/>
              <p:cNvSpPr>
                <a:spLocks noEditPoints="1"/>
              </p:cNvSpPr>
              <p:nvPr/>
            </p:nvSpPr>
            <p:spPr bwMode="auto">
              <a:xfrm>
                <a:off x="6486525" y="5722938"/>
                <a:ext cx="50800" cy="1223962"/>
              </a:xfrm>
              <a:custGeom>
                <a:avLst/>
                <a:gdLst>
                  <a:gd name="T0" fmla="*/ 32 w 32"/>
                  <a:gd name="T1" fmla="*/ 771 h 771"/>
                  <a:gd name="T2" fmla="*/ 32 w 32"/>
                  <a:gd name="T3" fmla="*/ 0 h 771"/>
                  <a:gd name="T4" fmla="*/ 32 w 32"/>
                  <a:gd name="T5" fmla="*/ 767 h 771"/>
                  <a:gd name="T6" fmla="*/ 0 w 32"/>
                  <a:gd name="T7" fmla="*/ 767 h 771"/>
                  <a:gd name="T8" fmla="*/ 32 w 32"/>
                  <a:gd name="T9" fmla="*/ 576 h 771"/>
                  <a:gd name="T10" fmla="*/ 0 w 32"/>
                  <a:gd name="T11" fmla="*/ 576 h 771"/>
                  <a:gd name="T12" fmla="*/ 32 w 32"/>
                  <a:gd name="T13" fmla="*/ 386 h 771"/>
                  <a:gd name="T14" fmla="*/ 0 w 32"/>
                  <a:gd name="T15" fmla="*/ 386 h 771"/>
                  <a:gd name="T16" fmla="*/ 32 w 32"/>
                  <a:gd name="T17" fmla="*/ 195 h 771"/>
                  <a:gd name="T18" fmla="*/ 0 w 32"/>
                  <a:gd name="T19" fmla="*/ 195 h 771"/>
                  <a:gd name="T20" fmla="*/ 32 w 32"/>
                  <a:gd name="T21" fmla="*/ 4 h 771"/>
                  <a:gd name="T22" fmla="*/ 0 w 32"/>
                  <a:gd name="T23" fmla="*/ 4 h 7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2" h="771">
                    <a:moveTo>
                      <a:pt x="32" y="771"/>
                    </a:moveTo>
                    <a:lnTo>
                      <a:pt x="32" y="0"/>
                    </a:lnTo>
                    <a:moveTo>
                      <a:pt x="32" y="767"/>
                    </a:moveTo>
                    <a:lnTo>
                      <a:pt x="0" y="767"/>
                    </a:lnTo>
                    <a:moveTo>
                      <a:pt x="32" y="576"/>
                    </a:moveTo>
                    <a:lnTo>
                      <a:pt x="0" y="576"/>
                    </a:lnTo>
                    <a:moveTo>
                      <a:pt x="32" y="386"/>
                    </a:moveTo>
                    <a:lnTo>
                      <a:pt x="0" y="386"/>
                    </a:lnTo>
                    <a:moveTo>
                      <a:pt x="32" y="195"/>
                    </a:moveTo>
                    <a:lnTo>
                      <a:pt x="0" y="195"/>
                    </a:lnTo>
                    <a:moveTo>
                      <a:pt x="32" y="4"/>
                    </a:moveTo>
                    <a:lnTo>
                      <a:pt x="0" y="4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0" name="Oval 81"/>
              <p:cNvSpPr>
                <a:spLocks noChangeArrowheads="1"/>
              </p:cNvSpPr>
              <p:nvPr/>
            </p:nvSpPr>
            <p:spPr bwMode="auto">
              <a:xfrm>
                <a:off x="8229600" y="668655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1" name="Oval 82"/>
              <p:cNvSpPr>
                <a:spLocks noChangeArrowheads="1"/>
              </p:cNvSpPr>
              <p:nvPr/>
            </p:nvSpPr>
            <p:spPr bwMode="auto">
              <a:xfrm>
                <a:off x="8229600" y="668655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2" name="Oval 83"/>
              <p:cNvSpPr>
                <a:spLocks noChangeArrowheads="1"/>
              </p:cNvSpPr>
              <p:nvPr/>
            </p:nvSpPr>
            <p:spPr bwMode="auto">
              <a:xfrm>
                <a:off x="8132763" y="665638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3" name="Oval 84"/>
              <p:cNvSpPr>
                <a:spLocks noChangeArrowheads="1"/>
              </p:cNvSpPr>
              <p:nvPr/>
            </p:nvSpPr>
            <p:spPr bwMode="auto">
              <a:xfrm>
                <a:off x="8132763" y="665638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4" name="Oval 85"/>
              <p:cNvSpPr>
                <a:spLocks noChangeArrowheads="1"/>
              </p:cNvSpPr>
              <p:nvPr/>
            </p:nvSpPr>
            <p:spPr bwMode="auto">
              <a:xfrm>
                <a:off x="8132763" y="66262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5" name="Oval 86"/>
              <p:cNvSpPr>
                <a:spLocks noChangeArrowheads="1"/>
              </p:cNvSpPr>
              <p:nvPr/>
            </p:nvSpPr>
            <p:spPr bwMode="auto">
              <a:xfrm>
                <a:off x="8132763" y="66262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6" name="Oval 87"/>
              <p:cNvSpPr>
                <a:spLocks noChangeArrowheads="1"/>
              </p:cNvSpPr>
              <p:nvPr/>
            </p:nvSpPr>
            <p:spPr bwMode="auto">
              <a:xfrm>
                <a:off x="8132763" y="68373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7" name="Oval 88"/>
              <p:cNvSpPr>
                <a:spLocks noChangeArrowheads="1"/>
              </p:cNvSpPr>
              <p:nvPr/>
            </p:nvSpPr>
            <p:spPr bwMode="auto">
              <a:xfrm>
                <a:off x="8132763" y="68373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8" name="Oval 89"/>
              <p:cNvSpPr>
                <a:spLocks noChangeArrowheads="1"/>
              </p:cNvSpPr>
              <p:nvPr/>
            </p:nvSpPr>
            <p:spPr bwMode="auto">
              <a:xfrm>
                <a:off x="8180388" y="6626225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9" name="Oval 90"/>
              <p:cNvSpPr>
                <a:spLocks noChangeArrowheads="1"/>
              </p:cNvSpPr>
              <p:nvPr/>
            </p:nvSpPr>
            <p:spPr bwMode="auto">
              <a:xfrm>
                <a:off x="8180388" y="6626225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0" name="Oval 91"/>
              <p:cNvSpPr>
                <a:spLocks noChangeArrowheads="1"/>
              </p:cNvSpPr>
              <p:nvPr/>
            </p:nvSpPr>
            <p:spPr bwMode="auto">
              <a:xfrm>
                <a:off x="8229600" y="680720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1" name="Oval 92"/>
              <p:cNvSpPr>
                <a:spLocks noChangeArrowheads="1"/>
              </p:cNvSpPr>
              <p:nvPr/>
            </p:nvSpPr>
            <p:spPr bwMode="auto">
              <a:xfrm>
                <a:off x="8229600" y="680720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2" name="Oval 93"/>
              <p:cNvSpPr>
                <a:spLocks noChangeArrowheads="1"/>
              </p:cNvSpPr>
              <p:nvPr/>
            </p:nvSpPr>
            <p:spPr bwMode="auto">
              <a:xfrm>
                <a:off x="8180388" y="683736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3" name="Oval 94"/>
              <p:cNvSpPr>
                <a:spLocks noChangeArrowheads="1"/>
              </p:cNvSpPr>
              <p:nvPr/>
            </p:nvSpPr>
            <p:spPr bwMode="auto">
              <a:xfrm>
                <a:off x="8180388" y="683736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4" name="Oval 95"/>
              <p:cNvSpPr>
                <a:spLocks noChangeArrowheads="1"/>
              </p:cNvSpPr>
              <p:nvPr/>
            </p:nvSpPr>
            <p:spPr bwMode="auto">
              <a:xfrm>
                <a:off x="8229600" y="671671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5" name="Oval 96"/>
              <p:cNvSpPr>
                <a:spLocks noChangeArrowheads="1"/>
              </p:cNvSpPr>
              <p:nvPr/>
            </p:nvSpPr>
            <p:spPr bwMode="auto">
              <a:xfrm>
                <a:off x="8229600" y="671671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6" name="Oval 97"/>
              <p:cNvSpPr>
                <a:spLocks noChangeArrowheads="1"/>
              </p:cNvSpPr>
              <p:nvPr/>
            </p:nvSpPr>
            <p:spPr bwMode="auto">
              <a:xfrm>
                <a:off x="8132763" y="67770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7" name="Oval 98"/>
              <p:cNvSpPr>
                <a:spLocks noChangeArrowheads="1"/>
              </p:cNvSpPr>
              <p:nvPr/>
            </p:nvSpPr>
            <p:spPr bwMode="auto">
              <a:xfrm>
                <a:off x="8132763" y="67770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8" name="Oval 99"/>
              <p:cNvSpPr>
                <a:spLocks noChangeArrowheads="1"/>
              </p:cNvSpPr>
              <p:nvPr/>
            </p:nvSpPr>
            <p:spPr bwMode="auto">
              <a:xfrm>
                <a:off x="8132763" y="668655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9" name="Oval 100"/>
              <p:cNvSpPr>
                <a:spLocks noChangeArrowheads="1"/>
              </p:cNvSpPr>
              <p:nvPr/>
            </p:nvSpPr>
            <p:spPr bwMode="auto">
              <a:xfrm>
                <a:off x="8132763" y="668655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0" name="Oval 101"/>
              <p:cNvSpPr>
                <a:spLocks noChangeArrowheads="1"/>
              </p:cNvSpPr>
              <p:nvPr/>
            </p:nvSpPr>
            <p:spPr bwMode="auto">
              <a:xfrm>
                <a:off x="8083550" y="671671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1" name="Oval 102"/>
              <p:cNvSpPr>
                <a:spLocks noChangeArrowheads="1"/>
              </p:cNvSpPr>
              <p:nvPr/>
            </p:nvSpPr>
            <p:spPr bwMode="auto">
              <a:xfrm>
                <a:off x="8083550" y="671671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2" name="Oval 103"/>
              <p:cNvSpPr>
                <a:spLocks noChangeArrowheads="1"/>
              </p:cNvSpPr>
              <p:nvPr/>
            </p:nvSpPr>
            <p:spPr bwMode="auto">
              <a:xfrm>
                <a:off x="8132763" y="674687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3" name="Oval 104"/>
              <p:cNvSpPr>
                <a:spLocks noChangeArrowheads="1"/>
              </p:cNvSpPr>
              <p:nvPr/>
            </p:nvSpPr>
            <p:spPr bwMode="auto">
              <a:xfrm>
                <a:off x="8132763" y="674687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4" name="Oval 105"/>
              <p:cNvSpPr>
                <a:spLocks noChangeArrowheads="1"/>
              </p:cNvSpPr>
              <p:nvPr/>
            </p:nvSpPr>
            <p:spPr bwMode="auto">
              <a:xfrm>
                <a:off x="8180388" y="659447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5" name="Oval 106"/>
              <p:cNvSpPr>
                <a:spLocks noChangeArrowheads="1"/>
              </p:cNvSpPr>
              <p:nvPr/>
            </p:nvSpPr>
            <p:spPr bwMode="auto">
              <a:xfrm>
                <a:off x="8180388" y="659447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6" name="Oval 107"/>
              <p:cNvSpPr>
                <a:spLocks noChangeArrowheads="1"/>
              </p:cNvSpPr>
              <p:nvPr/>
            </p:nvSpPr>
            <p:spPr bwMode="auto">
              <a:xfrm>
                <a:off x="8132763" y="671671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7" name="Oval 108"/>
              <p:cNvSpPr>
                <a:spLocks noChangeArrowheads="1"/>
              </p:cNvSpPr>
              <p:nvPr/>
            </p:nvSpPr>
            <p:spPr bwMode="auto">
              <a:xfrm>
                <a:off x="8132763" y="671671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8" name="Oval 109"/>
              <p:cNvSpPr>
                <a:spLocks noChangeArrowheads="1"/>
              </p:cNvSpPr>
              <p:nvPr/>
            </p:nvSpPr>
            <p:spPr bwMode="auto">
              <a:xfrm>
                <a:off x="8083550" y="6777038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9" name="Oval 110"/>
              <p:cNvSpPr>
                <a:spLocks noChangeArrowheads="1"/>
              </p:cNvSpPr>
              <p:nvPr/>
            </p:nvSpPr>
            <p:spPr bwMode="auto">
              <a:xfrm>
                <a:off x="8083550" y="6777038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0" name="Oval 111"/>
              <p:cNvSpPr>
                <a:spLocks noChangeArrowheads="1"/>
              </p:cNvSpPr>
              <p:nvPr/>
            </p:nvSpPr>
            <p:spPr bwMode="auto">
              <a:xfrm>
                <a:off x="8229600" y="67770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1" name="Oval 112"/>
              <p:cNvSpPr>
                <a:spLocks noChangeArrowheads="1"/>
              </p:cNvSpPr>
              <p:nvPr/>
            </p:nvSpPr>
            <p:spPr bwMode="auto">
              <a:xfrm>
                <a:off x="8229600" y="67770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2" name="Oval 113"/>
              <p:cNvSpPr>
                <a:spLocks noChangeArrowheads="1"/>
              </p:cNvSpPr>
              <p:nvPr/>
            </p:nvSpPr>
            <p:spPr bwMode="auto">
              <a:xfrm>
                <a:off x="8180388" y="6777038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3" name="Oval 114"/>
              <p:cNvSpPr>
                <a:spLocks noChangeArrowheads="1"/>
              </p:cNvSpPr>
              <p:nvPr/>
            </p:nvSpPr>
            <p:spPr bwMode="auto">
              <a:xfrm>
                <a:off x="8180388" y="6777038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4" name="Oval 115"/>
              <p:cNvSpPr>
                <a:spLocks noChangeArrowheads="1"/>
              </p:cNvSpPr>
              <p:nvPr/>
            </p:nvSpPr>
            <p:spPr bwMode="auto">
              <a:xfrm>
                <a:off x="8083550" y="6807200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5" name="Oval 116"/>
              <p:cNvSpPr>
                <a:spLocks noChangeArrowheads="1"/>
              </p:cNvSpPr>
              <p:nvPr/>
            </p:nvSpPr>
            <p:spPr bwMode="auto">
              <a:xfrm>
                <a:off x="8083550" y="6807200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6" name="Oval 117"/>
              <p:cNvSpPr>
                <a:spLocks noChangeArrowheads="1"/>
              </p:cNvSpPr>
              <p:nvPr/>
            </p:nvSpPr>
            <p:spPr bwMode="auto">
              <a:xfrm>
                <a:off x="8180388" y="6807200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7" name="Oval 118"/>
              <p:cNvSpPr>
                <a:spLocks noChangeArrowheads="1"/>
              </p:cNvSpPr>
              <p:nvPr/>
            </p:nvSpPr>
            <p:spPr bwMode="auto">
              <a:xfrm>
                <a:off x="8180388" y="6807200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8" name="Line 119"/>
              <p:cNvSpPr>
                <a:spLocks noChangeShapeType="1"/>
              </p:cNvSpPr>
              <p:nvPr/>
            </p:nvSpPr>
            <p:spPr bwMode="auto">
              <a:xfrm>
                <a:off x="8169275" y="6673850"/>
                <a:ext cx="0" cy="74612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9" name="Line 120"/>
              <p:cNvSpPr>
                <a:spLocks noChangeShapeType="1"/>
              </p:cNvSpPr>
              <p:nvPr/>
            </p:nvSpPr>
            <p:spPr bwMode="auto">
              <a:xfrm>
                <a:off x="8169275" y="6748463"/>
                <a:ext cx="0" cy="74612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0" name="Line 121"/>
              <p:cNvSpPr>
                <a:spLocks noChangeShapeType="1"/>
              </p:cNvSpPr>
              <p:nvPr/>
            </p:nvSpPr>
            <p:spPr bwMode="auto">
              <a:xfrm>
                <a:off x="8108950" y="6673850"/>
                <a:ext cx="12065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1" name="Line 122"/>
              <p:cNvSpPr>
                <a:spLocks noChangeShapeType="1"/>
              </p:cNvSpPr>
              <p:nvPr/>
            </p:nvSpPr>
            <p:spPr bwMode="auto">
              <a:xfrm>
                <a:off x="8108950" y="6823075"/>
                <a:ext cx="12065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2" name="Line 123"/>
              <p:cNvSpPr>
                <a:spLocks noChangeShapeType="1"/>
              </p:cNvSpPr>
              <p:nvPr/>
            </p:nvSpPr>
            <p:spPr bwMode="auto">
              <a:xfrm>
                <a:off x="7805738" y="6154738"/>
                <a:ext cx="0" cy="14605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3" name="Line 124"/>
              <p:cNvSpPr>
                <a:spLocks noChangeShapeType="1"/>
              </p:cNvSpPr>
              <p:nvPr/>
            </p:nvSpPr>
            <p:spPr bwMode="auto">
              <a:xfrm>
                <a:off x="7805738" y="6300788"/>
                <a:ext cx="0" cy="147637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4" name="Line 125"/>
              <p:cNvSpPr>
                <a:spLocks noChangeShapeType="1"/>
              </p:cNvSpPr>
              <p:nvPr/>
            </p:nvSpPr>
            <p:spPr bwMode="auto">
              <a:xfrm>
                <a:off x="7745413" y="6154738"/>
                <a:ext cx="122238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5" name="Line 126"/>
              <p:cNvSpPr>
                <a:spLocks noChangeShapeType="1"/>
              </p:cNvSpPr>
              <p:nvPr/>
            </p:nvSpPr>
            <p:spPr bwMode="auto">
              <a:xfrm>
                <a:off x="7745413" y="6448425"/>
                <a:ext cx="122238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6" name="Oval 127"/>
              <p:cNvSpPr>
                <a:spLocks noChangeArrowheads="1"/>
              </p:cNvSpPr>
              <p:nvPr/>
            </p:nvSpPr>
            <p:spPr bwMode="auto">
              <a:xfrm>
                <a:off x="7770813" y="6503988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7" name="Oval 128"/>
              <p:cNvSpPr>
                <a:spLocks noChangeArrowheads="1"/>
              </p:cNvSpPr>
              <p:nvPr/>
            </p:nvSpPr>
            <p:spPr bwMode="auto">
              <a:xfrm>
                <a:off x="7770813" y="6503988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8" name="Oval 129"/>
              <p:cNvSpPr>
                <a:spLocks noChangeArrowheads="1"/>
              </p:cNvSpPr>
              <p:nvPr/>
            </p:nvSpPr>
            <p:spPr bwMode="auto">
              <a:xfrm>
                <a:off x="7818438" y="635317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9" name="Oval 130"/>
              <p:cNvSpPr>
                <a:spLocks noChangeArrowheads="1"/>
              </p:cNvSpPr>
              <p:nvPr/>
            </p:nvSpPr>
            <p:spPr bwMode="auto">
              <a:xfrm>
                <a:off x="7818438" y="635317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0" name="Oval 131"/>
              <p:cNvSpPr>
                <a:spLocks noChangeArrowheads="1"/>
              </p:cNvSpPr>
              <p:nvPr/>
            </p:nvSpPr>
            <p:spPr bwMode="auto">
              <a:xfrm>
                <a:off x="7721600" y="63833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1" name="Oval 132"/>
              <p:cNvSpPr>
                <a:spLocks noChangeArrowheads="1"/>
              </p:cNvSpPr>
              <p:nvPr/>
            </p:nvSpPr>
            <p:spPr bwMode="auto">
              <a:xfrm>
                <a:off x="7721600" y="63833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2" name="Oval 133"/>
              <p:cNvSpPr>
                <a:spLocks noChangeArrowheads="1"/>
              </p:cNvSpPr>
              <p:nvPr/>
            </p:nvSpPr>
            <p:spPr bwMode="auto">
              <a:xfrm>
                <a:off x="7770813" y="64738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3" name="Oval 134"/>
              <p:cNvSpPr>
                <a:spLocks noChangeArrowheads="1"/>
              </p:cNvSpPr>
              <p:nvPr/>
            </p:nvSpPr>
            <p:spPr bwMode="auto">
              <a:xfrm>
                <a:off x="7770813" y="64738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4" name="Oval 135"/>
              <p:cNvSpPr>
                <a:spLocks noChangeArrowheads="1"/>
              </p:cNvSpPr>
              <p:nvPr/>
            </p:nvSpPr>
            <p:spPr bwMode="auto">
              <a:xfrm>
                <a:off x="7867650" y="632301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5" name="Oval 136"/>
              <p:cNvSpPr>
                <a:spLocks noChangeArrowheads="1"/>
              </p:cNvSpPr>
              <p:nvPr/>
            </p:nvSpPr>
            <p:spPr bwMode="auto">
              <a:xfrm>
                <a:off x="7867650" y="632301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6" name="Oval 137"/>
              <p:cNvSpPr>
                <a:spLocks noChangeArrowheads="1"/>
              </p:cNvSpPr>
              <p:nvPr/>
            </p:nvSpPr>
            <p:spPr bwMode="auto">
              <a:xfrm>
                <a:off x="7770813" y="63833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7" name="Oval 138"/>
              <p:cNvSpPr>
                <a:spLocks noChangeArrowheads="1"/>
              </p:cNvSpPr>
              <p:nvPr/>
            </p:nvSpPr>
            <p:spPr bwMode="auto">
              <a:xfrm>
                <a:off x="7770813" y="63833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8" name="Oval 139"/>
              <p:cNvSpPr>
                <a:spLocks noChangeArrowheads="1"/>
              </p:cNvSpPr>
              <p:nvPr/>
            </p:nvSpPr>
            <p:spPr bwMode="auto">
              <a:xfrm>
                <a:off x="7867650" y="63833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9" name="Oval 140"/>
              <p:cNvSpPr>
                <a:spLocks noChangeArrowheads="1"/>
              </p:cNvSpPr>
              <p:nvPr/>
            </p:nvSpPr>
            <p:spPr bwMode="auto">
              <a:xfrm>
                <a:off x="7867650" y="63833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0" name="Oval 141"/>
              <p:cNvSpPr>
                <a:spLocks noChangeArrowheads="1"/>
              </p:cNvSpPr>
              <p:nvPr/>
            </p:nvSpPr>
            <p:spPr bwMode="auto">
              <a:xfrm>
                <a:off x="7818438" y="6080125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1" name="Oval 142"/>
              <p:cNvSpPr>
                <a:spLocks noChangeArrowheads="1"/>
              </p:cNvSpPr>
              <p:nvPr/>
            </p:nvSpPr>
            <p:spPr bwMode="auto">
              <a:xfrm>
                <a:off x="7818438" y="6080125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2" name="Oval 143"/>
              <p:cNvSpPr>
                <a:spLocks noChangeArrowheads="1"/>
              </p:cNvSpPr>
              <p:nvPr/>
            </p:nvSpPr>
            <p:spPr bwMode="auto">
              <a:xfrm>
                <a:off x="7721600" y="635317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3" name="Oval 144"/>
              <p:cNvSpPr>
                <a:spLocks noChangeArrowheads="1"/>
              </p:cNvSpPr>
              <p:nvPr/>
            </p:nvSpPr>
            <p:spPr bwMode="auto">
              <a:xfrm>
                <a:off x="7721600" y="635317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4" name="Oval 145"/>
              <p:cNvSpPr>
                <a:spLocks noChangeArrowheads="1"/>
              </p:cNvSpPr>
              <p:nvPr/>
            </p:nvSpPr>
            <p:spPr bwMode="auto">
              <a:xfrm>
                <a:off x="7818438" y="63833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5" name="Oval 146"/>
              <p:cNvSpPr>
                <a:spLocks noChangeArrowheads="1"/>
              </p:cNvSpPr>
              <p:nvPr/>
            </p:nvSpPr>
            <p:spPr bwMode="auto">
              <a:xfrm>
                <a:off x="7818438" y="63833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6" name="Oval 147"/>
              <p:cNvSpPr>
                <a:spLocks noChangeArrowheads="1"/>
              </p:cNvSpPr>
              <p:nvPr/>
            </p:nvSpPr>
            <p:spPr bwMode="auto">
              <a:xfrm>
                <a:off x="7818438" y="60499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7" name="Oval 148"/>
              <p:cNvSpPr>
                <a:spLocks noChangeArrowheads="1"/>
              </p:cNvSpPr>
              <p:nvPr/>
            </p:nvSpPr>
            <p:spPr bwMode="auto">
              <a:xfrm>
                <a:off x="7818438" y="60499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8" name="Oval 149"/>
              <p:cNvSpPr>
                <a:spLocks noChangeArrowheads="1"/>
              </p:cNvSpPr>
              <p:nvPr/>
            </p:nvSpPr>
            <p:spPr bwMode="auto">
              <a:xfrm>
                <a:off x="7867650" y="635317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9" name="Oval 150"/>
              <p:cNvSpPr>
                <a:spLocks noChangeArrowheads="1"/>
              </p:cNvSpPr>
              <p:nvPr/>
            </p:nvSpPr>
            <p:spPr bwMode="auto">
              <a:xfrm>
                <a:off x="7867650" y="635317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0" name="Oval 151"/>
              <p:cNvSpPr>
                <a:spLocks noChangeArrowheads="1"/>
              </p:cNvSpPr>
              <p:nvPr/>
            </p:nvSpPr>
            <p:spPr bwMode="auto">
              <a:xfrm>
                <a:off x="7770813" y="6140450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1" name="Oval 152"/>
              <p:cNvSpPr>
                <a:spLocks noChangeArrowheads="1"/>
              </p:cNvSpPr>
              <p:nvPr/>
            </p:nvSpPr>
            <p:spPr bwMode="auto">
              <a:xfrm>
                <a:off x="7770813" y="6140450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2" name="Oval 153"/>
              <p:cNvSpPr>
                <a:spLocks noChangeArrowheads="1"/>
              </p:cNvSpPr>
              <p:nvPr/>
            </p:nvSpPr>
            <p:spPr bwMode="auto">
              <a:xfrm>
                <a:off x="7770813" y="60499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3" name="Oval 154"/>
              <p:cNvSpPr>
                <a:spLocks noChangeArrowheads="1"/>
              </p:cNvSpPr>
              <p:nvPr/>
            </p:nvSpPr>
            <p:spPr bwMode="auto">
              <a:xfrm>
                <a:off x="7770813" y="60499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4" name="Oval 155"/>
              <p:cNvSpPr>
                <a:spLocks noChangeArrowheads="1"/>
              </p:cNvSpPr>
              <p:nvPr/>
            </p:nvSpPr>
            <p:spPr bwMode="auto">
              <a:xfrm>
                <a:off x="7818438" y="6140450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5" name="Oval 156"/>
              <p:cNvSpPr>
                <a:spLocks noChangeArrowheads="1"/>
              </p:cNvSpPr>
              <p:nvPr/>
            </p:nvSpPr>
            <p:spPr bwMode="auto">
              <a:xfrm>
                <a:off x="7818438" y="6140450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6" name="Oval 157"/>
              <p:cNvSpPr>
                <a:spLocks noChangeArrowheads="1"/>
              </p:cNvSpPr>
              <p:nvPr/>
            </p:nvSpPr>
            <p:spPr bwMode="auto">
              <a:xfrm>
                <a:off x="7721600" y="632301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7" name="Oval 158"/>
              <p:cNvSpPr>
                <a:spLocks noChangeArrowheads="1"/>
              </p:cNvSpPr>
              <p:nvPr/>
            </p:nvSpPr>
            <p:spPr bwMode="auto">
              <a:xfrm>
                <a:off x="7721600" y="632301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8" name="Oval 159"/>
              <p:cNvSpPr>
                <a:spLocks noChangeArrowheads="1"/>
              </p:cNvSpPr>
              <p:nvPr/>
            </p:nvSpPr>
            <p:spPr bwMode="auto">
              <a:xfrm>
                <a:off x="7770813" y="6080125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9" name="Oval 160"/>
              <p:cNvSpPr>
                <a:spLocks noChangeArrowheads="1"/>
              </p:cNvSpPr>
              <p:nvPr/>
            </p:nvSpPr>
            <p:spPr bwMode="auto">
              <a:xfrm>
                <a:off x="7770813" y="6080125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0" name="Oval 161"/>
              <p:cNvSpPr>
                <a:spLocks noChangeArrowheads="1"/>
              </p:cNvSpPr>
              <p:nvPr/>
            </p:nvSpPr>
            <p:spPr bwMode="auto">
              <a:xfrm>
                <a:off x="7770813" y="62023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1" name="Oval 162"/>
              <p:cNvSpPr>
                <a:spLocks noChangeArrowheads="1"/>
              </p:cNvSpPr>
              <p:nvPr/>
            </p:nvSpPr>
            <p:spPr bwMode="auto">
              <a:xfrm>
                <a:off x="7770813" y="62023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2" name="Oval 163"/>
              <p:cNvSpPr>
                <a:spLocks noChangeArrowheads="1"/>
              </p:cNvSpPr>
              <p:nvPr/>
            </p:nvSpPr>
            <p:spPr bwMode="auto">
              <a:xfrm>
                <a:off x="7818438" y="626268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3" name="Oval 164"/>
              <p:cNvSpPr>
                <a:spLocks noChangeArrowheads="1"/>
              </p:cNvSpPr>
              <p:nvPr/>
            </p:nvSpPr>
            <p:spPr bwMode="auto">
              <a:xfrm>
                <a:off x="7818438" y="626268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4" name="Oval 165"/>
              <p:cNvSpPr>
                <a:spLocks noChangeArrowheads="1"/>
              </p:cNvSpPr>
              <p:nvPr/>
            </p:nvSpPr>
            <p:spPr bwMode="auto">
              <a:xfrm>
                <a:off x="7770813" y="635317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5" name="Oval 166"/>
              <p:cNvSpPr>
                <a:spLocks noChangeArrowheads="1"/>
              </p:cNvSpPr>
              <p:nvPr/>
            </p:nvSpPr>
            <p:spPr bwMode="auto">
              <a:xfrm>
                <a:off x="7770813" y="635317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6" name="Oval 167"/>
              <p:cNvSpPr>
                <a:spLocks noChangeArrowheads="1"/>
              </p:cNvSpPr>
              <p:nvPr/>
            </p:nvSpPr>
            <p:spPr bwMode="auto">
              <a:xfrm>
                <a:off x="7770813" y="6534150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7" name="Oval 168"/>
              <p:cNvSpPr>
                <a:spLocks noChangeArrowheads="1"/>
              </p:cNvSpPr>
              <p:nvPr/>
            </p:nvSpPr>
            <p:spPr bwMode="auto">
              <a:xfrm>
                <a:off x="7770813" y="6534150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8" name="Oval 169"/>
              <p:cNvSpPr>
                <a:spLocks noChangeArrowheads="1"/>
              </p:cNvSpPr>
              <p:nvPr/>
            </p:nvSpPr>
            <p:spPr bwMode="auto">
              <a:xfrm>
                <a:off x="7770813" y="62325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9" name="Oval 170"/>
              <p:cNvSpPr>
                <a:spLocks noChangeArrowheads="1"/>
              </p:cNvSpPr>
              <p:nvPr/>
            </p:nvSpPr>
            <p:spPr bwMode="auto">
              <a:xfrm>
                <a:off x="7770813" y="62325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0" name="Line 171"/>
              <p:cNvSpPr>
                <a:spLocks noChangeShapeType="1"/>
              </p:cNvSpPr>
              <p:nvPr/>
            </p:nvSpPr>
            <p:spPr bwMode="auto">
              <a:xfrm>
                <a:off x="7443788" y="6408738"/>
                <a:ext cx="0" cy="6985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1" name="Line 172"/>
              <p:cNvSpPr>
                <a:spLocks noChangeShapeType="1"/>
              </p:cNvSpPr>
              <p:nvPr/>
            </p:nvSpPr>
            <p:spPr bwMode="auto">
              <a:xfrm>
                <a:off x="7443788" y="6478588"/>
                <a:ext cx="0" cy="6985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2" name="Line 173"/>
              <p:cNvSpPr>
                <a:spLocks noChangeShapeType="1"/>
              </p:cNvSpPr>
              <p:nvPr/>
            </p:nvSpPr>
            <p:spPr bwMode="auto">
              <a:xfrm>
                <a:off x="7383463" y="6408738"/>
                <a:ext cx="12065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3" name="Line 174"/>
              <p:cNvSpPr>
                <a:spLocks noChangeShapeType="1"/>
              </p:cNvSpPr>
              <p:nvPr/>
            </p:nvSpPr>
            <p:spPr bwMode="auto">
              <a:xfrm>
                <a:off x="7383463" y="6548438"/>
                <a:ext cx="12065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4" name="Oval 175"/>
              <p:cNvSpPr>
                <a:spLocks noChangeArrowheads="1"/>
              </p:cNvSpPr>
              <p:nvPr/>
            </p:nvSpPr>
            <p:spPr bwMode="auto">
              <a:xfrm>
                <a:off x="7480300" y="6564313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5" name="Oval 176"/>
              <p:cNvSpPr>
                <a:spLocks noChangeArrowheads="1"/>
              </p:cNvSpPr>
              <p:nvPr/>
            </p:nvSpPr>
            <p:spPr bwMode="auto">
              <a:xfrm>
                <a:off x="7480300" y="6564313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6" name="Oval 177"/>
              <p:cNvSpPr>
                <a:spLocks noChangeArrowheads="1"/>
              </p:cNvSpPr>
              <p:nvPr/>
            </p:nvSpPr>
            <p:spPr bwMode="auto">
              <a:xfrm>
                <a:off x="7383463" y="64738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7" name="Oval 178"/>
              <p:cNvSpPr>
                <a:spLocks noChangeArrowheads="1"/>
              </p:cNvSpPr>
              <p:nvPr/>
            </p:nvSpPr>
            <p:spPr bwMode="auto">
              <a:xfrm>
                <a:off x="7383463" y="64738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8" name="Oval 179"/>
              <p:cNvSpPr>
                <a:spLocks noChangeArrowheads="1"/>
              </p:cNvSpPr>
              <p:nvPr/>
            </p:nvSpPr>
            <p:spPr bwMode="auto">
              <a:xfrm>
                <a:off x="7431088" y="6383338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9" name="Oval 180"/>
              <p:cNvSpPr>
                <a:spLocks noChangeArrowheads="1"/>
              </p:cNvSpPr>
              <p:nvPr/>
            </p:nvSpPr>
            <p:spPr bwMode="auto">
              <a:xfrm>
                <a:off x="7431088" y="6383338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0" name="Oval 181"/>
              <p:cNvSpPr>
                <a:spLocks noChangeArrowheads="1"/>
              </p:cNvSpPr>
              <p:nvPr/>
            </p:nvSpPr>
            <p:spPr bwMode="auto">
              <a:xfrm>
                <a:off x="7383463" y="6534150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1" name="Oval 182"/>
              <p:cNvSpPr>
                <a:spLocks noChangeArrowheads="1"/>
              </p:cNvSpPr>
              <p:nvPr/>
            </p:nvSpPr>
            <p:spPr bwMode="auto">
              <a:xfrm>
                <a:off x="7383463" y="6534150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2" name="Oval 183"/>
              <p:cNvSpPr>
                <a:spLocks noChangeArrowheads="1"/>
              </p:cNvSpPr>
              <p:nvPr/>
            </p:nvSpPr>
            <p:spPr bwMode="auto">
              <a:xfrm>
                <a:off x="7383463" y="6503988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3" name="Oval 184"/>
              <p:cNvSpPr>
                <a:spLocks noChangeArrowheads="1"/>
              </p:cNvSpPr>
              <p:nvPr/>
            </p:nvSpPr>
            <p:spPr bwMode="auto">
              <a:xfrm>
                <a:off x="7383463" y="6503988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4" name="Oval 185"/>
              <p:cNvSpPr>
                <a:spLocks noChangeArrowheads="1"/>
              </p:cNvSpPr>
              <p:nvPr/>
            </p:nvSpPr>
            <p:spPr bwMode="auto">
              <a:xfrm>
                <a:off x="7431088" y="65039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5" name="Oval 186"/>
              <p:cNvSpPr>
                <a:spLocks noChangeArrowheads="1"/>
              </p:cNvSpPr>
              <p:nvPr/>
            </p:nvSpPr>
            <p:spPr bwMode="auto">
              <a:xfrm>
                <a:off x="7431088" y="65039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6" name="Oval 187"/>
              <p:cNvSpPr>
                <a:spLocks noChangeArrowheads="1"/>
              </p:cNvSpPr>
              <p:nvPr/>
            </p:nvSpPr>
            <p:spPr bwMode="auto">
              <a:xfrm>
                <a:off x="7431088" y="644366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7" name="Oval 188"/>
              <p:cNvSpPr>
                <a:spLocks noChangeArrowheads="1"/>
              </p:cNvSpPr>
              <p:nvPr/>
            </p:nvSpPr>
            <p:spPr bwMode="auto">
              <a:xfrm>
                <a:off x="7431088" y="644366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8" name="Oval 189"/>
              <p:cNvSpPr>
                <a:spLocks noChangeArrowheads="1"/>
              </p:cNvSpPr>
              <p:nvPr/>
            </p:nvSpPr>
            <p:spPr bwMode="auto">
              <a:xfrm>
                <a:off x="7431088" y="659447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9" name="Oval 190"/>
              <p:cNvSpPr>
                <a:spLocks noChangeArrowheads="1"/>
              </p:cNvSpPr>
              <p:nvPr/>
            </p:nvSpPr>
            <p:spPr bwMode="auto">
              <a:xfrm>
                <a:off x="7431088" y="659447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0" name="Oval 191"/>
              <p:cNvSpPr>
                <a:spLocks noChangeArrowheads="1"/>
              </p:cNvSpPr>
              <p:nvPr/>
            </p:nvSpPr>
            <p:spPr bwMode="auto">
              <a:xfrm>
                <a:off x="7431088" y="65643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1" name="Oval 192"/>
              <p:cNvSpPr>
                <a:spLocks noChangeArrowheads="1"/>
              </p:cNvSpPr>
              <p:nvPr/>
            </p:nvSpPr>
            <p:spPr bwMode="auto">
              <a:xfrm>
                <a:off x="7431088" y="65643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2" name="Oval 193"/>
              <p:cNvSpPr>
                <a:spLocks noChangeArrowheads="1"/>
              </p:cNvSpPr>
              <p:nvPr/>
            </p:nvSpPr>
            <p:spPr bwMode="auto">
              <a:xfrm>
                <a:off x="7480300" y="6534150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3" name="Oval 194"/>
              <p:cNvSpPr>
                <a:spLocks noChangeArrowheads="1"/>
              </p:cNvSpPr>
              <p:nvPr/>
            </p:nvSpPr>
            <p:spPr bwMode="auto">
              <a:xfrm>
                <a:off x="7480300" y="6534150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4" name="Oval 195"/>
              <p:cNvSpPr>
                <a:spLocks noChangeArrowheads="1"/>
              </p:cNvSpPr>
              <p:nvPr/>
            </p:nvSpPr>
            <p:spPr bwMode="auto">
              <a:xfrm>
                <a:off x="7527925" y="6473825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5" name="Oval 196"/>
              <p:cNvSpPr>
                <a:spLocks noChangeArrowheads="1"/>
              </p:cNvSpPr>
              <p:nvPr/>
            </p:nvSpPr>
            <p:spPr bwMode="auto">
              <a:xfrm>
                <a:off x="7527925" y="6473825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6" name="Oval 197"/>
              <p:cNvSpPr>
                <a:spLocks noChangeArrowheads="1"/>
              </p:cNvSpPr>
              <p:nvPr/>
            </p:nvSpPr>
            <p:spPr bwMode="auto">
              <a:xfrm>
                <a:off x="7480300" y="63833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7" name="Oval 198"/>
              <p:cNvSpPr>
                <a:spLocks noChangeArrowheads="1"/>
              </p:cNvSpPr>
              <p:nvPr/>
            </p:nvSpPr>
            <p:spPr bwMode="auto">
              <a:xfrm>
                <a:off x="7480300" y="63833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8" name="Oval 199"/>
              <p:cNvSpPr>
                <a:spLocks noChangeArrowheads="1"/>
              </p:cNvSpPr>
              <p:nvPr/>
            </p:nvSpPr>
            <p:spPr bwMode="auto">
              <a:xfrm>
                <a:off x="7383463" y="64436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9" name="Oval 200"/>
              <p:cNvSpPr>
                <a:spLocks noChangeArrowheads="1"/>
              </p:cNvSpPr>
              <p:nvPr/>
            </p:nvSpPr>
            <p:spPr bwMode="auto">
              <a:xfrm>
                <a:off x="7383463" y="64436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0" name="Oval 201"/>
              <p:cNvSpPr>
                <a:spLocks noChangeArrowheads="1"/>
              </p:cNvSpPr>
              <p:nvPr/>
            </p:nvSpPr>
            <p:spPr bwMode="auto">
              <a:xfrm>
                <a:off x="7480300" y="64436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1" name="Oval 202"/>
              <p:cNvSpPr>
                <a:spLocks noChangeArrowheads="1"/>
              </p:cNvSpPr>
              <p:nvPr/>
            </p:nvSpPr>
            <p:spPr bwMode="auto">
              <a:xfrm>
                <a:off x="7480300" y="64436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2" name="Oval 203"/>
              <p:cNvSpPr>
                <a:spLocks noChangeArrowheads="1"/>
              </p:cNvSpPr>
              <p:nvPr/>
            </p:nvSpPr>
            <p:spPr bwMode="auto">
              <a:xfrm>
                <a:off x="7431088" y="632301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3" name="Oval 204"/>
              <p:cNvSpPr>
                <a:spLocks noChangeArrowheads="1"/>
              </p:cNvSpPr>
              <p:nvPr/>
            </p:nvSpPr>
            <p:spPr bwMode="auto">
              <a:xfrm>
                <a:off x="7431088" y="632301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" name="Oval 206"/>
              <p:cNvSpPr>
                <a:spLocks noChangeArrowheads="1"/>
              </p:cNvSpPr>
              <p:nvPr/>
            </p:nvSpPr>
            <p:spPr bwMode="auto">
              <a:xfrm>
                <a:off x="7431088" y="6353175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" name="Oval 207"/>
              <p:cNvSpPr>
                <a:spLocks noChangeArrowheads="1"/>
              </p:cNvSpPr>
              <p:nvPr/>
            </p:nvSpPr>
            <p:spPr bwMode="auto">
              <a:xfrm>
                <a:off x="7431088" y="6353175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" name="Oval 208"/>
              <p:cNvSpPr>
                <a:spLocks noChangeArrowheads="1"/>
              </p:cNvSpPr>
              <p:nvPr/>
            </p:nvSpPr>
            <p:spPr bwMode="auto">
              <a:xfrm>
                <a:off x="7334250" y="644366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7" name="Oval 209"/>
              <p:cNvSpPr>
                <a:spLocks noChangeArrowheads="1"/>
              </p:cNvSpPr>
              <p:nvPr/>
            </p:nvSpPr>
            <p:spPr bwMode="auto">
              <a:xfrm>
                <a:off x="7334250" y="644366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8" name="Oval 210"/>
              <p:cNvSpPr>
                <a:spLocks noChangeArrowheads="1"/>
              </p:cNvSpPr>
              <p:nvPr/>
            </p:nvSpPr>
            <p:spPr bwMode="auto">
              <a:xfrm>
                <a:off x="7431088" y="653415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9" name="Oval 211"/>
              <p:cNvSpPr>
                <a:spLocks noChangeArrowheads="1"/>
              </p:cNvSpPr>
              <p:nvPr/>
            </p:nvSpPr>
            <p:spPr bwMode="auto">
              <a:xfrm>
                <a:off x="7431088" y="653415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0" name="Oval 212"/>
              <p:cNvSpPr>
                <a:spLocks noChangeArrowheads="1"/>
              </p:cNvSpPr>
              <p:nvPr/>
            </p:nvSpPr>
            <p:spPr bwMode="auto">
              <a:xfrm>
                <a:off x="7334250" y="6473825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2" name="Oval 213"/>
              <p:cNvSpPr>
                <a:spLocks noChangeArrowheads="1"/>
              </p:cNvSpPr>
              <p:nvPr/>
            </p:nvSpPr>
            <p:spPr bwMode="auto">
              <a:xfrm>
                <a:off x="7334250" y="6473825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3" name="Oval 214"/>
              <p:cNvSpPr>
                <a:spLocks noChangeArrowheads="1"/>
              </p:cNvSpPr>
              <p:nvPr/>
            </p:nvSpPr>
            <p:spPr bwMode="auto">
              <a:xfrm>
                <a:off x="7480300" y="641350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4" name="Oval 215"/>
              <p:cNvSpPr>
                <a:spLocks noChangeArrowheads="1"/>
              </p:cNvSpPr>
              <p:nvPr/>
            </p:nvSpPr>
            <p:spPr bwMode="auto">
              <a:xfrm>
                <a:off x="7480300" y="641350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5" name="Oval 216"/>
              <p:cNvSpPr>
                <a:spLocks noChangeArrowheads="1"/>
              </p:cNvSpPr>
              <p:nvPr/>
            </p:nvSpPr>
            <p:spPr bwMode="auto">
              <a:xfrm>
                <a:off x="7527925" y="6413500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6" name="Oval 217"/>
              <p:cNvSpPr>
                <a:spLocks noChangeArrowheads="1"/>
              </p:cNvSpPr>
              <p:nvPr/>
            </p:nvSpPr>
            <p:spPr bwMode="auto">
              <a:xfrm>
                <a:off x="7527925" y="6413500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7" name="Oval 218"/>
              <p:cNvSpPr>
                <a:spLocks noChangeArrowheads="1"/>
              </p:cNvSpPr>
              <p:nvPr/>
            </p:nvSpPr>
            <p:spPr bwMode="auto">
              <a:xfrm>
                <a:off x="7480300" y="64738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8" name="Oval 219"/>
              <p:cNvSpPr>
                <a:spLocks noChangeArrowheads="1"/>
              </p:cNvSpPr>
              <p:nvPr/>
            </p:nvSpPr>
            <p:spPr bwMode="auto">
              <a:xfrm>
                <a:off x="7480300" y="64738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" name="Oval 220"/>
              <p:cNvSpPr>
                <a:spLocks noChangeArrowheads="1"/>
              </p:cNvSpPr>
              <p:nvPr/>
            </p:nvSpPr>
            <p:spPr bwMode="auto">
              <a:xfrm>
                <a:off x="7527925" y="644366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" name="Oval 221"/>
              <p:cNvSpPr>
                <a:spLocks noChangeArrowheads="1"/>
              </p:cNvSpPr>
              <p:nvPr/>
            </p:nvSpPr>
            <p:spPr bwMode="auto">
              <a:xfrm>
                <a:off x="7527925" y="644366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" name="Line 222"/>
              <p:cNvSpPr>
                <a:spLocks noChangeShapeType="1"/>
              </p:cNvSpPr>
              <p:nvPr/>
            </p:nvSpPr>
            <p:spPr bwMode="auto">
              <a:xfrm>
                <a:off x="7081838" y="6288088"/>
                <a:ext cx="0" cy="134937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" name="Line 223"/>
              <p:cNvSpPr>
                <a:spLocks noChangeShapeType="1"/>
              </p:cNvSpPr>
              <p:nvPr/>
            </p:nvSpPr>
            <p:spPr bwMode="auto">
              <a:xfrm>
                <a:off x="7081838" y="6423025"/>
                <a:ext cx="0" cy="13335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3" name="Line 224"/>
              <p:cNvSpPr>
                <a:spLocks noChangeShapeType="1"/>
              </p:cNvSpPr>
              <p:nvPr/>
            </p:nvSpPr>
            <p:spPr bwMode="auto">
              <a:xfrm>
                <a:off x="7019925" y="6288088"/>
                <a:ext cx="122238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4" name="Line 225"/>
              <p:cNvSpPr>
                <a:spLocks noChangeShapeType="1"/>
              </p:cNvSpPr>
              <p:nvPr/>
            </p:nvSpPr>
            <p:spPr bwMode="auto">
              <a:xfrm>
                <a:off x="7019925" y="6556375"/>
                <a:ext cx="122238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5" name="Oval 226"/>
              <p:cNvSpPr>
                <a:spLocks noChangeArrowheads="1"/>
              </p:cNvSpPr>
              <p:nvPr/>
            </p:nvSpPr>
            <p:spPr bwMode="auto">
              <a:xfrm>
                <a:off x="7092950" y="641350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" name="Oval 227"/>
              <p:cNvSpPr>
                <a:spLocks noChangeArrowheads="1"/>
              </p:cNvSpPr>
              <p:nvPr/>
            </p:nvSpPr>
            <p:spPr bwMode="auto">
              <a:xfrm>
                <a:off x="7092950" y="641350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" name="Oval 228"/>
              <p:cNvSpPr>
                <a:spLocks noChangeArrowheads="1"/>
              </p:cNvSpPr>
              <p:nvPr/>
            </p:nvSpPr>
            <p:spPr bwMode="auto">
              <a:xfrm>
                <a:off x="7045325" y="641350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" name="Oval 229"/>
              <p:cNvSpPr>
                <a:spLocks noChangeArrowheads="1"/>
              </p:cNvSpPr>
              <p:nvPr/>
            </p:nvSpPr>
            <p:spPr bwMode="auto">
              <a:xfrm>
                <a:off x="7045325" y="641350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" name="Oval 230"/>
              <p:cNvSpPr>
                <a:spLocks noChangeArrowheads="1"/>
              </p:cNvSpPr>
              <p:nvPr/>
            </p:nvSpPr>
            <p:spPr bwMode="auto">
              <a:xfrm>
                <a:off x="6996113" y="635317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" name="Oval 231"/>
              <p:cNvSpPr>
                <a:spLocks noChangeArrowheads="1"/>
              </p:cNvSpPr>
              <p:nvPr/>
            </p:nvSpPr>
            <p:spPr bwMode="auto">
              <a:xfrm>
                <a:off x="6996113" y="635317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" name="Oval 232"/>
              <p:cNvSpPr>
                <a:spLocks noChangeArrowheads="1"/>
              </p:cNvSpPr>
              <p:nvPr/>
            </p:nvSpPr>
            <p:spPr bwMode="auto">
              <a:xfrm>
                <a:off x="6996113" y="6564313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" name="Oval 233"/>
              <p:cNvSpPr>
                <a:spLocks noChangeArrowheads="1"/>
              </p:cNvSpPr>
              <p:nvPr/>
            </p:nvSpPr>
            <p:spPr bwMode="auto">
              <a:xfrm>
                <a:off x="6996113" y="6564313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" name="Oval 234"/>
              <p:cNvSpPr>
                <a:spLocks noChangeArrowheads="1"/>
              </p:cNvSpPr>
              <p:nvPr/>
            </p:nvSpPr>
            <p:spPr bwMode="auto">
              <a:xfrm>
                <a:off x="7045325" y="66262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" name="Oval 235"/>
              <p:cNvSpPr>
                <a:spLocks noChangeArrowheads="1"/>
              </p:cNvSpPr>
              <p:nvPr/>
            </p:nvSpPr>
            <p:spPr bwMode="auto">
              <a:xfrm>
                <a:off x="7045325" y="66262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" name="Oval 236"/>
              <p:cNvSpPr>
                <a:spLocks noChangeArrowheads="1"/>
              </p:cNvSpPr>
              <p:nvPr/>
            </p:nvSpPr>
            <p:spPr bwMode="auto">
              <a:xfrm>
                <a:off x="7142163" y="641350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" name="Oval 237"/>
              <p:cNvSpPr>
                <a:spLocks noChangeArrowheads="1"/>
              </p:cNvSpPr>
              <p:nvPr/>
            </p:nvSpPr>
            <p:spPr bwMode="auto">
              <a:xfrm>
                <a:off x="7142163" y="641350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" name="Oval 238"/>
              <p:cNvSpPr>
                <a:spLocks noChangeArrowheads="1"/>
              </p:cNvSpPr>
              <p:nvPr/>
            </p:nvSpPr>
            <p:spPr bwMode="auto">
              <a:xfrm>
                <a:off x="7142163" y="63833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8" name="Oval 239"/>
              <p:cNvSpPr>
                <a:spLocks noChangeArrowheads="1"/>
              </p:cNvSpPr>
              <p:nvPr/>
            </p:nvSpPr>
            <p:spPr bwMode="auto">
              <a:xfrm>
                <a:off x="7142163" y="63833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9" name="Oval 240"/>
              <p:cNvSpPr>
                <a:spLocks noChangeArrowheads="1"/>
              </p:cNvSpPr>
              <p:nvPr/>
            </p:nvSpPr>
            <p:spPr bwMode="auto">
              <a:xfrm>
                <a:off x="7092950" y="62325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0" name="Oval 241"/>
              <p:cNvSpPr>
                <a:spLocks noChangeArrowheads="1"/>
              </p:cNvSpPr>
              <p:nvPr/>
            </p:nvSpPr>
            <p:spPr bwMode="auto">
              <a:xfrm>
                <a:off x="7092950" y="62325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" name="Oval 242"/>
              <p:cNvSpPr>
                <a:spLocks noChangeArrowheads="1"/>
              </p:cNvSpPr>
              <p:nvPr/>
            </p:nvSpPr>
            <p:spPr bwMode="auto">
              <a:xfrm>
                <a:off x="7092950" y="626268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" name="Oval 243"/>
              <p:cNvSpPr>
                <a:spLocks noChangeArrowheads="1"/>
              </p:cNvSpPr>
              <p:nvPr/>
            </p:nvSpPr>
            <p:spPr bwMode="auto">
              <a:xfrm>
                <a:off x="7092950" y="626268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7" name="Oval 244"/>
              <p:cNvSpPr>
                <a:spLocks noChangeArrowheads="1"/>
              </p:cNvSpPr>
              <p:nvPr/>
            </p:nvSpPr>
            <p:spPr bwMode="auto">
              <a:xfrm>
                <a:off x="7045325" y="6503988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0" name="Oval 245"/>
              <p:cNvSpPr>
                <a:spLocks noChangeArrowheads="1"/>
              </p:cNvSpPr>
              <p:nvPr/>
            </p:nvSpPr>
            <p:spPr bwMode="auto">
              <a:xfrm>
                <a:off x="7045325" y="6503988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3" name="Oval 246"/>
              <p:cNvSpPr>
                <a:spLocks noChangeArrowheads="1"/>
              </p:cNvSpPr>
              <p:nvPr/>
            </p:nvSpPr>
            <p:spPr bwMode="auto">
              <a:xfrm>
                <a:off x="7092950" y="632301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4" name="Oval 247"/>
              <p:cNvSpPr>
                <a:spLocks noChangeArrowheads="1"/>
              </p:cNvSpPr>
              <p:nvPr/>
            </p:nvSpPr>
            <p:spPr bwMode="auto">
              <a:xfrm>
                <a:off x="7092950" y="632301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5" name="Oval 248"/>
              <p:cNvSpPr>
                <a:spLocks noChangeArrowheads="1"/>
              </p:cNvSpPr>
              <p:nvPr/>
            </p:nvSpPr>
            <p:spPr bwMode="auto">
              <a:xfrm>
                <a:off x="7092950" y="63833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9" name="Oval 249"/>
              <p:cNvSpPr>
                <a:spLocks noChangeArrowheads="1"/>
              </p:cNvSpPr>
              <p:nvPr/>
            </p:nvSpPr>
            <p:spPr bwMode="auto">
              <a:xfrm>
                <a:off x="7092950" y="63833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0" name="Oval 250"/>
              <p:cNvSpPr>
                <a:spLocks noChangeArrowheads="1"/>
              </p:cNvSpPr>
              <p:nvPr/>
            </p:nvSpPr>
            <p:spPr bwMode="auto">
              <a:xfrm>
                <a:off x="7092950" y="64436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1" name="Oval 251"/>
              <p:cNvSpPr>
                <a:spLocks noChangeArrowheads="1"/>
              </p:cNvSpPr>
              <p:nvPr/>
            </p:nvSpPr>
            <p:spPr bwMode="auto">
              <a:xfrm>
                <a:off x="7092950" y="64436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2" name="Oval 252"/>
              <p:cNvSpPr>
                <a:spLocks noChangeArrowheads="1"/>
              </p:cNvSpPr>
              <p:nvPr/>
            </p:nvSpPr>
            <p:spPr bwMode="auto">
              <a:xfrm>
                <a:off x="7045325" y="6080125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5" name="Oval 253"/>
              <p:cNvSpPr>
                <a:spLocks noChangeArrowheads="1"/>
              </p:cNvSpPr>
              <p:nvPr/>
            </p:nvSpPr>
            <p:spPr bwMode="auto">
              <a:xfrm>
                <a:off x="7045325" y="6080125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7" name="Oval 254"/>
              <p:cNvSpPr>
                <a:spLocks noChangeArrowheads="1"/>
              </p:cNvSpPr>
              <p:nvPr/>
            </p:nvSpPr>
            <p:spPr bwMode="auto">
              <a:xfrm>
                <a:off x="6996113" y="641350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9" name="Oval 255"/>
              <p:cNvSpPr>
                <a:spLocks noChangeArrowheads="1"/>
              </p:cNvSpPr>
              <p:nvPr/>
            </p:nvSpPr>
            <p:spPr bwMode="auto">
              <a:xfrm>
                <a:off x="6996113" y="641350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6" name="Oval 256"/>
              <p:cNvSpPr>
                <a:spLocks noChangeArrowheads="1"/>
              </p:cNvSpPr>
              <p:nvPr/>
            </p:nvSpPr>
            <p:spPr bwMode="auto">
              <a:xfrm>
                <a:off x="6996113" y="6534150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7" name="Oval 257"/>
              <p:cNvSpPr>
                <a:spLocks noChangeArrowheads="1"/>
              </p:cNvSpPr>
              <p:nvPr/>
            </p:nvSpPr>
            <p:spPr bwMode="auto">
              <a:xfrm>
                <a:off x="6996113" y="6534150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8" name="Oval 258"/>
              <p:cNvSpPr>
                <a:spLocks noChangeArrowheads="1"/>
              </p:cNvSpPr>
              <p:nvPr/>
            </p:nvSpPr>
            <p:spPr bwMode="auto">
              <a:xfrm>
                <a:off x="7142163" y="6564313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5" name="Oval 259"/>
              <p:cNvSpPr>
                <a:spLocks noChangeArrowheads="1"/>
              </p:cNvSpPr>
              <p:nvPr/>
            </p:nvSpPr>
            <p:spPr bwMode="auto">
              <a:xfrm>
                <a:off x="7142163" y="6564313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7" name="Oval 260"/>
              <p:cNvSpPr>
                <a:spLocks noChangeArrowheads="1"/>
              </p:cNvSpPr>
              <p:nvPr/>
            </p:nvSpPr>
            <p:spPr bwMode="auto">
              <a:xfrm>
                <a:off x="7092950" y="66262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2" name="Oval 261"/>
              <p:cNvSpPr>
                <a:spLocks noChangeArrowheads="1"/>
              </p:cNvSpPr>
              <p:nvPr/>
            </p:nvSpPr>
            <p:spPr bwMode="auto">
              <a:xfrm>
                <a:off x="7092950" y="66262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3" name="Oval 262"/>
              <p:cNvSpPr>
                <a:spLocks noChangeArrowheads="1"/>
              </p:cNvSpPr>
              <p:nvPr/>
            </p:nvSpPr>
            <p:spPr bwMode="auto">
              <a:xfrm>
                <a:off x="7045325" y="635317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4" name="Oval 263"/>
              <p:cNvSpPr>
                <a:spLocks noChangeArrowheads="1"/>
              </p:cNvSpPr>
              <p:nvPr/>
            </p:nvSpPr>
            <p:spPr bwMode="auto">
              <a:xfrm>
                <a:off x="7045325" y="635317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5" name="Oval 264"/>
              <p:cNvSpPr>
                <a:spLocks noChangeArrowheads="1"/>
              </p:cNvSpPr>
              <p:nvPr/>
            </p:nvSpPr>
            <p:spPr bwMode="auto">
              <a:xfrm>
                <a:off x="7092950" y="629285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6" name="Oval 265"/>
              <p:cNvSpPr>
                <a:spLocks noChangeArrowheads="1"/>
              </p:cNvSpPr>
              <p:nvPr/>
            </p:nvSpPr>
            <p:spPr bwMode="auto">
              <a:xfrm>
                <a:off x="7092950" y="629285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7" name="Oval 266"/>
              <p:cNvSpPr>
                <a:spLocks noChangeArrowheads="1"/>
              </p:cNvSpPr>
              <p:nvPr/>
            </p:nvSpPr>
            <p:spPr bwMode="auto">
              <a:xfrm>
                <a:off x="7045325" y="629285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8" name="Oval 267"/>
              <p:cNvSpPr>
                <a:spLocks noChangeArrowheads="1"/>
              </p:cNvSpPr>
              <p:nvPr/>
            </p:nvSpPr>
            <p:spPr bwMode="auto">
              <a:xfrm>
                <a:off x="7045325" y="629285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9" name="Oval 268"/>
              <p:cNvSpPr>
                <a:spLocks noChangeArrowheads="1"/>
              </p:cNvSpPr>
              <p:nvPr/>
            </p:nvSpPr>
            <p:spPr bwMode="auto">
              <a:xfrm>
                <a:off x="7092950" y="6564313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0" name="Oval 269"/>
              <p:cNvSpPr>
                <a:spLocks noChangeArrowheads="1"/>
              </p:cNvSpPr>
              <p:nvPr/>
            </p:nvSpPr>
            <p:spPr bwMode="auto">
              <a:xfrm>
                <a:off x="7092950" y="6564313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1" name="Oval 270"/>
              <p:cNvSpPr>
                <a:spLocks noChangeArrowheads="1"/>
              </p:cNvSpPr>
              <p:nvPr/>
            </p:nvSpPr>
            <p:spPr bwMode="auto">
              <a:xfrm>
                <a:off x="7045325" y="6383338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2" name="Oval 271"/>
              <p:cNvSpPr>
                <a:spLocks noChangeArrowheads="1"/>
              </p:cNvSpPr>
              <p:nvPr/>
            </p:nvSpPr>
            <p:spPr bwMode="auto">
              <a:xfrm>
                <a:off x="7045325" y="6383338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3" name="Line 272"/>
              <p:cNvSpPr>
                <a:spLocks noChangeShapeType="1"/>
              </p:cNvSpPr>
              <p:nvPr/>
            </p:nvSpPr>
            <p:spPr bwMode="auto">
              <a:xfrm>
                <a:off x="6718300" y="6456363"/>
                <a:ext cx="0" cy="8255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4" name="Line 273"/>
              <p:cNvSpPr>
                <a:spLocks noChangeShapeType="1"/>
              </p:cNvSpPr>
              <p:nvPr/>
            </p:nvSpPr>
            <p:spPr bwMode="auto">
              <a:xfrm>
                <a:off x="6718300" y="6538913"/>
                <a:ext cx="0" cy="84137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5" name="Line 274"/>
              <p:cNvSpPr>
                <a:spLocks noChangeShapeType="1"/>
              </p:cNvSpPr>
              <p:nvPr/>
            </p:nvSpPr>
            <p:spPr bwMode="auto">
              <a:xfrm>
                <a:off x="6657975" y="6456363"/>
                <a:ext cx="12065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6" name="Line 275"/>
              <p:cNvSpPr>
                <a:spLocks noChangeShapeType="1"/>
              </p:cNvSpPr>
              <p:nvPr/>
            </p:nvSpPr>
            <p:spPr bwMode="auto">
              <a:xfrm>
                <a:off x="6657975" y="6623050"/>
                <a:ext cx="12065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7" name="Oval 276"/>
              <p:cNvSpPr>
                <a:spLocks noChangeArrowheads="1"/>
              </p:cNvSpPr>
              <p:nvPr/>
            </p:nvSpPr>
            <p:spPr bwMode="auto">
              <a:xfrm>
                <a:off x="6705600" y="653415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8" name="Oval 277"/>
              <p:cNvSpPr>
                <a:spLocks noChangeArrowheads="1"/>
              </p:cNvSpPr>
              <p:nvPr/>
            </p:nvSpPr>
            <p:spPr bwMode="auto">
              <a:xfrm>
                <a:off x="6705600" y="653415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9" name="Oval 278"/>
              <p:cNvSpPr>
                <a:spLocks noChangeArrowheads="1"/>
              </p:cNvSpPr>
              <p:nvPr/>
            </p:nvSpPr>
            <p:spPr bwMode="auto">
              <a:xfrm>
                <a:off x="6705600" y="671671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0" name="Oval 279"/>
              <p:cNvSpPr>
                <a:spLocks noChangeArrowheads="1"/>
              </p:cNvSpPr>
              <p:nvPr/>
            </p:nvSpPr>
            <p:spPr bwMode="auto">
              <a:xfrm>
                <a:off x="6705600" y="671671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1" name="Oval 280"/>
              <p:cNvSpPr>
                <a:spLocks noChangeArrowheads="1"/>
              </p:cNvSpPr>
              <p:nvPr/>
            </p:nvSpPr>
            <p:spPr bwMode="auto">
              <a:xfrm>
                <a:off x="6657975" y="6594475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2" name="Oval 281"/>
              <p:cNvSpPr>
                <a:spLocks noChangeArrowheads="1"/>
              </p:cNvSpPr>
              <p:nvPr/>
            </p:nvSpPr>
            <p:spPr bwMode="auto">
              <a:xfrm>
                <a:off x="6657975" y="6594475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3" name="Oval 282"/>
              <p:cNvSpPr>
                <a:spLocks noChangeArrowheads="1"/>
              </p:cNvSpPr>
              <p:nvPr/>
            </p:nvSpPr>
            <p:spPr bwMode="auto">
              <a:xfrm>
                <a:off x="6705600" y="65643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4" name="Oval 283"/>
              <p:cNvSpPr>
                <a:spLocks noChangeArrowheads="1"/>
              </p:cNvSpPr>
              <p:nvPr/>
            </p:nvSpPr>
            <p:spPr bwMode="auto">
              <a:xfrm>
                <a:off x="6705600" y="65643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5" name="Oval 284"/>
              <p:cNvSpPr>
                <a:spLocks noChangeArrowheads="1"/>
              </p:cNvSpPr>
              <p:nvPr/>
            </p:nvSpPr>
            <p:spPr bwMode="auto">
              <a:xfrm>
                <a:off x="6657975" y="6503988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6" name="Oval 285"/>
              <p:cNvSpPr>
                <a:spLocks noChangeArrowheads="1"/>
              </p:cNvSpPr>
              <p:nvPr/>
            </p:nvSpPr>
            <p:spPr bwMode="auto">
              <a:xfrm>
                <a:off x="6657975" y="6503988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7" name="Oval 286"/>
              <p:cNvSpPr>
                <a:spLocks noChangeArrowheads="1"/>
              </p:cNvSpPr>
              <p:nvPr/>
            </p:nvSpPr>
            <p:spPr bwMode="auto">
              <a:xfrm>
                <a:off x="6657975" y="6564313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8" name="Oval 287"/>
              <p:cNvSpPr>
                <a:spLocks noChangeArrowheads="1"/>
              </p:cNvSpPr>
              <p:nvPr/>
            </p:nvSpPr>
            <p:spPr bwMode="auto">
              <a:xfrm>
                <a:off x="6657975" y="6564313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9" name="Oval 288"/>
              <p:cNvSpPr>
                <a:spLocks noChangeArrowheads="1"/>
              </p:cNvSpPr>
              <p:nvPr/>
            </p:nvSpPr>
            <p:spPr bwMode="auto">
              <a:xfrm>
                <a:off x="6657975" y="64436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0" name="Oval 289"/>
              <p:cNvSpPr>
                <a:spLocks noChangeArrowheads="1"/>
              </p:cNvSpPr>
              <p:nvPr/>
            </p:nvSpPr>
            <p:spPr bwMode="auto">
              <a:xfrm>
                <a:off x="6657975" y="64436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1" name="Oval 290"/>
              <p:cNvSpPr>
                <a:spLocks noChangeArrowheads="1"/>
              </p:cNvSpPr>
              <p:nvPr/>
            </p:nvSpPr>
            <p:spPr bwMode="auto">
              <a:xfrm>
                <a:off x="6754813" y="64738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2" name="Oval 291"/>
              <p:cNvSpPr>
                <a:spLocks noChangeArrowheads="1"/>
              </p:cNvSpPr>
              <p:nvPr/>
            </p:nvSpPr>
            <p:spPr bwMode="auto">
              <a:xfrm>
                <a:off x="6754813" y="64738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3" name="Oval 292"/>
              <p:cNvSpPr>
                <a:spLocks noChangeArrowheads="1"/>
              </p:cNvSpPr>
              <p:nvPr/>
            </p:nvSpPr>
            <p:spPr bwMode="auto">
              <a:xfrm>
                <a:off x="6705600" y="659447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4" name="Oval 293"/>
              <p:cNvSpPr>
                <a:spLocks noChangeArrowheads="1"/>
              </p:cNvSpPr>
              <p:nvPr/>
            </p:nvSpPr>
            <p:spPr bwMode="auto">
              <a:xfrm>
                <a:off x="6705600" y="659447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5" name="Oval 294"/>
              <p:cNvSpPr>
                <a:spLocks noChangeArrowheads="1"/>
              </p:cNvSpPr>
              <p:nvPr/>
            </p:nvSpPr>
            <p:spPr bwMode="auto">
              <a:xfrm>
                <a:off x="6705600" y="65039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6" name="Oval 295"/>
              <p:cNvSpPr>
                <a:spLocks noChangeArrowheads="1"/>
              </p:cNvSpPr>
              <p:nvPr/>
            </p:nvSpPr>
            <p:spPr bwMode="auto">
              <a:xfrm>
                <a:off x="6705600" y="65039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7" name="Oval 296"/>
              <p:cNvSpPr>
                <a:spLocks noChangeArrowheads="1"/>
              </p:cNvSpPr>
              <p:nvPr/>
            </p:nvSpPr>
            <p:spPr bwMode="auto">
              <a:xfrm>
                <a:off x="6657975" y="64738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8" name="Oval 297"/>
              <p:cNvSpPr>
                <a:spLocks noChangeArrowheads="1"/>
              </p:cNvSpPr>
              <p:nvPr/>
            </p:nvSpPr>
            <p:spPr bwMode="auto">
              <a:xfrm>
                <a:off x="6657975" y="64738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9" name="Oval 298"/>
              <p:cNvSpPr>
                <a:spLocks noChangeArrowheads="1"/>
              </p:cNvSpPr>
              <p:nvPr/>
            </p:nvSpPr>
            <p:spPr bwMode="auto">
              <a:xfrm>
                <a:off x="6705600" y="6626225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0" name="Oval 299"/>
              <p:cNvSpPr>
                <a:spLocks noChangeArrowheads="1"/>
              </p:cNvSpPr>
              <p:nvPr/>
            </p:nvSpPr>
            <p:spPr bwMode="auto">
              <a:xfrm>
                <a:off x="6705600" y="6626225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1" name="Oval 300"/>
              <p:cNvSpPr>
                <a:spLocks noChangeArrowheads="1"/>
              </p:cNvSpPr>
              <p:nvPr/>
            </p:nvSpPr>
            <p:spPr bwMode="auto">
              <a:xfrm>
                <a:off x="6754813" y="6564313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2" name="Oval 301"/>
              <p:cNvSpPr>
                <a:spLocks noChangeArrowheads="1"/>
              </p:cNvSpPr>
              <p:nvPr/>
            </p:nvSpPr>
            <p:spPr bwMode="auto">
              <a:xfrm>
                <a:off x="6754813" y="6564313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3" name="Oval 302"/>
              <p:cNvSpPr>
                <a:spLocks noChangeArrowheads="1"/>
              </p:cNvSpPr>
              <p:nvPr/>
            </p:nvSpPr>
            <p:spPr bwMode="auto">
              <a:xfrm>
                <a:off x="6802438" y="653415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4" name="Oval 303"/>
              <p:cNvSpPr>
                <a:spLocks noChangeArrowheads="1"/>
              </p:cNvSpPr>
              <p:nvPr/>
            </p:nvSpPr>
            <p:spPr bwMode="auto">
              <a:xfrm>
                <a:off x="6802438" y="653415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5" name="Oval 304"/>
              <p:cNvSpPr>
                <a:spLocks noChangeArrowheads="1"/>
              </p:cNvSpPr>
              <p:nvPr/>
            </p:nvSpPr>
            <p:spPr bwMode="auto">
              <a:xfrm>
                <a:off x="6754813" y="6626225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6" name="Oval 305"/>
              <p:cNvSpPr>
                <a:spLocks noChangeArrowheads="1"/>
              </p:cNvSpPr>
              <p:nvPr/>
            </p:nvSpPr>
            <p:spPr bwMode="auto">
              <a:xfrm>
                <a:off x="6754813" y="6626225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7" name="Oval 306"/>
              <p:cNvSpPr>
                <a:spLocks noChangeArrowheads="1"/>
              </p:cNvSpPr>
              <p:nvPr/>
            </p:nvSpPr>
            <p:spPr bwMode="auto">
              <a:xfrm>
                <a:off x="6802438" y="65643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8" name="Oval 307"/>
              <p:cNvSpPr>
                <a:spLocks noChangeArrowheads="1"/>
              </p:cNvSpPr>
              <p:nvPr/>
            </p:nvSpPr>
            <p:spPr bwMode="auto">
              <a:xfrm>
                <a:off x="6802438" y="65643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9" name="Oval 308"/>
              <p:cNvSpPr>
                <a:spLocks noChangeArrowheads="1"/>
              </p:cNvSpPr>
              <p:nvPr/>
            </p:nvSpPr>
            <p:spPr bwMode="auto">
              <a:xfrm>
                <a:off x="6705600" y="632301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0" name="Oval 309"/>
              <p:cNvSpPr>
                <a:spLocks noChangeArrowheads="1"/>
              </p:cNvSpPr>
              <p:nvPr/>
            </p:nvSpPr>
            <p:spPr bwMode="auto">
              <a:xfrm>
                <a:off x="6705600" y="632301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1" name="Oval 310"/>
              <p:cNvSpPr>
                <a:spLocks noChangeArrowheads="1"/>
              </p:cNvSpPr>
              <p:nvPr/>
            </p:nvSpPr>
            <p:spPr bwMode="auto">
              <a:xfrm>
                <a:off x="6754813" y="6503988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2" name="Oval 311"/>
              <p:cNvSpPr>
                <a:spLocks noChangeArrowheads="1"/>
              </p:cNvSpPr>
              <p:nvPr/>
            </p:nvSpPr>
            <p:spPr bwMode="auto">
              <a:xfrm>
                <a:off x="6754813" y="6503988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3" name="Oval 312"/>
              <p:cNvSpPr>
                <a:spLocks noChangeArrowheads="1"/>
              </p:cNvSpPr>
              <p:nvPr/>
            </p:nvSpPr>
            <p:spPr bwMode="auto">
              <a:xfrm>
                <a:off x="6705600" y="6443663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4" name="Oval 313"/>
              <p:cNvSpPr>
                <a:spLocks noChangeArrowheads="1"/>
              </p:cNvSpPr>
              <p:nvPr/>
            </p:nvSpPr>
            <p:spPr bwMode="auto">
              <a:xfrm>
                <a:off x="6705600" y="6443663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5" name="Oval 314"/>
              <p:cNvSpPr>
                <a:spLocks noChangeArrowheads="1"/>
              </p:cNvSpPr>
              <p:nvPr/>
            </p:nvSpPr>
            <p:spPr bwMode="auto">
              <a:xfrm>
                <a:off x="6705600" y="6473825"/>
                <a:ext cx="25400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0" name="Oval 315"/>
              <p:cNvSpPr>
                <a:spLocks noChangeArrowheads="1"/>
              </p:cNvSpPr>
              <p:nvPr/>
            </p:nvSpPr>
            <p:spPr bwMode="auto">
              <a:xfrm>
                <a:off x="6705600" y="6473825"/>
                <a:ext cx="25400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1" name="Oval 316"/>
              <p:cNvSpPr>
                <a:spLocks noChangeArrowheads="1"/>
              </p:cNvSpPr>
              <p:nvPr/>
            </p:nvSpPr>
            <p:spPr bwMode="auto">
              <a:xfrm>
                <a:off x="6754813" y="6443663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0" name="Oval 317"/>
              <p:cNvSpPr>
                <a:spLocks noChangeArrowheads="1"/>
              </p:cNvSpPr>
              <p:nvPr/>
            </p:nvSpPr>
            <p:spPr bwMode="auto">
              <a:xfrm>
                <a:off x="6754813" y="6443663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1" name="Oval 318"/>
              <p:cNvSpPr>
                <a:spLocks noChangeArrowheads="1"/>
              </p:cNvSpPr>
              <p:nvPr/>
            </p:nvSpPr>
            <p:spPr bwMode="auto">
              <a:xfrm>
                <a:off x="6610350" y="6564313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" name="Oval 319"/>
              <p:cNvSpPr>
                <a:spLocks noChangeArrowheads="1"/>
              </p:cNvSpPr>
              <p:nvPr/>
            </p:nvSpPr>
            <p:spPr bwMode="auto">
              <a:xfrm>
                <a:off x="6610350" y="6564313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" name="Oval 320"/>
              <p:cNvSpPr>
                <a:spLocks noChangeArrowheads="1"/>
              </p:cNvSpPr>
              <p:nvPr/>
            </p:nvSpPr>
            <p:spPr bwMode="auto">
              <a:xfrm>
                <a:off x="6754813" y="6594475"/>
                <a:ext cx="23813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8" name="Oval 321"/>
              <p:cNvSpPr>
                <a:spLocks noChangeArrowheads="1"/>
              </p:cNvSpPr>
              <p:nvPr/>
            </p:nvSpPr>
            <p:spPr bwMode="auto">
              <a:xfrm>
                <a:off x="6754813" y="6594475"/>
                <a:ext cx="23813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" name="Oval 322"/>
              <p:cNvSpPr>
                <a:spLocks noChangeArrowheads="1"/>
              </p:cNvSpPr>
              <p:nvPr/>
            </p:nvSpPr>
            <p:spPr bwMode="auto">
              <a:xfrm>
                <a:off x="6657975" y="6413500"/>
                <a:ext cx="23813" cy="238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" name="Oval 323"/>
              <p:cNvSpPr>
                <a:spLocks noChangeArrowheads="1"/>
              </p:cNvSpPr>
              <p:nvPr/>
            </p:nvSpPr>
            <p:spPr bwMode="auto">
              <a:xfrm>
                <a:off x="6657975" y="6413500"/>
                <a:ext cx="23813" cy="238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88" name="Freeform 364"/>
              <p:cNvSpPr>
                <a:spLocks/>
              </p:cNvSpPr>
              <p:nvPr/>
            </p:nvSpPr>
            <p:spPr bwMode="auto">
              <a:xfrm>
                <a:off x="6718299" y="5999163"/>
                <a:ext cx="361951" cy="277812"/>
              </a:xfrm>
              <a:custGeom>
                <a:avLst/>
                <a:gdLst>
                  <a:gd name="T0" fmla="*/ 0 w 225"/>
                  <a:gd name="T1" fmla="*/ 175 h 175"/>
                  <a:gd name="T2" fmla="*/ 0 w 225"/>
                  <a:gd name="T3" fmla="*/ 0 h 175"/>
                  <a:gd name="T4" fmla="*/ 225 w 225"/>
                  <a:gd name="T5" fmla="*/ 0 h 175"/>
                  <a:gd name="T6" fmla="*/ 225 w 225"/>
                  <a:gd name="T7" fmla="*/ 37 h 1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25" h="175">
                    <a:moveTo>
                      <a:pt x="0" y="175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37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90" name="Freeform 366"/>
              <p:cNvSpPr>
                <a:spLocks/>
              </p:cNvSpPr>
              <p:nvPr/>
            </p:nvSpPr>
            <p:spPr bwMode="auto">
              <a:xfrm>
                <a:off x="6718300" y="5768975"/>
                <a:ext cx="1082675" cy="206375"/>
              </a:xfrm>
              <a:custGeom>
                <a:avLst/>
                <a:gdLst>
                  <a:gd name="T0" fmla="*/ 0 w 682"/>
                  <a:gd name="T1" fmla="*/ 130 h 130"/>
                  <a:gd name="T2" fmla="*/ 0 w 682"/>
                  <a:gd name="T3" fmla="*/ 0 h 130"/>
                  <a:gd name="T4" fmla="*/ 682 w 682"/>
                  <a:gd name="T5" fmla="*/ 0 h 130"/>
                  <a:gd name="T6" fmla="*/ 682 w 682"/>
                  <a:gd name="T7" fmla="*/ 130 h 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82" h="130">
                    <a:moveTo>
                      <a:pt x="0" y="130"/>
                    </a:moveTo>
                    <a:lnTo>
                      <a:pt x="0" y="0"/>
                    </a:lnTo>
                    <a:lnTo>
                      <a:pt x="682" y="0"/>
                    </a:lnTo>
                    <a:lnTo>
                      <a:pt x="682" y="13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92" name="Freeform 368"/>
              <p:cNvSpPr>
                <a:spLocks/>
              </p:cNvSpPr>
              <p:nvPr/>
            </p:nvSpPr>
            <p:spPr bwMode="auto">
              <a:xfrm>
                <a:off x="6718300" y="5629275"/>
                <a:ext cx="1450976" cy="884238"/>
              </a:xfrm>
              <a:custGeom>
                <a:avLst/>
                <a:gdLst>
                  <a:gd name="T0" fmla="*/ 0 w 914"/>
                  <a:gd name="T1" fmla="*/ 57 h 580"/>
                  <a:gd name="T2" fmla="*/ 0 w 914"/>
                  <a:gd name="T3" fmla="*/ 0 h 580"/>
                  <a:gd name="T4" fmla="*/ 914 w 914"/>
                  <a:gd name="T5" fmla="*/ 0 h 580"/>
                  <a:gd name="T6" fmla="*/ 914 w 914"/>
                  <a:gd name="T7" fmla="*/ 580 h 5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14" h="580">
                    <a:moveTo>
                      <a:pt x="0" y="57"/>
                    </a:moveTo>
                    <a:lnTo>
                      <a:pt x="0" y="0"/>
                    </a:lnTo>
                    <a:lnTo>
                      <a:pt x="914" y="0"/>
                    </a:lnTo>
                    <a:lnTo>
                      <a:pt x="914" y="58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4" name="Rectangle 532"/>
              <p:cNvSpPr>
                <a:spLocks noChangeArrowheads="1"/>
              </p:cNvSpPr>
              <p:nvPr/>
            </p:nvSpPr>
            <p:spPr bwMode="auto">
              <a:xfrm>
                <a:off x="6819456" y="5868194"/>
                <a:ext cx="141288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**</a:t>
                </a:r>
                <a:endParaRPr kumimoji="0" lang="el-GR" altLang="el-GR" sz="4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5" name="Rectangle 534"/>
              <p:cNvSpPr>
                <a:spLocks noChangeArrowheads="1"/>
              </p:cNvSpPr>
              <p:nvPr/>
            </p:nvSpPr>
            <p:spPr bwMode="auto">
              <a:xfrm>
                <a:off x="7142163" y="5627274"/>
                <a:ext cx="282575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****</a:t>
                </a:r>
                <a:endParaRPr kumimoji="0" lang="el-GR" altLang="el-GR" sz="4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6" name="Rectangle 534"/>
              <p:cNvSpPr>
                <a:spLocks noChangeArrowheads="1"/>
              </p:cNvSpPr>
              <p:nvPr/>
            </p:nvSpPr>
            <p:spPr bwMode="auto">
              <a:xfrm>
                <a:off x="7302500" y="5488125"/>
                <a:ext cx="282575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****</a:t>
                </a:r>
                <a:endParaRPr kumimoji="0" lang="el-GR" altLang="el-GR" sz="4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36" name="Ευθεία γραμμή σύνδεσης 435"/>
            <p:cNvCxnSpPr/>
            <p:nvPr/>
          </p:nvCxnSpPr>
          <p:spPr>
            <a:xfrm flipV="1">
              <a:off x="795151" y="6370475"/>
              <a:ext cx="370541" cy="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7" name="Ευθεία γραμμή σύνδεσης 436"/>
            <p:cNvCxnSpPr/>
            <p:nvPr/>
          </p:nvCxnSpPr>
          <p:spPr>
            <a:xfrm flipV="1">
              <a:off x="795151" y="6939222"/>
              <a:ext cx="370541" cy="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8" name="Ευθεία γραμμή σύνδεσης 437"/>
            <p:cNvCxnSpPr/>
            <p:nvPr/>
          </p:nvCxnSpPr>
          <p:spPr>
            <a:xfrm flipV="1">
              <a:off x="795151" y="7511674"/>
              <a:ext cx="370541" cy="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9" name="Ευθεία γραμμή σύνδεσης 438"/>
            <p:cNvCxnSpPr/>
            <p:nvPr/>
          </p:nvCxnSpPr>
          <p:spPr>
            <a:xfrm flipV="1">
              <a:off x="795151" y="8079586"/>
              <a:ext cx="370541" cy="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0" name="Δεξιά αγκύλη 439"/>
            <p:cNvSpPr/>
            <p:nvPr/>
          </p:nvSpPr>
          <p:spPr>
            <a:xfrm>
              <a:off x="2735447" y="750801"/>
              <a:ext cx="36000" cy="180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41" name="Δεξιά αγκύλη 440"/>
            <p:cNvSpPr/>
            <p:nvPr/>
          </p:nvSpPr>
          <p:spPr>
            <a:xfrm>
              <a:off x="2881824" y="754476"/>
              <a:ext cx="36000" cy="288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43" name="TextBox 442"/>
            <p:cNvSpPr txBox="1"/>
            <p:nvPr/>
          </p:nvSpPr>
          <p:spPr>
            <a:xfrm rot="5400000">
              <a:off x="2594991" y="701387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5" name="TextBox 444"/>
            <p:cNvSpPr txBox="1"/>
            <p:nvPr/>
          </p:nvSpPr>
          <p:spPr>
            <a:xfrm rot="5400000">
              <a:off x="2757227" y="747678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6" name="Δεξιά αγκύλη 445"/>
            <p:cNvSpPr/>
            <p:nvPr/>
          </p:nvSpPr>
          <p:spPr>
            <a:xfrm>
              <a:off x="2699513" y="1044021"/>
              <a:ext cx="36000" cy="216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47" name="TextBox 446"/>
            <p:cNvSpPr txBox="1"/>
            <p:nvPr/>
          </p:nvSpPr>
          <p:spPr>
            <a:xfrm rot="5400000">
              <a:off x="2564227" y="1008286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8" name="Δεξιά αγκύλη 447"/>
            <p:cNvSpPr/>
            <p:nvPr/>
          </p:nvSpPr>
          <p:spPr>
            <a:xfrm>
              <a:off x="2843889" y="3047101"/>
              <a:ext cx="36000" cy="180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49" name="TextBox 448"/>
            <p:cNvSpPr txBox="1"/>
            <p:nvPr/>
          </p:nvSpPr>
          <p:spPr>
            <a:xfrm rot="5400000">
              <a:off x="2679374" y="299317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0" name="Δεξιά αγκύλη 449"/>
            <p:cNvSpPr/>
            <p:nvPr/>
          </p:nvSpPr>
          <p:spPr>
            <a:xfrm>
              <a:off x="3072186" y="3357733"/>
              <a:ext cx="36000" cy="180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51" name="TextBox 450"/>
            <p:cNvSpPr txBox="1"/>
            <p:nvPr/>
          </p:nvSpPr>
          <p:spPr>
            <a:xfrm rot="5400000">
              <a:off x="2966982" y="3303811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2" name="Δεξιά αγκύλη 451"/>
            <p:cNvSpPr/>
            <p:nvPr/>
          </p:nvSpPr>
          <p:spPr>
            <a:xfrm>
              <a:off x="2963491" y="3041026"/>
              <a:ext cx="36000" cy="324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53" name="TextBox 452"/>
            <p:cNvSpPr txBox="1"/>
            <p:nvPr/>
          </p:nvSpPr>
          <p:spPr>
            <a:xfrm rot="5400000">
              <a:off x="2809429" y="3050186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4" name="Δεξιά αγκύλη 453"/>
            <p:cNvSpPr/>
            <p:nvPr/>
          </p:nvSpPr>
          <p:spPr>
            <a:xfrm>
              <a:off x="5997976" y="3073671"/>
              <a:ext cx="36000" cy="180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55" name="TextBox 454"/>
            <p:cNvSpPr txBox="1"/>
            <p:nvPr/>
          </p:nvSpPr>
          <p:spPr>
            <a:xfrm rot="5400000">
              <a:off x="5833461" y="301974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6" name="Δεξιά αγκύλη 455"/>
            <p:cNvSpPr/>
            <p:nvPr/>
          </p:nvSpPr>
          <p:spPr>
            <a:xfrm>
              <a:off x="6199603" y="3384303"/>
              <a:ext cx="36000" cy="180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57" name="TextBox 456"/>
            <p:cNvSpPr txBox="1"/>
            <p:nvPr/>
          </p:nvSpPr>
          <p:spPr>
            <a:xfrm>
              <a:off x="6179326" y="3338897"/>
              <a:ext cx="3064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l-G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8" name="Δεξιά αγκύλη 457"/>
            <p:cNvSpPr/>
            <p:nvPr/>
          </p:nvSpPr>
          <p:spPr>
            <a:xfrm>
              <a:off x="6117578" y="3067596"/>
              <a:ext cx="36000" cy="324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59" name="TextBox 458"/>
            <p:cNvSpPr txBox="1"/>
            <p:nvPr/>
          </p:nvSpPr>
          <p:spPr>
            <a:xfrm rot="5400000">
              <a:off x="5963516" y="3076756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092803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4</TotalTime>
  <Words>183</Words>
  <Application>Microsoft Office PowerPoint</Application>
  <PresentationFormat>Χαρτί Α4 (210x297 χιλ.)</PresentationFormat>
  <Paragraphs>121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2</dc:creator>
  <cp:lastModifiedBy>christina ploumi</cp:lastModifiedBy>
  <cp:revision>32</cp:revision>
  <dcterms:created xsi:type="dcterms:W3CDTF">2021-03-01T21:37:34Z</dcterms:created>
  <dcterms:modified xsi:type="dcterms:W3CDTF">2022-12-13T13:53:29Z</dcterms:modified>
</cp:coreProperties>
</file>